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DE"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2143080" y="685440"/>
            <a:ext cx="257184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DE"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EA02AF8-4113-477F-B58F-8BEB0DC05800}" type="slidenum">
              <a:rPr b="0" lang="de-DE"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7" name="PlaceHolder 1"/>
          <p:cNvSpPr>
            <a:spLocks noGrp="1"/>
          </p:cNvSpPr>
          <p:nvPr>
            <p:ph type="sldImg"/>
          </p:nvPr>
        </p:nvSpPr>
        <p:spPr>
          <a:xfrm>
            <a:off x="2143080" y="685800"/>
            <a:ext cx="2571840" cy="3429000"/>
          </a:xfrm>
          <a:prstGeom prst="rect">
            <a:avLst/>
          </a:prstGeom>
          <a:ln w="0">
            <a:noFill/>
          </a:ln>
        </p:spPr>
      </p:sp>
      <p:sp>
        <p:nvSpPr>
          <p:cNvPr id="508"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de-DE" sz="1200" spc="-1" strike="noStrike">
              <a:solidFill>
                <a:srgbClr val="000000"/>
              </a:solidFill>
              <a:latin typeface="Calibri"/>
            </a:endParaRPr>
          </a:p>
        </p:txBody>
      </p:sp>
      <p:sp>
        <p:nvSpPr>
          <p:cNvPr id="509"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4F28DA9-6812-426B-B26F-F8535BD96F64}" type="slidenum">
              <a:rPr b="0" lang="de-DE"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332728E-4D1D-4EA8-B2CA-AB16E427BB9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36CEA02-0474-4F13-830A-C7334B9B95B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152155A-D4C7-4618-BDA2-B311DA8B7AC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9E73F56-F882-42C2-9329-7C3BED3B474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1BE7195-6424-4E76-8986-8FE773AE9C6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E623339-7A44-443C-8699-CDA000510AB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61903C9-45B2-4C12-B0D0-35AAC3C5F72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5A41764-A277-45F8-8618-6CB70BC1157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4488087-0FA2-429F-B26D-87C6C175A4D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C9E9C28-CB25-41CF-B1B9-01D88F5A0A9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0338E99-1D81-461F-B9D5-EE323B55465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52DD2B6-0DB8-4D2E-892C-375C4CDE6EF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DE"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DE"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B2CB373-4D92-4A9B-B2BC-A682B0644080}" type="slidenum">
              <a:rPr b="0" lang="de-DE"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Rectangle 10"/>
          <p:cNvSpPr/>
          <p:nvPr/>
        </p:nvSpPr>
        <p:spPr>
          <a:xfrm>
            <a:off x="2308320" y="969840"/>
            <a:ext cx="6120" cy="960480"/>
          </a:xfrm>
          <a:prstGeom prst="rect">
            <a:avLst/>
          </a:prstGeom>
          <a:solidFill>
            <a:srgbClr val="868686"/>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9" name="Rectangle 11"/>
          <p:cNvSpPr/>
          <p:nvPr/>
        </p:nvSpPr>
        <p:spPr>
          <a:xfrm>
            <a:off x="2308320" y="1930320"/>
            <a:ext cx="2338200" cy="6480"/>
          </a:xfrm>
          <a:prstGeom prst="rect">
            <a:avLst/>
          </a:prstGeom>
          <a:solidFill>
            <a:srgbClr val="868686"/>
          </a:solidFill>
          <a:ln w="648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Calibri"/>
            </a:endParaRPr>
          </a:p>
        </p:txBody>
      </p:sp>
      <p:sp>
        <p:nvSpPr>
          <p:cNvPr id="50" name="Rectangle 49"/>
          <p:cNvSpPr/>
          <p:nvPr/>
        </p:nvSpPr>
        <p:spPr>
          <a:xfrm>
            <a:off x="2366640" y="939960"/>
            <a:ext cx="9579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y = 0.1073x – 16.892</a:t>
            </a:r>
            <a:endParaRPr b="0" lang="en-US" sz="800" spc="-1" strike="noStrike">
              <a:solidFill>
                <a:srgbClr val="000000"/>
              </a:solidFill>
              <a:latin typeface="Calibri"/>
            </a:endParaRPr>
          </a:p>
        </p:txBody>
      </p:sp>
      <p:sp>
        <p:nvSpPr>
          <p:cNvPr id="51" name="Rectangle 50"/>
          <p:cNvSpPr/>
          <p:nvPr/>
        </p:nvSpPr>
        <p:spPr>
          <a:xfrm>
            <a:off x="2361960" y="1049400"/>
            <a:ext cx="535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R² = 0.6916</a:t>
            </a:r>
            <a:endParaRPr b="0" lang="en-US" sz="800" spc="-1" strike="noStrike">
              <a:solidFill>
                <a:srgbClr val="000000"/>
              </a:solidFill>
              <a:latin typeface="Calibri"/>
            </a:endParaRPr>
          </a:p>
        </p:txBody>
      </p:sp>
      <p:sp>
        <p:nvSpPr>
          <p:cNvPr id="52" name="Rectangle 51"/>
          <p:cNvSpPr/>
          <p:nvPr/>
        </p:nvSpPr>
        <p:spPr>
          <a:xfrm>
            <a:off x="2225520" y="18781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53" name="Rectangle 52"/>
          <p:cNvSpPr/>
          <p:nvPr/>
        </p:nvSpPr>
        <p:spPr>
          <a:xfrm>
            <a:off x="2111400" y="1720800"/>
            <a:ext cx="169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500</a:t>
            </a:r>
            <a:endParaRPr b="0" lang="en-US" sz="800" spc="-1" strike="noStrike">
              <a:solidFill>
                <a:srgbClr val="000000"/>
              </a:solidFill>
              <a:latin typeface="Calibri"/>
            </a:endParaRPr>
          </a:p>
        </p:txBody>
      </p:sp>
      <p:sp>
        <p:nvSpPr>
          <p:cNvPr id="54" name="Rectangle 53"/>
          <p:cNvSpPr/>
          <p:nvPr/>
        </p:nvSpPr>
        <p:spPr>
          <a:xfrm>
            <a:off x="2054520" y="1562040"/>
            <a:ext cx="2264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000</a:t>
            </a:r>
            <a:endParaRPr b="0" lang="en-US" sz="800" spc="-1" strike="noStrike">
              <a:solidFill>
                <a:srgbClr val="000000"/>
              </a:solidFill>
              <a:latin typeface="Calibri"/>
            </a:endParaRPr>
          </a:p>
        </p:txBody>
      </p:sp>
      <p:sp>
        <p:nvSpPr>
          <p:cNvPr id="55" name="Rectangle 54"/>
          <p:cNvSpPr/>
          <p:nvPr/>
        </p:nvSpPr>
        <p:spPr>
          <a:xfrm>
            <a:off x="2054520" y="1398600"/>
            <a:ext cx="2264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500</a:t>
            </a:r>
            <a:endParaRPr b="0" lang="en-US" sz="800" spc="-1" strike="noStrike">
              <a:solidFill>
                <a:srgbClr val="000000"/>
              </a:solidFill>
              <a:latin typeface="Calibri"/>
            </a:endParaRPr>
          </a:p>
        </p:txBody>
      </p:sp>
      <p:sp>
        <p:nvSpPr>
          <p:cNvPr id="56" name="Rectangle 55"/>
          <p:cNvSpPr/>
          <p:nvPr/>
        </p:nvSpPr>
        <p:spPr>
          <a:xfrm>
            <a:off x="2054520" y="1239840"/>
            <a:ext cx="2264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2000</a:t>
            </a:r>
            <a:endParaRPr b="0" lang="en-US" sz="800" spc="-1" strike="noStrike">
              <a:solidFill>
                <a:srgbClr val="000000"/>
              </a:solidFill>
              <a:latin typeface="Calibri"/>
            </a:endParaRPr>
          </a:p>
        </p:txBody>
      </p:sp>
      <p:sp>
        <p:nvSpPr>
          <p:cNvPr id="57" name="Rectangle 56"/>
          <p:cNvSpPr/>
          <p:nvPr/>
        </p:nvSpPr>
        <p:spPr>
          <a:xfrm>
            <a:off x="2054520" y="1082520"/>
            <a:ext cx="2264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2500</a:t>
            </a:r>
            <a:endParaRPr b="0" lang="en-US" sz="800" spc="-1" strike="noStrike">
              <a:solidFill>
                <a:srgbClr val="000000"/>
              </a:solidFill>
              <a:latin typeface="Calibri"/>
            </a:endParaRPr>
          </a:p>
        </p:txBody>
      </p:sp>
      <p:sp>
        <p:nvSpPr>
          <p:cNvPr id="58" name="Rectangle 57"/>
          <p:cNvSpPr/>
          <p:nvPr/>
        </p:nvSpPr>
        <p:spPr>
          <a:xfrm>
            <a:off x="2054520" y="917640"/>
            <a:ext cx="2264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3000</a:t>
            </a:r>
            <a:endParaRPr b="0" lang="en-US" sz="800" spc="-1" strike="noStrike">
              <a:solidFill>
                <a:srgbClr val="000000"/>
              </a:solidFill>
              <a:latin typeface="Calibri"/>
            </a:endParaRPr>
          </a:p>
        </p:txBody>
      </p:sp>
      <p:sp>
        <p:nvSpPr>
          <p:cNvPr id="59" name="Rectangle 58"/>
          <p:cNvSpPr/>
          <p:nvPr/>
        </p:nvSpPr>
        <p:spPr>
          <a:xfrm>
            <a:off x="2283480" y="197820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60" name="Rectangle 60"/>
          <p:cNvSpPr/>
          <p:nvPr/>
        </p:nvSpPr>
        <p:spPr>
          <a:xfrm>
            <a:off x="2903040" y="1978200"/>
            <a:ext cx="2264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5000</a:t>
            </a:r>
            <a:endParaRPr b="0" lang="en-US" sz="800" spc="-1" strike="noStrike">
              <a:solidFill>
                <a:srgbClr val="000000"/>
              </a:solidFill>
              <a:latin typeface="Calibri"/>
            </a:endParaRPr>
          </a:p>
        </p:txBody>
      </p:sp>
      <p:sp>
        <p:nvSpPr>
          <p:cNvPr id="61" name="Rectangle 62"/>
          <p:cNvSpPr/>
          <p:nvPr/>
        </p:nvSpPr>
        <p:spPr>
          <a:xfrm>
            <a:off x="3568680" y="1978200"/>
            <a:ext cx="2826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0000</a:t>
            </a:r>
            <a:endParaRPr b="0" lang="en-US" sz="800" spc="-1" strike="noStrike">
              <a:solidFill>
                <a:srgbClr val="000000"/>
              </a:solidFill>
              <a:latin typeface="Calibri"/>
            </a:endParaRPr>
          </a:p>
        </p:txBody>
      </p:sp>
      <p:sp>
        <p:nvSpPr>
          <p:cNvPr id="62" name="Rectangle 64"/>
          <p:cNvSpPr/>
          <p:nvPr/>
        </p:nvSpPr>
        <p:spPr>
          <a:xfrm>
            <a:off x="4240080" y="1978200"/>
            <a:ext cx="2826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5000</a:t>
            </a:r>
            <a:endParaRPr b="0" lang="en-US" sz="800" spc="-1" strike="noStrike">
              <a:solidFill>
                <a:srgbClr val="000000"/>
              </a:solidFill>
              <a:latin typeface="Calibri"/>
            </a:endParaRPr>
          </a:p>
        </p:txBody>
      </p:sp>
      <p:sp>
        <p:nvSpPr>
          <p:cNvPr id="63" name="Rectangle 102"/>
          <p:cNvSpPr/>
          <p:nvPr/>
        </p:nvSpPr>
        <p:spPr>
          <a:xfrm>
            <a:off x="2557800" y="487440"/>
            <a:ext cx="1761120" cy="27432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Arial"/>
                <a:ea typeface="Arial"/>
              </a:rPr>
              <a:t>TPS10 products</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a:t>
            </a:r>
            <a:r>
              <a:rPr b="0" i="1" lang="de-DE" sz="800" spc="-1" strike="noStrike">
                <a:solidFill>
                  <a:srgbClr val="000000"/>
                </a:solidFill>
                <a:latin typeface="Arial"/>
                <a:ea typeface="Arial"/>
              </a:rPr>
              <a:t>E</a:t>
            </a:r>
            <a:r>
              <a:rPr b="0" lang="de-DE" sz="800" spc="-1" strike="noStrike">
                <a:solidFill>
                  <a:srgbClr val="000000"/>
                </a:solidFill>
                <a:latin typeface="Arial"/>
                <a:ea typeface="Arial"/>
              </a:rPr>
              <a:t>)-</a:t>
            </a:r>
            <a:r>
              <a:rPr b="0" lang="el-GR" sz="800" spc="-1" strike="noStrike">
                <a:solidFill>
                  <a:srgbClr val="000000"/>
                </a:solidFill>
                <a:latin typeface="Arial"/>
                <a:ea typeface="Arial"/>
              </a:rPr>
              <a:t>β</a:t>
            </a:r>
            <a:r>
              <a:rPr b="0" lang="de-DE" sz="800" spc="-1" strike="noStrike">
                <a:solidFill>
                  <a:srgbClr val="000000"/>
                </a:solidFill>
                <a:latin typeface="Arial"/>
                <a:ea typeface="Arial"/>
              </a:rPr>
              <a:t>-farnesene + (</a:t>
            </a:r>
            <a:r>
              <a:rPr b="0" i="1" lang="de-DE" sz="800" spc="-1" strike="noStrike">
                <a:solidFill>
                  <a:srgbClr val="000000"/>
                </a:solidFill>
                <a:latin typeface="Arial"/>
                <a:ea typeface="Arial"/>
              </a:rPr>
              <a:t>E</a:t>
            </a:r>
            <a:r>
              <a:rPr b="0" lang="de-DE" sz="800" spc="-1" strike="noStrike">
                <a:solidFill>
                  <a:srgbClr val="000000"/>
                </a:solidFill>
                <a:latin typeface="Arial"/>
                <a:ea typeface="Arial"/>
              </a:rPr>
              <a:t>)-</a:t>
            </a:r>
            <a:r>
              <a:rPr b="0" lang="el-GR" sz="800" spc="-1" strike="noStrike">
                <a:solidFill>
                  <a:srgbClr val="000000"/>
                </a:solidFill>
                <a:latin typeface="Arial"/>
                <a:ea typeface="Arial"/>
              </a:rPr>
              <a:t>α</a:t>
            </a:r>
            <a:r>
              <a:rPr b="0" lang="de-DE" sz="800" spc="-1" strike="noStrike">
                <a:solidFill>
                  <a:srgbClr val="000000"/>
                </a:solidFill>
                <a:latin typeface="Arial"/>
                <a:ea typeface="Arial"/>
              </a:rPr>
              <a:t>-bergamotene)</a:t>
            </a:r>
            <a:endParaRPr b="0" lang="en-US" sz="800" spc="-1" strike="noStrike">
              <a:solidFill>
                <a:srgbClr val="000000"/>
              </a:solidFill>
              <a:latin typeface="Calibri"/>
            </a:endParaRPr>
          </a:p>
        </p:txBody>
      </p:sp>
      <p:sp>
        <p:nvSpPr>
          <p:cNvPr id="64" name="Rectangle 109"/>
          <p:cNvSpPr/>
          <p:nvPr/>
        </p:nvSpPr>
        <p:spPr>
          <a:xfrm>
            <a:off x="2319480" y="2851200"/>
            <a:ext cx="6120" cy="850680"/>
          </a:xfrm>
          <a:prstGeom prst="rect">
            <a:avLst/>
          </a:prstGeom>
          <a:solidFill>
            <a:srgbClr val="868686"/>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5" name="Rectangle 110"/>
          <p:cNvSpPr/>
          <p:nvPr/>
        </p:nvSpPr>
        <p:spPr>
          <a:xfrm>
            <a:off x="2319480" y="3701880"/>
            <a:ext cx="2270160" cy="6480"/>
          </a:xfrm>
          <a:prstGeom prst="rect">
            <a:avLst/>
          </a:prstGeom>
          <a:solidFill>
            <a:srgbClr val="868686"/>
          </a:solidFill>
          <a:ln w="648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Calibri"/>
            </a:endParaRPr>
          </a:p>
        </p:txBody>
      </p:sp>
      <p:sp>
        <p:nvSpPr>
          <p:cNvPr id="66" name="Rectangle 148"/>
          <p:cNvSpPr/>
          <p:nvPr/>
        </p:nvSpPr>
        <p:spPr>
          <a:xfrm>
            <a:off x="2379240" y="2811600"/>
            <a:ext cx="793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y = 0.1106x -11.7</a:t>
            </a:r>
            <a:endParaRPr b="0" lang="en-US" sz="800" spc="-1" strike="noStrike">
              <a:solidFill>
                <a:srgbClr val="000000"/>
              </a:solidFill>
              <a:latin typeface="Calibri"/>
            </a:endParaRPr>
          </a:p>
        </p:txBody>
      </p:sp>
      <p:sp>
        <p:nvSpPr>
          <p:cNvPr id="67" name="Rectangle 149"/>
          <p:cNvSpPr/>
          <p:nvPr/>
        </p:nvSpPr>
        <p:spPr>
          <a:xfrm>
            <a:off x="2372760" y="2938320"/>
            <a:ext cx="535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R² = 0.7864</a:t>
            </a:r>
            <a:endParaRPr b="0" lang="en-US" sz="800" spc="-1" strike="noStrike">
              <a:solidFill>
                <a:srgbClr val="000000"/>
              </a:solidFill>
              <a:latin typeface="Calibri"/>
            </a:endParaRPr>
          </a:p>
        </p:txBody>
      </p:sp>
      <p:sp>
        <p:nvSpPr>
          <p:cNvPr id="68" name="Rectangle 150"/>
          <p:cNvSpPr/>
          <p:nvPr/>
        </p:nvSpPr>
        <p:spPr>
          <a:xfrm>
            <a:off x="2193840" y="36511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69" name="Rectangle 151"/>
          <p:cNvSpPr/>
          <p:nvPr/>
        </p:nvSpPr>
        <p:spPr>
          <a:xfrm>
            <a:off x="2098440" y="3479760"/>
            <a:ext cx="169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200</a:t>
            </a:r>
            <a:endParaRPr b="0" lang="en-US" sz="800" spc="-1" strike="noStrike">
              <a:solidFill>
                <a:srgbClr val="000000"/>
              </a:solidFill>
              <a:latin typeface="Calibri"/>
            </a:endParaRPr>
          </a:p>
        </p:txBody>
      </p:sp>
      <p:sp>
        <p:nvSpPr>
          <p:cNvPr id="70" name="Rectangle 152"/>
          <p:cNvSpPr/>
          <p:nvPr/>
        </p:nvSpPr>
        <p:spPr>
          <a:xfrm>
            <a:off x="2098440" y="3314880"/>
            <a:ext cx="169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400</a:t>
            </a:r>
            <a:endParaRPr b="0" lang="en-US" sz="800" spc="-1" strike="noStrike">
              <a:solidFill>
                <a:srgbClr val="000000"/>
              </a:solidFill>
              <a:latin typeface="Calibri"/>
            </a:endParaRPr>
          </a:p>
        </p:txBody>
      </p:sp>
      <p:sp>
        <p:nvSpPr>
          <p:cNvPr id="71" name="Rectangle 153"/>
          <p:cNvSpPr/>
          <p:nvPr/>
        </p:nvSpPr>
        <p:spPr>
          <a:xfrm>
            <a:off x="2098440" y="3143160"/>
            <a:ext cx="169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600</a:t>
            </a:r>
            <a:endParaRPr b="0" lang="en-US" sz="800" spc="-1" strike="noStrike">
              <a:solidFill>
                <a:srgbClr val="000000"/>
              </a:solidFill>
              <a:latin typeface="Calibri"/>
            </a:endParaRPr>
          </a:p>
        </p:txBody>
      </p:sp>
      <p:sp>
        <p:nvSpPr>
          <p:cNvPr id="72" name="Rectangle 154"/>
          <p:cNvSpPr/>
          <p:nvPr/>
        </p:nvSpPr>
        <p:spPr>
          <a:xfrm>
            <a:off x="2098440" y="2971800"/>
            <a:ext cx="169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800</a:t>
            </a:r>
            <a:endParaRPr b="0" lang="en-US" sz="800" spc="-1" strike="noStrike">
              <a:solidFill>
                <a:srgbClr val="000000"/>
              </a:solidFill>
              <a:latin typeface="Calibri"/>
            </a:endParaRPr>
          </a:p>
        </p:txBody>
      </p:sp>
      <p:sp>
        <p:nvSpPr>
          <p:cNvPr id="73" name="Rectangle 155"/>
          <p:cNvSpPr/>
          <p:nvPr/>
        </p:nvSpPr>
        <p:spPr>
          <a:xfrm>
            <a:off x="2057760" y="2800440"/>
            <a:ext cx="2264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000</a:t>
            </a:r>
            <a:endParaRPr b="0" lang="en-US" sz="800" spc="-1" strike="noStrike">
              <a:solidFill>
                <a:srgbClr val="000000"/>
              </a:solidFill>
              <a:latin typeface="Calibri"/>
            </a:endParaRPr>
          </a:p>
        </p:txBody>
      </p:sp>
      <p:sp>
        <p:nvSpPr>
          <p:cNvPr id="74" name="Rectangle 156"/>
          <p:cNvSpPr/>
          <p:nvPr/>
        </p:nvSpPr>
        <p:spPr>
          <a:xfrm>
            <a:off x="2294640" y="374184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75" name="Rectangle 157"/>
          <p:cNvSpPr/>
          <p:nvPr/>
        </p:nvSpPr>
        <p:spPr>
          <a:xfrm>
            <a:off x="2719440" y="3741840"/>
            <a:ext cx="2264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000</a:t>
            </a:r>
            <a:endParaRPr b="0" lang="en-US" sz="800" spc="-1" strike="noStrike">
              <a:solidFill>
                <a:srgbClr val="000000"/>
              </a:solidFill>
              <a:latin typeface="Calibri"/>
            </a:endParaRPr>
          </a:p>
        </p:txBody>
      </p:sp>
      <p:sp>
        <p:nvSpPr>
          <p:cNvPr id="76" name="Rectangle 158"/>
          <p:cNvSpPr/>
          <p:nvPr/>
        </p:nvSpPr>
        <p:spPr>
          <a:xfrm>
            <a:off x="3171960" y="3741840"/>
            <a:ext cx="2264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2000</a:t>
            </a:r>
            <a:endParaRPr b="0" lang="en-US" sz="800" spc="-1" strike="noStrike">
              <a:solidFill>
                <a:srgbClr val="000000"/>
              </a:solidFill>
              <a:latin typeface="Calibri"/>
            </a:endParaRPr>
          </a:p>
        </p:txBody>
      </p:sp>
      <p:sp>
        <p:nvSpPr>
          <p:cNvPr id="77" name="Rectangle 159"/>
          <p:cNvSpPr/>
          <p:nvPr/>
        </p:nvSpPr>
        <p:spPr>
          <a:xfrm>
            <a:off x="3624480" y="3741840"/>
            <a:ext cx="2264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3000</a:t>
            </a:r>
            <a:endParaRPr b="0" lang="en-US" sz="800" spc="-1" strike="noStrike">
              <a:solidFill>
                <a:srgbClr val="000000"/>
              </a:solidFill>
              <a:latin typeface="Calibri"/>
            </a:endParaRPr>
          </a:p>
        </p:txBody>
      </p:sp>
      <p:sp>
        <p:nvSpPr>
          <p:cNvPr id="78" name="Rectangle 160"/>
          <p:cNvSpPr/>
          <p:nvPr/>
        </p:nvSpPr>
        <p:spPr>
          <a:xfrm>
            <a:off x="4077000" y="3741840"/>
            <a:ext cx="2264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4000</a:t>
            </a:r>
            <a:endParaRPr b="0" lang="en-US" sz="800" spc="-1" strike="noStrike">
              <a:solidFill>
                <a:srgbClr val="000000"/>
              </a:solidFill>
              <a:latin typeface="Calibri"/>
            </a:endParaRPr>
          </a:p>
        </p:txBody>
      </p:sp>
      <p:sp>
        <p:nvSpPr>
          <p:cNvPr id="79" name="Rectangle 198"/>
          <p:cNvSpPr/>
          <p:nvPr/>
        </p:nvSpPr>
        <p:spPr>
          <a:xfrm>
            <a:off x="2948400" y="2462040"/>
            <a:ext cx="959400" cy="27432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Arial"/>
                <a:ea typeface="Arial"/>
              </a:rPr>
              <a:t>TPS23 product</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a:t>
            </a:r>
            <a:r>
              <a:rPr b="0" i="1" lang="de-DE" sz="800" spc="-1" strike="noStrike">
                <a:solidFill>
                  <a:srgbClr val="000000"/>
                </a:solidFill>
                <a:latin typeface="Arial"/>
                <a:ea typeface="Arial"/>
              </a:rPr>
              <a:t>E</a:t>
            </a:r>
            <a:r>
              <a:rPr b="0" lang="de-DE" sz="800" spc="-1" strike="noStrike">
                <a:solidFill>
                  <a:srgbClr val="000000"/>
                </a:solidFill>
                <a:latin typeface="Arial"/>
                <a:ea typeface="Arial"/>
              </a:rPr>
              <a:t>)-</a:t>
            </a:r>
            <a:r>
              <a:rPr b="0" lang="el-GR" sz="800" spc="-1" strike="noStrike">
                <a:solidFill>
                  <a:srgbClr val="000000"/>
                </a:solidFill>
                <a:latin typeface="Arial"/>
                <a:ea typeface="Arial"/>
              </a:rPr>
              <a:t>β</a:t>
            </a:r>
            <a:r>
              <a:rPr b="0" lang="de-DE" sz="800" spc="-1" strike="noStrike">
                <a:solidFill>
                  <a:srgbClr val="000000"/>
                </a:solidFill>
                <a:latin typeface="Arial"/>
                <a:ea typeface="Arial"/>
              </a:rPr>
              <a:t>-caryophyllene)</a:t>
            </a:r>
            <a:endParaRPr b="0" lang="en-US" sz="800" spc="-1" strike="noStrike">
              <a:solidFill>
                <a:srgbClr val="000000"/>
              </a:solidFill>
              <a:latin typeface="Calibri"/>
            </a:endParaRPr>
          </a:p>
        </p:txBody>
      </p:sp>
      <p:sp>
        <p:nvSpPr>
          <p:cNvPr id="80" name="Rectangle 50"/>
          <p:cNvSpPr/>
          <p:nvPr/>
        </p:nvSpPr>
        <p:spPr>
          <a:xfrm>
            <a:off x="2364840" y="1155600"/>
            <a:ext cx="491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F = 85.424</a:t>
            </a:r>
            <a:endParaRPr b="0" lang="en-US" sz="800" spc="-1" strike="noStrike">
              <a:solidFill>
                <a:srgbClr val="000000"/>
              </a:solidFill>
              <a:latin typeface="Calibri"/>
            </a:endParaRPr>
          </a:p>
        </p:txBody>
      </p:sp>
      <p:sp>
        <p:nvSpPr>
          <p:cNvPr id="81" name="Rectangle 50"/>
          <p:cNvSpPr/>
          <p:nvPr/>
        </p:nvSpPr>
        <p:spPr>
          <a:xfrm>
            <a:off x="2367000" y="1263600"/>
            <a:ext cx="529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P = &lt; 0.001</a:t>
            </a:r>
            <a:endParaRPr b="0" lang="en-US" sz="800" spc="-1" strike="noStrike">
              <a:solidFill>
                <a:srgbClr val="000000"/>
              </a:solidFill>
              <a:latin typeface="Calibri"/>
            </a:endParaRPr>
          </a:p>
        </p:txBody>
      </p:sp>
      <p:sp>
        <p:nvSpPr>
          <p:cNvPr id="82" name="TextBox 206"/>
          <p:cNvSpPr/>
          <p:nvPr/>
        </p:nvSpPr>
        <p:spPr>
          <a:xfrm>
            <a:off x="4205160" y="2090880"/>
            <a:ext cx="185760" cy="369720"/>
          </a:xfrm>
          <a:prstGeom prst="rect">
            <a:avLst/>
          </a:prstGeom>
          <a:noFill/>
          <a:ln w="0">
            <a:noFill/>
          </a:ln>
        </p:spPr>
        <p:style>
          <a:lnRef idx="0"/>
          <a:fillRef idx="0"/>
          <a:effectRef idx="0"/>
          <a:fontRef idx="minor"/>
        </p:style>
        <p:txBody>
          <a:bodyPr wrap="none" lIns="90000" rIns="90000" tIns="46800" bIns="46800" anchor="t">
            <a:spAutoFit/>
          </a:bodyPr>
          <a:p>
            <a:endParaRPr b="0" lang="en-US" sz="1800" spc="-1" strike="noStrike">
              <a:solidFill>
                <a:srgbClr val="000000"/>
              </a:solidFill>
              <a:latin typeface="Calibri"/>
            </a:endParaRPr>
          </a:p>
        </p:txBody>
      </p:sp>
      <p:sp>
        <p:nvSpPr>
          <p:cNvPr id="83" name="TextBox 152"/>
          <p:cNvSpPr/>
          <p:nvPr/>
        </p:nvSpPr>
        <p:spPr>
          <a:xfrm>
            <a:off x="2301840" y="2090880"/>
            <a:ext cx="24318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Emission from intact plants (peak area x 100,000)</a:t>
            </a:r>
            <a:endParaRPr b="0" lang="en-US" sz="800" spc="-1" strike="noStrike">
              <a:solidFill>
                <a:srgbClr val="000000"/>
              </a:solidFill>
              <a:latin typeface="Calibri"/>
            </a:endParaRPr>
          </a:p>
        </p:txBody>
      </p:sp>
      <p:sp>
        <p:nvSpPr>
          <p:cNvPr id="84" name="TextBox 153"/>
          <p:cNvSpPr/>
          <p:nvPr/>
        </p:nvSpPr>
        <p:spPr>
          <a:xfrm rot="16200000">
            <a:off x="1059120" y="1297800"/>
            <a:ext cx="16225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Release from macerated leaves</a:t>
            </a:r>
            <a:endParaRPr b="0" lang="en-US" sz="8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peak area  x 100,000)</a:t>
            </a:r>
            <a:endParaRPr b="0" lang="en-US" sz="800" spc="-1" strike="noStrike">
              <a:solidFill>
                <a:srgbClr val="000000"/>
              </a:solidFill>
              <a:latin typeface="Calibri"/>
            </a:endParaRPr>
          </a:p>
        </p:txBody>
      </p:sp>
      <p:sp>
        <p:nvSpPr>
          <p:cNvPr id="85" name="Rectangle 149"/>
          <p:cNvSpPr/>
          <p:nvPr/>
        </p:nvSpPr>
        <p:spPr>
          <a:xfrm>
            <a:off x="2376720" y="3057480"/>
            <a:ext cx="491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F = 58.896</a:t>
            </a:r>
            <a:endParaRPr b="0" lang="en-US" sz="800" spc="-1" strike="noStrike">
              <a:solidFill>
                <a:srgbClr val="000000"/>
              </a:solidFill>
              <a:latin typeface="Calibri"/>
            </a:endParaRPr>
          </a:p>
        </p:txBody>
      </p:sp>
      <p:sp>
        <p:nvSpPr>
          <p:cNvPr id="86" name="Rectangle 149"/>
          <p:cNvSpPr/>
          <p:nvPr/>
        </p:nvSpPr>
        <p:spPr>
          <a:xfrm>
            <a:off x="2375280" y="3162240"/>
            <a:ext cx="529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P = &lt; 0.001</a:t>
            </a:r>
            <a:endParaRPr b="0" lang="en-US" sz="800" spc="-1" strike="noStrike">
              <a:solidFill>
                <a:srgbClr val="000000"/>
              </a:solidFill>
              <a:latin typeface="Calibri"/>
            </a:endParaRPr>
          </a:p>
        </p:txBody>
      </p:sp>
      <p:sp>
        <p:nvSpPr>
          <p:cNvPr id="87" name="TextBox 156"/>
          <p:cNvSpPr/>
          <p:nvPr/>
        </p:nvSpPr>
        <p:spPr>
          <a:xfrm>
            <a:off x="2262240" y="3840120"/>
            <a:ext cx="24318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Emission from intact plants (peak area x 100,000)</a:t>
            </a:r>
            <a:endParaRPr b="0" lang="en-US" sz="800" spc="-1" strike="noStrike">
              <a:solidFill>
                <a:srgbClr val="000000"/>
              </a:solidFill>
              <a:latin typeface="Calibri"/>
            </a:endParaRPr>
          </a:p>
        </p:txBody>
      </p:sp>
      <p:sp>
        <p:nvSpPr>
          <p:cNvPr id="88" name="TextBox 157"/>
          <p:cNvSpPr/>
          <p:nvPr/>
        </p:nvSpPr>
        <p:spPr>
          <a:xfrm rot="16200000">
            <a:off x="1057680" y="3094920"/>
            <a:ext cx="16225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Release from macerated leaves</a:t>
            </a:r>
            <a:endParaRPr b="0" lang="en-US" sz="8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peak area x 100,000)</a:t>
            </a:r>
            <a:endParaRPr b="0" lang="en-US" sz="800" spc="-1" strike="noStrike">
              <a:solidFill>
                <a:srgbClr val="000000"/>
              </a:solidFill>
              <a:latin typeface="Calibri"/>
            </a:endParaRPr>
          </a:p>
        </p:txBody>
      </p:sp>
      <p:sp>
        <p:nvSpPr>
          <p:cNvPr id="89" name="TextBox 158"/>
          <p:cNvSpPr/>
          <p:nvPr/>
        </p:nvSpPr>
        <p:spPr>
          <a:xfrm>
            <a:off x="1702800" y="395280"/>
            <a:ext cx="3088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A</a:t>
            </a:r>
            <a:endParaRPr b="0" lang="en-US" sz="1400" spc="-1" strike="noStrike">
              <a:solidFill>
                <a:srgbClr val="000000"/>
              </a:solidFill>
              <a:latin typeface="Calibri"/>
            </a:endParaRPr>
          </a:p>
        </p:txBody>
      </p:sp>
      <p:sp>
        <p:nvSpPr>
          <p:cNvPr id="90" name="TextBox 159"/>
          <p:cNvSpPr/>
          <p:nvPr/>
        </p:nvSpPr>
        <p:spPr>
          <a:xfrm>
            <a:off x="694800" y="4119480"/>
            <a:ext cx="3088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ea typeface="Arial"/>
              </a:rPr>
              <a:t>B</a:t>
            </a:r>
            <a:endParaRPr b="0" lang="en-US" sz="1400" spc="-1" strike="noStrike">
              <a:solidFill>
                <a:srgbClr val="000000"/>
              </a:solidFill>
              <a:latin typeface="Calibri"/>
            </a:endParaRPr>
          </a:p>
        </p:txBody>
      </p:sp>
      <p:sp>
        <p:nvSpPr>
          <p:cNvPr id="91" name="Line 202"/>
          <p:cNvSpPr/>
          <p:nvPr/>
        </p:nvSpPr>
        <p:spPr>
          <a:xfrm>
            <a:off x="1301760" y="5448240"/>
            <a:ext cx="19828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92" name="Line 203"/>
          <p:cNvSpPr/>
          <p:nvPr/>
        </p:nvSpPr>
        <p:spPr>
          <a:xfrm flipV="1">
            <a:off x="132876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93" name="Line 204"/>
          <p:cNvSpPr/>
          <p:nvPr/>
        </p:nvSpPr>
        <p:spPr>
          <a:xfrm flipV="1">
            <a:off x="135396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94" name="Line 205"/>
          <p:cNvSpPr/>
          <p:nvPr/>
        </p:nvSpPr>
        <p:spPr>
          <a:xfrm flipV="1">
            <a:off x="138096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95" name="Line 206"/>
          <p:cNvSpPr/>
          <p:nvPr/>
        </p:nvSpPr>
        <p:spPr>
          <a:xfrm flipV="1">
            <a:off x="140796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96" name="Line 207"/>
          <p:cNvSpPr/>
          <p:nvPr/>
        </p:nvSpPr>
        <p:spPr>
          <a:xfrm flipV="1">
            <a:off x="143352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97" name="Line 208"/>
          <p:cNvSpPr/>
          <p:nvPr/>
        </p:nvSpPr>
        <p:spPr>
          <a:xfrm flipV="1">
            <a:off x="146052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98" name="Line 209"/>
          <p:cNvSpPr/>
          <p:nvPr/>
        </p:nvSpPr>
        <p:spPr>
          <a:xfrm flipV="1">
            <a:off x="148608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99" name="Line 210"/>
          <p:cNvSpPr/>
          <p:nvPr/>
        </p:nvSpPr>
        <p:spPr>
          <a:xfrm flipV="1">
            <a:off x="151272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00" name="Line 211"/>
          <p:cNvSpPr/>
          <p:nvPr/>
        </p:nvSpPr>
        <p:spPr>
          <a:xfrm flipV="1">
            <a:off x="153972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01" name="Line 212"/>
          <p:cNvSpPr/>
          <p:nvPr/>
        </p:nvSpPr>
        <p:spPr>
          <a:xfrm flipV="1">
            <a:off x="156528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02" name="Line 213"/>
          <p:cNvSpPr/>
          <p:nvPr/>
        </p:nvSpPr>
        <p:spPr>
          <a:xfrm flipV="1">
            <a:off x="159228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03" name="Line 214"/>
          <p:cNvSpPr/>
          <p:nvPr/>
        </p:nvSpPr>
        <p:spPr>
          <a:xfrm flipV="1">
            <a:off x="161928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04" name="Line 215"/>
          <p:cNvSpPr/>
          <p:nvPr/>
        </p:nvSpPr>
        <p:spPr>
          <a:xfrm flipV="1">
            <a:off x="164448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05" name="Line 216"/>
          <p:cNvSpPr/>
          <p:nvPr/>
        </p:nvSpPr>
        <p:spPr>
          <a:xfrm flipV="1">
            <a:off x="167148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06" name="Line 217"/>
          <p:cNvSpPr/>
          <p:nvPr/>
        </p:nvSpPr>
        <p:spPr>
          <a:xfrm flipV="1">
            <a:off x="169848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07" name="Line 218"/>
          <p:cNvSpPr/>
          <p:nvPr/>
        </p:nvSpPr>
        <p:spPr>
          <a:xfrm flipV="1">
            <a:off x="172404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08" name="Line 219"/>
          <p:cNvSpPr/>
          <p:nvPr/>
        </p:nvSpPr>
        <p:spPr>
          <a:xfrm flipV="1">
            <a:off x="175104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09" name="Line 220"/>
          <p:cNvSpPr/>
          <p:nvPr/>
        </p:nvSpPr>
        <p:spPr>
          <a:xfrm flipV="1">
            <a:off x="177804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10" name="Line 221"/>
          <p:cNvSpPr/>
          <p:nvPr/>
        </p:nvSpPr>
        <p:spPr>
          <a:xfrm flipV="1">
            <a:off x="180324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11" name="Line 222"/>
          <p:cNvSpPr/>
          <p:nvPr/>
        </p:nvSpPr>
        <p:spPr>
          <a:xfrm flipV="1">
            <a:off x="183024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12" name="Line 223"/>
          <p:cNvSpPr/>
          <p:nvPr/>
        </p:nvSpPr>
        <p:spPr>
          <a:xfrm flipV="1">
            <a:off x="185580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13" name="Line 224"/>
          <p:cNvSpPr/>
          <p:nvPr/>
        </p:nvSpPr>
        <p:spPr>
          <a:xfrm flipV="1">
            <a:off x="188280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14" name="Line 225"/>
          <p:cNvSpPr/>
          <p:nvPr/>
        </p:nvSpPr>
        <p:spPr>
          <a:xfrm flipV="1">
            <a:off x="190980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15" name="Line 226"/>
          <p:cNvSpPr/>
          <p:nvPr/>
        </p:nvSpPr>
        <p:spPr>
          <a:xfrm flipV="1">
            <a:off x="193500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16" name="Line 227"/>
          <p:cNvSpPr/>
          <p:nvPr/>
        </p:nvSpPr>
        <p:spPr>
          <a:xfrm flipV="1">
            <a:off x="196200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17" name="Line 228"/>
          <p:cNvSpPr/>
          <p:nvPr/>
        </p:nvSpPr>
        <p:spPr>
          <a:xfrm flipV="1">
            <a:off x="198900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18" name="Line 229"/>
          <p:cNvSpPr/>
          <p:nvPr/>
        </p:nvSpPr>
        <p:spPr>
          <a:xfrm flipV="1">
            <a:off x="201456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19" name="Line 230"/>
          <p:cNvSpPr/>
          <p:nvPr/>
        </p:nvSpPr>
        <p:spPr>
          <a:xfrm flipV="1">
            <a:off x="204156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20" name="Line 231"/>
          <p:cNvSpPr/>
          <p:nvPr/>
        </p:nvSpPr>
        <p:spPr>
          <a:xfrm flipV="1">
            <a:off x="206856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21" name="Line 232"/>
          <p:cNvSpPr/>
          <p:nvPr/>
        </p:nvSpPr>
        <p:spPr>
          <a:xfrm flipV="1">
            <a:off x="209376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22" name="Line 233"/>
          <p:cNvSpPr/>
          <p:nvPr/>
        </p:nvSpPr>
        <p:spPr>
          <a:xfrm flipV="1">
            <a:off x="212076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23" name="Line 234"/>
          <p:cNvSpPr/>
          <p:nvPr/>
        </p:nvSpPr>
        <p:spPr>
          <a:xfrm flipV="1">
            <a:off x="214632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24" name="Line 235"/>
          <p:cNvSpPr/>
          <p:nvPr/>
        </p:nvSpPr>
        <p:spPr>
          <a:xfrm flipV="1">
            <a:off x="217332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25" name="Line 236"/>
          <p:cNvSpPr/>
          <p:nvPr/>
        </p:nvSpPr>
        <p:spPr>
          <a:xfrm flipV="1">
            <a:off x="220032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26" name="Line 237"/>
          <p:cNvSpPr/>
          <p:nvPr/>
        </p:nvSpPr>
        <p:spPr>
          <a:xfrm flipV="1">
            <a:off x="222552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27" name="Line 238"/>
          <p:cNvSpPr/>
          <p:nvPr/>
        </p:nvSpPr>
        <p:spPr>
          <a:xfrm flipV="1">
            <a:off x="225252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28" name="Line 239"/>
          <p:cNvSpPr/>
          <p:nvPr/>
        </p:nvSpPr>
        <p:spPr>
          <a:xfrm flipV="1">
            <a:off x="227952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29" name="Line 240"/>
          <p:cNvSpPr/>
          <p:nvPr/>
        </p:nvSpPr>
        <p:spPr>
          <a:xfrm flipV="1">
            <a:off x="230508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30" name="Line 241"/>
          <p:cNvSpPr/>
          <p:nvPr/>
        </p:nvSpPr>
        <p:spPr>
          <a:xfrm flipV="1">
            <a:off x="233208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31" name="Line 242"/>
          <p:cNvSpPr/>
          <p:nvPr/>
        </p:nvSpPr>
        <p:spPr>
          <a:xfrm flipV="1">
            <a:off x="235908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32" name="Line 243"/>
          <p:cNvSpPr/>
          <p:nvPr/>
        </p:nvSpPr>
        <p:spPr>
          <a:xfrm flipV="1">
            <a:off x="238428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33" name="Line 244"/>
          <p:cNvSpPr/>
          <p:nvPr/>
        </p:nvSpPr>
        <p:spPr>
          <a:xfrm flipV="1">
            <a:off x="241128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34" name="Line 245"/>
          <p:cNvSpPr/>
          <p:nvPr/>
        </p:nvSpPr>
        <p:spPr>
          <a:xfrm flipV="1">
            <a:off x="243828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35" name="Line 246"/>
          <p:cNvSpPr/>
          <p:nvPr/>
        </p:nvSpPr>
        <p:spPr>
          <a:xfrm flipV="1">
            <a:off x="246384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36" name="Line 247"/>
          <p:cNvSpPr/>
          <p:nvPr/>
        </p:nvSpPr>
        <p:spPr>
          <a:xfrm flipV="1">
            <a:off x="249084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37" name="Line 248"/>
          <p:cNvSpPr/>
          <p:nvPr/>
        </p:nvSpPr>
        <p:spPr>
          <a:xfrm flipV="1">
            <a:off x="251604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38" name="Line 249"/>
          <p:cNvSpPr/>
          <p:nvPr/>
        </p:nvSpPr>
        <p:spPr>
          <a:xfrm flipV="1">
            <a:off x="254304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39" name="Line 250"/>
          <p:cNvSpPr/>
          <p:nvPr/>
        </p:nvSpPr>
        <p:spPr>
          <a:xfrm flipV="1">
            <a:off x="257004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40" name="Line 251"/>
          <p:cNvSpPr/>
          <p:nvPr/>
        </p:nvSpPr>
        <p:spPr>
          <a:xfrm flipV="1">
            <a:off x="259560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41" name="Line 252"/>
          <p:cNvSpPr/>
          <p:nvPr/>
        </p:nvSpPr>
        <p:spPr>
          <a:xfrm flipV="1">
            <a:off x="262260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42" name="Line 253"/>
          <p:cNvSpPr/>
          <p:nvPr/>
        </p:nvSpPr>
        <p:spPr>
          <a:xfrm flipV="1">
            <a:off x="264960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43" name="Line 254"/>
          <p:cNvSpPr/>
          <p:nvPr/>
        </p:nvSpPr>
        <p:spPr>
          <a:xfrm flipV="1">
            <a:off x="267480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44" name="Line 255"/>
          <p:cNvSpPr/>
          <p:nvPr/>
        </p:nvSpPr>
        <p:spPr>
          <a:xfrm flipV="1">
            <a:off x="270180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45" name="Line 256"/>
          <p:cNvSpPr/>
          <p:nvPr/>
        </p:nvSpPr>
        <p:spPr>
          <a:xfrm flipV="1">
            <a:off x="272880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46" name="Line 257"/>
          <p:cNvSpPr/>
          <p:nvPr/>
        </p:nvSpPr>
        <p:spPr>
          <a:xfrm flipV="1">
            <a:off x="275436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47" name="Line 258"/>
          <p:cNvSpPr/>
          <p:nvPr/>
        </p:nvSpPr>
        <p:spPr>
          <a:xfrm flipV="1">
            <a:off x="278136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48" name="Line 259"/>
          <p:cNvSpPr/>
          <p:nvPr/>
        </p:nvSpPr>
        <p:spPr>
          <a:xfrm flipV="1">
            <a:off x="280656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49" name="Line 260"/>
          <p:cNvSpPr/>
          <p:nvPr/>
        </p:nvSpPr>
        <p:spPr>
          <a:xfrm flipV="1">
            <a:off x="283356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50" name="Line 261"/>
          <p:cNvSpPr/>
          <p:nvPr/>
        </p:nvSpPr>
        <p:spPr>
          <a:xfrm flipV="1">
            <a:off x="286056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51" name="Line 262"/>
          <p:cNvSpPr/>
          <p:nvPr/>
        </p:nvSpPr>
        <p:spPr>
          <a:xfrm flipV="1">
            <a:off x="288612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52" name="Line 263"/>
          <p:cNvSpPr/>
          <p:nvPr/>
        </p:nvSpPr>
        <p:spPr>
          <a:xfrm flipV="1">
            <a:off x="291312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53" name="Line 264"/>
          <p:cNvSpPr/>
          <p:nvPr/>
        </p:nvSpPr>
        <p:spPr>
          <a:xfrm flipV="1">
            <a:off x="294012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54" name="Line 265"/>
          <p:cNvSpPr/>
          <p:nvPr/>
        </p:nvSpPr>
        <p:spPr>
          <a:xfrm flipV="1">
            <a:off x="296532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55" name="Line 266"/>
          <p:cNvSpPr/>
          <p:nvPr/>
        </p:nvSpPr>
        <p:spPr>
          <a:xfrm flipV="1">
            <a:off x="299232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56" name="Line 267"/>
          <p:cNvSpPr/>
          <p:nvPr/>
        </p:nvSpPr>
        <p:spPr>
          <a:xfrm flipV="1">
            <a:off x="301932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57" name="Line 268"/>
          <p:cNvSpPr/>
          <p:nvPr/>
        </p:nvSpPr>
        <p:spPr>
          <a:xfrm flipV="1">
            <a:off x="304488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58" name="Line 269"/>
          <p:cNvSpPr/>
          <p:nvPr/>
        </p:nvSpPr>
        <p:spPr>
          <a:xfrm flipV="1">
            <a:off x="307188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59" name="Line 270"/>
          <p:cNvSpPr/>
          <p:nvPr/>
        </p:nvSpPr>
        <p:spPr>
          <a:xfrm flipV="1">
            <a:off x="309888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60" name="Line 271"/>
          <p:cNvSpPr/>
          <p:nvPr/>
        </p:nvSpPr>
        <p:spPr>
          <a:xfrm flipV="1">
            <a:off x="312408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61" name="Line 272"/>
          <p:cNvSpPr/>
          <p:nvPr/>
        </p:nvSpPr>
        <p:spPr>
          <a:xfrm flipV="1">
            <a:off x="315108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62" name="Line 273"/>
          <p:cNvSpPr/>
          <p:nvPr/>
        </p:nvSpPr>
        <p:spPr>
          <a:xfrm flipV="1">
            <a:off x="317664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63" name="Line 274"/>
          <p:cNvSpPr/>
          <p:nvPr/>
        </p:nvSpPr>
        <p:spPr>
          <a:xfrm flipV="1">
            <a:off x="320364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64" name="Line 275"/>
          <p:cNvSpPr/>
          <p:nvPr/>
        </p:nvSpPr>
        <p:spPr>
          <a:xfrm flipV="1">
            <a:off x="3230640" y="5447880"/>
            <a:ext cx="144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65" name="Line 276"/>
          <p:cNvSpPr/>
          <p:nvPr/>
        </p:nvSpPr>
        <p:spPr>
          <a:xfrm flipV="1">
            <a:off x="325584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66" name="Line 277"/>
          <p:cNvSpPr/>
          <p:nvPr/>
        </p:nvSpPr>
        <p:spPr>
          <a:xfrm flipV="1">
            <a:off x="3282840" y="5447880"/>
            <a:ext cx="180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Calibri"/>
            </a:endParaRPr>
          </a:p>
        </p:txBody>
      </p:sp>
      <p:sp>
        <p:nvSpPr>
          <p:cNvPr id="167" name="Rectangle 278"/>
          <p:cNvSpPr/>
          <p:nvPr/>
        </p:nvSpPr>
        <p:spPr>
          <a:xfrm>
            <a:off x="1348200" y="5467320"/>
            <a:ext cx="198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4.2</a:t>
            </a:r>
            <a:endParaRPr b="0" lang="en-US" sz="800" spc="-1" strike="noStrike">
              <a:solidFill>
                <a:srgbClr val="000000"/>
              </a:solidFill>
              <a:latin typeface="Calibri"/>
            </a:endParaRPr>
          </a:p>
        </p:txBody>
      </p:sp>
      <p:sp>
        <p:nvSpPr>
          <p:cNvPr id="168" name="Rectangle 280"/>
          <p:cNvSpPr/>
          <p:nvPr/>
        </p:nvSpPr>
        <p:spPr>
          <a:xfrm>
            <a:off x="1613520" y="5467320"/>
            <a:ext cx="198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4.6</a:t>
            </a:r>
            <a:endParaRPr b="0" lang="en-US" sz="800" spc="-1" strike="noStrike">
              <a:solidFill>
                <a:srgbClr val="000000"/>
              </a:solidFill>
              <a:latin typeface="Calibri"/>
            </a:endParaRPr>
          </a:p>
        </p:txBody>
      </p:sp>
      <p:sp>
        <p:nvSpPr>
          <p:cNvPr id="169" name="Rectangle 282"/>
          <p:cNvSpPr/>
          <p:nvPr/>
        </p:nvSpPr>
        <p:spPr>
          <a:xfrm>
            <a:off x="1877040" y="5467320"/>
            <a:ext cx="198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5.0</a:t>
            </a:r>
            <a:endParaRPr b="0" lang="en-US" sz="800" spc="-1" strike="noStrike">
              <a:solidFill>
                <a:srgbClr val="000000"/>
              </a:solidFill>
              <a:latin typeface="Calibri"/>
            </a:endParaRPr>
          </a:p>
        </p:txBody>
      </p:sp>
      <p:sp>
        <p:nvSpPr>
          <p:cNvPr id="170" name="Rectangle 284"/>
          <p:cNvSpPr/>
          <p:nvPr/>
        </p:nvSpPr>
        <p:spPr>
          <a:xfrm>
            <a:off x="2140560" y="5467320"/>
            <a:ext cx="198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5.4</a:t>
            </a:r>
            <a:endParaRPr b="0" lang="en-US" sz="800" spc="-1" strike="noStrike">
              <a:solidFill>
                <a:srgbClr val="000000"/>
              </a:solidFill>
              <a:latin typeface="Calibri"/>
            </a:endParaRPr>
          </a:p>
        </p:txBody>
      </p:sp>
      <p:sp>
        <p:nvSpPr>
          <p:cNvPr id="171" name="Rectangle 286"/>
          <p:cNvSpPr/>
          <p:nvPr/>
        </p:nvSpPr>
        <p:spPr>
          <a:xfrm>
            <a:off x="2405520" y="5467320"/>
            <a:ext cx="198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5.8</a:t>
            </a:r>
            <a:endParaRPr b="0" lang="en-US" sz="800" spc="-1" strike="noStrike">
              <a:solidFill>
                <a:srgbClr val="000000"/>
              </a:solidFill>
              <a:latin typeface="Calibri"/>
            </a:endParaRPr>
          </a:p>
        </p:txBody>
      </p:sp>
      <p:sp>
        <p:nvSpPr>
          <p:cNvPr id="172" name="Rectangle 288"/>
          <p:cNvSpPr/>
          <p:nvPr/>
        </p:nvSpPr>
        <p:spPr>
          <a:xfrm>
            <a:off x="2669040" y="5467320"/>
            <a:ext cx="198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6.2</a:t>
            </a:r>
            <a:endParaRPr b="0" lang="en-US" sz="800" spc="-1" strike="noStrike">
              <a:solidFill>
                <a:srgbClr val="000000"/>
              </a:solidFill>
              <a:latin typeface="Calibri"/>
            </a:endParaRPr>
          </a:p>
        </p:txBody>
      </p:sp>
      <p:sp>
        <p:nvSpPr>
          <p:cNvPr id="173" name="Rectangle 290"/>
          <p:cNvSpPr/>
          <p:nvPr/>
        </p:nvSpPr>
        <p:spPr>
          <a:xfrm>
            <a:off x="2934360" y="5467320"/>
            <a:ext cx="198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6.6</a:t>
            </a:r>
            <a:endParaRPr b="0" lang="en-US" sz="800" spc="-1" strike="noStrike">
              <a:solidFill>
                <a:srgbClr val="000000"/>
              </a:solidFill>
              <a:latin typeface="Calibri"/>
            </a:endParaRPr>
          </a:p>
        </p:txBody>
      </p:sp>
      <p:sp>
        <p:nvSpPr>
          <p:cNvPr id="174" name="Line 292"/>
          <p:cNvSpPr/>
          <p:nvPr/>
        </p:nvSpPr>
        <p:spPr>
          <a:xfrm flipV="1">
            <a:off x="1433520" y="5447880"/>
            <a:ext cx="144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175" name="Line 293"/>
          <p:cNvSpPr/>
          <p:nvPr/>
        </p:nvSpPr>
        <p:spPr>
          <a:xfrm flipV="1">
            <a:off x="1565280" y="5447880"/>
            <a:ext cx="144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176" name="Line 294"/>
          <p:cNvSpPr/>
          <p:nvPr/>
        </p:nvSpPr>
        <p:spPr>
          <a:xfrm flipV="1">
            <a:off x="1698480" y="5447880"/>
            <a:ext cx="180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177" name="Line 295"/>
          <p:cNvSpPr/>
          <p:nvPr/>
        </p:nvSpPr>
        <p:spPr>
          <a:xfrm flipV="1">
            <a:off x="1830240" y="5447880"/>
            <a:ext cx="180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178" name="Line 296"/>
          <p:cNvSpPr/>
          <p:nvPr/>
        </p:nvSpPr>
        <p:spPr>
          <a:xfrm flipV="1">
            <a:off x="1962000" y="5447880"/>
            <a:ext cx="180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179" name="Line 297"/>
          <p:cNvSpPr/>
          <p:nvPr/>
        </p:nvSpPr>
        <p:spPr>
          <a:xfrm flipV="1">
            <a:off x="2093760" y="5447880"/>
            <a:ext cx="180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180" name="Line 298"/>
          <p:cNvSpPr/>
          <p:nvPr/>
        </p:nvSpPr>
        <p:spPr>
          <a:xfrm flipV="1">
            <a:off x="2225520" y="5447880"/>
            <a:ext cx="180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181" name="Line 299"/>
          <p:cNvSpPr/>
          <p:nvPr/>
        </p:nvSpPr>
        <p:spPr>
          <a:xfrm flipV="1">
            <a:off x="2359080" y="5447880"/>
            <a:ext cx="144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182" name="Line 300"/>
          <p:cNvSpPr/>
          <p:nvPr/>
        </p:nvSpPr>
        <p:spPr>
          <a:xfrm flipV="1">
            <a:off x="2490840" y="5447880"/>
            <a:ext cx="144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183" name="Line 301"/>
          <p:cNvSpPr/>
          <p:nvPr/>
        </p:nvSpPr>
        <p:spPr>
          <a:xfrm flipV="1">
            <a:off x="2622600" y="5447880"/>
            <a:ext cx="144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184" name="Line 302"/>
          <p:cNvSpPr/>
          <p:nvPr/>
        </p:nvSpPr>
        <p:spPr>
          <a:xfrm flipV="1">
            <a:off x="2754360" y="5447880"/>
            <a:ext cx="144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185" name="Line 303"/>
          <p:cNvSpPr/>
          <p:nvPr/>
        </p:nvSpPr>
        <p:spPr>
          <a:xfrm flipV="1">
            <a:off x="2886120" y="5447880"/>
            <a:ext cx="144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186" name="Line 304"/>
          <p:cNvSpPr/>
          <p:nvPr/>
        </p:nvSpPr>
        <p:spPr>
          <a:xfrm flipV="1">
            <a:off x="3019320" y="5447880"/>
            <a:ext cx="180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187" name="Line 305"/>
          <p:cNvSpPr/>
          <p:nvPr/>
        </p:nvSpPr>
        <p:spPr>
          <a:xfrm flipV="1">
            <a:off x="3151080" y="5447880"/>
            <a:ext cx="180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188" name="Line 306"/>
          <p:cNvSpPr/>
          <p:nvPr/>
        </p:nvSpPr>
        <p:spPr>
          <a:xfrm flipV="1">
            <a:off x="3282840" y="5447880"/>
            <a:ext cx="180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189" name="Line 307"/>
          <p:cNvSpPr/>
          <p:nvPr/>
        </p:nvSpPr>
        <p:spPr>
          <a:xfrm flipV="1">
            <a:off x="1301760" y="4600080"/>
            <a:ext cx="1440" cy="8478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90" name="Line 308"/>
          <p:cNvSpPr/>
          <p:nvPr/>
        </p:nvSpPr>
        <p:spPr>
          <a:xfrm>
            <a:off x="1298520" y="542772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191" name="Line 309"/>
          <p:cNvSpPr/>
          <p:nvPr/>
        </p:nvSpPr>
        <p:spPr>
          <a:xfrm>
            <a:off x="1298520" y="5405400"/>
            <a:ext cx="32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192" name="Line 310"/>
          <p:cNvSpPr/>
          <p:nvPr/>
        </p:nvSpPr>
        <p:spPr>
          <a:xfrm>
            <a:off x="1298520" y="5383080"/>
            <a:ext cx="32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193" name="Line 311"/>
          <p:cNvSpPr/>
          <p:nvPr/>
        </p:nvSpPr>
        <p:spPr>
          <a:xfrm>
            <a:off x="1298520" y="536112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194" name="Line 312"/>
          <p:cNvSpPr/>
          <p:nvPr/>
        </p:nvSpPr>
        <p:spPr>
          <a:xfrm>
            <a:off x="1298520" y="5340240"/>
            <a:ext cx="32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195" name="Line 313"/>
          <p:cNvSpPr/>
          <p:nvPr/>
        </p:nvSpPr>
        <p:spPr>
          <a:xfrm>
            <a:off x="1298520" y="531828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196" name="Line 314"/>
          <p:cNvSpPr/>
          <p:nvPr/>
        </p:nvSpPr>
        <p:spPr>
          <a:xfrm>
            <a:off x="1298520" y="529596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197" name="Line 315"/>
          <p:cNvSpPr/>
          <p:nvPr/>
        </p:nvSpPr>
        <p:spPr>
          <a:xfrm>
            <a:off x="1298520" y="5273640"/>
            <a:ext cx="32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198" name="Line 316"/>
          <p:cNvSpPr/>
          <p:nvPr/>
        </p:nvSpPr>
        <p:spPr>
          <a:xfrm>
            <a:off x="1298520" y="525312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199" name="Line 317"/>
          <p:cNvSpPr/>
          <p:nvPr/>
        </p:nvSpPr>
        <p:spPr>
          <a:xfrm>
            <a:off x="1298520" y="523080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00" name="Line 318"/>
          <p:cNvSpPr/>
          <p:nvPr/>
        </p:nvSpPr>
        <p:spPr>
          <a:xfrm>
            <a:off x="1298520" y="5208480"/>
            <a:ext cx="32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201" name="Line 319"/>
          <p:cNvSpPr/>
          <p:nvPr/>
        </p:nvSpPr>
        <p:spPr>
          <a:xfrm>
            <a:off x="1298520" y="518652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02" name="Line 320"/>
          <p:cNvSpPr/>
          <p:nvPr/>
        </p:nvSpPr>
        <p:spPr>
          <a:xfrm>
            <a:off x="1298520" y="516420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03" name="Line 321"/>
          <p:cNvSpPr/>
          <p:nvPr/>
        </p:nvSpPr>
        <p:spPr>
          <a:xfrm>
            <a:off x="1298520" y="514368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04" name="Line 322"/>
          <p:cNvSpPr/>
          <p:nvPr/>
        </p:nvSpPr>
        <p:spPr>
          <a:xfrm>
            <a:off x="1298520" y="512136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05" name="Line 323"/>
          <p:cNvSpPr/>
          <p:nvPr/>
        </p:nvSpPr>
        <p:spPr>
          <a:xfrm>
            <a:off x="1298520" y="509904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06" name="Line 324"/>
          <p:cNvSpPr/>
          <p:nvPr/>
        </p:nvSpPr>
        <p:spPr>
          <a:xfrm>
            <a:off x="1298520" y="5076720"/>
            <a:ext cx="32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207" name="Line 325"/>
          <p:cNvSpPr/>
          <p:nvPr/>
        </p:nvSpPr>
        <p:spPr>
          <a:xfrm>
            <a:off x="1298520" y="505476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08" name="Line 326"/>
          <p:cNvSpPr/>
          <p:nvPr/>
        </p:nvSpPr>
        <p:spPr>
          <a:xfrm>
            <a:off x="1298520" y="5033880"/>
            <a:ext cx="32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209" name="Line 327"/>
          <p:cNvSpPr/>
          <p:nvPr/>
        </p:nvSpPr>
        <p:spPr>
          <a:xfrm>
            <a:off x="1298520" y="5011560"/>
            <a:ext cx="32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210" name="Line 328"/>
          <p:cNvSpPr/>
          <p:nvPr/>
        </p:nvSpPr>
        <p:spPr>
          <a:xfrm>
            <a:off x="1298520" y="498960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11" name="Line 329"/>
          <p:cNvSpPr/>
          <p:nvPr/>
        </p:nvSpPr>
        <p:spPr>
          <a:xfrm>
            <a:off x="1298520" y="496728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12" name="Line 330"/>
          <p:cNvSpPr/>
          <p:nvPr/>
        </p:nvSpPr>
        <p:spPr>
          <a:xfrm>
            <a:off x="1298520" y="494676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13" name="Line 331"/>
          <p:cNvSpPr/>
          <p:nvPr/>
        </p:nvSpPr>
        <p:spPr>
          <a:xfrm>
            <a:off x="1298520" y="492444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14" name="Line 332"/>
          <p:cNvSpPr/>
          <p:nvPr/>
        </p:nvSpPr>
        <p:spPr>
          <a:xfrm>
            <a:off x="1298520" y="4902120"/>
            <a:ext cx="32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215" name="Line 333"/>
          <p:cNvSpPr/>
          <p:nvPr/>
        </p:nvSpPr>
        <p:spPr>
          <a:xfrm>
            <a:off x="1298520" y="4879800"/>
            <a:ext cx="32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216" name="Line 334"/>
          <p:cNvSpPr/>
          <p:nvPr/>
        </p:nvSpPr>
        <p:spPr>
          <a:xfrm>
            <a:off x="1298520" y="485784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17" name="Line 335"/>
          <p:cNvSpPr/>
          <p:nvPr/>
        </p:nvSpPr>
        <p:spPr>
          <a:xfrm>
            <a:off x="1298520" y="4836960"/>
            <a:ext cx="32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218" name="Line 336"/>
          <p:cNvSpPr/>
          <p:nvPr/>
        </p:nvSpPr>
        <p:spPr>
          <a:xfrm>
            <a:off x="1298520" y="481500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19" name="Line 337"/>
          <p:cNvSpPr/>
          <p:nvPr/>
        </p:nvSpPr>
        <p:spPr>
          <a:xfrm>
            <a:off x="1298520" y="479268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20" name="Line 338"/>
          <p:cNvSpPr/>
          <p:nvPr/>
        </p:nvSpPr>
        <p:spPr>
          <a:xfrm>
            <a:off x="1298520" y="4770360"/>
            <a:ext cx="32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221" name="Line 339"/>
          <p:cNvSpPr/>
          <p:nvPr/>
        </p:nvSpPr>
        <p:spPr>
          <a:xfrm>
            <a:off x="1298520" y="474984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22" name="Line 340"/>
          <p:cNvSpPr/>
          <p:nvPr/>
        </p:nvSpPr>
        <p:spPr>
          <a:xfrm>
            <a:off x="1298520" y="4727520"/>
            <a:ext cx="32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223" name="Line 341"/>
          <p:cNvSpPr/>
          <p:nvPr/>
        </p:nvSpPr>
        <p:spPr>
          <a:xfrm>
            <a:off x="1298520" y="4705200"/>
            <a:ext cx="32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224" name="Line 342"/>
          <p:cNvSpPr/>
          <p:nvPr/>
        </p:nvSpPr>
        <p:spPr>
          <a:xfrm>
            <a:off x="1298520" y="468324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25" name="Line 343"/>
          <p:cNvSpPr/>
          <p:nvPr/>
        </p:nvSpPr>
        <p:spPr>
          <a:xfrm>
            <a:off x="1298520" y="466092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26" name="Line 344"/>
          <p:cNvSpPr/>
          <p:nvPr/>
        </p:nvSpPr>
        <p:spPr>
          <a:xfrm>
            <a:off x="1298520" y="464040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27" name="Line 345"/>
          <p:cNvSpPr/>
          <p:nvPr/>
        </p:nvSpPr>
        <p:spPr>
          <a:xfrm>
            <a:off x="1298520" y="4618080"/>
            <a:ext cx="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28" name="Line 346"/>
          <p:cNvSpPr/>
          <p:nvPr/>
        </p:nvSpPr>
        <p:spPr>
          <a:xfrm>
            <a:off x="1295280" y="5340240"/>
            <a:ext cx="64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229" name="Line 348"/>
          <p:cNvSpPr/>
          <p:nvPr/>
        </p:nvSpPr>
        <p:spPr>
          <a:xfrm>
            <a:off x="1295280" y="5230800"/>
            <a:ext cx="64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30" name="Rectangle 349"/>
          <p:cNvSpPr/>
          <p:nvPr/>
        </p:nvSpPr>
        <p:spPr>
          <a:xfrm>
            <a:off x="1085760" y="5170320"/>
            <a:ext cx="169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00</a:t>
            </a:r>
            <a:endParaRPr b="0" lang="en-US" sz="800" spc="-1" strike="noStrike">
              <a:solidFill>
                <a:srgbClr val="000000"/>
              </a:solidFill>
              <a:latin typeface="Calibri"/>
            </a:endParaRPr>
          </a:p>
        </p:txBody>
      </p:sp>
      <p:sp>
        <p:nvSpPr>
          <p:cNvPr id="231" name="Line 350"/>
          <p:cNvSpPr/>
          <p:nvPr/>
        </p:nvSpPr>
        <p:spPr>
          <a:xfrm>
            <a:off x="1295280" y="5121360"/>
            <a:ext cx="64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32" name="Line 352"/>
          <p:cNvSpPr/>
          <p:nvPr/>
        </p:nvSpPr>
        <p:spPr>
          <a:xfrm>
            <a:off x="1295280" y="5011560"/>
            <a:ext cx="64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233" name="Rectangle 353"/>
          <p:cNvSpPr/>
          <p:nvPr/>
        </p:nvSpPr>
        <p:spPr>
          <a:xfrm>
            <a:off x="1085760" y="4951440"/>
            <a:ext cx="169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200</a:t>
            </a:r>
            <a:endParaRPr b="0" lang="en-US" sz="800" spc="-1" strike="noStrike">
              <a:solidFill>
                <a:srgbClr val="000000"/>
              </a:solidFill>
              <a:latin typeface="Calibri"/>
            </a:endParaRPr>
          </a:p>
        </p:txBody>
      </p:sp>
      <p:sp>
        <p:nvSpPr>
          <p:cNvPr id="234" name="Line 354"/>
          <p:cNvSpPr/>
          <p:nvPr/>
        </p:nvSpPr>
        <p:spPr>
          <a:xfrm>
            <a:off x="1295280" y="4902120"/>
            <a:ext cx="64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235" name="Line 356"/>
          <p:cNvSpPr/>
          <p:nvPr/>
        </p:nvSpPr>
        <p:spPr>
          <a:xfrm>
            <a:off x="1295280" y="4792680"/>
            <a:ext cx="64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36" name="Rectangle 357"/>
          <p:cNvSpPr/>
          <p:nvPr/>
        </p:nvSpPr>
        <p:spPr>
          <a:xfrm>
            <a:off x="1085760" y="4732200"/>
            <a:ext cx="169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300</a:t>
            </a:r>
            <a:endParaRPr b="0" lang="en-US" sz="800" spc="-1" strike="noStrike">
              <a:solidFill>
                <a:srgbClr val="000000"/>
              </a:solidFill>
              <a:latin typeface="Calibri"/>
            </a:endParaRPr>
          </a:p>
        </p:txBody>
      </p:sp>
      <p:sp>
        <p:nvSpPr>
          <p:cNvPr id="237" name="Line 358"/>
          <p:cNvSpPr/>
          <p:nvPr/>
        </p:nvSpPr>
        <p:spPr>
          <a:xfrm>
            <a:off x="1295280" y="4683240"/>
            <a:ext cx="64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38" name="Freeform 363"/>
          <p:cNvSpPr/>
          <p:nvPr/>
        </p:nvSpPr>
        <p:spPr>
          <a:xfrm flipV="1">
            <a:off x="1301760" y="4640400"/>
            <a:ext cx="1982880" cy="806400"/>
          </a:xfrm>
          <a:custGeom>
            <a:avLst/>
            <a:gdLst>
              <a:gd name="textAreaLeft" fmla="*/ 0 w 1982880"/>
              <a:gd name="textAreaRight" fmla="*/ 1983240 w 1982880"/>
              <a:gd name="textAreaTop" fmla="*/ 360 h 806400"/>
              <a:gd name="textAreaBottom" fmla="*/ 807120 h 806400"/>
            </a:gdLst>
            <a:ahLst/>
            <a:rect l="textAreaLeft" t="textAreaTop" r="textAreaRight" b="textAreaBottom"/>
            <a:pathLst>
              <a:path w="11253" h="7194">
                <a:moveTo>
                  <a:pt x="0" y="7"/>
                </a:moveTo>
                <a:lnTo>
                  <a:pt x="1" y="7"/>
                </a:lnTo>
                <a:lnTo>
                  <a:pt x="11" y="7"/>
                </a:lnTo>
                <a:lnTo>
                  <a:pt x="21" y="9"/>
                </a:lnTo>
                <a:lnTo>
                  <a:pt x="31" y="12"/>
                </a:lnTo>
                <a:lnTo>
                  <a:pt x="42" y="15"/>
                </a:lnTo>
                <a:lnTo>
                  <a:pt x="52" y="12"/>
                </a:lnTo>
                <a:lnTo>
                  <a:pt x="62" y="18"/>
                </a:lnTo>
                <a:lnTo>
                  <a:pt x="72" y="16"/>
                </a:lnTo>
                <a:lnTo>
                  <a:pt x="83" y="18"/>
                </a:lnTo>
                <a:lnTo>
                  <a:pt x="93" y="19"/>
                </a:lnTo>
                <a:lnTo>
                  <a:pt x="103" y="23"/>
                </a:lnTo>
                <a:lnTo>
                  <a:pt x="113" y="17"/>
                </a:lnTo>
                <a:lnTo>
                  <a:pt x="124" y="18"/>
                </a:lnTo>
                <a:lnTo>
                  <a:pt x="134" y="17"/>
                </a:lnTo>
                <a:lnTo>
                  <a:pt x="144" y="22"/>
                </a:lnTo>
                <a:lnTo>
                  <a:pt x="154" y="23"/>
                </a:lnTo>
                <a:lnTo>
                  <a:pt x="164" y="24"/>
                </a:lnTo>
                <a:lnTo>
                  <a:pt x="175" y="24"/>
                </a:lnTo>
                <a:lnTo>
                  <a:pt x="185" y="31"/>
                </a:lnTo>
                <a:lnTo>
                  <a:pt x="195" y="30"/>
                </a:lnTo>
                <a:lnTo>
                  <a:pt x="205" y="27"/>
                </a:lnTo>
                <a:lnTo>
                  <a:pt x="216" y="29"/>
                </a:lnTo>
                <a:lnTo>
                  <a:pt x="226" y="29"/>
                </a:lnTo>
                <a:lnTo>
                  <a:pt x="236" y="30"/>
                </a:lnTo>
                <a:lnTo>
                  <a:pt x="246" y="40"/>
                </a:lnTo>
                <a:lnTo>
                  <a:pt x="257" y="38"/>
                </a:lnTo>
                <a:lnTo>
                  <a:pt x="267" y="47"/>
                </a:lnTo>
                <a:lnTo>
                  <a:pt x="277" y="52"/>
                </a:lnTo>
                <a:lnTo>
                  <a:pt x="287" y="64"/>
                </a:lnTo>
                <a:lnTo>
                  <a:pt x="297" y="77"/>
                </a:lnTo>
                <a:lnTo>
                  <a:pt x="308" y="92"/>
                </a:lnTo>
                <a:lnTo>
                  <a:pt x="318" y="102"/>
                </a:lnTo>
                <a:lnTo>
                  <a:pt x="328" y="106"/>
                </a:lnTo>
                <a:lnTo>
                  <a:pt x="338" y="115"/>
                </a:lnTo>
                <a:lnTo>
                  <a:pt x="349" y="125"/>
                </a:lnTo>
                <a:lnTo>
                  <a:pt x="359" y="121"/>
                </a:lnTo>
                <a:lnTo>
                  <a:pt x="369" y="115"/>
                </a:lnTo>
                <a:lnTo>
                  <a:pt x="379" y="112"/>
                </a:lnTo>
                <a:lnTo>
                  <a:pt x="390" y="101"/>
                </a:lnTo>
                <a:lnTo>
                  <a:pt x="400" y="89"/>
                </a:lnTo>
                <a:lnTo>
                  <a:pt x="410" y="77"/>
                </a:lnTo>
                <a:lnTo>
                  <a:pt x="420" y="70"/>
                </a:lnTo>
                <a:lnTo>
                  <a:pt x="431" y="62"/>
                </a:lnTo>
                <a:lnTo>
                  <a:pt x="441" y="56"/>
                </a:lnTo>
                <a:lnTo>
                  <a:pt x="451" y="50"/>
                </a:lnTo>
                <a:lnTo>
                  <a:pt x="461" y="40"/>
                </a:lnTo>
                <a:lnTo>
                  <a:pt x="471" y="43"/>
                </a:lnTo>
                <a:lnTo>
                  <a:pt x="482" y="35"/>
                </a:lnTo>
                <a:lnTo>
                  <a:pt x="492" y="29"/>
                </a:lnTo>
                <a:lnTo>
                  <a:pt x="502" y="29"/>
                </a:lnTo>
                <a:lnTo>
                  <a:pt x="512" y="26"/>
                </a:lnTo>
                <a:lnTo>
                  <a:pt x="523" y="24"/>
                </a:lnTo>
                <a:lnTo>
                  <a:pt x="533" y="24"/>
                </a:lnTo>
                <a:lnTo>
                  <a:pt x="543" y="21"/>
                </a:lnTo>
                <a:lnTo>
                  <a:pt x="553" y="18"/>
                </a:lnTo>
                <a:lnTo>
                  <a:pt x="564" y="19"/>
                </a:lnTo>
                <a:lnTo>
                  <a:pt x="574" y="18"/>
                </a:lnTo>
                <a:lnTo>
                  <a:pt x="584" y="16"/>
                </a:lnTo>
                <a:lnTo>
                  <a:pt x="594" y="19"/>
                </a:lnTo>
                <a:lnTo>
                  <a:pt x="604" y="14"/>
                </a:lnTo>
                <a:lnTo>
                  <a:pt x="615" y="21"/>
                </a:lnTo>
                <a:lnTo>
                  <a:pt x="625" y="19"/>
                </a:lnTo>
                <a:lnTo>
                  <a:pt x="635" y="23"/>
                </a:lnTo>
                <a:lnTo>
                  <a:pt x="645" y="26"/>
                </a:lnTo>
                <a:lnTo>
                  <a:pt x="656" y="26"/>
                </a:lnTo>
                <a:lnTo>
                  <a:pt x="666" y="32"/>
                </a:lnTo>
                <a:lnTo>
                  <a:pt x="676" y="42"/>
                </a:lnTo>
                <a:lnTo>
                  <a:pt x="686" y="55"/>
                </a:lnTo>
                <a:lnTo>
                  <a:pt x="697" y="58"/>
                </a:lnTo>
                <a:lnTo>
                  <a:pt x="707" y="78"/>
                </a:lnTo>
                <a:lnTo>
                  <a:pt x="717" y="80"/>
                </a:lnTo>
                <a:lnTo>
                  <a:pt x="727" y="92"/>
                </a:lnTo>
                <a:lnTo>
                  <a:pt x="738" y="108"/>
                </a:lnTo>
                <a:lnTo>
                  <a:pt x="748" y="112"/>
                </a:lnTo>
                <a:lnTo>
                  <a:pt x="758" y="114"/>
                </a:lnTo>
                <a:lnTo>
                  <a:pt x="768" y="114"/>
                </a:lnTo>
                <a:lnTo>
                  <a:pt x="778" y="118"/>
                </a:lnTo>
                <a:lnTo>
                  <a:pt x="789" y="114"/>
                </a:lnTo>
                <a:lnTo>
                  <a:pt x="799" y="99"/>
                </a:lnTo>
                <a:lnTo>
                  <a:pt x="809" y="91"/>
                </a:lnTo>
                <a:lnTo>
                  <a:pt x="819" y="76"/>
                </a:lnTo>
                <a:lnTo>
                  <a:pt x="830" y="74"/>
                </a:lnTo>
                <a:lnTo>
                  <a:pt x="840" y="60"/>
                </a:lnTo>
                <a:lnTo>
                  <a:pt x="850" y="47"/>
                </a:lnTo>
                <a:lnTo>
                  <a:pt x="860" y="41"/>
                </a:lnTo>
                <a:lnTo>
                  <a:pt x="871" y="34"/>
                </a:lnTo>
                <a:lnTo>
                  <a:pt x="881" y="30"/>
                </a:lnTo>
                <a:lnTo>
                  <a:pt x="891" y="25"/>
                </a:lnTo>
                <a:lnTo>
                  <a:pt x="901" y="24"/>
                </a:lnTo>
                <a:lnTo>
                  <a:pt x="911" y="24"/>
                </a:lnTo>
                <a:lnTo>
                  <a:pt x="922" y="19"/>
                </a:lnTo>
                <a:lnTo>
                  <a:pt x="932" y="13"/>
                </a:lnTo>
                <a:lnTo>
                  <a:pt x="942" y="14"/>
                </a:lnTo>
                <a:lnTo>
                  <a:pt x="952" y="15"/>
                </a:lnTo>
                <a:lnTo>
                  <a:pt x="963" y="13"/>
                </a:lnTo>
                <a:lnTo>
                  <a:pt x="973" y="12"/>
                </a:lnTo>
                <a:lnTo>
                  <a:pt x="983" y="12"/>
                </a:lnTo>
                <a:lnTo>
                  <a:pt x="993" y="13"/>
                </a:lnTo>
                <a:lnTo>
                  <a:pt x="1004" y="17"/>
                </a:lnTo>
                <a:lnTo>
                  <a:pt x="1014" y="14"/>
                </a:lnTo>
                <a:lnTo>
                  <a:pt x="1024" y="23"/>
                </a:lnTo>
                <a:lnTo>
                  <a:pt x="1034" y="24"/>
                </a:lnTo>
                <a:lnTo>
                  <a:pt x="1045" y="29"/>
                </a:lnTo>
                <a:lnTo>
                  <a:pt x="1055" y="31"/>
                </a:lnTo>
                <a:lnTo>
                  <a:pt x="1065" y="31"/>
                </a:lnTo>
                <a:lnTo>
                  <a:pt x="1075" y="31"/>
                </a:lnTo>
                <a:lnTo>
                  <a:pt x="1085" y="26"/>
                </a:lnTo>
                <a:lnTo>
                  <a:pt x="1096" y="26"/>
                </a:lnTo>
                <a:lnTo>
                  <a:pt x="1106" y="22"/>
                </a:lnTo>
                <a:lnTo>
                  <a:pt x="1116" y="21"/>
                </a:lnTo>
                <a:lnTo>
                  <a:pt x="1126" y="16"/>
                </a:lnTo>
                <a:lnTo>
                  <a:pt x="1137" y="16"/>
                </a:lnTo>
                <a:lnTo>
                  <a:pt x="1147" y="11"/>
                </a:lnTo>
                <a:lnTo>
                  <a:pt x="1157" y="9"/>
                </a:lnTo>
                <a:lnTo>
                  <a:pt x="1167" y="13"/>
                </a:lnTo>
                <a:lnTo>
                  <a:pt x="1178" y="3"/>
                </a:lnTo>
                <a:lnTo>
                  <a:pt x="1188" y="5"/>
                </a:lnTo>
                <a:lnTo>
                  <a:pt x="1198" y="2"/>
                </a:lnTo>
                <a:lnTo>
                  <a:pt x="1208" y="5"/>
                </a:lnTo>
                <a:lnTo>
                  <a:pt x="1218" y="2"/>
                </a:lnTo>
                <a:lnTo>
                  <a:pt x="1229" y="4"/>
                </a:lnTo>
                <a:lnTo>
                  <a:pt x="1239" y="6"/>
                </a:lnTo>
                <a:lnTo>
                  <a:pt x="1249" y="10"/>
                </a:lnTo>
                <a:lnTo>
                  <a:pt x="1259" y="10"/>
                </a:lnTo>
                <a:lnTo>
                  <a:pt x="1270" y="11"/>
                </a:lnTo>
                <a:lnTo>
                  <a:pt x="1280" y="11"/>
                </a:lnTo>
                <a:lnTo>
                  <a:pt x="1290" y="11"/>
                </a:lnTo>
                <a:lnTo>
                  <a:pt x="1300" y="13"/>
                </a:lnTo>
                <a:lnTo>
                  <a:pt x="1311" y="13"/>
                </a:lnTo>
                <a:lnTo>
                  <a:pt x="1321" y="16"/>
                </a:lnTo>
                <a:lnTo>
                  <a:pt x="1331" y="15"/>
                </a:lnTo>
                <a:lnTo>
                  <a:pt x="1341" y="12"/>
                </a:lnTo>
                <a:lnTo>
                  <a:pt x="1352" y="16"/>
                </a:lnTo>
                <a:lnTo>
                  <a:pt x="1362" y="16"/>
                </a:lnTo>
                <a:lnTo>
                  <a:pt x="1372" y="15"/>
                </a:lnTo>
                <a:lnTo>
                  <a:pt x="1382" y="21"/>
                </a:lnTo>
                <a:lnTo>
                  <a:pt x="1392" y="18"/>
                </a:lnTo>
                <a:lnTo>
                  <a:pt x="1403" y="25"/>
                </a:lnTo>
                <a:lnTo>
                  <a:pt x="1413" y="23"/>
                </a:lnTo>
                <a:lnTo>
                  <a:pt x="1423" y="22"/>
                </a:lnTo>
                <a:lnTo>
                  <a:pt x="1433" y="27"/>
                </a:lnTo>
                <a:lnTo>
                  <a:pt x="1444" y="31"/>
                </a:lnTo>
                <a:lnTo>
                  <a:pt x="1454" y="31"/>
                </a:lnTo>
                <a:lnTo>
                  <a:pt x="1464" y="36"/>
                </a:lnTo>
                <a:lnTo>
                  <a:pt x="1474" y="37"/>
                </a:lnTo>
                <a:lnTo>
                  <a:pt x="1485" y="39"/>
                </a:lnTo>
                <a:lnTo>
                  <a:pt x="1495" y="39"/>
                </a:lnTo>
                <a:lnTo>
                  <a:pt x="1505" y="47"/>
                </a:lnTo>
                <a:lnTo>
                  <a:pt x="1515" y="40"/>
                </a:lnTo>
                <a:lnTo>
                  <a:pt x="1525" y="44"/>
                </a:lnTo>
                <a:lnTo>
                  <a:pt x="1536" y="46"/>
                </a:lnTo>
                <a:lnTo>
                  <a:pt x="1546" y="43"/>
                </a:lnTo>
                <a:lnTo>
                  <a:pt x="1556" y="42"/>
                </a:lnTo>
                <a:lnTo>
                  <a:pt x="1566" y="35"/>
                </a:lnTo>
                <a:lnTo>
                  <a:pt x="1577" y="35"/>
                </a:lnTo>
                <a:lnTo>
                  <a:pt x="1587" y="33"/>
                </a:lnTo>
                <a:lnTo>
                  <a:pt x="1597" y="28"/>
                </a:lnTo>
                <a:lnTo>
                  <a:pt x="1607" y="26"/>
                </a:lnTo>
                <a:lnTo>
                  <a:pt x="1618" y="21"/>
                </a:lnTo>
                <a:lnTo>
                  <a:pt x="1628" y="23"/>
                </a:lnTo>
                <a:lnTo>
                  <a:pt x="1638" y="20"/>
                </a:lnTo>
                <a:lnTo>
                  <a:pt x="1648" y="15"/>
                </a:lnTo>
                <a:lnTo>
                  <a:pt x="1659" y="12"/>
                </a:lnTo>
                <a:lnTo>
                  <a:pt x="1669" y="13"/>
                </a:lnTo>
                <a:lnTo>
                  <a:pt x="1679" y="9"/>
                </a:lnTo>
                <a:lnTo>
                  <a:pt x="1689" y="11"/>
                </a:lnTo>
                <a:lnTo>
                  <a:pt x="1699" y="9"/>
                </a:lnTo>
                <a:lnTo>
                  <a:pt x="1710" y="9"/>
                </a:lnTo>
                <a:lnTo>
                  <a:pt x="1720" y="9"/>
                </a:lnTo>
                <a:lnTo>
                  <a:pt x="1730" y="12"/>
                </a:lnTo>
                <a:lnTo>
                  <a:pt x="1740" y="13"/>
                </a:lnTo>
                <a:lnTo>
                  <a:pt x="1751" y="12"/>
                </a:lnTo>
                <a:lnTo>
                  <a:pt x="1761" y="18"/>
                </a:lnTo>
                <a:lnTo>
                  <a:pt x="1771" y="23"/>
                </a:lnTo>
                <a:lnTo>
                  <a:pt x="1781" y="25"/>
                </a:lnTo>
                <a:lnTo>
                  <a:pt x="1792" y="30"/>
                </a:lnTo>
                <a:lnTo>
                  <a:pt x="1802" y="29"/>
                </a:lnTo>
                <a:lnTo>
                  <a:pt x="1812" y="37"/>
                </a:lnTo>
                <a:lnTo>
                  <a:pt x="1822" y="33"/>
                </a:lnTo>
                <a:lnTo>
                  <a:pt x="1832" y="38"/>
                </a:lnTo>
                <a:lnTo>
                  <a:pt x="1843" y="33"/>
                </a:lnTo>
                <a:lnTo>
                  <a:pt x="1853" y="36"/>
                </a:lnTo>
                <a:lnTo>
                  <a:pt x="1863" y="29"/>
                </a:lnTo>
                <a:lnTo>
                  <a:pt x="1873" y="24"/>
                </a:lnTo>
                <a:lnTo>
                  <a:pt x="1884" y="21"/>
                </a:lnTo>
                <a:lnTo>
                  <a:pt x="1894" y="22"/>
                </a:lnTo>
                <a:lnTo>
                  <a:pt x="1904" y="15"/>
                </a:lnTo>
                <a:lnTo>
                  <a:pt x="1914" y="17"/>
                </a:lnTo>
                <a:lnTo>
                  <a:pt x="1925" y="13"/>
                </a:lnTo>
                <a:lnTo>
                  <a:pt x="1935" y="9"/>
                </a:lnTo>
                <a:lnTo>
                  <a:pt x="1945" y="4"/>
                </a:lnTo>
                <a:lnTo>
                  <a:pt x="1955" y="7"/>
                </a:lnTo>
                <a:lnTo>
                  <a:pt x="1966" y="5"/>
                </a:lnTo>
                <a:lnTo>
                  <a:pt x="1976" y="3"/>
                </a:lnTo>
                <a:lnTo>
                  <a:pt x="1986" y="7"/>
                </a:lnTo>
                <a:lnTo>
                  <a:pt x="1996" y="3"/>
                </a:lnTo>
                <a:lnTo>
                  <a:pt x="2006" y="3"/>
                </a:lnTo>
                <a:lnTo>
                  <a:pt x="2017" y="4"/>
                </a:lnTo>
                <a:lnTo>
                  <a:pt x="2027" y="4"/>
                </a:lnTo>
                <a:lnTo>
                  <a:pt x="2037" y="5"/>
                </a:lnTo>
                <a:lnTo>
                  <a:pt x="2047" y="5"/>
                </a:lnTo>
                <a:lnTo>
                  <a:pt x="2058" y="5"/>
                </a:lnTo>
                <a:lnTo>
                  <a:pt x="2068" y="2"/>
                </a:lnTo>
                <a:lnTo>
                  <a:pt x="2078" y="3"/>
                </a:lnTo>
                <a:lnTo>
                  <a:pt x="2088" y="8"/>
                </a:lnTo>
                <a:lnTo>
                  <a:pt x="2099" y="8"/>
                </a:lnTo>
                <a:lnTo>
                  <a:pt x="2109" y="7"/>
                </a:lnTo>
                <a:lnTo>
                  <a:pt x="2119" y="8"/>
                </a:lnTo>
                <a:lnTo>
                  <a:pt x="2129" y="9"/>
                </a:lnTo>
                <a:lnTo>
                  <a:pt x="2140" y="9"/>
                </a:lnTo>
                <a:lnTo>
                  <a:pt x="2150" y="14"/>
                </a:lnTo>
                <a:lnTo>
                  <a:pt x="2160" y="12"/>
                </a:lnTo>
                <a:lnTo>
                  <a:pt x="2170" y="15"/>
                </a:lnTo>
                <a:lnTo>
                  <a:pt x="2180" y="15"/>
                </a:lnTo>
                <a:lnTo>
                  <a:pt x="2191" y="15"/>
                </a:lnTo>
                <a:lnTo>
                  <a:pt x="2201" y="19"/>
                </a:lnTo>
                <a:lnTo>
                  <a:pt x="2211" y="15"/>
                </a:lnTo>
                <a:lnTo>
                  <a:pt x="2221" y="13"/>
                </a:lnTo>
                <a:lnTo>
                  <a:pt x="2232" y="13"/>
                </a:lnTo>
                <a:lnTo>
                  <a:pt x="2242" y="12"/>
                </a:lnTo>
                <a:lnTo>
                  <a:pt x="2252" y="7"/>
                </a:lnTo>
                <a:lnTo>
                  <a:pt x="2262" y="5"/>
                </a:lnTo>
                <a:lnTo>
                  <a:pt x="2273" y="6"/>
                </a:lnTo>
                <a:lnTo>
                  <a:pt x="2283" y="4"/>
                </a:lnTo>
                <a:lnTo>
                  <a:pt x="2293" y="4"/>
                </a:lnTo>
                <a:lnTo>
                  <a:pt x="2303" y="1"/>
                </a:lnTo>
                <a:lnTo>
                  <a:pt x="2313" y="4"/>
                </a:lnTo>
                <a:lnTo>
                  <a:pt x="2324" y="3"/>
                </a:lnTo>
                <a:lnTo>
                  <a:pt x="2334" y="1"/>
                </a:lnTo>
                <a:lnTo>
                  <a:pt x="2344" y="2"/>
                </a:lnTo>
                <a:lnTo>
                  <a:pt x="2354" y="2"/>
                </a:lnTo>
                <a:lnTo>
                  <a:pt x="2365" y="2"/>
                </a:lnTo>
                <a:lnTo>
                  <a:pt x="2375" y="3"/>
                </a:lnTo>
                <a:lnTo>
                  <a:pt x="2385" y="6"/>
                </a:lnTo>
                <a:lnTo>
                  <a:pt x="2395" y="7"/>
                </a:lnTo>
                <a:lnTo>
                  <a:pt x="2406" y="4"/>
                </a:lnTo>
                <a:lnTo>
                  <a:pt x="2416" y="4"/>
                </a:lnTo>
                <a:lnTo>
                  <a:pt x="2426" y="4"/>
                </a:lnTo>
                <a:lnTo>
                  <a:pt x="2436" y="6"/>
                </a:lnTo>
                <a:lnTo>
                  <a:pt x="2447" y="6"/>
                </a:lnTo>
                <a:lnTo>
                  <a:pt x="2457" y="5"/>
                </a:lnTo>
                <a:lnTo>
                  <a:pt x="2467" y="9"/>
                </a:lnTo>
                <a:lnTo>
                  <a:pt x="2477" y="9"/>
                </a:lnTo>
                <a:lnTo>
                  <a:pt x="2487" y="8"/>
                </a:lnTo>
                <a:lnTo>
                  <a:pt x="2498" y="12"/>
                </a:lnTo>
                <a:lnTo>
                  <a:pt x="2508" y="18"/>
                </a:lnTo>
                <a:lnTo>
                  <a:pt x="2518" y="23"/>
                </a:lnTo>
                <a:lnTo>
                  <a:pt x="2528" y="25"/>
                </a:lnTo>
                <a:lnTo>
                  <a:pt x="2539" y="41"/>
                </a:lnTo>
                <a:lnTo>
                  <a:pt x="2549" y="54"/>
                </a:lnTo>
                <a:lnTo>
                  <a:pt x="2559" y="83"/>
                </a:lnTo>
                <a:lnTo>
                  <a:pt x="2569" y="134"/>
                </a:lnTo>
                <a:lnTo>
                  <a:pt x="2580" y="199"/>
                </a:lnTo>
                <a:lnTo>
                  <a:pt x="2590" y="298"/>
                </a:lnTo>
                <a:lnTo>
                  <a:pt x="2600" y="454"/>
                </a:lnTo>
                <a:lnTo>
                  <a:pt x="2610" y="642"/>
                </a:lnTo>
                <a:lnTo>
                  <a:pt x="2620" y="879"/>
                </a:lnTo>
                <a:lnTo>
                  <a:pt x="2631" y="1204"/>
                </a:lnTo>
                <a:lnTo>
                  <a:pt x="2641" y="1513"/>
                </a:lnTo>
                <a:lnTo>
                  <a:pt x="2651" y="1812"/>
                </a:lnTo>
                <a:lnTo>
                  <a:pt x="2661" y="2170"/>
                </a:lnTo>
                <a:lnTo>
                  <a:pt x="2672" y="2472"/>
                </a:lnTo>
                <a:lnTo>
                  <a:pt x="2682" y="2769"/>
                </a:lnTo>
                <a:lnTo>
                  <a:pt x="2692" y="2981"/>
                </a:lnTo>
                <a:lnTo>
                  <a:pt x="2702" y="3126"/>
                </a:lnTo>
                <a:lnTo>
                  <a:pt x="2713" y="3098"/>
                </a:lnTo>
                <a:lnTo>
                  <a:pt x="2723" y="3047"/>
                </a:lnTo>
                <a:lnTo>
                  <a:pt x="2733" y="2901"/>
                </a:lnTo>
                <a:lnTo>
                  <a:pt x="2743" y="2678"/>
                </a:lnTo>
                <a:lnTo>
                  <a:pt x="2754" y="2305"/>
                </a:lnTo>
                <a:lnTo>
                  <a:pt x="2764" y="1922"/>
                </a:lnTo>
                <a:lnTo>
                  <a:pt x="2774" y="1629"/>
                </a:lnTo>
                <a:lnTo>
                  <a:pt x="2784" y="1327"/>
                </a:lnTo>
                <a:lnTo>
                  <a:pt x="2794" y="1039"/>
                </a:lnTo>
                <a:lnTo>
                  <a:pt x="2805" y="781"/>
                </a:lnTo>
                <a:lnTo>
                  <a:pt x="2815" y="586"/>
                </a:lnTo>
                <a:lnTo>
                  <a:pt x="2825" y="431"/>
                </a:lnTo>
                <a:lnTo>
                  <a:pt x="2835" y="324"/>
                </a:lnTo>
                <a:lnTo>
                  <a:pt x="2846" y="230"/>
                </a:lnTo>
                <a:lnTo>
                  <a:pt x="2856" y="167"/>
                </a:lnTo>
                <a:lnTo>
                  <a:pt x="2866" y="132"/>
                </a:lnTo>
                <a:lnTo>
                  <a:pt x="2876" y="98"/>
                </a:lnTo>
                <a:lnTo>
                  <a:pt x="2887" y="71"/>
                </a:lnTo>
                <a:lnTo>
                  <a:pt x="2897" y="52"/>
                </a:lnTo>
                <a:lnTo>
                  <a:pt x="2907" y="42"/>
                </a:lnTo>
                <a:lnTo>
                  <a:pt x="2917" y="30"/>
                </a:lnTo>
                <a:lnTo>
                  <a:pt x="2927" y="22"/>
                </a:lnTo>
                <a:lnTo>
                  <a:pt x="2938" y="18"/>
                </a:lnTo>
                <a:lnTo>
                  <a:pt x="2948" y="15"/>
                </a:lnTo>
                <a:lnTo>
                  <a:pt x="2958" y="11"/>
                </a:lnTo>
                <a:lnTo>
                  <a:pt x="2968" y="7"/>
                </a:lnTo>
                <a:lnTo>
                  <a:pt x="2979" y="6"/>
                </a:lnTo>
                <a:lnTo>
                  <a:pt x="2989" y="5"/>
                </a:lnTo>
                <a:lnTo>
                  <a:pt x="2999" y="4"/>
                </a:lnTo>
                <a:lnTo>
                  <a:pt x="3009" y="4"/>
                </a:lnTo>
                <a:lnTo>
                  <a:pt x="3020" y="8"/>
                </a:lnTo>
                <a:lnTo>
                  <a:pt x="3030" y="6"/>
                </a:lnTo>
                <a:lnTo>
                  <a:pt x="3040" y="13"/>
                </a:lnTo>
                <a:lnTo>
                  <a:pt x="3050" y="11"/>
                </a:lnTo>
                <a:lnTo>
                  <a:pt x="3061" y="12"/>
                </a:lnTo>
                <a:lnTo>
                  <a:pt x="3071" y="12"/>
                </a:lnTo>
                <a:lnTo>
                  <a:pt x="3081" y="16"/>
                </a:lnTo>
                <a:lnTo>
                  <a:pt x="3091" y="12"/>
                </a:lnTo>
                <a:lnTo>
                  <a:pt x="3101" y="13"/>
                </a:lnTo>
                <a:lnTo>
                  <a:pt x="3112" y="10"/>
                </a:lnTo>
                <a:lnTo>
                  <a:pt x="3122" y="11"/>
                </a:lnTo>
                <a:lnTo>
                  <a:pt x="3132" y="12"/>
                </a:lnTo>
                <a:lnTo>
                  <a:pt x="3142" y="12"/>
                </a:lnTo>
                <a:lnTo>
                  <a:pt x="3153" y="18"/>
                </a:lnTo>
                <a:lnTo>
                  <a:pt x="3163" y="28"/>
                </a:lnTo>
                <a:lnTo>
                  <a:pt x="3173" y="53"/>
                </a:lnTo>
                <a:lnTo>
                  <a:pt x="3183" y="82"/>
                </a:lnTo>
                <a:lnTo>
                  <a:pt x="3194" y="135"/>
                </a:lnTo>
                <a:lnTo>
                  <a:pt x="3204" y="216"/>
                </a:lnTo>
                <a:lnTo>
                  <a:pt x="3214" y="326"/>
                </a:lnTo>
                <a:lnTo>
                  <a:pt x="3224" y="492"/>
                </a:lnTo>
                <a:lnTo>
                  <a:pt x="3234" y="727"/>
                </a:lnTo>
                <a:lnTo>
                  <a:pt x="3245" y="1027"/>
                </a:lnTo>
                <a:lnTo>
                  <a:pt x="3255" y="1401"/>
                </a:lnTo>
                <a:lnTo>
                  <a:pt x="3265" y="1827"/>
                </a:lnTo>
                <a:lnTo>
                  <a:pt x="3275" y="2264"/>
                </a:lnTo>
                <a:lnTo>
                  <a:pt x="3286" y="2667"/>
                </a:lnTo>
                <a:lnTo>
                  <a:pt x="3296" y="3033"/>
                </a:lnTo>
                <a:lnTo>
                  <a:pt x="3306" y="3315"/>
                </a:lnTo>
                <a:lnTo>
                  <a:pt x="3316" y="3388"/>
                </a:lnTo>
                <a:lnTo>
                  <a:pt x="3327" y="3385"/>
                </a:lnTo>
                <a:lnTo>
                  <a:pt x="3337" y="3277"/>
                </a:lnTo>
                <a:lnTo>
                  <a:pt x="3347" y="3088"/>
                </a:lnTo>
                <a:lnTo>
                  <a:pt x="3357" y="2728"/>
                </a:lnTo>
                <a:lnTo>
                  <a:pt x="3368" y="2395"/>
                </a:lnTo>
                <a:lnTo>
                  <a:pt x="3378" y="1977"/>
                </a:lnTo>
                <a:lnTo>
                  <a:pt x="3388" y="1577"/>
                </a:lnTo>
                <a:lnTo>
                  <a:pt x="3398" y="1256"/>
                </a:lnTo>
                <a:lnTo>
                  <a:pt x="3408" y="959"/>
                </a:lnTo>
                <a:lnTo>
                  <a:pt x="3419" y="725"/>
                </a:lnTo>
                <a:lnTo>
                  <a:pt x="3429" y="527"/>
                </a:lnTo>
                <a:lnTo>
                  <a:pt x="3439" y="397"/>
                </a:lnTo>
                <a:lnTo>
                  <a:pt x="3449" y="280"/>
                </a:lnTo>
                <a:lnTo>
                  <a:pt x="3460" y="212"/>
                </a:lnTo>
                <a:lnTo>
                  <a:pt x="3470" y="158"/>
                </a:lnTo>
                <a:lnTo>
                  <a:pt x="3480" y="118"/>
                </a:lnTo>
                <a:lnTo>
                  <a:pt x="3490" y="98"/>
                </a:lnTo>
                <a:lnTo>
                  <a:pt x="3501" y="83"/>
                </a:lnTo>
                <a:lnTo>
                  <a:pt x="3511" y="76"/>
                </a:lnTo>
                <a:lnTo>
                  <a:pt x="3521" y="62"/>
                </a:lnTo>
                <a:lnTo>
                  <a:pt x="3531" y="56"/>
                </a:lnTo>
                <a:lnTo>
                  <a:pt x="3541" y="58"/>
                </a:lnTo>
                <a:lnTo>
                  <a:pt x="3552" y="51"/>
                </a:lnTo>
                <a:lnTo>
                  <a:pt x="3562" y="54"/>
                </a:lnTo>
                <a:lnTo>
                  <a:pt x="3572" y="46"/>
                </a:lnTo>
                <a:lnTo>
                  <a:pt x="3582" y="42"/>
                </a:lnTo>
                <a:lnTo>
                  <a:pt x="3593" y="45"/>
                </a:lnTo>
                <a:lnTo>
                  <a:pt x="3603" y="40"/>
                </a:lnTo>
                <a:lnTo>
                  <a:pt x="3613" y="38"/>
                </a:lnTo>
                <a:lnTo>
                  <a:pt x="3623" y="40"/>
                </a:lnTo>
                <a:lnTo>
                  <a:pt x="3634" y="38"/>
                </a:lnTo>
                <a:lnTo>
                  <a:pt x="3644" y="30"/>
                </a:lnTo>
                <a:lnTo>
                  <a:pt x="3654" y="32"/>
                </a:lnTo>
                <a:lnTo>
                  <a:pt x="3664" y="32"/>
                </a:lnTo>
                <a:lnTo>
                  <a:pt x="3675" y="30"/>
                </a:lnTo>
                <a:lnTo>
                  <a:pt x="3685" y="29"/>
                </a:lnTo>
                <a:lnTo>
                  <a:pt x="3695" y="30"/>
                </a:lnTo>
                <a:lnTo>
                  <a:pt x="3705" y="33"/>
                </a:lnTo>
                <a:lnTo>
                  <a:pt x="3715" y="38"/>
                </a:lnTo>
                <a:lnTo>
                  <a:pt x="3726" y="48"/>
                </a:lnTo>
                <a:lnTo>
                  <a:pt x="3736" y="55"/>
                </a:lnTo>
                <a:lnTo>
                  <a:pt x="3746" y="62"/>
                </a:lnTo>
                <a:lnTo>
                  <a:pt x="3756" y="76"/>
                </a:lnTo>
                <a:lnTo>
                  <a:pt x="3767" y="86"/>
                </a:lnTo>
                <a:lnTo>
                  <a:pt x="3777" y="99"/>
                </a:lnTo>
                <a:lnTo>
                  <a:pt x="3787" y="113"/>
                </a:lnTo>
                <a:lnTo>
                  <a:pt x="3797" y="118"/>
                </a:lnTo>
                <a:lnTo>
                  <a:pt x="3808" y="123"/>
                </a:lnTo>
                <a:lnTo>
                  <a:pt x="3818" y="123"/>
                </a:lnTo>
                <a:lnTo>
                  <a:pt x="3828" y="123"/>
                </a:lnTo>
                <a:lnTo>
                  <a:pt x="3838" y="116"/>
                </a:lnTo>
                <a:lnTo>
                  <a:pt x="3848" y="104"/>
                </a:lnTo>
                <a:lnTo>
                  <a:pt x="3859" y="96"/>
                </a:lnTo>
                <a:lnTo>
                  <a:pt x="3869" y="91"/>
                </a:lnTo>
                <a:lnTo>
                  <a:pt x="3879" y="84"/>
                </a:lnTo>
                <a:lnTo>
                  <a:pt x="3889" y="69"/>
                </a:lnTo>
                <a:lnTo>
                  <a:pt x="3900" y="64"/>
                </a:lnTo>
                <a:lnTo>
                  <a:pt x="3910" y="59"/>
                </a:lnTo>
                <a:lnTo>
                  <a:pt x="3920" y="58"/>
                </a:lnTo>
                <a:lnTo>
                  <a:pt x="3930" y="52"/>
                </a:lnTo>
                <a:lnTo>
                  <a:pt x="3941" y="48"/>
                </a:lnTo>
                <a:lnTo>
                  <a:pt x="3951" y="48"/>
                </a:lnTo>
                <a:lnTo>
                  <a:pt x="3961" y="47"/>
                </a:lnTo>
                <a:lnTo>
                  <a:pt x="3971" y="47"/>
                </a:lnTo>
                <a:lnTo>
                  <a:pt x="3982" y="45"/>
                </a:lnTo>
                <a:lnTo>
                  <a:pt x="3992" y="47"/>
                </a:lnTo>
                <a:lnTo>
                  <a:pt x="4002" y="45"/>
                </a:lnTo>
                <a:lnTo>
                  <a:pt x="4012" y="52"/>
                </a:lnTo>
                <a:lnTo>
                  <a:pt x="4022" y="48"/>
                </a:lnTo>
                <a:lnTo>
                  <a:pt x="4033" y="51"/>
                </a:lnTo>
                <a:lnTo>
                  <a:pt x="4043" y="55"/>
                </a:lnTo>
                <a:lnTo>
                  <a:pt x="4053" y="53"/>
                </a:lnTo>
                <a:lnTo>
                  <a:pt x="4063" y="55"/>
                </a:lnTo>
                <a:lnTo>
                  <a:pt x="4074" y="52"/>
                </a:lnTo>
                <a:lnTo>
                  <a:pt x="4084" y="52"/>
                </a:lnTo>
                <a:lnTo>
                  <a:pt x="4094" y="48"/>
                </a:lnTo>
                <a:lnTo>
                  <a:pt x="4104" y="48"/>
                </a:lnTo>
                <a:lnTo>
                  <a:pt x="4115" y="48"/>
                </a:lnTo>
                <a:lnTo>
                  <a:pt x="4125" y="49"/>
                </a:lnTo>
                <a:lnTo>
                  <a:pt x="4135" y="48"/>
                </a:lnTo>
                <a:lnTo>
                  <a:pt x="4145" y="38"/>
                </a:lnTo>
                <a:lnTo>
                  <a:pt x="4155" y="39"/>
                </a:lnTo>
                <a:lnTo>
                  <a:pt x="4166" y="41"/>
                </a:lnTo>
                <a:lnTo>
                  <a:pt x="4176" y="42"/>
                </a:lnTo>
                <a:lnTo>
                  <a:pt x="4186" y="39"/>
                </a:lnTo>
                <a:lnTo>
                  <a:pt x="4196" y="34"/>
                </a:lnTo>
                <a:lnTo>
                  <a:pt x="4207" y="32"/>
                </a:lnTo>
                <a:lnTo>
                  <a:pt x="4217" y="34"/>
                </a:lnTo>
                <a:lnTo>
                  <a:pt x="4227" y="32"/>
                </a:lnTo>
                <a:lnTo>
                  <a:pt x="4237" y="39"/>
                </a:lnTo>
                <a:lnTo>
                  <a:pt x="4248" y="47"/>
                </a:lnTo>
                <a:lnTo>
                  <a:pt x="4258" y="67"/>
                </a:lnTo>
                <a:lnTo>
                  <a:pt x="4268" y="98"/>
                </a:lnTo>
                <a:lnTo>
                  <a:pt x="4278" y="171"/>
                </a:lnTo>
                <a:lnTo>
                  <a:pt x="4289" y="262"/>
                </a:lnTo>
                <a:lnTo>
                  <a:pt x="4299" y="447"/>
                </a:lnTo>
                <a:lnTo>
                  <a:pt x="4309" y="719"/>
                </a:lnTo>
                <a:lnTo>
                  <a:pt x="4319" y="1067"/>
                </a:lnTo>
                <a:lnTo>
                  <a:pt x="4329" y="1543"/>
                </a:lnTo>
                <a:lnTo>
                  <a:pt x="4340" y="2165"/>
                </a:lnTo>
                <a:lnTo>
                  <a:pt x="4350" y="2897"/>
                </a:lnTo>
                <a:lnTo>
                  <a:pt x="4360" y="3672"/>
                </a:lnTo>
                <a:lnTo>
                  <a:pt x="4370" y="4534"/>
                </a:lnTo>
                <a:lnTo>
                  <a:pt x="4381" y="5423"/>
                </a:lnTo>
                <a:lnTo>
                  <a:pt x="4391" y="6082"/>
                </a:lnTo>
                <a:lnTo>
                  <a:pt x="4401" y="6749"/>
                </a:lnTo>
                <a:lnTo>
                  <a:pt x="4411" y="7194"/>
                </a:lnTo>
                <a:lnTo>
                  <a:pt x="4422" y="7137"/>
                </a:lnTo>
                <a:lnTo>
                  <a:pt x="4432" y="6727"/>
                </a:lnTo>
                <a:lnTo>
                  <a:pt x="4442" y="6216"/>
                </a:lnTo>
                <a:lnTo>
                  <a:pt x="4452" y="5584"/>
                </a:lnTo>
                <a:lnTo>
                  <a:pt x="4462" y="4588"/>
                </a:lnTo>
                <a:lnTo>
                  <a:pt x="4473" y="3632"/>
                </a:lnTo>
                <a:lnTo>
                  <a:pt x="4483" y="2780"/>
                </a:lnTo>
                <a:lnTo>
                  <a:pt x="4493" y="2026"/>
                </a:lnTo>
                <a:lnTo>
                  <a:pt x="4503" y="1442"/>
                </a:lnTo>
                <a:lnTo>
                  <a:pt x="4514" y="1009"/>
                </a:lnTo>
                <a:lnTo>
                  <a:pt x="4524" y="684"/>
                </a:lnTo>
                <a:lnTo>
                  <a:pt x="4534" y="454"/>
                </a:lnTo>
                <a:lnTo>
                  <a:pt x="4544" y="318"/>
                </a:lnTo>
                <a:lnTo>
                  <a:pt x="4555" y="230"/>
                </a:lnTo>
                <a:lnTo>
                  <a:pt x="4565" y="167"/>
                </a:lnTo>
                <a:lnTo>
                  <a:pt x="4575" y="135"/>
                </a:lnTo>
                <a:lnTo>
                  <a:pt x="4585" y="105"/>
                </a:lnTo>
                <a:lnTo>
                  <a:pt x="4596" y="95"/>
                </a:lnTo>
                <a:lnTo>
                  <a:pt x="4606" y="82"/>
                </a:lnTo>
                <a:lnTo>
                  <a:pt x="4616" y="69"/>
                </a:lnTo>
                <a:lnTo>
                  <a:pt x="4626" y="66"/>
                </a:lnTo>
                <a:lnTo>
                  <a:pt x="4636" y="61"/>
                </a:lnTo>
                <a:lnTo>
                  <a:pt x="4647" y="57"/>
                </a:lnTo>
                <a:lnTo>
                  <a:pt x="4657" y="52"/>
                </a:lnTo>
                <a:lnTo>
                  <a:pt x="4667" y="46"/>
                </a:lnTo>
                <a:lnTo>
                  <a:pt x="4677" y="42"/>
                </a:lnTo>
                <a:lnTo>
                  <a:pt x="4688" y="42"/>
                </a:lnTo>
                <a:lnTo>
                  <a:pt x="4698" y="45"/>
                </a:lnTo>
                <a:lnTo>
                  <a:pt x="4708" y="39"/>
                </a:lnTo>
                <a:lnTo>
                  <a:pt x="4718" y="30"/>
                </a:lnTo>
                <a:lnTo>
                  <a:pt x="4729" y="33"/>
                </a:lnTo>
                <a:lnTo>
                  <a:pt x="4739" y="30"/>
                </a:lnTo>
                <a:lnTo>
                  <a:pt x="4749" y="32"/>
                </a:lnTo>
                <a:lnTo>
                  <a:pt x="4759" y="34"/>
                </a:lnTo>
                <a:lnTo>
                  <a:pt x="4769" y="30"/>
                </a:lnTo>
                <a:lnTo>
                  <a:pt x="4780" y="32"/>
                </a:lnTo>
                <a:lnTo>
                  <a:pt x="4790" y="34"/>
                </a:lnTo>
                <a:lnTo>
                  <a:pt x="4800" y="34"/>
                </a:lnTo>
                <a:lnTo>
                  <a:pt x="4810" y="38"/>
                </a:lnTo>
                <a:lnTo>
                  <a:pt x="4821" y="40"/>
                </a:lnTo>
                <a:lnTo>
                  <a:pt x="4831" y="36"/>
                </a:lnTo>
                <a:lnTo>
                  <a:pt x="4841" y="42"/>
                </a:lnTo>
                <a:lnTo>
                  <a:pt x="4851" y="51"/>
                </a:lnTo>
                <a:lnTo>
                  <a:pt x="4862" y="48"/>
                </a:lnTo>
                <a:lnTo>
                  <a:pt x="4872" y="51"/>
                </a:lnTo>
                <a:lnTo>
                  <a:pt x="4882" y="54"/>
                </a:lnTo>
                <a:lnTo>
                  <a:pt x="4892" y="58"/>
                </a:lnTo>
                <a:lnTo>
                  <a:pt x="4903" y="57"/>
                </a:lnTo>
                <a:lnTo>
                  <a:pt x="4913" y="56"/>
                </a:lnTo>
                <a:lnTo>
                  <a:pt x="4923" y="56"/>
                </a:lnTo>
                <a:lnTo>
                  <a:pt x="4933" y="49"/>
                </a:lnTo>
                <a:lnTo>
                  <a:pt x="4943" y="48"/>
                </a:lnTo>
                <a:lnTo>
                  <a:pt x="4954" y="45"/>
                </a:lnTo>
                <a:lnTo>
                  <a:pt x="4964" y="40"/>
                </a:lnTo>
                <a:lnTo>
                  <a:pt x="4974" y="39"/>
                </a:lnTo>
                <a:lnTo>
                  <a:pt x="4984" y="37"/>
                </a:lnTo>
                <a:lnTo>
                  <a:pt x="4995" y="38"/>
                </a:lnTo>
                <a:lnTo>
                  <a:pt x="5005" y="41"/>
                </a:lnTo>
                <a:lnTo>
                  <a:pt x="5015" y="50"/>
                </a:lnTo>
                <a:lnTo>
                  <a:pt x="5025" y="51"/>
                </a:lnTo>
                <a:lnTo>
                  <a:pt x="5036" y="57"/>
                </a:lnTo>
                <a:lnTo>
                  <a:pt x="5046" y="65"/>
                </a:lnTo>
                <a:lnTo>
                  <a:pt x="5056" y="74"/>
                </a:lnTo>
                <a:lnTo>
                  <a:pt x="5066" y="91"/>
                </a:lnTo>
                <a:lnTo>
                  <a:pt x="5076" y="112"/>
                </a:lnTo>
                <a:lnTo>
                  <a:pt x="5087" y="131"/>
                </a:lnTo>
                <a:lnTo>
                  <a:pt x="5097" y="160"/>
                </a:lnTo>
                <a:lnTo>
                  <a:pt x="5107" y="187"/>
                </a:lnTo>
                <a:lnTo>
                  <a:pt x="5117" y="219"/>
                </a:lnTo>
                <a:lnTo>
                  <a:pt x="5128" y="261"/>
                </a:lnTo>
                <a:lnTo>
                  <a:pt x="5138" y="298"/>
                </a:lnTo>
                <a:lnTo>
                  <a:pt x="5148" y="328"/>
                </a:lnTo>
                <a:lnTo>
                  <a:pt x="5158" y="345"/>
                </a:lnTo>
                <a:lnTo>
                  <a:pt x="5169" y="355"/>
                </a:lnTo>
                <a:lnTo>
                  <a:pt x="5179" y="353"/>
                </a:lnTo>
                <a:lnTo>
                  <a:pt x="5189" y="336"/>
                </a:lnTo>
                <a:lnTo>
                  <a:pt x="5199" y="322"/>
                </a:lnTo>
                <a:lnTo>
                  <a:pt x="5210" y="309"/>
                </a:lnTo>
                <a:lnTo>
                  <a:pt x="5220" y="273"/>
                </a:lnTo>
                <a:lnTo>
                  <a:pt x="5230" y="252"/>
                </a:lnTo>
                <a:lnTo>
                  <a:pt x="5240" y="216"/>
                </a:lnTo>
                <a:lnTo>
                  <a:pt x="5250" y="191"/>
                </a:lnTo>
                <a:lnTo>
                  <a:pt x="5261" y="167"/>
                </a:lnTo>
                <a:lnTo>
                  <a:pt x="5271" y="137"/>
                </a:lnTo>
                <a:lnTo>
                  <a:pt x="5281" y="116"/>
                </a:lnTo>
                <a:lnTo>
                  <a:pt x="5291" y="91"/>
                </a:lnTo>
                <a:lnTo>
                  <a:pt x="5302" y="80"/>
                </a:lnTo>
                <a:lnTo>
                  <a:pt x="5312" y="66"/>
                </a:lnTo>
                <a:lnTo>
                  <a:pt x="5322" y="58"/>
                </a:lnTo>
                <a:lnTo>
                  <a:pt x="5332" y="47"/>
                </a:lnTo>
                <a:lnTo>
                  <a:pt x="5343" y="32"/>
                </a:lnTo>
                <a:lnTo>
                  <a:pt x="5353" y="32"/>
                </a:lnTo>
                <a:lnTo>
                  <a:pt x="5363" y="33"/>
                </a:lnTo>
                <a:lnTo>
                  <a:pt x="5373" y="24"/>
                </a:lnTo>
                <a:lnTo>
                  <a:pt x="5383" y="22"/>
                </a:lnTo>
                <a:lnTo>
                  <a:pt x="5394" y="18"/>
                </a:lnTo>
                <a:lnTo>
                  <a:pt x="5404" y="14"/>
                </a:lnTo>
                <a:lnTo>
                  <a:pt x="5414" y="14"/>
                </a:lnTo>
                <a:lnTo>
                  <a:pt x="5424" y="16"/>
                </a:lnTo>
                <a:lnTo>
                  <a:pt x="5435" y="13"/>
                </a:lnTo>
                <a:lnTo>
                  <a:pt x="5445" y="15"/>
                </a:lnTo>
                <a:lnTo>
                  <a:pt x="5455" y="11"/>
                </a:lnTo>
                <a:lnTo>
                  <a:pt x="5465" y="15"/>
                </a:lnTo>
                <a:lnTo>
                  <a:pt x="5476" y="15"/>
                </a:lnTo>
                <a:lnTo>
                  <a:pt x="5486" y="17"/>
                </a:lnTo>
                <a:lnTo>
                  <a:pt x="5496" y="18"/>
                </a:lnTo>
                <a:lnTo>
                  <a:pt x="5506" y="16"/>
                </a:lnTo>
                <a:lnTo>
                  <a:pt x="5517" y="17"/>
                </a:lnTo>
                <a:lnTo>
                  <a:pt x="5527" y="21"/>
                </a:lnTo>
                <a:lnTo>
                  <a:pt x="5537" y="18"/>
                </a:lnTo>
                <a:lnTo>
                  <a:pt x="5547" y="21"/>
                </a:lnTo>
                <a:lnTo>
                  <a:pt x="5557" y="15"/>
                </a:lnTo>
                <a:lnTo>
                  <a:pt x="5568" y="16"/>
                </a:lnTo>
                <a:lnTo>
                  <a:pt x="5578" y="12"/>
                </a:lnTo>
                <a:lnTo>
                  <a:pt x="5588" y="14"/>
                </a:lnTo>
                <a:lnTo>
                  <a:pt x="5598" y="15"/>
                </a:lnTo>
                <a:lnTo>
                  <a:pt x="5609" y="13"/>
                </a:lnTo>
                <a:lnTo>
                  <a:pt x="5619" y="12"/>
                </a:lnTo>
                <a:lnTo>
                  <a:pt x="5629" y="10"/>
                </a:lnTo>
                <a:lnTo>
                  <a:pt x="5639" y="10"/>
                </a:lnTo>
                <a:lnTo>
                  <a:pt x="5650" y="13"/>
                </a:lnTo>
                <a:lnTo>
                  <a:pt x="5660" y="12"/>
                </a:lnTo>
                <a:lnTo>
                  <a:pt x="5670" y="8"/>
                </a:lnTo>
                <a:lnTo>
                  <a:pt x="5680" y="13"/>
                </a:lnTo>
                <a:lnTo>
                  <a:pt x="5690" y="7"/>
                </a:lnTo>
                <a:lnTo>
                  <a:pt x="5701" y="12"/>
                </a:lnTo>
                <a:lnTo>
                  <a:pt x="5711" y="11"/>
                </a:lnTo>
                <a:lnTo>
                  <a:pt x="5721" y="10"/>
                </a:lnTo>
                <a:lnTo>
                  <a:pt x="5731" y="12"/>
                </a:lnTo>
                <a:lnTo>
                  <a:pt x="5742" y="11"/>
                </a:lnTo>
                <a:lnTo>
                  <a:pt x="5752" y="12"/>
                </a:lnTo>
                <a:lnTo>
                  <a:pt x="5762" y="13"/>
                </a:lnTo>
                <a:lnTo>
                  <a:pt x="5772" y="12"/>
                </a:lnTo>
                <a:lnTo>
                  <a:pt x="5783" y="13"/>
                </a:lnTo>
                <a:lnTo>
                  <a:pt x="5793" y="14"/>
                </a:lnTo>
                <a:lnTo>
                  <a:pt x="5803" y="10"/>
                </a:lnTo>
                <a:lnTo>
                  <a:pt x="5813" y="14"/>
                </a:lnTo>
                <a:lnTo>
                  <a:pt x="5824" y="14"/>
                </a:lnTo>
                <a:lnTo>
                  <a:pt x="5834" y="17"/>
                </a:lnTo>
                <a:lnTo>
                  <a:pt x="5844" y="13"/>
                </a:lnTo>
                <a:lnTo>
                  <a:pt x="5854" y="9"/>
                </a:lnTo>
                <a:lnTo>
                  <a:pt x="5864" y="13"/>
                </a:lnTo>
                <a:lnTo>
                  <a:pt x="5875" y="9"/>
                </a:lnTo>
                <a:lnTo>
                  <a:pt x="5885" y="13"/>
                </a:lnTo>
                <a:lnTo>
                  <a:pt x="5895" y="9"/>
                </a:lnTo>
                <a:lnTo>
                  <a:pt x="5905" y="15"/>
                </a:lnTo>
                <a:lnTo>
                  <a:pt x="5916" y="15"/>
                </a:lnTo>
                <a:lnTo>
                  <a:pt x="5926" y="14"/>
                </a:lnTo>
                <a:lnTo>
                  <a:pt x="5936" y="17"/>
                </a:lnTo>
                <a:lnTo>
                  <a:pt x="5946" y="14"/>
                </a:lnTo>
                <a:lnTo>
                  <a:pt x="5957" y="18"/>
                </a:lnTo>
                <a:lnTo>
                  <a:pt x="5967" y="21"/>
                </a:lnTo>
                <a:lnTo>
                  <a:pt x="5977" y="22"/>
                </a:lnTo>
                <a:lnTo>
                  <a:pt x="5987" y="20"/>
                </a:lnTo>
                <a:lnTo>
                  <a:pt x="5997" y="31"/>
                </a:lnTo>
                <a:lnTo>
                  <a:pt x="6008" y="31"/>
                </a:lnTo>
                <a:lnTo>
                  <a:pt x="6018" y="33"/>
                </a:lnTo>
                <a:lnTo>
                  <a:pt x="6028" y="32"/>
                </a:lnTo>
                <a:lnTo>
                  <a:pt x="6038" y="36"/>
                </a:lnTo>
                <a:lnTo>
                  <a:pt x="6049" y="37"/>
                </a:lnTo>
                <a:lnTo>
                  <a:pt x="6059" y="34"/>
                </a:lnTo>
                <a:lnTo>
                  <a:pt x="6069" y="34"/>
                </a:lnTo>
                <a:lnTo>
                  <a:pt x="6079" y="32"/>
                </a:lnTo>
                <a:lnTo>
                  <a:pt x="6090" y="34"/>
                </a:lnTo>
                <a:lnTo>
                  <a:pt x="6100" y="27"/>
                </a:lnTo>
                <a:lnTo>
                  <a:pt x="6110" y="21"/>
                </a:lnTo>
                <a:lnTo>
                  <a:pt x="6120" y="25"/>
                </a:lnTo>
                <a:lnTo>
                  <a:pt x="6131" y="17"/>
                </a:lnTo>
                <a:lnTo>
                  <a:pt x="6141" y="17"/>
                </a:lnTo>
                <a:lnTo>
                  <a:pt x="6151" y="19"/>
                </a:lnTo>
                <a:lnTo>
                  <a:pt x="6161" y="13"/>
                </a:lnTo>
                <a:lnTo>
                  <a:pt x="6171" y="17"/>
                </a:lnTo>
                <a:lnTo>
                  <a:pt x="6182" y="19"/>
                </a:lnTo>
                <a:lnTo>
                  <a:pt x="6192" y="17"/>
                </a:lnTo>
                <a:lnTo>
                  <a:pt x="6202" y="17"/>
                </a:lnTo>
                <a:lnTo>
                  <a:pt x="6212" y="14"/>
                </a:lnTo>
                <a:lnTo>
                  <a:pt x="6223" y="18"/>
                </a:lnTo>
                <a:lnTo>
                  <a:pt x="6233" y="25"/>
                </a:lnTo>
                <a:lnTo>
                  <a:pt x="6243" y="34"/>
                </a:lnTo>
                <a:lnTo>
                  <a:pt x="6253" y="45"/>
                </a:lnTo>
                <a:lnTo>
                  <a:pt x="6264" y="63"/>
                </a:lnTo>
                <a:lnTo>
                  <a:pt x="6274" y="85"/>
                </a:lnTo>
                <a:lnTo>
                  <a:pt x="6284" y="122"/>
                </a:lnTo>
                <a:lnTo>
                  <a:pt x="6294" y="171"/>
                </a:lnTo>
                <a:lnTo>
                  <a:pt x="6305" y="247"/>
                </a:lnTo>
                <a:lnTo>
                  <a:pt x="6315" y="325"/>
                </a:lnTo>
                <a:lnTo>
                  <a:pt x="6325" y="431"/>
                </a:lnTo>
                <a:lnTo>
                  <a:pt x="6335" y="530"/>
                </a:lnTo>
                <a:lnTo>
                  <a:pt x="6345" y="643"/>
                </a:lnTo>
                <a:lnTo>
                  <a:pt x="6356" y="748"/>
                </a:lnTo>
                <a:lnTo>
                  <a:pt x="6366" y="876"/>
                </a:lnTo>
                <a:lnTo>
                  <a:pt x="6376" y="964"/>
                </a:lnTo>
                <a:lnTo>
                  <a:pt x="6386" y="1040"/>
                </a:lnTo>
                <a:lnTo>
                  <a:pt x="6397" y="1069"/>
                </a:lnTo>
                <a:lnTo>
                  <a:pt x="6407" y="1085"/>
                </a:lnTo>
                <a:lnTo>
                  <a:pt x="6417" y="1032"/>
                </a:lnTo>
                <a:lnTo>
                  <a:pt x="6427" y="1009"/>
                </a:lnTo>
                <a:lnTo>
                  <a:pt x="6438" y="942"/>
                </a:lnTo>
                <a:lnTo>
                  <a:pt x="6448" y="872"/>
                </a:lnTo>
                <a:lnTo>
                  <a:pt x="6458" y="810"/>
                </a:lnTo>
                <a:lnTo>
                  <a:pt x="6468" y="758"/>
                </a:lnTo>
                <a:lnTo>
                  <a:pt x="6478" y="703"/>
                </a:lnTo>
                <a:lnTo>
                  <a:pt x="6489" y="657"/>
                </a:lnTo>
                <a:lnTo>
                  <a:pt x="6499" y="600"/>
                </a:lnTo>
                <a:lnTo>
                  <a:pt x="6509" y="538"/>
                </a:lnTo>
                <a:lnTo>
                  <a:pt x="6519" y="499"/>
                </a:lnTo>
                <a:lnTo>
                  <a:pt x="6530" y="478"/>
                </a:lnTo>
                <a:lnTo>
                  <a:pt x="6540" y="468"/>
                </a:lnTo>
                <a:lnTo>
                  <a:pt x="6550" y="450"/>
                </a:lnTo>
                <a:lnTo>
                  <a:pt x="6560" y="443"/>
                </a:lnTo>
                <a:lnTo>
                  <a:pt x="6571" y="429"/>
                </a:lnTo>
                <a:lnTo>
                  <a:pt x="6581" y="420"/>
                </a:lnTo>
                <a:lnTo>
                  <a:pt x="6591" y="397"/>
                </a:lnTo>
                <a:lnTo>
                  <a:pt x="6601" y="390"/>
                </a:lnTo>
                <a:lnTo>
                  <a:pt x="6612" y="388"/>
                </a:lnTo>
                <a:lnTo>
                  <a:pt x="6622" y="381"/>
                </a:lnTo>
                <a:lnTo>
                  <a:pt x="6632" y="360"/>
                </a:lnTo>
                <a:lnTo>
                  <a:pt x="6642" y="354"/>
                </a:lnTo>
                <a:lnTo>
                  <a:pt x="6652" y="335"/>
                </a:lnTo>
                <a:lnTo>
                  <a:pt x="6663" y="312"/>
                </a:lnTo>
                <a:lnTo>
                  <a:pt x="6673" y="296"/>
                </a:lnTo>
                <a:lnTo>
                  <a:pt x="6683" y="273"/>
                </a:lnTo>
                <a:lnTo>
                  <a:pt x="6693" y="261"/>
                </a:lnTo>
                <a:lnTo>
                  <a:pt x="6704" y="251"/>
                </a:lnTo>
                <a:lnTo>
                  <a:pt x="6714" y="244"/>
                </a:lnTo>
                <a:lnTo>
                  <a:pt x="6724" y="240"/>
                </a:lnTo>
                <a:lnTo>
                  <a:pt x="6734" y="236"/>
                </a:lnTo>
                <a:lnTo>
                  <a:pt x="6745" y="233"/>
                </a:lnTo>
                <a:lnTo>
                  <a:pt x="6755" y="219"/>
                </a:lnTo>
                <a:lnTo>
                  <a:pt x="6765" y="201"/>
                </a:lnTo>
                <a:lnTo>
                  <a:pt x="6775" y="192"/>
                </a:lnTo>
                <a:lnTo>
                  <a:pt x="6785" y="182"/>
                </a:lnTo>
                <a:lnTo>
                  <a:pt x="6796" y="161"/>
                </a:lnTo>
                <a:lnTo>
                  <a:pt x="6806" y="152"/>
                </a:lnTo>
                <a:lnTo>
                  <a:pt x="6816" y="144"/>
                </a:lnTo>
                <a:lnTo>
                  <a:pt x="6826" y="130"/>
                </a:lnTo>
                <a:lnTo>
                  <a:pt x="6837" y="126"/>
                </a:lnTo>
                <a:lnTo>
                  <a:pt x="6847" y="111"/>
                </a:lnTo>
                <a:lnTo>
                  <a:pt x="6857" y="103"/>
                </a:lnTo>
                <a:lnTo>
                  <a:pt x="6867" y="98"/>
                </a:lnTo>
                <a:lnTo>
                  <a:pt x="6878" y="90"/>
                </a:lnTo>
                <a:lnTo>
                  <a:pt x="6888" y="83"/>
                </a:lnTo>
                <a:lnTo>
                  <a:pt x="6898" y="77"/>
                </a:lnTo>
                <a:lnTo>
                  <a:pt x="6908" y="74"/>
                </a:lnTo>
                <a:lnTo>
                  <a:pt x="6919" y="67"/>
                </a:lnTo>
                <a:lnTo>
                  <a:pt x="6929" y="71"/>
                </a:lnTo>
                <a:lnTo>
                  <a:pt x="6939" y="60"/>
                </a:lnTo>
                <a:lnTo>
                  <a:pt x="6949" y="56"/>
                </a:lnTo>
                <a:lnTo>
                  <a:pt x="6959" y="55"/>
                </a:lnTo>
                <a:lnTo>
                  <a:pt x="6970" y="53"/>
                </a:lnTo>
                <a:lnTo>
                  <a:pt x="6980" y="54"/>
                </a:lnTo>
                <a:lnTo>
                  <a:pt x="6990" y="53"/>
                </a:lnTo>
                <a:lnTo>
                  <a:pt x="7000" y="48"/>
                </a:lnTo>
                <a:lnTo>
                  <a:pt x="7011" y="53"/>
                </a:lnTo>
                <a:lnTo>
                  <a:pt x="7021" y="49"/>
                </a:lnTo>
                <a:lnTo>
                  <a:pt x="7031" y="55"/>
                </a:lnTo>
                <a:lnTo>
                  <a:pt x="7041" y="53"/>
                </a:lnTo>
                <a:lnTo>
                  <a:pt x="7052" y="57"/>
                </a:lnTo>
                <a:lnTo>
                  <a:pt x="7062" y="55"/>
                </a:lnTo>
                <a:lnTo>
                  <a:pt x="7072" y="50"/>
                </a:lnTo>
                <a:lnTo>
                  <a:pt x="7082" y="49"/>
                </a:lnTo>
                <a:lnTo>
                  <a:pt x="7092" y="41"/>
                </a:lnTo>
                <a:lnTo>
                  <a:pt x="7103" y="45"/>
                </a:lnTo>
                <a:lnTo>
                  <a:pt x="7113" y="44"/>
                </a:lnTo>
                <a:lnTo>
                  <a:pt x="7123" y="43"/>
                </a:lnTo>
                <a:lnTo>
                  <a:pt x="7133" y="35"/>
                </a:lnTo>
                <a:lnTo>
                  <a:pt x="7144" y="42"/>
                </a:lnTo>
                <a:lnTo>
                  <a:pt x="7154" y="32"/>
                </a:lnTo>
                <a:lnTo>
                  <a:pt x="7164" y="34"/>
                </a:lnTo>
                <a:lnTo>
                  <a:pt x="7174" y="36"/>
                </a:lnTo>
                <a:lnTo>
                  <a:pt x="7185" y="35"/>
                </a:lnTo>
                <a:lnTo>
                  <a:pt x="7195" y="35"/>
                </a:lnTo>
                <a:lnTo>
                  <a:pt x="7205" y="38"/>
                </a:lnTo>
                <a:lnTo>
                  <a:pt x="7215" y="36"/>
                </a:lnTo>
                <a:lnTo>
                  <a:pt x="7226" y="36"/>
                </a:lnTo>
                <a:lnTo>
                  <a:pt x="7236" y="36"/>
                </a:lnTo>
                <a:lnTo>
                  <a:pt x="7246" y="41"/>
                </a:lnTo>
                <a:lnTo>
                  <a:pt x="7256" y="38"/>
                </a:lnTo>
                <a:lnTo>
                  <a:pt x="7266" y="33"/>
                </a:lnTo>
                <a:lnTo>
                  <a:pt x="7277" y="39"/>
                </a:lnTo>
                <a:lnTo>
                  <a:pt x="7287" y="39"/>
                </a:lnTo>
                <a:lnTo>
                  <a:pt x="7297" y="38"/>
                </a:lnTo>
                <a:lnTo>
                  <a:pt x="7307" y="41"/>
                </a:lnTo>
                <a:lnTo>
                  <a:pt x="7318" y="36"/>
                </a:lnTo>
                <a:lnTo>
                  <a:pt x="7328" y="37"/>
                </a:lnTo>
                <a:lnTo>
                  <a:pt x="7338" y="39"/>
                </a:lnTo>
                <a:lnTo>
                  <a:pt x="7348" y="46"/>
                </a:lnTo>
                <a:lnTo>
                  <a:pt x="7359" y="51"/>
                </a:lnTo>
                <a:lnTo>
                  <a:pt x="7369" y="57"/>
                </a:lnTo>
                <a:lnTo>
                  <a:pt x="7379" y="62"/>
                </a:lnTo>
                <a:lnTo>
                  <a:pt x="7389" y="73"/>
                </a:lnTo>
                <a:lnTo>
                  <a:pt x="7399" y="77"/>
                </a:lnTo>
                <a:lnTo>
                  <a:pt x="7410" y="88"/>
                </a:lnTo>
                <a:lnTo>
                  <a:pt x="7420" y="91"/>
                </a:lnTo>
                <a:lnTo>
                  <a:pt x="7430" y="88"/>
                </a:lnTo>
                <a:lnTo>
                  <a:pt x="7440" y="91"/>
                </a:lnTo>
                <a:lnTo>
                  <a:pt x="7451" y="91"/>
                </a:lnTo>
                <a:lnTo>
                  <a:pt x="7461" y="85"/>
                </a:lnTo>
                <a:lnTo>
                  <a:pt x="7471" y="79"/>
                </a:lnTo>
                <a:lnTo>
                  <a:pt x="7481" y="74"/>
                </a:lnTo>
                <a:lnTo>
                  <a:pt x="7492" y="67"/>
                </a:lnTo>
                <a:lnTo>
                  <a:pt x="7502" y="61"/>
                </a:lnTo>
                <a:lnTo>
                  <a:pt x="7512" y="56"/>
                </a:lnTo>
                <a:lnTo>
                  <a:pt x="7522" y="64"/>
                </a:lnTo>
                <a:lnTo>
                  <a:pt x="7533" y="59"/>
                </a:lnTo>
                <a:lnTo>
                  <a:pt x="7543" y="64"/>
                </a:lnTo>
                <a:lnTo>
                  <a:pt x="7553" y="67"/>
                </a:lnTo>
                <a:lnTo>
                  <a:pt x="7563" y="70"/>
                </a:lnTo>
                <a:lnTo>
                  <a:pt x="7573" y="70"/>
                </a:lnTo>
                <a:lnTo>
                  <a:pt x="7584" y="82"/>
                </a:lnTo>
                <a:lnTo>
                  <a:pt x="7594" y="86"/>
                </a:lnTo>
                <a:lnTo>
                  <a:pt x="7604" y="83"/>
                </a:lnTo>
                <a:lnTo>
                  <a:pt x="7614" y="87"/>
                </a:lnTo>
                <a:lnTo>
                  <a:pt x="7625" y="83"/>
                </a:lnTo>
                <a:lnTo>
                  <a:pt x="7635" y="83"/>
                </a:lnTo>
                <a:lnTo>
                  <a:pt x="7645" y="79"/>
                </a:lnTo>
                <a:lnTo>
                  <a:pt x="7655" y="77"/>
                </a:lnTo>
                <a:lnTo>
                  <a:pt x="7666" y="72"/>
                </a:lnTo>
                <a:lnTo>
                  <a:pt x="7676" y="68"/>
                </a:lnTo>
                <a:lnTo>
                  <a:pt x="7686" y="61"/>
                </a:lnTo>
                <a:lnTo>
                  <a:pt x="7696" y="60"/>
                </a:lnTo>
                <a:lnTo>
                  <a:pt x="7706" y="58"/>
                </a:lnTo>
                <a:lnTo>
                  <a:pt x="7717" y="55"/>
                </a:lnTo>
                <a:lnTo>
                  <a:pt x="7727" y="54"/>
                </a:lnTo>
                <a:lnTo>
                  <a:pt x="7737" y="55"/>
                </a:lnTo>
                <a:lnTo>
                  <a:pt x="7747" y="55"/>
                </a:lnTo>
                <a:lnTo>
                  <a:pt x="7758" y="54"/>
                </a:lnTo>
                <a:lnTo>
                  <a:pt x="7768" y="53"/>
                </a:lnTo>
                <a:lnTo>
                  <a:pt x="7778" y="48"/>
                </a:lnTo>
                <a:lnTo>
                  <a:pt x="7788" y="51"/>
                </a:lnTo>
                <a:lnTo>
                  <a:pt x="7799" y="55"/>
                </a:lnTo>
                <a:lnTo>
                  <a:pt x="7809" y="59"/>
                </a:lnTo>
                <a:lnTo>
                  <a:pt x="7819" y="66"/>
                </a:lnTo>
                <a:lnTo>
                  <a:pt x="7829" y="80"/>
                </a:lnTo>
                <a:lnTo>
                  <a:pt x="7840" y="102"/>
                </a:lnTo>
                <a:lnTo>
                  <a:pt x="7850" y="133"/>
                </a:lnTo>
                <a:lnTo>
                  <a:pt x="7860" y="190"/>
                </a:lnTo>
                <a:lnTo>
                  <a:pt x="7870" y="239"/>
                </a:lnTo>
                <a:lnTo>
                  <a:pt x="7880" y="314"/>
                </a:lnTo>
                <a:lnTo>
                  <a:pt x="7891" y="389"/>
                </a:lnTo>
                <a:lnTo>
                  <a:pt x="7901" y="463"/>
                </a:lnTo>
                <a:lnTo>
                  <a:pt x="7911" y="551"/>
                </a:lnTo>
                <a:lnTo>
                  <a:pt x="7921" y="587"/>
                </a:lnTo>
                <a:lnTo>
                  <a:pt x="7932" y="615"/>
                </a:lnTo>
                <a:lnTo>
                  <a:pt x="7942" y="626"/>
                </a:lnTo>
                <a:lnTo>
                  <a:pt x="7952" y="619"/>
                </a:lnTo>
                <a:lnTo>
                  <a:pt x="7962" y="587"/>
                </a:lnTo>
                <a:lnTo>
                  <a:pt x="7973" y="533"/>
                </a:lnTo>
                <a:lnTo>
                  <a:pt x="7983" y="458"/>
                </a:lnTo>
                <a:lnTo>
                  <a:pt x="7993" y="394"/>
                </a:lnTo>
                <a:lnTo>
                  <a:pt x="8003" y="320"/>
                </a:lnTo>
                <a:lnTo>
                  <a:pt x="8013" y="265"/>
                </a:lnTo>
                <a:lnTo>
                  <a:pt x="8024" y="220"/>
                </a:lnTo>
                <a:lnTo>
                  <a:pt x="8034" y="171"/>
                </a:lnTo>
                <a:lnTo>
                  <a:pt x="8044" y="139"/>
                </a:lnTo>
                <a:lnTo>
                  <a:pt x="8054" y="112"/>
                </a:lnTo>
                <a:lnTo>
                  <a:pt x="8065" y="99"/>
                </a:lnTo>
                <a:lnTo>
                  <a:pt x="8075" y="76"/>
                </a:lnTo>
                <a:lnTo>
                  <a:pt x="8085" y="63"/>
                </a:lnTo>
                <a:lnTo>
                  <a:pt x="8095" y="55"/>
                </a:lnTo>
                <a:lnTo>
                  <a:pt x="8106" y="56"/>
                </a:lnTo>
                <a:lnTo>
                  <a:pt x="8116" y="56"/>
                </a:lnTo>
                <a:lnTo>
                  <a:pt x="8126" y="55"/>
                </a:lnTo>
                <a:lnTo>
                  <a:pt x="8136" y="53"/>
                </a:lnTo>
                <a:lnTo>
                  <a:pt x="8147" y="61"/>
                </a:lnTo>
                <a:lnTo>
                  <a:pt x="8157" y="69"/>
                </a:lnTo>
                <a:lnTo>
                  <a:pt x="8167" y="74"/>
                </a:lnTo>
                <a:lnTo>
                  <a:pt x="8177" y="86"/>
                </a:lnTo>
                <a:lnTo>
                  <a:pt x="8187" y="98"/>
                </a:lnTo>
                <a:lnTo>
                  <a:pt x="8198" y="115"/>
                </a:lnTo>
                <a:lnTo>
                  <a:pt x="8208" y="134"/>
                </a:lnTo>
                <a:lnTo>
                  <a:pt x="8218" y="148"/>
                </a:lnTo>
                <a:lnTo>
                  <a:pt x="8228" y="179"/>
                </a:lnTo>
                <a:lnTo>
                  <a:pt x="8239" y="213"/>
                </a:lnTo>
                <a:lnTo>
                  <a:pt x="8249" y="258"/>
                </a:lnTo>
                <a:lnTo>
                  <a:pt x="8259" y="276"/>
                </a:lnTo>
                <a:lnTo>
                  <a:pt x="8269" y="309"/>
                </a:lnTo>
                <a:lnTo>
                  <a:pt x="8280" y="345"/>
                </a:lnTo>
                <a:lnTo>
                  <a:pt x="8290" y="372"/>
                </a:lnTo>
                <a:lnTo>
                  <a:pt x="8300" y="388"/>
                </a:lnTo>
                <a:lnTo>
                  <a:pt x="8310" y="405"/>
                </a:lnTo>
                <a:lnTo>
                  <a:pt x="8320" y="405"/>
                </a:lnTo>
                <a:lnTo>
                  <a:pt x="8331" y="389"/>
                </a:lnTo>
                <a:lnTo>
                  <a:pt x="8341" y="384"/>
                </a:lnTo>
                <a:lnTo>
                  <a:pt x="8351" y="350"/>
                </a:lnTo>
                <a:lnTo>
                  <a:pt x="8361" y="318"/>
                </a:lnTo>
                <a:lnTo>
                  <a:pt x="8372" y="277"/>
                </a:lnTo>
                <a:lnTo>
                  <a:pt x="8382" y="247"/>
                </a:lnTo>
                <a:lnTo>
                  <a:pt x="8392" y="221"/>
                </a:lnTo>
                <a:lnTo>
                  <a:pt x="8402" y="197"/>
                </a:lnTo>
                <a:lnTo>
                  <a:pt x="8413" y="177"/>
                </a:lnTo>
                <a:lnTo>
                  <a:pt x="8423" y="158"/>
                </a:lnTo>
                <a:lnTo>
                  <a:pt x="8433" y="143"/>
                </a:lnTo>
                <a:lnTo>
                  <a:pt x="8443" y="127"/>
                </a:lnTo>
                <a:lnTo>
                  <a:pt x="8454" y="120"/>
                </a:lnTo>
                <a:lnTo>
                  <a:pt x="8464" y="107"/>
                </a:lnTo>
                <a:lnTo>
                  <a:pt x="8474" y="100"/>
                </a:lnTo>
                <a:lnTo>
                  <a:pt x="8484" y="94"/>
                </a:lnTo>
                <a:lnTo>
                  <a:pt x="8494" y="88"/>
                </a:lnTo>
                <a:lnTo>
                  <a:pt x="8505" y="82"/>
                </a:lnTo>
                <a:lnTo>
                  <a:pt x="8515" y="83"/>
                </a:lnTo>
                <a:lnTo>
                  <a:pt x="8525" y="83"/>
                </a:lnTo>
                <a:lnTo>
                  <a:pt x="8535" y="82"/>
                </a:lnTo>
                <a:lnTo>
                  <a:pt x="8546" y="81"/>
                </a:lnTo>
                <a:lnTo>
                  <a:pt x="8556" y="83"/>
                </a:lnTo>
                <a:lnTo>
                  <a:pt x="8566" y="80"/>
                </a:lnTo>
                <a:lnTo>
                  <a:pt x="8576" y="85"/>
                </a:lnTo>
                <a:lnTo>
                  <a:pt x="8587" y="82"/>
                </a:lnTo>
                <a:lnTo>
                  <a:pt x="8597" y="86"/>
                </a:lnTo>
                <a:lnTo>
                  <a:pt x="8607" y="85"/>
                </a:lnTo>
                <a:lnTo>
                  <a:pt x="8617" y="90"/>
                </a:lnTo>
                <a:lnTo>
                  <a:pt x="8627" y="92"/>
                </a:lnTo>
                <a:lnTo>
                  <a:pt x="8638" y="88"/>
                </a:lnTo>
                <a:lnTo>
                  <a:pt x="8648" y="86"/>
                </a:lnTo>
                <a:lnTo>
                  <a:pt x="8658" y="86"/>
                </a:lnTo>
                <a:lnTo>
                  <a:pt x="8668" y="85"/>
                </a:lnTo>
                <a:lnTo>
                  <a:pt x="8679" y="77"/>
                </a:lnTo>
                <a:lnTo>
                  <a:pt x="8689" y="73"/>
                </a:lnTo>
                <a:lnTo>
                  <a:pt x="8699" y="70"/>
                </a:lnTo>
                <a:lnTo>
                  <a:pt x="8709" y="63"/>
                </a:lnTo>
                <a:lnTo>
                  <a:pt x="8720" y="67"/>
                </a:lnTo>
                <a:lnTo>
                  <a:pt x="8730" y="63"/>
                </a:lnTo>
                <a:lnTo>
                  <a:pt x="8740" y="56"/>
                </a:lnTo>
                <a:lnTo>
                  <a:pt x="8750" y="58"/>
                </a:lnTo>
                <a:lnTo>
                  <a:pt x="8761" y="53"/>
                </a:lnTo>
                <a:lnTo>
                  <a:pt x="8771" y="49"/>
                </a:lnTo>
                <a:lnTo>
                  <a:pt x="8781" y="52"/>
                </a:lnTo>
                <a:lnTo>
                  <a:pt x="8791" y="49"/>
                </a:lnTo>
                <a:lnTo>
                  <a:pt x="8801" y="47"/>
                </a:lnTo>
                <a:lnTo>
                  <a:pt x="8812" y="42"/>
                </a:lnTo>
                <a:lnTo>
                  <a:pt x="8822" y="38"/>
                </a:lnTo>
                <a:lnTo>
                  <a:pt x="8832" y="34"/>
                </a:lnTo>
                <a:lnTo>
                  <a:pt x="8842" y="32"/>
                </a:lnTo>
                <a:lnTo>
                  <a:pt x="8853" y="31"/>
                </a:lnTo>
                <a:lnTo>
                  <a:pt x="8863" y="35"/>
                </a:lnTo>
                <a:lnTo>
                  <a:pt x="8873" y="32"/>
                </a:lnTo>
                <a:lnTo>
                  <a:pt x="8883" y="30"/>
                </a:lnTo>
                <a:lnTo>
                  <a:pt x="8894" y="28"/>
                </a:lnTo>
                <a:lnTo>
                  <a:pt x="8904" y="30"/>
                </a:lnTo>
                <a:lnTo>
                  <a:pt x="8914" y="30"/>
                </a:lnTo>
                <a:lnTo>
                  <a:pt x="8924" y="27"/>
                </a:lnTo>
                <a:lnTo>
                  <a:pt x="8934" y="30"/>
                </a:lnTo>
                <a:lnTo>
                  <a:pt x="8945" y="28"/>
                </a:lnTo>
                <a:lnTo>
                  <a:pt x="8955" y="25"/>
                </a:lnTo>
                <a:lnTo>
                  <a:pt x="8965" y="27"/>
                </a:lnTo>
                <a:lnTo>
                  <a:pt x="8975" y="26"/>
                </a:lnTo>
                <a:lnTo>
                  <a:pt x="8986" y="19"/>
                </a:lnTo>
                <a:lnTo>
                  <a:pt x="8996" y="19"/>
                </a:lnTo>
                <a:lnTo>
                  <a:pt x="9006" y="18"/>
                </a:lnTo>
                <a:lnTo>
                  <a:pt x="9016" y="23"/>
                </a:lnTo>
                <a:lnTo>
                  <a:pt x="9027" y="20"/>
                </a:lnTo>
                <a:lnTo>
                  <a:pt x="9037" y="18"/>
                </a:lnTo>
                <a:lnTo>
                  <a:pt x="9047" y="18"/>
                </a:lnTo>
                <a:lnTo>
                  <a:pt x="9057" y="23"/>
                </a:lnTo>
                <a:lnTo>
                  <a:pt x="9068" y="20"/>
                </a:lnTo>
                <a:lnTo>
                  <a:pt x="9078" y="20"/>
                </a:lnTo>
                <a:lnTo>
                  <a:pt x="9088" y="20"/>
                </a:lnTo>
                <a:lnTo>
                  <a:pt x="9098" y="19"/>
                </a:lnTo>
                <a:lnTo>
                  <a:pt x="9108" y="21"/>
                </a:lnTo>
                <a:lnTo>
                  <a:pt x="9119" y="17"/>
                </a:lnTo>
                <a:lnTo>
                  <a:pt x="9129" y="14"/>
                </a:lnTo>
                <a:lnTo>
                  <a:pt x="9139" y="19"/>
                </a:lnTo>
                <a:lnTo>
                  <a:pt x="9149" y="16"/>
                </a:lnTo>
                <a:lnTo>
                  <a:pt x="9160" y="15"/>
                </a:lnTo>
                <a:lnTo>
                  <a:pt x="9170" y="14"/>
                </a:lnTo>
                <a:lnTo>
                  <a:pt x="9180" y="15"/>
                </a:lnTo>
                <a:lnTo>
                  <a:pt x="9190" y="14"/>
                </a:lnTo>
                <a:lnTo>
                  <a:pt x="9201" y="14"/>
                </a:lnTo>
                <a:lnTo>
                  <a:pt x="9211" y="13"/>
                </a:lnTo>
                <a:lnTo>
                  <a:pt x="9221" y="16"/>
                </a:lnTo>
                <a:lnTo>
                  <a:pt x="9231" y="14"/>
                </a:lnTo>
                <a:lnTo>
                  <a:pt x="9241" y="15"/>
                </a:lnTo>
                <a:lnTo>
                  <a:pt x="9252" y="14"/>
                </a:lnTo>
                <a:lnTo>
                  <a:pt x="9262" y="19"/>
                </a:lnTo>
                <a:lnTo>
                  <a:pt x="9272" y="19"/>
                </a:lnTo>
                <a:lnTo>
                  <a:pt x="9282" y="25"/>
                </a:lnTo>
                <a:lnTo>
                  <a:pt x="9293" y="35"/>
                </a:lnTo>
                <a:lnTo>
                  <a:pt x="9303" y="51"/>
                </a:lnTo>
                <a:lnTo>
                  <a:pt x="9313" y="71"/>
                </a:lnTo>
                <a:lnTo>
                  <a:pt x="9323" y="98"/>
                </a:lnTo>
                <a:lnTo>
                  <a:pt x="9334" y="133"/>
                </a:lnTo>
                <a:lnTo>
                  <a:pt x="9344" y="180"/>
                </a:lnTo>
                <a:lnTo>
                  <a:pt x="9354" y="230"/>
                </a:lnTo>
                <a:lnTo>
                  <a:pt x="9364" y="288"/>
                </a:lnTo>
                <a:lnTo>
                  <a:pt x="9375" y="356"/>
                </a:lnTo>
                <a:lnTo>
                  <a:pt x="9385" y="416"/>
                </a:lnTo>
                <a:lnTo>
                  <a:pt x="9395" y="473"/>
                </a:lnTo>
                <a:lnTo>
                  <a:pt x="9405" y="503"/>
                </a:lnTo>
                <a:lnTo>
                  <a:pt x="9415" y="519"/>
                </a:lnTo>
                <a:lnTo>
                  <a:pt x="9426" y="516"/>
                </a:lnTo>
                <a:lnTo>
                  <a:pt x="9436" y="499"/>
                </a:lnTo>
                <a:lnTo>
                  <a:pt x="9446" y="461"/>
                </a:lnTo>
                <a:lnTo>
                  <a:pt x="9456" y="395"/>
                </a:lnTo>
                <a:lnTo>
                  <a:pt x="9467" y="343"/>
                </a:lnTo>
                <a:lnTo>
                  <a:pt x="9477" y="277"/>
                </a:lnTo>
                <a:lnTo>
                  <a:pt x="9487" y="223"/>
                </a:lnTo>
                <a:lnTo>
                  <a:pt x="9497" y="174"/>
                </a:lnTo>
                <a:lnTo>
                  <a:pt x="9508" y="127"/>
                </a:lnTo>
                <a:lnTo>
                  <a:pt x="9518" y="97"/>
                </a:lnTo>
                <a:lnTo>
                  <a:pt x="9528" y="72"/>
                </a:lnTo>
                <a:lnTo>
                  <a:pt x="9538" y="55"/>
                </a:lnTo>
                <a:lnTo>
                  <a:pt x="9548" y="39"/>
                </a:lnTo>
                <a:lnTo>
                  <a:pt x="9559" y="33"/>
                </a:lnTo>
                <a:lnTo>
                  <a:pt x="9569" y="26"/>
                </a:lnTo>
                <a:lnTo>
                  <a:pt x="9579" y="22"/>
                </a:lnTo>
                <a:lnTo>
                  <a:pt x="9589" y="21"/>
                </a:lnTo>
                <a:lnTo>
                  <a:pt x="9600" y="23"/>
                </a:lnTo>
                <a:lnTo>
                  <a:pt x="9610" y="21"/>
                </a:lnTo>
                <a:lnTo>
                  <a:pt x="9620" y="20"/>
                </a:lnTo>
                <a:lnTo>
                  <a:pt x="9630" y="22"/>
                </a:lnTo>
                <a:lnTo>
                  <a:pt x="9641" y="20"/>
                </a:lnTo>
                <a:lnTo>
                  <a:pt x="9651" y="20"/>
                </a:lnTo>
                <a:lnTo>
                  <a:pt x="9661" y="26"/>
                </a:lnTo>
                <a:lnTo>
                  <a:pt x="9671" y="23"/>
                </a:lnTo>
                <a:lnTo>
                  <a:pt x="9682" y="24"/>
                </a:lnTo>
                <a:lnTo>
                  <a:pt x="9692" y="21"/>
                </a:lnTo>
                <a:lnTo>
                  <a:pt x="9702" y="23"/>
                </a:lnTo>
                <a:lnTo>
                  <a:pt x="9712" y="25"/>
                </a:lnTo>
                <a:lnTo>
                  <a:pt x="9722" y="25"/>
                </a:lnTo>
                <a:lnTo>
                  <a:pt x="9733" y="29"/>
                </a:lnTo>
                <a:lnTo>
                  <a:pt x="9743" y="31"/>
                </a:lnTo>
                <a:lnTo>
                  <a:pt x="9753" y="33"/>
                </a:lnTo>
                <a:lnTo>
                  <a:pt x="9763" y="30"/>
                </a:lnTo>
                <a:lnTo>
                  <a:pt x="9774" y="30"/>
                </a:lnTo>
                <a:lnTo>
                  <a:pt x="9784" y="33"/>
                </a:lnTo>
                <a:lnTo>
                  <a:pt x="9794" y="31"/>
                </a:lnTo>
                <a:lnTo>
                  <a:pt x="9804" y="27"/>
                </a:lnTo>
                <a:lnTo>
                  <a:pt x="9815" y="23"/>
                </a:lnTo>
                <a:lnTo>
                  <a:pt x="9825" y="22"/>
                </a:lnTo>
                <a:lnTo>
                  <a:pt x="9835" y="20"/>
                </a:lnTo>
                <a:lnTo>
                  <a:pt x="9845" y="21"/>
                </a:lnTo>
                <a:lnTo>
                  <a:pt x="9855" y="10"/>
                </a:lnTo>
                <a:lnTo>
                  <a:pt x="9866" y="13"/>
                </a:lnTo>
                <a:lnTo>
                  <a:pt x="9876" y="10"/>
                </a:lnTo>
                <a:lnTo>
                  <a:pt x="9886" y="4"/>
                </a:lnTo>
                <a:lnTo>
                  <a:pt x="9896" y="7"/>
                </a:lnTo>
                <a:lnTo>
                  <a:pt x="9907" y="3"/>
                </a:lnTo>
                <a:lnTo>
                  <a:pt x="9917" y="3"/>
                </a:lnTo>
                <a:lnTo>
                  <a:pt x="9927" y="4"/>
                </a:lnTo>
                <a:lnTo>
                  <a:pt x="9937" y="7"/>
                </a:lnTo>
                <a:lnTo>
                  <a:pt x="9948" y="7"/>
                </a:lnTo>
                <a:lnTo>
                  <a:pt x="9958" y="7"/>
                </a:lnTo>
                <a:lnTo>
                  <a:pt x="9968" y="2"/>
                </a:lnTo>
                <a:lnTo>
                  <a:pt x="9978" y="5"/>
                </a:lnTo>
                <a:lnTo>
                  <a:pt x="9989" y="5"/>
                </a:lnTo>
                <a:lnTo>
                  <a:pt x="9999" y="6"/>
                </a:lnTo>
                <a:lnTo>
                  <a:pt x="10009" y="6"/>
                </a:lnTo>
                <a:lnTo>
                  <a:pt x="10019" y="0"/>
                </a:lnTo>
                <a:lnTo>
                  <a:pt x="10029" y="3"/>
                </a:lnTo>
                <a:lnTo>
                  <a:pt x="10040" y="0"/>
                </a:lnTo>
                <a:lnTo>
                  <a:pt x="10050" y="2"/>
                </a:lnTo>
                <a:lnTo>
                  <a:pt x="10060" y="6"/>
                </a:lnTo>
                <a:lnTo>
                  <a:pt x="10070" y="0"/>
                </a:lnTo>
                <a:lnTo>
                  <a:pt x="10081" y="1"/>
                </a:lnTo>
                <a:lnTo>
                  <a:pt x="10091" y="3"/>
                </a:lnTo>
                <a:lnTo>
                  <a:pt x="10101" y="6"/>
                </a:lnTo>
                <a:lnTo>
                  <a:pt x="10111" y="1"/>
                </a:lnTo>
                <a:lnTo>
                  <a:pt x="10122" y="5"/>
                </a:lnTo>
                <a:lnTo>
                  <a:pt x="10132" y="5"/>
                </a:lnTo>
                <a:lnTo>
                  <a:pt x="10142" y="6"/>
                </a:lnTo>
                <a:lnTo>
                  <a:pt x="10152" y="8"/>
                </a:lnTo>
                <a:lnTo>
                  <a:pt x="10162" y="13"/>
                </a:lnTo>
                <a:lnTo>
                  <a:pt x="10173" y="17"/>
                </a:lnTo>
                <a:lnTo>
                  <a:pt x="10183" y="20"/>
                </a:lnTo>
                <a:lnTo>
                  <a:pt x="10193" y="26"/>
                </a:lnTo>
                <a:lnTo>
                  <a:pt x="10203" y="34"/>
                </a:lnTo>
                <a:lnTo>
                  <a:pt x="10214" y="45"/>
                </a:lnTo>
                <a:lnTo>
                  <a:pt x="10224" y="46"/>
                </a:lnTo>
                <a:lnTo>
                  <a:pt x="10234" y="58"/>
                </a:lnTo>
                <a:lnTo>
                  <a:pt x="10244" y="61"/>
                </a:lnTo>
                <a:lnTo>
                  <a:pt x="10255" y="67"/>
                </a:lnTo>
                <a:lnTo>
                  <a:pt x="10265" y="71"/>
                </a:lnTo>
                <a:lnTo>
                  <a:pt x="10275" y="71"/>
                </a:lnTo>
                <a:lnTo>
                  <a:pt x="10285" y="79"/>
                </a:lnTo>
                <a:lnTo>
                  <a:pt x="10296" y="72"/>
                </a:lnTo>
                <a:lnTo>
                  <a:pt x="10306" y="71"/>
                </a:lnTo>
                <a:lnTo>
                  <a:pt x="10316" y="69"/>
                </a:lnTo>
                <a:lnTo>
                  <a:pt x="10326" y="66"/>
                </a:lnTo>
                <a:lnTo>
                  <a:pt x="10336" y="63"/>
                </a:lnTo>
                <a:lnTo>
                  <a:pt x="10347" y="60"/>
                </a:lnTo>
                <a:lnTo>
                  <a:pt x="10357" y="57"/>
                </a:lnTo>
                <a:lnTo>
                  <a:pt x="10367" y="52"/>
                </a:lnTo>
                <a:lnTo>
                  <a:pt x="10377" y="47"/>
                </a:lnTo>
                <a:lnTo>
                  <a:pt x="10388" y="49"/>
                </a:lnTo>
                <a:lnTo>
                  <a:pt x="10398" y="46"/>
                </a:lnTo>
                <a:lnTo>
                  <a:pt x="10408" y="43"/>
                </a:lnTo>
                <a:lnTo>
                  <a:pt x="10418" y="45"/>
                </a:lnTo>
                <a:lnTo>
                  <a:pt x="10429" y="42"/>
                </a:lnTo>
                <a:lnTo>
                  <a:pt x="10439" y="38"/>
                </a:lnTo>
                <a:lnTo>
                  <a:pt x="10449" y="40"/>
                </a:lnTo>
                <a:lnTo>
                  <a:pt x="10459" y="34"/>
                </a:lnTo>
                <a:lnTo>
                  <a:pt x="10470" y="30"/>
                </a:lnTo>
                <a:lnTo>
                  <a:pt x="10480" y="25"/>
                </a:lnTo>
                <a:lnTo>
                  <a:pt x="10490" y="24"/>
                </a:lnTo>
                <a:lnTo>
                  <a:pt x="10500" y="21"/>
                </a:lnTo>
                <a:lnTo>
                  <a:pt x="10510" y="19"/>
                </a:lnTo>
                <a:lnTo>
                  <a:pt x="10521" y="13"/>
                </a:lnTo>
                <a:lnTo>
                  <a:pt x="10531" y="18"/>
                </a:lnTo>
                <a:lnTo>
                  <a:pt x="10541" y="15"/>
                </a:lnTo>
                <a:lnTo>
                  <a:pt x="10551" y="15"/>
                </a:lnTo>
                <a:lnTo>
                  <a:pt x="10562" y="15"/>
                </a:lnTo>
                <a:lnTo>
                  <a:pt x="10572" y="15"/>
                </a:lnTo>
                <a:lnTo>
                  <a:pt x="10582" y="15"/>
                </a:lnTo>
                <a:lnTo>
                  <a:pt x="10592" y="18"/>
                </a:lnTo>
                <a:lnTo>
                  <a:pt x="10603" y="10"/>
                </a:lnTo>
                <a:lnTo>
                  <a:pt x="10613" y="12"/>
                </a:lnTo>
                <a:lnTo>
                  <a:pt x="10623" y="10"/>
                </a:lnTo>
                <a:lnTo>
                  <a:pt x="10633" y="15"/>
                </a:lnTo>
                <a:lnTo>
                  <a:pt x="10643" y="13"/>
                </a:lnTo>
                <a:lnTo>
                  <a:pt x="10654" y="15"/>
                </a:lnTo>
                <a:lnTo>
                  <a:pt x="10664" y="12"/>
                </a:lnTo>
                <a:lnTo>
                  <a:pt x="10674" y="13"/>
                </a:lnTo>
                <a:lnTo>
                  <a:pt x="10684" y="12"/>
                </a:lnTo>
                <a:lnTo>
                  <a:pt x="10695" y="17"/>
                </a:lnTo>
                <a:lnTo>
                  <a:pt x="10705" y="12"/>
                </a:lnTo>
                <a:lnTo>
                  <a:pt x="10715" y="16"/>
                </a:lnTo>
                <a:lnTo>
                  <a:pt x="10725" y="14"/>
                </a:lnTo>
                <a:lnTo>
                  <a:pt x="10736" y="12"/>
                </a:lnTo>
                <a:lnTo>
                  <a:pt x="10746" y="12"/>
                </a:lnTo>
                <a:lnTo>
                  <a:pt x="10756" y="11"/>
                </a:lnTo>
                <a:lnTo>
                  <a:pt x="10766" y="8"/>
                </a:lnTo>
                <a:lnTo>
                  <a:pt x="10777" y="10"/>
                </a:lnTo>
                <a:lnTo>
                  <a:pt x="10787" y="4"/>
                </a:lnTo>
                <a:lnTo>
                  <a:pt x="10797" y="9"/>
                </a:lnTo>
                <a:lnTo>
                  <a:pt x="10807" y="8"/>
                </a:lnTo>
                <a:lnTo>
                  <a:pt x="10817" y="8"/>
                </a:lnTo>
                <a:lnTo>
                  <a:pt x="10828" y="5"/>
                </a:lnTo>
                <a:lnTo>
                  <a:pt x="10838" y="1"/>
                </a:lnTo>
                <a:lnTo>
                  <a:pt x="10848" y="6"/>
                </a:lnTo>
                <a:lnTo>
                  <a:pt x="10858" y="4"/>
                </a:lnTo>
                <a:lnTo>
                  <a:pt x="10869" y="5"/>
                </a:lnTo>
                <a:lnTo>
                  <a:pt x="10879" y="6"/>
                </a:lnTo>
                <a:lnTo>
                  <a:pt x="10889" y="5"/>
                </a:lnTo>
                <a:lnTo>
                  <a:pt x="10899" y="4"/>
                </a:lnTo>
                <a:lnTo>
                  <a:pt x="10910" y="7"/>
                </a:lnTo>
                <a:lnTo>
                  <a:pt x="10920" y="4"/>
                </a:lnTo>
                <a:lnTo>
                  <a:pt x="10930" y="3"/>
                </a:lnTo>
                <a:lnTo>
                  <a:pt x="10940" y="7"/>
                </a:lnTo>
                <a:lnTo>
                  <a:pt x="10950" y="11"/>
                </a:lnTo>
                <a:lnTo>
                  <a:pt x="10961" y="10"/>
                </a:lnTo>
                <a:lnTo>
                  <a:pt x="10971" y="12"/>
                </a:lnTo>
                <a:lnTo>
                  <a:pt x="10981" y="13"/>
                </a:lnTo>
                <a:lnTo>
                  <a:pt x="10991" y="17"/>
                </a:lnTo>
                <a:lnTo>
                  <a:pt x="11002" y="18"/>
                </a:lnTo>
                <a:lnTo>
                  <a:pt x="11012" y="22"/>
                </a:lnTo>
                <a:lnTo>
                  <a:pt x="11022" y="27"/>
                </a:lnTo>
                <a:lnTo>
                  <a:pt x="11032" y="30"/>
                </a:lnTo>
                <a:lnTo>
                  <a:pt x="11043" y="33"/>
                </a:lnTo>
                <a:lnTo>
                  <a:pt x="11053" y="39"/>
                </a:lnTo>
                <a:lnTo>
                  <a:pt x="11063" y="34"/>
                </a:lnTo>
                <a:lnTo>
                  <a:pt x="11073" y="38"/>
                </a:lnTo>
                <a:lnTo>
                  <a:pt x="11084" y="39"/>
                </a:lnTo>
                <a:lnTo>
                  <a:pt x="11094" y="35"/>
                </a:lnTo>
                <a:lnTo>
                  <a:pt x="11104" y="37"/>
                </a:lnTo>
                <a:lnTo>
                  <a:pt x="11114" y="31"/>
                </a:lnTo>
                <a:lnTo>
                  <a:pt x="11124" y="31"/>
                </a:lnTo>
                <a:lnTo>
                  <a:pt x="11135" y="33"/>
                </a:lnTo>
                <a:lnTo>
                  <a:pt x="11145" y="26"/>
                </a:lnTo>
                <a:lnTo>
                  <a:pt x="11155" y="24"/>
                </a:lnTo>
                <a:lnTo>
                  <a:pt x="11165" y="28"/>
                </a:lnTo>
                <a:lnTo>
                  <a:pt x="11176" y="22"/>
                </a:lnTo>
                <a:lnTo>
                  <a:pt x="11186" y="24"/>
                </a:lnTo>
                <a:lnTo>
                  <a:pt x="11196" y="25"/>
                </a:lnTo>
                <a:lnTo>
                  <a:pt x="11206" y="22"/>
                </a:lnTo>
                <a:lnTo>
                  <a:pt x="11217" y="21"/>
                </a:lnTo>
                <a:lnTo>
                  <a:pt x="11227" y="26"/>
                </a:lnTo>
                <a:lnTo>
                  <a:pt x="11237" y="23"/>
                </a:lnTo>
                <a:lnTo>
                  <a:pt x="11247" y="22"/>
                </a:lnTo>
                <a:lnTo>
                  <a:pt x="11253" y="18"/>
                </a:lnTo>
              </a:path>
            </a:pathLst>
          </a:custGeom>
          <a:noFill/>
          <a:ln w="9360">
            <a:solidFill>
              <a:srgbClr val="00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grpSp>
        <p:nvGrpSpPr>
          <p:cNvPr id="239" name="Group 728"/>
          <p:cNvGrpSpPr/>
          <p:nvPr/>
        </p:nvGrpSpPr>
        <p:grpSpPr>
          <a:xfrm>
            <a:off x="2289240" y="1054080"/>
            <a:ext cx="2265120" cy="905040"/>
            <a:chOff x="2289240" y="1054080"/>
            <a:chExt cx="2265120" cy="905040"/>
          </a:xfrm>
        </p:grpSpPr>
        <p:sp>
          <p:nvSpPr>
            <p:cNvPr id="240" name="Freeform 374"/>
            <p:cNvSpPr/>
            <p:nvPr/>
          </p:nvSpPr>
          <p:spPr>
            <a:xfrm>
              <a:off x="2289240" y="1899000"/>
              <a:ext cx="66240" cy="60120"/>
            </a:xfrm>
            <a:custGeom>
              <a:avLst/>
              <a:gdLst>
                <a:gd name="textAreaLeft" fmla="*/ 0 w 66240"/>
                <a:gd name="textAreaRight" fmla="*/ 66600 w 66240"/>
                <a:gd name="textAreaTop" fmla="*/ 0 h 60120"/>
                <a:gd name="textAreaBottom" fmla="*/ 60480 h 60120"/>
              </a:gdLst>
              <a:ahLst/>
              <a:rect l="textAreaLeft" t="textAreaTop" r="textAreaRight" b="textAreaBottom"/>
              <a:pathLst>
                <a:path w="39" h="38">
                  <a:moveTo>
                    <a:pt x="22" y="38"/>
                  </a:moveTo>
                  <a:lnTo>
                    <a:pt x="0" y="17"/>
                  </a:lnTo>
                  <a:lnTo>
                    <a:pt x="22" y="0"/>
                  </a:lnTo>
                  <a:lnTo>
                    <a:pt x="39" y="17"/>
                  </a:lnTo>
                  <a:lnTo>
                    <a:pt x="22" y="38"/>
                  </a:lnTo>
                  <a:close/>
                </a:path>
              </a:pathLst>
            </a:custGeom>
            <a:solidFill>
              <a:srgbClr val="4f81bd"/>
            </a:solidFill>
            <a:ln w="0">
              <a:no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241" name="Freeform 375"/>
            <p:cNvSpPr/>
            <p:nvPr/>
          </p:nvSpPr>
          <p:spPr>
            <a:xfrm>
              <a:off x="2289240" y="1891080"/>
              <a:ext cx="74880" cy="68040"/>
            </a:xfrm>
            <a:custGeom>
              <a:avLst/>
              <a:gdLst>
                <a:gd name="textAreaLeft" fmla="*/ 0 w 74880"/>
                <a:gd name="textAreaRight" fmla="*/ 75240 w 74880"/>
                <a:gd name="textAreaTop" fmla="*/ 0 h 68040"/>
                <a:gd name="textAreaBottom" fmla="*/ 68400 h 68040"/>
              </a:gdLst>
              <a:ahLst/>
              <a:rect l="textAreaLeft" t="textAreaTop" r="textAreaRight" b="textAreaBottom"/>
              <a:pathLst>
                <a:path w="44" h="43">
                  <a:moveTo>
                    <a:pt x="22" y="43"/>
                  </a:moveTo>
                  <a:lnTo>
                    <a:pt x="18" y="43"/>
                  </a:lnTo>
                  <a:lnTo>
                    <a:pt x="0" y="22"/>
                  </a:lnTo>
                  <a:lnTo>
                    <a:pt x="0" y="22"/>
                  </a:lnTo>
                  <a:lnTo>
                    <a:pt x="18" y="0"/>
                  </a:lnTo>
                  <a:lnTo>
                    <a:pt x="22" y="0"/>
                  </a:lnTo>
                  <a:lnTo>
                    <a:pt x="44" y="22"/>
                  </a:lnTo>
                  <a:lnTo>
                    <a:pt x="44" y="22"/>
                  </a:lnTo>
                  <a:lnTo>
                    <a:pt x="22" y="43"/>
                  </a:lnTo>
                  <a:close/>
                  <a:moveTo>
                    <a:pt x="39" y="22"/>
                  </a:moveTo>
                  <a:lnTo>
                    <a:pt x="39" y="22"/>
                  </a:lnTo>
                  <a:lnTo>
                    <a:pt x="18" y="5"/>
                  </a:lnTo>
                  <a:lnTo>
                    <a:pt x="22" y="5"/>
                  </a:lnTo>
                  <a:lnTo>
                    <a:pt x="5" y="22"/>
                  </a:lnTo>
                  <a:lnTo>
                    <a:pt x="5" y="22"/>
                  </a:lnTo>
                  <a:lnTo>
                    <a:pt x="22" y="39"/>
                  </a:lnTo>
                  <a:lnTo>
                    <a:pt x="18" y="39"/>
                  </a:lnTo>
                  <a:lnTo>
                    <a:pt x="39" y="22"/>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42" name="Freeform 376"/>
            <p:cNvSpPr/>
            <p:nvPr/>
          </p:nvSpPr>
          <p:spPr>
            <a:xfrm>
              <a:off x="2289240" y="1899000"/>
              <a:ext cx="66240" cy="60120"/>
            </a:xfrm>
            <a:custGeom>
              <a:avLst/>
              <a:gdLst>
                <a:gd name="textAreaLeft" fmla="*/ 0 w 66240"/>
                <a:gd name="textAreaRight" fmla="*/ 66600 w 66240"/>
                <a:gd name="textAreaTop" fmla="*/ 0 h 60120"/>
                <a:gd name="textAreaBottom" fmla="*/ 60480 h 60120"/>
              </a:gdLst>
              <a:ahLst/>
              <a:rect l="textAreaLeft" t="textAreaTop" r="textAreaRight" b="textAreaBottom"/>
              <a:pathLst>
                <a:path w="39" h="38">
                  <a:moveTo>
                    <a:pt x="22" y="38"/>
                  </a:moveTo>
                  <a:lnTo>
                    <a:pt x="0" y="17"/>
                  </a:lnTo>
                  <a:lnTo>
                    <a:pt x="22" y="0"/>
                  </a:lnTo>
                  <a:lnTo>
                    <a:pt x="39" y="17"/>
                  </a:lnTo>
                  <a:lnTo>
                    <a:pt x="22" y="38"/>
                  </a:lnTo>
                  <a:close/>
                </a:path>
              </a:pathLst>
            </a:custGeom>
            <a:solidFill>
              <a:srgbClr val="4f81bd"/>
            </a:solidFill>
            <a:ln w="0">
              <a:no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243" name="Freeform 377"/>
            <p:cNvSpPr/>
            <p:nvPr/>
          </p:nvSpPr>
          <p:spPr>
            <a:xfrm>
              <a:off x="2289240" y="1891080"/>
              <a:ext cx="74880" cy="68040"/>
            </a:xfrm>
            <a:custGeom>
              <a:avLst/>
              <a:gdLst>
                <a:gd name="textAreaLeft" fmla="*/ 0 w 74880"/>
                <a:gd name="textAreaRight" fmla="*/ 75240 w 74880"/>
                <a:gd name="textAreaTop" fmla="*/ 0 h 68040"/>
                <a:gd name="textAreaBottom" fmla="*/ 68400 h 68040"/>
              </a:gdLst>
              <a:ahLst/>
              <a:rect l="textAreaLeft" t="textAreaTop" r="textAreaRight" b="textAreaBottom"/>
              <a:pathLst>
                <a:path w="44" h="43">
                  <a:moveTo>
                    <a:pt x="22" y="43"/>
                  </a:moveTo>
                  <a:lnTo>
                    <a:pt x="18" y="43"/>
                  </a:lnTo>
                  <a:lnTo>
                    <a:pt x="0" y="22"/>
                  </a:lnTo>
                  <a:lnTo>
                    <a:pt x="0" y="22"/>
                  </a:lnTo>
                  <a:lnTo>
                    <a:pt x="18" y="0"/>
                  </a:lnTo>
                  <a:lnTo>
                    <a:pt x="22" y="0"/>
                  </a:lnTo>
                  <a:lnTo>
                    <a:pt x="44" y="22"/>
                  </a:lnTo>
                  <a:lnTo>
                    <a:pt x="44" y="22"/>
                  </a:lnTo>
                  <a:lnTo>
                    <a:pt x="22" y="43"/>
                  </a:lnTo>
                  <a:close/>
                  <a:moveTo>
                    <a:pt x="39" y="22"/>
                  </a:moveTo>
                  <a:lnTo>
                    <a:pt x="39" y="22"/>
                  </a:lnTo>
                  <a:lnTo>
                    <a:pt x="18" y="5"/>
                  </a:lnTo>
                  <a:lnTo>
                    <a:pt x="22" y="5"/>
                  </a:lnTo>
                  <a:lnTo>
                    <a:pt x="5" y="22"/>
                  </a:lnTo>
                  <a:lnTo>
                    <a:pt x="5" y="22"/>
                  </a:lnTo>
                  <a:lnTo>
                    <a:pt x="22" y="39"/>
                  </a:lnTo>
                  <a:lnTo>
                    <a:pt x="18" y="39"/>
                  </a:lnTo>
                  <a:lnTo>
                    <a:pt x="39" y="22"/>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44" name="Freeform 378"/>
            <p:cNvSpPr/>
            <p:nvPr/>
          </p:nvSpPr>
          <p:spPr>
            <a:xfrm>
              <a:off x="2289240" y="1899000"/>
              <a:ext cx="66240" cy="60120"/>
            </a:xfrm>
            <a:custGeom>
              <a:avLst/>
              <a:gdLst>
                <a:gd name="textAreaLeft" fmla="*/ 0 w 66240"/>
                <a:gd name="textAreaRight" fmla="*/ 66600 w 66240"/>
                <a:gd name="textAreaTop" fmla="*/ 0 h 60120"/>
                <a:gd name="textAreaBottom" fmla="*/ 60480 h 60120"/>
              </a:gdLst>
              <a:ahLst/>
              <a:rect l="textAreaLeft" t="textAreaTop" r="textAreaRight" b="textAreaBottom"/>
              <a:pathLst>
                <a:path w="39" h="38">
                  <a:moveTo>
                    <a:pt x="22" y="38"/>
                  </a:moveTo>
                  <a:lnTo>
                    <a:pt x="0" y="17"/>
                  </a:lnTo>
                  <a:lnTo>
                    <a:pt x="22" y="0"/>
                  </a:lnTo>
                  <a:lnTo>
                    <a:pt x="39" y="17"/>
                  </a:lnTo>
                  <a:lnTo>
                    <a:pt x="22" y="38"/>
                  </a:lnTo>
                  <a:close/>
                </a:path>
              </a:pathLst>
            </a:custGeom>
            <a:solidFill>
              <a:srgbClr val="4f81bd"/>
            </a:solidFill>
            <a:ln w="0">
              <a:no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245" name="Freeform 379"/>
            <p:cNvSpPr/>
            <p:nvPr/>
          </p:nvSpPr>
          <p:spPr>
            <a:xfrm>
              <a:off x="2289240" y="1891080"/>
              <a:ext cx="74880" cy="68040"/>
            </a:xfrm>
            <a:custGeom>
              <a:avLst/>
              <a:gdLst>
                <a:gd name="textAreaLeft" fmla="*/ 0 w 74880"/>
                <a:gd name="textAreaRight" fmla="*/ 75240 w 74880"/>
                <a:gd name="textAreaTop" fmla="*/ 0 h 68040"/>
                <a:gd name="textAreaBottom" fmla="*/ 68400 h 68040"/>
              </a:gdLst>
              <a:ahLst/>
              <a:rect l="textAreaLeft" t="textAreaTop" r="textAreaRight" b="textAreaBottom"/>
              <a:pathLst>
                <a:path w="44" h="43">
                  <a:moveTo>
                    <a:pt x="22" y="43"/>
                  </a:moveTo>
                  <a:lnTo>
                    <a:pt x="18" y="43"/>
                  </a:lnTo>
                  <a:lnTo>
                    <a:pt x="0" y="22"/>
                  </a:lnTo>
                  <a:lnTo>
                    <a:pt x="0" y="22"/>
                  </a:lnTo>
                  <a:lnTo>
                    <a:pt x="18" y="0"/>
                  </a:lnTo>
                  <a:lnTo>
                    <a:pt x="22" y="0"/>
                  </a:lnTo>
                  <a:lnTo>
                    <a:pt x="44" y="22"/>
                  </a:lnTo>
                  <a:lnTo>
                    <a:pt x="44" y="22"/>
                  </a:lnTo>
                  <a:lnTo>
                    <a:pt x="22" y="43"/>
                  </a:lnTo>
                  <a:close/>
                  <a:moveTo>
                    <a:pt x="39" y="22"/>
                  </a:moveTo>
                  <a:lnTo>
                    <a:pt x="39" y="22"/>
                  </a:lnTo>
                  <a:lnTo>
                    <a:pt x="18" y="5"/>
                  </a:lnTo>
                  <a:lnTo>
                    <a:pt x="22" y="5"/>
                  </a:lnTo>
                  <a:lnTo>
                    <a:pt x="5" y="22"/>
                  </a:lnTo>
                  <a:lnTo>
                    <a:pt x="5" y="22"/>
                  </a:lnTo>
                  <a:lnTo>
                    <a:pt x="22" y="39"/>
                  </a:lnTo>
                  <a:lnTo>
                    <a:pt x="18" y="39"/>
                  </a:lnTo>
                  <a:lnTo>
                    <a:pt x="39" y="22"/>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46" name="Freeform 380"/>
            <p:cNvSpPr/>
            <p:nvPr/>
          </p:nvSpPr>
          <p:spPr>
            <a:xfrm>
              <a:off x="2289240" y="1899000"/>
              <a:ext cx="66240" cy="60120"/>
            </a:xfrm>
            <a:custGeom>
              <a:avLst/>
              <a:gdLst>
                <a:gd name="textAreaLeft" fmla="*/ 0 w 66240"/>
                <a:gd name="textAreaRight" fmla="*/ 66600 w 66240"/>
                <a:gd name="textAreaTop" fmla="*/ 0 h 60120"/>
                <a:gd name="textAreaBottom" fmla="*/ 60480 h 60120"/>
              </a:gdLst>
              <a:ahLst/>
              <a:rect l="textAreaLeft" t="textAreaTop" r="textAreaRight" b="textAreaBottom"/>
              <a:pathLst>
                <a:path w="39" h="38">
                  <a:moveTo>
                    <a:pt x="22" y="38"/>
                  </a:moveTo>
                  <a:lnTo>
                    <a:pt x="0" y="17"/>
                  </a:lnTo>
                  <a:lnTo>
                    <a:pt x="22" y="0"/>
                  </a:lnTo>
                  <a:lnTo>
                    <a:pt x="39" y="17"/>
                  </a:lnTo>
                  <a:lnTo>
                    <a:pt x="22" y="38"/>
                  </a:lnTo>
                  <a:close/>
                </a:path>
              </a:pathLst>
            </a:custGeom>
            <a:solidFill>
              <a:srgbClr val="4f81bd"/>
            </a:solidFill>
            <a:ln w="0">
              <a:no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247" name="Freeform 381"/>
            <p:cNvSpPr/>
            <p:nvPr/>
          </p:nvSpPr>
          <p:spPr>
            <a:xfrm>
              <a:off x="2289240" y="1891080"/>
              <a:ext cx="74880" cy="68040"/>
            </a:xfrm>
            <a:custGeom>
              <a:avLst/>
              <a:gdLst>
                <a:gd name="textAreaLeft" fmla="*/ 0 w 74880"/>
                <a:gd name="textAreaRight" fmla="*/ 75240 w 74880"/>
                <a:gd name="textAreaTop" fmla="*/ 0 h 68040"/>
                <a:gd name="textAreaBottom" fmla="*/ 68400 h 68040"/>
              </a:gdLst>
              <a:ahLst/>
              <a:rect l="textAreaLeft" t="textAreaTop" r="textAreaRight" b="textAreaBottom"/>
              <a:pathLst>
                <a:path w="44" h="43">
                  <a:moveTo>
                    <a:pt x="22" y="43"/>
                  </a:moveTo>
                  <a:lnTo>
                    <a:pt x="18" y="43"/>
                  </a:lnTo>
                  <a:lnTo>
                    <a:pt x="0" y="22"/>
                  </a:lnTo>
                  <a:lnTo>
                    <a:pt x="0" y="22"/>
                  </a:lnTo>
                  <a:lnTo>
                    <a:pt x="18" y="0"/>
                  </a:lnTo>
                  <a:lnTo>
                    <a:pt x="22" y="0"/>
                  </a:lnTo>
                  <a:lnTo>
                    <a:pt x="44" y="22"/>
                  </a:lnTo>
                  <a:lnTo>
                    <a:pt x="44" y="22"/>
                  </a:lnTo>
                  <a:lnTo>
                    <a:pt x="22" y="43"/>
                  </a:lnTo>
                  <a:close/>
                  <a:moveTo>
                    <a:pt x="39" y="22"/>
                  </a:moveTo>
                  <a:lnTo>
                    <a:pt x="39" y="22"/>
                  </a:lnTo>
                  <a:lnTo>
                    <a:pt x="18" y="5"/>
                  </a:lnTo>
                  <a:lnTo>
                    <a:pt x="22" y="5"/>
                  </a:lnTo>
                  <a:lnTo>
                    <a:pt x="5" y="22"/>
                  </a:lnTo>
                  <a:lnTo>
                    <a:pt x="5" y="22"/>
                  </a:lnTo>
                  <a:lnTo>
                    <a:pt x="22" y="39"/>
                  </a:lnTo>
                  <a:lnTo>
                    <a:pt x="18" y="39"/>
                  </a:lnTo>
                  <a:lnTo>
                    <a:pt x="39" y="22"/>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48" name="Freeform 382"/>
            <p:cNvSpPr/>
            <p:nvPr/>
          </p:nvSpPr>
          <p:spPr>
            <a:xfrm>
              <a:off x="2753640" y="1760760"/>
              <a:ext cx="64440" cy="61920"/>
            </a:xfrm>
            <a:custGeom>
              <a:avLst/>
              <a:gdLst>
                <a:gd name="textAreaLeft" fmla="*/ 0 w 64440"/>
                <a:gd name="textAreaRight" fmla="*/ 64800 w 64440"/>
                <a:gd name="textAreaTop" fmla="*/ 0 h 61920"/>
                <a:gd name="textAreaBottom" fmla="*/ 62280 h 61920"/>
              </a:gdLst>
              <a:ahLst/>
              <a:rect l="textAreaLeft" t="textAreaTop" r="textAreaRight" b="textAreaBottom"/>
              <a:pathLst>
                <a:path w="38" h="39">
                  <a:moveTo>
                    <a:pt x="21" y="39"/>
                  </a:moveTo>
                  <a:lnTo>
                    <a:pt x="0" y="18"/>
                  </a:lnTo>
                  <a:lnTo>
                    <a:pt x="21" y="0"/>
                  </a:lnTo>
                  <a:lnTo>
                    <a:pt x="38" y="18"/>
                  </a:lnTo>
                  <a:lnTo>
                    <a:pt x="21" y="39"/>
                  </a:lnTo>
                  <a:close/>
                </a:path>
              </a:pathLst>
            </a:custGeom>
            <a:solidFill>
              <a:srgbClr val="4f81bd"/>
            </a:solidFill>
            <a:ln w="0">
              <a:no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249" name="Freeform 383"/>
            <p:cNvSpPr/>
            <p:nvPr/>
          </p:nvSpPr>
          <p:spPr>
            <a:xfrm>
              <a:off x="2753640" y="1760760"/>
              <a:ext cx="64440" cy="61920"/>
            </a:xfrm>
            <a:custGeom>
              <a:avLst/>
              <a:gdLst>
                <a:gd name="textAreaLeft" fmla="*/ 0 w 64440"/>
                <a:gd name="textAreaRight" fmla="*/ 64800 w 64440"/>
                <a:gd name="textAreaTop" fmla="*/ 0 h 61920"/>
                <a:gd name="textAreaBottom" fmla="*/ 62280 h 61920"/>
              </a:gdLst>
              <a:ahLst/>
              <a:rect l="textAreaLeft" t="textAreaTop" r="textAreaRight" b="textAreaBottom"/>
              <a:pathLst>
                <a:path w="38" h="39">
                  <a:moveTo>
                    <a:pt x="21" y="39"/>
                  </a:moveTo>
                  <a:lnTo>
                    <a:pt x="17" y="39"/>
                  </a:lnTo>
                  <a:lnTo>
                    <a:pt x="0" y="22"/>
                  </a:lnTo>
                  <a:lnTo>
                    <a:pt x="0" y="18"/>
                  </a:lnTo>
                  <a:lnTo>
                    <a:pt x="17" y="0"/>
                  </a:lnTo>
                  <a:lnTo>
                    <a:pt x="21" y="0"/>
                  </a:lnTo>
                  <a:lnTo>
                    <a:pt x="38" y="18"/>
                  </a:lnTo>
                  <a:lnTo>
                    <a:pt x="38" y="22"/>
                  </a:lnTo>
                  <a:lnTo>
                    <a:pt x="21" y="39"/>
                  </a:lnTo>
                  <a:close/>
                  <a:moveTo>
                    <a:pt x="38" y="18"/>
                  </a:moveTo>
                  <a:lnTo>
                    <a:pt x="38" y="22"/>
                  </a:lnTo>
                  <a:lnTo>
                    <a:pt x="17" y="0"/>
                  </a:lnTo>
                  <a:lnTo>
                    <a:pt x="21" y="0"/>
                  </a:lnTo>
                  <a:lnTo>
                    <a:pt x="0" y="22"/>
                  </a:lnTo>
                  <a:lnTo>
                    <a:pt x="0" y="18"/>
                  </a:lnTo>
                  <a:lnTo>
                    <a:pt x="21" y="39"/>
                  </a:lnTo>
                  <a:lnTo>
                    <a:pt x="17" y="39"/>
                  </a:lnTo>
                  <a:lnTo>
                    <a:pt x="38" y="18"/>
                  </a:lnTo>
                  <a:close/>
                </a:path>
              </a:pathLst>
            </a:custGeom>
            <a:solidFill>
              <a:srgbClr val="4a7ebb"/>
            </a:solidFill>
            <a:ln w="0">
              <a:solidFill>
                <a:srgbClr val="4a7ebb"/>
              </a:solid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250" name="Freeform 384"/>
            <p:cNvSpPr/>
            <p:nvPr/>
          </p:nvSpPr>
          <p:spPr>
            <a:xfrm>
              <a:off x="2466000" y="1857600"/>
              <a:ext cx="66240" cy="61920"/>
            </a:xfrm>
            <a:custGeom>
              <a:avLst/>
              <a:gdLst>
                <a:gd name="textAreaLeft" fmla="*/ 0 w 66240"/>
                <a:gd name="textAreaRight" fmla="*/ 66600 w 66240"/>
                <a:gd name="textAreaTop" fmla="*/ 0 h 61920"/>
                <a:gd name="textAreaBottom" fmla="*/ 62280 h 61920"/>
              </a:gdLst>
              <a:ahLst/>
              <a:rect l="textAreaLeft" t="textAreaTop" r="textAreaRight" b="textAreaBottom"/>
              <a:pathLst>
                <a:path w="39" h="39">
                  <a:moveTo>
                    <a:pt x="22" y="39"/>
                  </a:moveTo>
                  <a:lnTo>
                    <a:pt x="0" y="21"/>
                  </a:lnTo>
                  <a:lnTo>
                    <a:pt x="22" y="0"/>
                  </a:lnTo>
                  <a:lnTo>
                    <a:pt x="39" y="21"/>
                  </a:lnTo>
                  <a:lnTo>
                    <a:pt x="22" y="39"/>
                  </a:lnTo>
                  <a:close/>
                </a:path>
              </a:pathLst>
            </a:custGeom>
            <a:solidFill>
              <a:srgbClr val="4f81bd"/>
            </a:solidFill>
            <a:ln w="0">
              <a:no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251" name="Freeform 385"/>
            <p:cNvSpPr/>
            <p:nvPr/>
          </p:nvSpPr>
          <p:spPr>
            <a:xfrm>
              <a:off x="2466000" y="1857600"/>
              <a:ext cx="73080" cy="68040"/>
            </a:xfrm>
            <a:custGeom>
              <a:avLst/>
              <a:gdLst>
                <a:gd name="textAreaLeft" fmla="*/ 0 w 73080"/>
                <a:gd name="textAreaRight" fmla="*/ 73440 w 73080"/>
                <a:gd name="textAreaTop" fmla="*/ 0 h 68040"/>
                <a:gd name="textAreaBottom" fmla="*/ 68400 h 68040"/>
              </a:gdLst>
              <a:ahLst/>
              <a:rect l="textAreaLeft" t="textAreaTop" r="textAreaRight" b="textAreaBottom"/>
              <a:pathLst>
                <a:path w="43" h="43">
                  <a:moveTo>
                    <a:pt x="22" y="43"/>
                  </a:moveTo>
                  <a:lnTo>
                    <a:pt x="17" y="43"/>
                  </a:lnTo>
                  <a:lnTo>
                    <a:pt x="0" y="21"/>
                  </a:lnTo>
                  <a:lnTo>
                    <a:pt x="0" y="17"/>
                  </a:lnTo>
                  <a:lnTo>
                    <a:pt x="17" y="0"/>
                  </a:lnTo>
                  <a:lnTo>
                    <a:pt x="22" y="0"/>
                  </a:lnTo>
                  <a:lnTo>
                    <a:pt x="43" y="17"/>
                  </a:lnTo>
                  <a:lnTo>
                    <a:pt x="43" y="21"/>
                  </a:lnTo>
                  <a:lnTo>
                    <a:pt x="22" y="43"/>
                  </a:lnTo>
                  <a:close/>
                  <a:moveTo>
                    <a:pt x="39" y="17"/>
                  </a:moveTo>
                  <a:lnTo>
                    <a:pt x="39" y="21"/>
                  </a:lnTo>
                  <a:lnTo>
                    <a:pt x="17" y="4"/>
                  </a:lnTo>
                  <a:lnTo>
                    <a:pt x="22" y="4"/>
                  </a:lnTo>
                  <a:lnTo>
                    <a:pt x="4" y="21"/>
                  </a:lnTo>
                  <a:lnTo>
                    <a:pt x="4" y="17"/>
                  </a:lnTo>
                  <a:lnTo>
                    <a:pt x="22" y="39"/>
                  </a:lnTo>
                  <a:lnTo>
                    <a:pt x="17" y="39"/>
                  </a:lnTo>
                  <a:lnTo>
                    <a:pt x="39" y="17"/>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52" name="Freeform 386"/>
            <p:cNvSpPr/>
            <p:nvPr/>
          </p:nvSpPr>
          <p:spPr>
            <a:xfrm>
              <a:off x="2341800" y="1857600"/>
              <a:ext cx="66240" cy="61920"/>
            </a:xfrm>
            <a:custGeom>
              <a:avLst/>
              <a:gdLst>
                <a:gd name="textAreaLeft" fmla="*/ 0 w 66240"/>
                <a:gd name="textAreaRight" fmla="*/ 66600 w 66240"/>
                <a:gd name="textAreaTop" fmla="*/ 0 h 61920"/>
                <a:gd name="textAreaBottom" fmla="*/ 62280 h 61920"/>
              </a:gdLst>
              <a:ahLst/>
              <a:rect l="textAreaLeft" t="textAreaTop" r="textAreaRight" b="textAreaBottom"/>
              <a:pathLst>
                <a:path w="39" h="39">
                  <a:moveTo>
                    <a:pt x="17" y="39"/>
                  </a:moveTo>
                  <a:lnTo>
                    <a:pt x="0" y="21"/>
                  </a:lnTo>
                  <a:lnTo>
                    <a:pt x="17" y="0"/>
                  </a:lnTo>
                  <a:lnTo>
                    <a:pt x="39" y="21"/>
                  </a:lnTo>
                  <a:lnTo>
                    <a:pt x="17" y="39"/>
                  </a:lnTo>
                  <a:close/>
                </a:path>
              </a:pathLst>
            </a:custGeom>
            <a:solidFill>
              <a:srgbClr val="4f81bd"/>
            </a:solidFill>
            <a:ln w="0">
              <a:no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253" name="Freeform 387"/>
            <p:cNvSpPr/>
            <p:nvPr/>
          </p:nvSpPr>
          <p:spPr>
            <a:xfrm>
              <a:off x="2341800" y="1857600"/>
              <a:ext cx="66240" cy="68040"/>
            </a:xfrm>
            <a:custGeom>
              <a:avLst/>
              <a:gdLst>
                <a:gd name="textAreaLeft" fmla="*/ 0 w 66240"/>
                <a:gd name="textAreaRight" fmla="*/ 66600 w 66240"/>
                <a:gd name="textAreaTop" fmla="*/ 0 h 68040"/>
                <a:gd name="textAreaBottom" fmla="*/ 68400 h 68040"/>
              </a:gdLst>
              <a:ahLst/>
              <a:rect l="textAreaLeft" t="textAreaTop" r="textAreaRight" b="textAreaBottom"/>
              <a:pathLst>
                <a:path w="39" h="43">
                  <a:moveTo>
                    <a:pt x="21" y="43"/>
                  </a:moveTo>
                  <a:lnTo>
                    <a:pt x="17" y="43"/>
                  </a:lnTo>
                  <a:lnTo>
                    <a:pt x="0" y="21"/>
                  </a:lnTo>
                  <a:lnTo>
                    <a:pt x="0" y="17"/>
                  </a:lnTo>
                  <a:lnTo>
                    <a:pt x="17" y="0"/>
                  </a:lnTo>
                  <a:lnTo>
                    <a:pt x="21" y="0"/>
                  </a:lnTo>
                  <a:lnTo>
                    <a:pt x="39" y="17"/>
                  </a:lnTo>
                  <a:lnTo>
                    <a:pt x="39" y="21"/>
                  </a:lnTo>
                  <a:lnTo>
                    <a:pt x="21" y="43"/>
                  </a:lnTo>
                  <a:close/>
                  <a:moveTo>
                    <a:pt x="39" y="17"/>
                  </a:moveTo>
                  <a:lnTo>
                    <a:pt x="39" y="21"/>
                  </a:lnTo>
                  <a:lnTo>
                    <a:pt x="17" y="4"/>
                  </a:lnTo>
                  <a:lnTo>
                    <a:pt x="21" y="4"/>
                  </a:lnTo>
                  <a:lnTo>
                    <a:pt x="0" y="21"/>
                  </a:lnTo>
                  <a:lnTo>
                    <a:pt x="0" y="17"/>
                  </a:lnTo>
                  <a:lnTo>
                    <a:pt x="21" y="39"/>
                  </a:lnTo>
                  <a:lnTo>
                    <a:pt x="17" y="39"/>
                  </a:lnTo>
                  <a:lnTo>
                    <a:pt x="39" y="17"/>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54" name="Freeform 388"/>
            <p:cNvSpPr/>
            <p:nvPr/>
          </p:nvSpPr>
          <p:spPr>
            <a:xfrm>
              <a:off x="2370600" y="1829160"/>
              <a:ext cx="66240" cy="61920"/>
            </a:xfrm>
            <a:custGeom>
              <a:avLst/>
              <a:gdLst>
                <a:gd name="textAreaLeft" fmla="*/ 0 w 66240"/>
                <a:gd name="textAreaRight" fmla="*/ 66600 w 66240"/>
                <a:gd name="textAreaTop" fmla="*/ 0 h 61920"/>
                <a:gd name="textAreaBottom" fmla="*/ 62280 h 61920"/>
              </a:gdLst>
              <a:ahLst/>
              <a:rect l="textAreaLeft" t="textAreaTop" r="textAreaRight" b="textAreaBottom"/>
              <a:pathLst>
                <a:path w="39" h="39">
                  <a:moveTo>
                    <a:pt x="17" y="39"/>
                  </a:moveTo>
                  <a:lnTo>
                    <a:pt x="0" y="22"/>
                  </a:lnTo>
                  <a:lnTo>
                    <a:pt x="17" y="0"/>
                  </a:lnTo>
                  <a:lnTo>
                    <a:pt x="39" y="22"/>
                  </a:lnTo>
                  <a:lnTo>
                    <a:pt x="17" y="39"/>
                  </a:lnTo>
                  <a:close/>
                </a:path>
              </a:pathLst>
            </a:custGeom>
            <a:solidFill>
              <a:srgbClr val="4f81bd"/>
            </a:solidFill>
            <a:ln w="0">
              <a:no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255" name="Freeform 389"/>
            <p:cNvSpPr/>
            <p:nvPr/>
          </p:nvSpPr>
          <p:spPr>
            <a:xfrm>
              <a:off x="2364120" y="1829160"/>
              <a:ext cx="73080" cy="69840"/>
            </a:xfrm>
            <a:custGeom>
              <a:avLst/>
              <a:gdLst>
                <a:gd name="textAreaLeft" fmla="*/ 0 w 73080"/>
                <a:gd name="textAreaRight" fmla="*/ 73440 w 73080"/>
                <a:gd name="textAreaTop" fmla="*/ 0 h 69840"/>
                <a:gd name="textAreaBottom" fmla="*/ 70200 h 69840"/>
              </a:gdLst>
              <a:ahLst/>
              <a:rect l="textAreaLeft" t="textAreaTop" r="textAreaRight" b="textAreaBottom"/>
              <a:pathLst>
                <a:path w="43" h="44">
                  <a:moveTo>
                    <a:pt x="26" y="44"/>
                  </a:moveTo>
                  <a:lnTo>
                    <a:pt x="21" y="44"/>
                  </a:lnTo>
                  <a:lnTo>
                    <a:pt x="0" y="22"/>
                  </a:lnTo>
                  <a:lnTo>
                    <a:pt x="0" y="22"/>
                  </a:lnTo>
                  <a:lnTo>
                    <a:pt x="21" y="0"/>
                  </a:lnTo>
                  <a:lnTo>
                    <a:pt x="26" y="0"/>
                  </a:lnTo>
                  <a:lnTo>
                    <a:pt x="43" y="22"/>
                  </a:lnTo>
                  <a:lnTo>
                    <a:pt x="43" y="22"/>
                  </a:lnTo>
                  <a:lnTo>
                    <a:pt x="26" y="44"/>
                  </a:lnTo>
                  <a:close/>
                  <a:moveTo>
                    <a:pt x="39" y="22"/>
                  </a:moveTo>
                  <a:lnTo>
                    <a:pt x="39" y="22"/>
                  </a:lnTo>
                  <a:lnTo>
                    <a:pt x="21" y="5"/>
                  </a:lnTo>
                  <a:lnTo>
                    <a:pt x="26" y="5"/>
                  </a:lnTo>
                  <a:lnTo>
                    <a:pt x="4" y="22"/>
                  </a:lnTo>
                  <a:lnTo>
                    <a:pt x="4" y="22"/>
                  </a:lnTo>
                  <a:lnTo>
                    <a:pt x="26" y="39"/>
                  </a:lnTo>
                  <a:lnTo>
                    <a:pt x="21" y="39"/>
                  </a:lnTo>
                  <a:lnTo>
                    <a:pt x="39" y="22"/>
                  </a:lnTo>
                  <a:close/>
                </a:path>
              </a:pathLst>
            </a:custGeom>
            <a:solidFill>
              <a:srgbClr val="4a7ebb"/>
            </a:solidFill>
            <a:ln w="0">
              <a:solidFill>
                <a:srgbClr val="4a7ebb"/>
              </a:solidFill>
            </a:ln>
          </p:spPr>
          <p:style>
            <a:lnRef idx="0"/>
            <a:fillRef idx="0"/>
            <a:effectRef idx="0"/>
            <a:fontRef idx="minor"/>
          </p:style>
          <p:txBody>
            <a:bodyPr tIns="24480" bIns="24480" anchor="t">
              <a:noAutofit/>
            </a:bodyPr>
            <a:p>
              <a:endParaRPr b="0" lang="en-US" sz="1800" spc="-1" strike="noStrike">
                <a:solidFill>
                  <a:srgbClr val="000000"/>
                </a:solidFill>
                <a:latin typeface="Calibri"/>
              </a:endParaRPr>
            </a:p>
          </p:txBody>
        </p:sp>
        <p:sp>
          <p:nvSpPr>
            <p:cNvPr id="256" name="Freeform 390"/>
            <p:cNvSpPr/>
            <p:nvPr/>
          </p:nvSpPr>
          <p:spPr>
            <a:xfrm>
              <a:off x="2620800" y="1808280"/>
              <a:ext cx="66240" cy="61920"/>
            </a:xfrm>
            <a:custGeom>
              <a:avLst/>
              <a:gdLst>
                <a:gd name="textAreaLeft" fmla="*/ 0 w 66240"/>
                <a:gd name="textAreaRight" fmla="*/ 66600 w 66240"/>
                <a:gd name="textAreaTop" fmla="*/ 0 h 61920"/>
                <a:gd name="textAreaBottom" fmla="*/ 62280 h 61920"/>
              </a:gdLst>
              <a:ahLst/>
              <a:rect l="textAreaLeft" t="textAreaTop" r="textAreaRight" b="textAreaBottom"/>
              <a:pathLst>
                <a:path w="39" h="39">
                  <a:moveTo>
                    <a:pt x="17" y="39"/>
                  </a:moveTo>
                  <a:lnTo>
                    <a:pt x="0" y="18"/>
                  </a:lnTo>
                  <a:lnTo>
                    <a:pt x="17" y="0"/>
                  </a:lnTo>
                  <a:lnTo>
                    <a:pt x="39" y="18"/>
                  </a:lnTo>
                  <a:lnTo>
                    <a:pt x="17" y="39"/>
                  </a:lnTo>
                  <a:close/>
                </a:path>
              </a:pathLst>
            </a:custGeom>
            <a:solidFill>
              <a:srgbClr val="4f81bd"/>
            </a:solidFill>
            <a:ln w="0">
              <a:no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257" name="Freeform 391"/>
            <p:cNvSpPr/>
            <p:nvPr/>
          </p:nvSpPr>
          <p:spPr>
            <a:xfrm>
              <a:off x="2614320" y="1802160"/>
              <a:ext cx="73080" cy="68040"/>
            </a:xfrm>
            <a:custGeom>
              <a:avLst/>
              <a:gdLst>
                <a:gd name="textAreaLeft" fmla="*/ 0 w 73080"/>
                <a:gd name="textAreaRight" fmla="*/ 73440 w 73080"/>
                <a:gd name="textAreaTop" fmla="*/ 0 h 68040"/>
                <a:gd name="textAreaBottom" fmla="*/ 68400 h 68040"/>
              </a:gdLst>
              <a:ahLst/>
              <a:rect l="textAreaLeft" t="textAreaTop" r="textAreaRight" b="textAreaBottom"/>
              <a:pathLst>
                <a:path w="43" h="43">
                  <a:moveTo>
                    <a:pt x="25" y="43"/>
                  </a:moveTo>
                  <a:lnTo>
                    <a:pt x="21" y="43"/>
                  </a:lnTo>
                  <a:lnTo>
                    <a:pt x="0" y="22"/>
                  </a:lnTo>
                  <a:lnTo>
                    <a:pt x="0" y="22"/>
                  </a:lnTo>
                  <a:lnTo>
                    <a:pt x="21" y="0"/>
                  </a:lnTo>
                  <a:lnTo>
                    <a:pt x="25" y="0"/>
                  </a:lnTo>
                  <a:lnTo>
                    <a:pt x="43" y="22"/>
                  </a:lnTo>
                  <a:lnTo>
                    <a:pt x="43" y="22"/>
                  </a:lnTo>
                  <a:lnTo>
                    <a:pt x="25" y="43"/>
                  </a:lnTo>
                  <a:close/>
                  <a:moveTo>
                    <a:pt x="38" y="22"/>
                  </a:moveTo>
                  <a:lnTo>
                    <a:pt x="38" y="22"/>
                  </a:lnTo>
                  <a:lnTo>
                    <a:pt x="21" y="4"/>
                  </a:lnTo>
                  <a:lnTo>
                    <a:pt x="25" y="4"/>
                  </a:lnTo>
                  <a:lnTo>
                    <a:pt x="4" y="22"/>
                  </a:lnTo>
                  <a:lnTo>
                    <a:pt x="4" y="22"/>
                  </a:lnTo>
                  <a:lnTo>
                    <a:pt x="25" y="39"/>
                  </a:lnTo>
                  <a:lnTo>
                    <a:pt x="21" y="39"/>
                  </a:lnTo>
                  <a:lnTo>
                    <a:pt x="38" y="22"/>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58" name="Freeform 392"/>
            <p:cNvSpPr/>
            <p:nvPr/>
          </p:nvSpPr>
          <p:spPr>
            <a:xfrm>
              <a:off x="2444040" y="1849680"/>
              <a:ext cx="66240" cy="61920"/>
            </a:xfrm>
            <a:custGeom>
              <a:avLst/>
              <a:gdLst>
                <a:gd name="textAreaLeft" fmla="*/ 0 w 66240"/>
                <a:gd name="textAreaRight" fmla="*/ 66600 w 66240"/>
                <a:gd name="textAreaTop" fmla="*/ 0 h 61920"/>
                <a:gd name="textAreaBottom" fmla="*/ 62280 h 61920"/>
              </a:gdLst>
              <a:ahLst/>
              <a:rect l="textAreaLeft" t="textAreaTop" r="textAreaRight" b="textAreaBottom"/>
              <a:pathLst>
                <a:path w="39" h="39">
                  <a:moveTo>
                    <a:pt x="22" y="39"/>
                  </a:moveTo>
                  <a:lnTo>
                    <a:pt x="0" y="22"/>
                  </a:lnTo>
                  <a:lnTo>
                    <a:pt x="22" y="0"/>
                  </a:lnTo>
                  <a:lnTo>
                    <a:pt x="39" y="22"/>
                  </a:lnTo>
                  <a:lnTo>
                    <a:pt x="22" y="39"/>
                  </a:lnTo>
                  <a:close/>
                </a:path>
              </a:pathLst>
            </a:custGeom>
            <a:solidFill>
              <a:srgbClr val="4f81bd"/>
            </a:solidFill>
            <a:ln w="0">
              <a:no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259" name="Freeform 393"/>
            <p:cNvSpPr/>
            <p:nvPr/>
          </p:nvSpPr>
          <p:spPr>
            <a:xfrm>
              <a:off x="2444040" y="1849680"/>
              <a:ext cx="73080" cy="69840"/>
            </a:xfrm>
            <a:custGeom>
              <a:avLst/>
              <a:gdLst>
                <a:gd name="textAreaLeft" fmla="*/ 0 w 73080"/>
                <a:gd name="textAreaRight" fmla="*/ 73440 w 73080"/>
                <a:gd name="textAreaTop" fmla="*/ 0 h 69840"/>
                <a:gd name="textAreaBottom" fmla="*/ 70200 h 69840"/>
              </a:gdLst>
              <a:ahLst/>
              <a:rect l="textAreaLeft" t="textAreaTop" r="textAreaRight" b="textAreaBottom"/>
              <a:pathLst>
                <a:path w="43" h="44">
                  <a:moveTo>
                    <a:pt x="22" y="44"/>
                  </a:moveTo>
                  <a:lnTo>
                    <a:pt x="17" y="44"/>
                  </a:lnTo>
                  <a:lnTo>
                    <a:pt x="0" y="22"/>
                  </a:lnTo>
                  <a:lnTo>
                    <a:pt x="0" y="18"/>
                  </a:lnTo>
                  <a:lnTo>
                    <a:pt x="17" y="0"/>
                  </a:lnTo>
                  <a:lnTo>
                    <a:pt x="22" y="0"/>
                  </a:lnTo>
                  <a:lnTo>
                    <a:pt x="43" y="18"/>
                  </a:lnTo>
                  <a:lnTo>
                    <a:pt x="43" y="22"/>
                  </a:lnTo>
                  <a:lnTo>
                    <a:pt x="22" y="44"/>
                  </a:lnTo>
                  <a:close/>
                  <a:moveTo>
                    <a:pt x="39" y="18"/>
                  </a:moveTo>
                  <a:lnTo>
                    <a:pt x="39" y="22"/>
                  </a:lnTo>
                  <a:lnTo>
                    <a:pt x="17" y="5"/>
                  </a:lnTo>
                  <a:lnTo>
                    <a:pt x="22" y="5"/>
                  </a:lnTo>
                  <a:lnTo>
                    <a:pt x="4" y="22"/>
                  </a:lnTo>
                  <a:lnTo>
                    <a:pt x="4" y="18"/>
                  </a:lnTo>
                  <a:lnTo>
                    <a:pt x="22" y="39"/>
                  </a:lnTo>
                  <a:lnTo>
                    <a:pt x="17" y="39"/>
                  </a:lnTo>
                  <a:lnTo>
                    <a:pt x="39" y="18"/>
                  </a:lnTo>
                  <a:close/>
                </a:path>
              </a:pathLst>
            </a:custGeom>
            <a:solidFill>
              <a:srgbClr val="4a7ebb"/>
            </a:solidFill>
            <a:ln w="0">
              <a:solidFill>
                <a:srgbClr val="4a7ebb"/>
              </a:solidFill>
            </a:ln>
          </p:spPr>
          <p:style>
            <a:lnRef idx="0"/>
            <a:fillRef idx="0"/>
            <a:effectRef idx="0"/>
            <a:fontRef idx="minor"/>
          </p:style>
          <p:txBody>
            <a:bodyPr tIns="24480" bIns="24480" anchor="t">
              <a:noAutofit/>
            </a:bodyPr>
            <a:p>
              <a:endParaRPr b="0" lang="en-US" sz="1800" spc="-1" strike="noStrike">
                <a:solidFill>
                  <a:srgbClr val="000000"/>
                </a:solidFill>
                <a:latin typeface="Calibri"/>
              </a:endParaRPr>
            </a:p>
          </p:txBody>
        </p:sp>
        <p:sp>
          <p:nvSpPr>
            <p:cNvPr id="260" name="Freeform 394"/>
            <p:cNvSpPr/>
            <p:nvPr/>
          </p:nvSpPr>
          <p:spPr>
            <a:xfrm>
              <a:off x="4481280" y="1054080"/>
              <a:ext cx="66240" cy="61920"/>
            </a:xfrm>
            <a:custGeom>
              <a:avLst/>
              <a:gdLst>
                <a:gd name="textAreaLeft" fmla="*/ 0 w 66240"/>
                <a:gd name="textAreaRight" fmla="*/ 66600 w 66240"/>
                <a:gd name="textAreaTop" fmla="*/ 0 h 61920"/>
                <a:gd name="textAreaBottom" fmla="*/ 62280 h 61920"/>
              </a:gdLst>
              <a:ahLst/>
              <a:rect l="textAreaLeft" t="textAreaTop" r="textAreaRight" b="textAreaBottom"/>
              <a:pathLst>
                <a:path w="39" h="39">
                  <a:moveTo>
                    <a:pt x="21" y="39"/>
                  </a:moveTo>
                  <a:lnTo>
                    <a:pt x="0" y="22"/>
                  </a:lnTo>
                  <a:lnTo>
                    <a:pt x="21" y="0"/>
                  </a:lnTo>
                  <a:lnTo>
                    <a:pt x="39" y="22"/>
                  </a:lnTo>
                  <a:lnTo>
                    <a:pt x="21" y="39"/>
                  </a:lnTo>
                  <a:close/>
                </a:path>
              </a:pathLst>
            </a:custGeom>
            <a:solidFill>
              <a:srgbClr val="4f81bd"/>
            </a:solidFill>
            <a:ln w="0">
              <a:no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261" name="Freeform 395"/>
            <p:cNvSpPr/>
            <p:nvPr/>
          </p:nvSpPr>
          <p:spPr>
            <a:xfrm>
              <a:off x="4481280" y="1054080"/>
              <a:ext cx="73080" cy="69840"/>
            </a:xfrm>
            <a:custGeom>
              <a:avLst/>
              <a:gdLst>
                <a:gd name="textAreaLeft" fmla="*/ 0 w 73080"/>
                <a:gd name="textAreaRight" fmla="*/ 73440 w 73080"/>
                <a:gd name="textAreaTop" fmla="*/ 0 h 69840"/>
                <a:gd name="textAreaBottom" fmla="*/ 70200 h 69840"/>
              </a:gdLst>
              <a:ahLst/>
              <a:rect l="textAreaLeft" t="textAreaTop" r="textAreaRight" b="textAreaBottom"/>
              <a:pathLst>
                <a:path w="43" h="44">
                  <a:moveTo>
                    <a:pt x="21" y="44"/>
                  </a:moveTo>
                  <a:lnTo>
                    <a:pt x="17" y="44"/>
                  </a:lnTo>
                  <a:lnTo>
                    <a:pt x="0" y="22"/>
                  </a:lnTo>
                  <a:lnTo>
                    <a:pt x="0" y="18"/>
                  </a:lnTo>
                  <a:lnTo>
                    <a:pt x="17" y="0"/>
                  </a:lnTo>
                  <a:lnTo>
                    <a:pt x="21" y="0"/>
                  </a:lnTo>
                  <a:lnTo>
                    <a:pt x="43" y="18"/>
                  </a:lnTo>
                  <a:lnTo>
                    <a:pt x="43" y="22"/>
                  </a:lnTo>
                  <a:lnTo>
                    <a:pt x="21" y="44"/>
                  </a:lnTo>
                  <a:close/>
                  <a:moveTo>
                    <a:pt x="39" y="18"/>
                  </a:moveTo>
                  <a:lnTo>
                    <a:pt x="39" y="22"/>
                  </a:lnTo>
                  <a:lnTo>
                    <a:pt x="17" y="5"/>
                  </a:lnTo>
                  <a:lnTo>
                    <a:pt x="21" y="5"/>
                  </a:lnTo>
                  <a:lnTo>
                    <a:pt x="4" y="22"/>
                  </a:lnTo>
                  <a:lnTo>
                    <a:pt x="4" y="18"/>
                  </a:lnTo>
                  <a:lnTo>
                    <a:pt x="21" y="39"/>
                  </a:lnTo>
                  <a:lnTo>
                    <a:pt x="17" y="39"/>
                  </a:lnTo>
                  <a:lnTo>
                    <a:pt x="39" y="18"/>
                  </a:lnTo>
                  <a:close/>
                </a:path>
              </a:pathLst>
            </a:custGeom>
            <a:solidFill>
              <a:srgbClr val="4a7ebb"/>
            </a:solidFill>
            <a:ln w="0">
              <a:solidFill>
                <a:srgbClr val="4a7ebb"/>
              </a:solidFill>
            </a:ln>
          </p:spPr>
          <p:style>
            <a:lnRef idx="0"/>
            <a:fillRef idx="0"/>
            <a:effectRef idx="0"/>
            <a:fontRef idx="minor"/>
          </p:style>
          <p:txBody>
            <a:bodyPr tIns="24480" bIns="24480" anchor="t">
              <a:noAutofit/>
            </a:bodyPr>
            <a:p>
              <a:endParaRPr b="0" lang="en-US" sz="1800" spc="-1" strike="noStrike">
                <a:solidFill>
                  <a:srgbClr val="000000"/>
                </a:solidFill>
                <a:latin typeface="Calibri"/>
              </a:endParaRPr>
            </a:p>
          </p:txBody>
        </p:sp>
        <p:sp>
          <p:nvSpPr>
            <p:cNvPr id="262" name="Freeform 396"/>
            <p:cNvSpPr/>
            <p:nvPr/>
          </p:nvSpPr>
          <p:spPr>
            <a:xfrm>
              <a:off x="3870360" y="1727280"/>
              <a:ext cx="66240" cy="61920"/>
            </a:xfrm>
            <a:custGeom>
              <a:avLst/>
              <a:gdLst>
                <a:gd name="textAreaLeft" fmla="*/ 0 w 66240"/>
                <a:gd name="textAreaRight" fmla="*/ 66600 w 66240"/>
                <a:gd name="textAreaTop" fmla="*/ 0 h 61920"/>
                <a:gd name="textAreaBottom" fmla="*/ 62280 h 61920"/>
              </a:gdLst>
              <a:ahLst/>
              <a:rect l="textAreaLeft" t="textAreaTop" r="textAreaRight" b="textAreaBottom"/>
              <a:pathLst>
                <a:path w="39" h="39">
                  <a:moveTo>
                    <a:pt x="22" y="39"/>
                  </a:moveTo>
                  <a:lnTo>
                    <a:pt x="0" y="17"/>
                  </a:lnTo>
                  <a:lnTo>
                    <a:pt x="22" y="0"/>
                  </a:lnTo>
                  <a:lnTo>
                    <a:pt x="39" y="17"/>
                  </a:lnTo>
                  <a:lnTo>
                    <a:pt x="22" y="39"/>
                  </a:lnTo>
                  <a:close/>
                </a:path>
              </a:pathLst>
            </a:custGeom>
            <a:solidFill>
              <a:srgbClr val="4f81bd"/>
            </a:solidFill>
            <a:ln w="0">
              <a:no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263" name="Freeform 397"/>
            <p:cNvSpPr/>
            <p:nvPr/>
          </p:nvSpPr>
          <p:spPr>
            <a:xfrm>
              <a:off x="3870360" y="1727280"/>
              <a:ext cx="73080" cy="61920"/>
            </a:xfrm>
            <a:custGeom>
              <a:avLst/>
              <a:gdLst>
                <a:gd name="textAreaLeft" fmla="*/ 0 w 73080"/>
                <a:gd name="textAreaRight" fmla="*/ 73440 w 73080"/>
                <a:gd name="textAreaTop" fmla="*/ 0 h 61920"/>
                <a:gd name="textAreaBottom" fmla="*/ 62280 h 61920"/>
              </a:gdLst>
              <a:ahLst/>
              <a:rect l="textAreaLeft" t="textAreaTop" r="textAreaRight" b="textAreaBottom"/>
              <a:pathLst>
                <a:path w="43" h="39">
                  <a:moveTo>
                    <a:pt x="22" y="39"/>
                  </a:moveTo>
                  <a:lnTo>
                    <a:pt x="17" y="39"/>
                  </a:lnTo>
                  <a:lnTo>
                    <a:pt x="0" y="21"/>
                  </a:lnTo>
                  <a:lnTo>
                    <a:pt x="0" y="17"/>
                  </a:lnTo>
                  <a:lnTo>
                    <a:pt x="17" y="0"/>
                  </a:lnTo>
                  <a:lnTo>
                    <a:pt x="22" y="0"/>
                  </a:lnTo>
                  <a:lnTo>
                    <a:pt x="43" y="17"/>
                  </a:lnTo>
                  <a:lnTo>
                    <a:pt x="43" y="21"/>
                  </a:lnTo>
                  <a:lnTo>
                    <a:pt x="22" y="39"/>
                  </a:lnTo>
                  <a:close/>
                  <a:moveTo>
                    <a:pt x="39" y="17"/>
                  </a:moveTo>
                  <a:lnTo>
                    <a:pt x="39" y="21"/>
                  </a:lnTo>
                  <a:lnTo>
                    <a:pt x="17" y="0"/>
                  </a:lnTo>
                  <a:lnTo>
                    <a:pt x="22" y="0"/>
                  </a:lnTo>
                  <a:lnTo>
                    <a:pt x="4" y="21"/>
                  </a:lnTo>
                  <a:lnTo>
                    <a:pt x="4" y="17"/>
                  </a:lnTo>
                  <a:lnTo>
                    <a:pt x="22" y="39"/>
                  </a:lnTo>
                  <a:lnTo>
                    <a:pt x="17" y="39"/>
                  </a:lnTo>
                  <a:lnTo>
                    <a:pt x="39" y="17"/>
                  </a:lnTo>
                  <a:close/>
                </a:path>
              </a:pathLst>
            </a:custGeom>
            <a:solidFill>
              <a:srgbClr val="4a7ebb"/>
            </a:solidFill>
            <a:ln w="0">
              <a:solidFill>
                <a:srgbClr val="4a7ebb"/>
              </a:solid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264" name="Freeform 398"/>
            <p:cNvSpPr/>
            <p:nvPr/>
          </p:nvSpPr>
          <p:spPr>
            <a:xfrm>
              <a:off x="3781800" y="1636920"/>
              <a:ext cx="66240" cy="61920"/>
            </a:xfrm>
            <a:custGeom>
              <a:avLst/>
              <a:gdLst>
                <a:gd name="textAreaLeft" fmla="*/ 0 w 66240"/>
                <a:gd name="textAreaRight" fmla="*/ 66600 w 66240"/>
                <a:gd name="textAreaTop" fmla="*/ 0 h 61920"/>
                <a:gd name="textAreaBottom" fmla="*/ 62280 h 61920"/>
              </a:gdLst>
              <a:ahLst/>
              <a:rect l="textAreaLeft" t="textAreaTop" r="textAreaRight" b="textAreaBottom"/>
              <a:pathLst>
                <a:path w="39" h="39">
                  <a:moveTo>
                    <a:pt x="18" y="39"/>
                  </a:moveTo>
                  <a:lnTo>
                    <a:pt x="0" y="18"/>
                  </a:lnTo>
                  <a:lnTo>
                    <a:pt x="18" y="0"/>
                  </a:lnTo>
                  <a:lnTo>
                    <a:pt x="39" y="18"/>
                  </a:lnTo>
                  <a:lnTo>
                    <a:pt x="18" y="39"/>
                  </a:lnTo>
                  <a:close/>
                </a:path>
              </a:pathLst>
            </a:custGeom>
            <a:solidFill>
              <a:srgbClr val="4f81bd"/>
            </a:solidFill>
            <a:ln w="0">
              <a:no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265" name="Freeform 399"/>
            <p:cNvSpPr/>
            <p:nvPr/>
          </p:nvSpPr>
          <p:spPr>
            <a:xfrm>
              <a:off x="3774960" y="1630440"/>
              <a:ext cx="73080" cy="68040"/>
            </a:xfrm>
            <a:custGeom>
              <a:avLst/>
              <a:gdLst>
                <a:gd name="textAreaLeft" fmla="*/ 0 w 73080"/>
                <a:gd name="textAreaRight" fmla="*/ 73440 w 73080"/>
                <a:gd name="textAreaTop" fmla="*/ 0 h 68040"/>
                <a:gd name="textAreaBottom" fmla="*/ 68400 h 68040"/>
              </a:gdLst>
              <a:ahLst/>
              <a:rect l="textAreaLeft" t="textAreaTop" r="textAreaRight" b="textAreaBottom"/>
              <a:pathLst>
                <a:path w="43" h="43">
                  <a:moveTo>
                    <a:pt x="26" y="43"/>
                  </a:moveTo>
                  <a:lnTo>
                    <a:pt x="22" y="43"/>
                  </a:lnTo>
                  <a:lnTo>
                    <a:pt x="0" y="26"/>
                  </a:lnTo>
                  <a:lnTo>
                    <a:pt x="0" y="22"/>
                  </a:lnTo>
                  <a:lnTo>
                    <a:pt x="22" y="0"/>
                  </a:lnTo>
                  <a:lnTo>
                    <a:pt x="26" y="0"/>
                  </a:lnTo>
                  <a:lnTo>
                    <a:pt x="43" y="22"/>
                  </a:lnTo>
                  <a:lnTo>
                    <a:pt x="43" y="26"/>
                  </a:lnTo>
                  <a:lnTo>
                    <a:pt x="26" y="43"/>
                  </a:lnTo>
                  <a:close/>
                  <a:moveTo>
                    <a:pt x="39" y="22"/>
                  </a:moveTo>
                  <a:lnTo>
                    <a:pt x="39" y="26"/>
                  </a:lnTo>
                  <a:lnTo>
                    <a:pt x="22" y="4"/>
                  </a:lnTo>
                  <a:lnTo>
                    <a:pt x="26" y="4"/>
                  </a:lnTo>
                  <a:lnTo>
                    <a:pt x="4" y="26"/>
                  </a:lnTo>
                  <a:lnTo>
                    <a:pt x="4" y="22"/>
                  </a:lnTo>
                  <a:lnTo>
                    <a:pt x="26" y="39"/>
                  </a:lnTo>
                  <a:lnTo>
                    <a:pt x="22" y="39"/>
                  </a:lnTo>
                  <a:lnTo>
                    <a:pt x="39" y="22"/>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66" name="Freeform 400"/>
            <p:cNvSpPr/>
            <p:nvPr/>
          </p:nvSpPr>
          <p:spPr>
            <a:xfrm>
              <a:off x="3841200" y="1706760"/>
              <a:ext cx="66240" cy="61920"/>
            </a:xfrm>
            <a:custGeom>
              <a:avLst/>
              <a:gdLst>
                <a:gd name="textAreaLeft" fmla="*/ 0 w 66240"/>
                <a:gd name="textAreaRight" fmla="*/ 66600 w 66240"/>
                <a:gd name="textAreaTop" fmla="*/ 0 h 61920"/>
                <a:gd name="textAreaBottom" fmla="*/ 62280 h 61920"/>
              </a:gdLst>
              <a:ahLst/>
              <a:rect l="textAreaLeft" t="textAreaTop" r="textAreaRight" b="textAreaBottom"/>
              <a:pathLst>
                <a:path w="39" h="39">
                  <a:moveTo>
                    <a:pt x="21" y="39"/>
                  </a:moveTo>
                  <a:lnTo>
                    <a:pt x="0" y="17"/>
                  </a:lnTo>
                  <a:lnTo>
                    <a:pt x="21" y="0"/>
                  </a:lnTo>
                  <a:lnTo>
                    <a:pt x="39" y="17"/>
                  </a:lnTo>
                  <a:lnTo>
                    <a:pt x="21" y="39"/>
                  </a:lnTo>
                  <a:close/>
                </a:path>
              </a:pathLst>
            </a:custGeom>
            <a:solidFill>
              <a:srgbClr val="4f81bd"/>
            </a:solidFill>
            <a:ln w="0">
              <a:no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267" name="Freeform 401"/>
            <p:cNvSpPr/>
            <p:nvPr/>
          </p:nvSpPr>
          <p:spPr>
            <a:xfrm>
              <a:off x="3841200" y="1698840"/>
              <a:ext cx="73080" cy="69840"/>
            </a:xfrm>
            <a:custGeom>
              <a:avLst/>
              <a:gdLst>
                <a:gd name="textAreaLeft" fmla="*/ 0 w 73080"/>
                <a:gd name="textAreaRight" fmla="*/ 73440 w 73080"/>
                <a:gd name="textAreaTop" fmla="*/ 0 h 69840"/>
                <a:gd name="textAreaBottom" fmla="*/ 70200 h 69840"/>
              </a:gdLst>
              <a:ahLst/>
              <a:rect l="textAreaLeft" t="textAreaTop" r="textAreaRight" b="textAreaBottom"/>
              <a:pathLst>
                <a:path w="43" h="44">
                  <a:moveTo>
                    <a:pt x="21" y="44"/>
                  </a:moveTo>
                  <a:lnTo>
                    <a:pt x="17" y="44"/>
                  </a:lnTo>
                  <a:lnTo>
                    <a:pt x="0" y="26"/>
                  </a:lnTo>
                  <a:lnTo>
                    <a:pt x="0" y="22"/>
                  </a:lnTo>
                  <a:lnTo>
                    <a:pt x="17" y="0"/>
                  </a:lnTo>
                  <a:lnTo>
                    <a:pt x="21" y="0"/>
                  </a:lnTo>
                  <a:lnTo>
                    <a:pt x="43" y="22"/>
                  </a:lnTo>
                  <a:lnTo>
                    <a:pt x="43" y="26"/>
                  </a:lnTo>
                  <a:lnTo>
                    <a:pt x="21" y="44"/>
                  </a:lnTo>
                  <a:close/>
                  <a:moveTo>
                    <a:pt x="39" y="22"/>
                  </a:moveTo>
                  <a:lnTo>
                    <a:pt x="39" y="26"/>
                  </a:lnTo>
                  <a:lnTo>
                    <a:pt x="17" y="5"/>
                  </a:lnTo>
                  <a:lnTo>
                    <a:pt x="21" y="5"/>
                  </a:lnTo>
                  <a:lnTo>
                    <a:pt x="4" y="26"/>
                  </a:lnTo>
                  <a:lnTo>
                    <a:pt x="4" y="22"/>
                  </a:lnTo>
                  <a:lnTo>
                    <a:pt x="21" y="39"/>
                  </a:lnTo>
                  <a:lnTo>
                    <a:pt x="17" y="39"/>
                  </a:lnTo>
                  <a:lnTo>
                    <a:pt x="39" y="22"/>
                  </a:lnTo>
                  <a:close/>
                </a:path>
              </a:pathLst>
            </a:custGeom>
            <a:solidFill>
              <a:srgbClr val="4a7ebb"/>
            </a:solidFill>
            <a:ln w="0">
              <a:solidFill>
                <a:srgbClr val="4a7ebb"/>
              </a:solidFill>
            </a:ln>
          </p:spPr>
          <p:style>
            <a:lnRef idx="0"/>
            <a:fillRef idx="0"/>
            <a:effectRef idx="0"/>
            <a:fontRef idx="minor"/>
          </p:style>
          <p:txBody>
            <a:bodyPr tIns="24480" bIns="24480" anchor="t">
              <a:noAutofit/>
            </a:bodyPr>
            <a:p>
              <a:endParaRPr b="0" lang="en-US" sz="1800" spc="-1" strike="noStrike">
                <a:solidFill>
                  <a:srgbClr val="000000"/>
                </a:solidFill>
                <a:latin typeface="Calibri"/>
              </a:endParaRPr>
            </a:p>
          </p:txBody>
        </p:sp>
        <p:sp>
          <p:nvSpPr>
            <p:cNvPr id="268" name="Freeform 402"/>
            <p:cNvSpPr/>
            <p:nvPr/>
          </p:nvSpPr>
          <p:spPr>
            <a:xfrm>
              <a:off x="4215960" y="1617840"/>
              <a:ext cx="66240" cy="60120"/>
            </a:xfrm>
            <a:custGeom>
              <a:avLst/>
              <a:gdLst>
                <a:gd name="textAreaLeft" fmla="*/ 0 w 66240"/>
                <a:gd name="textAreaRight" fmla="*/ 66600 w 66240"/>
                <a:gd name="textAreaTop" fmla="*/ 0 h 60120"/>
                <a:gd name="textAreaBottom" fmla="*/ 60480 h 60120"/>
              </a:gdLst>
              <a:ahLst/>
              <a:rect l="textAreaLeft" t="textAreaTop" r="textAreaRight" b="textAreaBottom"/>
              <a:pathLst>
                <a:path w="39" h="38">
                  <a:moveTo>
                    <a:pt x="17" y="38"/>
                  </a:moveTo>
                  <a:lnTo>
                    <a:pt x="0" y="21"/>
                  </a:lnTo>
                  <a:lnTo>
                    <a:pt x="17" y="0"/>
                  </a:lnTo>
                  <a:lnTo>
                    <a:pt x="39" y="21"/>
                  </a:lnTo>
                  <a:lnTo>
                    <a:pt x="17" y="38"/>
                  </a:lnTo>
                  <a:close/>
                </a:path>
              </a:pathLst>
            </a:custGeom>
            <a:solidFill>
              <a:srgbClr val="4f81bd"/>
            </a:solidFill>
            <a:ln w="0">
              <a:no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269" name="Freeform 403"/>
            <p:cNvSpPr/>
            <p:nvPr/>
          </p:nvSpPr>
          <p:spPr>
            <a:xfrm>
              <a:off x="4209120" y="1617840"/>
              <a:ext cx="73080" cy="60120"/>
            </a:xfrm>
            <a:custGeom>
              <a:avLst/>
              <a:gdLst>
                <a:gd name="textAreaLeft" fmla="*/ 0 w 73080"/>
                <a:gd name="textAreaRight" fmla="*/ 73440 w 73080"/>
                <a:gd name="textAreaTop" fmla="*/ 0 h 60120"/>
                <a:gd name="textAreaBottom" fmla="*/ 60480 h 60120"/>
              </a:gdLst>
              <a:ahLst/>
              <a:rect l="textAreaLeft" t="textAreaTop" r="textAreaRight" b="textAreaBottom"/>
              <a:pathLst>
                <a:path w="43" h="38">
                  <a:moveTo>
                    <a:pt x="21" y="38"/>
                  </a:moveTo>
                  <a:lnTo>
                    <a:pt x="21" y="38"/>
                  </a:lnTo>
                  <a:lnTo>
                    <a:pt x="0" y="21"/>
                  </a:lnTo>
                  <a:lnTo>
                    <a:pt x="0" y="17"/>
                  </a:lnTo>
                  <a:lnTo>
                    <a:pt x="21" y="0"/>
                  </a:lnTo>
                  <a:lnTo>
                    <a:pt x="21" y="0"/>
                  </a:lnTo>
                  <a:lnTo>
                    <a:pt x="43" y="17"/>
                  </a:lnTo>
                  <a:lnTo>
                    <a:pt x="43" y="21"/>
                  </a:lnTo>
                  <a:lnTo>
                    <a:pt x="21" y="38"/>
                  </a:lnTo>
                  <a:close/>
                  <a:moveTo>
                    <a:pt x="39" y="17"/>
                  </a:moveTo>
                  <a:lnTo>
                    <a:pt x="39" y="21"/>
                  </a:lnTo>
                  <a:lnTo>
                    <a:pt x="21" y="0"/>
                  </a:lnTo>
                  <a:lnTo>
                    <a:pt x="21" y="0"/>
                  </a:lnTo>
                  <a:lnTo>
                    <a:pt x="4" y="21"/>
                  </a:lnTo>
                  <a:lnTo>
                    <a:pt x="4" y="17"/>
                  </a:lnTo>
                  <a:lnTo>
                    <a:pt x="21" y="38"/>
                  </a:lnTo>
                  <a:lnTo>
                    <a:pt x="21" y="38"/>
                  </a:lnTo>
                  <a:lnTo>
                    <a:pt x="39" y="17"/>
                  </a:lnTo>
                  <a:close/>
                </a:path>
              </a:pathLst>
            </a:custGeom>
            <a:solidFill>
              <a:srgbClr val="4a7ebb"/>
            </a:solidFill>
            <a:ln w="0">
              <a:solidFill>
                <a:srgbClr val="4a7ebb"/>
              </a:solid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270" name="Freeform 404"/>
            <p:cNvSpPr/>
            <p:nvPr/>
          </p:nvSpPr>
          <p:spPr>
            <a:xfrm>
              <a:off x="3509280" y="1548000"/>
              <a:ext cx="66240" cy="61920"/>
            </a:xfrm>
            <a:custGeom>
              <a:avLst/>
              <a:gdLst>
                <a:gd name="textAreaLeft" fmla="*/ 0 w 66240"/>
                <a:gd name="textAreaRight" fmla="*/ 66600 w 66240"/>
                <a:gd name="textAreaTop" fmla="*/ 0 h 61920"/>
                <a:gd name="textAreaBottom" fmla="*/ 62280 h 61920"/>
              </a:gdLst>
              <a:ahLst/>
              <a:rect l="textAreaLeft" t="textAreaTop" r="textAreaRight" b="textAreaBottom"/>
              <a:pathLst>
                <a:path w="39" h="39">
                  <a:moveTo>
                    <a:pt x="18" y="39"/>
                  </a:moveTo>
                  <a:lnTo>
                    <a:pt x="0" y="22"/>
                  </a:lnTo>
                  <a:lnTo>
                    <a:pt x="18" y="0"/>
                  </a:lnTo>
                  <a:lnTo>
                    <a:pt x="39" y="22"/>
                  </a:lnTo>
                  <a:lnTo>
                    <a:pt x="18" y="39"/>
                  </a:lnTo>
                  <a:close/>
                </a:path>
              </a:pathLst>
            </a:custGeom>
            <a:solidFill>
              <a:srgbClr val="4f81bd"/>
            </a:solidFill>
            <a:ln w="0">
              <a:no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271" name="Freeform 405"/>
            <p:cNvSpPr/>
            <p:nvPr/>
          </p:nvSpPr>
          <p:spPr>
            <a:xfrm>
              <a:off x="3502800" y="1548000"/>
              <a:ext cx="73080" cy="61920"/>
            </a:xfrm>
            <a:custGeom>
              <a:avLst/>
              <a:gdLst>
                <a:gd name="textAreaLeft" fmla="*/ 0 w 73080"/>
                <a:gd name="textAreaRight" fmla="*/ 73440 w 73080"/>
                <a:gd name="textAreaTop" fmla="*/ 0 h 61920"/>
                <a:gd name="textAreaBottom" fmla="*/ 62280 h 61920"/>
              </a:gdLst>
              <a:ahLst/>
              <a:rect l="textAreaLeft" t="textAreaTop" r="textAreaRight" b="textAreaBottom"/>
              <a:pathLst>
                <a:path w="43" h="39">
                  <a:moveTo>
                    <a:pt x="22" y="39"/>
                  </a:moveTo>
                  <a:lnTo>
                    <a:pt x="22" y="39"/>
                  </a:lnTo>
                  <a:lnTo>
                    <a:pt x="0" y="22"/>
                  </a:lnTo>
                  <a:lnTo>
                    <a:pt x="0" y="18"/>
                  </a:lnTo>
                  <a:lnTo>
                    <a:pt x="22" y="0"/>
                  </a:lnTo>
                  <a:lnTo>
                    <a:pt x="22" y="0"/>
                  </a:lnTo>
                  <a:lnTo>
                    <a:pt x="43" y="18"/>
                  </a:lnTo>
                  <a:lnTo>
                    <a:pt x="43" y="22"/>
                  </a:lnTo>
                  <a:lnTo>
                    <a:pt x="22" y="39"/>
                  </a:lnTo>
                  <a:close/>
                  <a:moveTo>
                    <a:pt x="39" y="18"/>
                  </a:moveTo>
                  <a:lnTo>
                    <a:pt x="39" y="22"/>
                  </a:lnTo>
                  <a:lnTo>
                    <a:pt x="22" y="0"/>
                  </a:lnTo>
                  <a:lnTo>
                    <a:pt x="22" y="0"/>
                  </a:lnTo>
                  <a:lnTo>
                    <a:pt x="4" y="22"/>
                  </a:lnTo>
                  <a:lnTo>
                    <a:pt x="4" y="18"/>
                  </a:lnTo>
                  <a:lnTo>
                    <a:pt x="22" y="39"/>
                  </a:lnTo>
                  <a:lnTo>
                    <a:pt x="22" y="39"/>
                  </a:lnTo>
                  <a:lnTo>
                    <a:pt x="39" y="18"/>
                  </a:lnTo>
                  <a:close/>
                </a:path>
              </a:pathLst>
            </a:custGeom>
            <a:solidFill>
              <a:srgbClr val="4a7ebb"/>
            </a:solidFill>
            <a:ln w="0">
              <a:solidFill>
                <a:srgbClr val="4a7ebb"/>
              </a:solid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272" name="Freeform 406"/>
            <p:cNvSpPr/>
            <p:nvPr/>
          </p:nvSpPr>
          <p:spPr>
            <a:xfrm>
              <a:off x="3157200" y="1795680"/>
              <a:ext cx="66240" cy="61920"/>
            </a:xfrm>
            <a:custGeom>
              <a:avLst/>
              <a:gdLst>
                <a:gd name="textAreaLeft" fmla="*/ 0 w 66240"/>
                <a:gd name="textAreaRight" fmla="*/ 66600 w 66240"/>
                <a:gd name="textAreaTop" fmla="*/ 0 h 61920"/>
                <a:gd name="textAreaBottom" fmla="*/ 62280 h 61920"/>
              </a:gdLst>
              <a:ahLst/>
              <a:rect l="textAreaLeft" t="textAreaTop" r="textAreaRight" b="textAreaBottom"/>
              <a:pathLst>
                <a:path w="39" h="39">
                  <a:moveTo>
                    <a:pt x="22" y="39"/>
                  </a:moveTo>
                  <a:lnTo>
                    <a:pt x="0" y="21"/>
                  </a:lnTo>
                  <a:lnTo>
                    <a:pt x="22" y="0"/>
                  </a:lnTo>
                  <a:lnTo>
                    <a:pt x="39" y="21"/>
                  </a:lnTo>
                  <a:lnTo>
                    <a:pt x="22" y="39"/>
                  </a:lnTo>
                  <a:close/>
                </a:path>
              </a:pathLst>
            </a:custGeom>
            <a:solidFill>
              <a:srgbClr val="4f81bd"/>
            </a:solidFill>
            <a:ln w="0">
              <a:no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273" name="Freeform 407"/>
            <p:cNvSpPr/>
            <p:nvPr/>
          </p:nvSpPr>
          <p:spPr>
            <a:xfrm>
              <a:off x="3157200" y="1795680"/>
              <a:ext cx="73080" cy="68040"/>
            </a:xfrm>
            <a:custGeom>
              <a:avLst/>
              <a:gdLst>
                <a:gd name="textAreaLeft" fmla="*/ 0 w 73080"/>
                <a:gd name="textAreaRight" fmla="*/ 73440 w 73080"/>
                <a:gd name="textAreaTop" fmla="*/ 0 h 68040"/>
                <a:gd name="textAreaBottom" fmla="*/ 68400 h 68040"/>
              </a:gdLst>
              <a:ahLst/>
              <a:rect l="textAreaLeft" t="textAreaTop" r="textAreaRight" b="textAreaBottom"/>
              <a:pathLst>
                <a:path w="43" h="43">
                  <a:moveTo>
                    <a:pt x="22" y="43"/>
                  </a:moveTo>
                  <a:lnTo>
                    <a:pt x="17" y="43"/>
                  </a:lnTo>
                  <a:lnTo>
                    <a:pt x="0" y="21"/>
                  </a:lnTo>
                  <a:lnTo>
                    <a:pt x="0" y="17"/>
                  </a:lnTo>
                  <a:lnTo>
                    <a:pt x="17" y="0"/>
                  </a:lnTo>
                  <a:lnTo>
                    <a:pt x="22" y="0"/>
                  </a:lnTo>
                  <a:lnTo>
                    <a:pt x="43" y="17"/>
                  </a:lnTo>
                  <a:lnTo>
                    <a:pt x="43" y="21"/>
                  </a:lnTo>
                  <a:lnTo>
                    <a:pt x="22" y="43"/>
                  </a:lnTo>
                  <a:close/>
                  <a:moveTo>
                    <a:pt x="39" y="17"/>
                  </a:moveTo>
                  <a:lnTo>
                    <a:pt x="39" y="21"/>
                  </a:lnTo>
                  <a:lnTo>
                    <a:pt x="17" y="4"/>
                  </a:lnTo>
                  <a:lnTo>
                    <a:pt x="22" y="4"/>
                  </a:lnTo>
                  <a:lnTo>
                    <a:pt x="4" y="21"/>
                  </a:lnTo>
                  <a:lnTo>
                    <a:pt x="4" y="17"/>
                  </a:lnTo>
                  <a:lnTo>
                    <a:pt x="22" y="39"/>
                  </a:lnTo>
                  <a:lnTo>
                    <a:pt x="17" y="39"/>
                  </a:lnTo>
                  <a:lnTo>
                    <a:pt x="39" y="17"/>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74" name="Freeform 408"/>
            <p:cNvSpPr/>
            <p:nvPr/>
          </p:nvSpPr>
          <p:spPr>
            <a:xfrm>
              <a:off x="4025160" y="1295280"/>
              <a:ext cx="66240" cy="60120"/>
            </a:xfrm>
            <a:custGeom>
              <a:avLst/>
              <a:gdLst>
                <a:gd name="textAreaLeft" fmla="*/ 0 w 66240"/>
                <a:gd name="textAreaRight" fmla="*/ 66600 w 66240"/>
                <a:gd name="textAreaTop" fmla="*/ 0 h 60120"/>
                <a:gd name="textAreaBottom" fmla="*/ 60480 h 60120"/>
              </a:gdLst>
              <a:ahLst/>
              <a:rect l="textAreaLeft" t="textAreaTop" r="textAreaRight" b="textAreaBottom"/>
              <a:pathLst>
                <a:path w="39" h="38">
                  <a:moveTo>
                    <a:pt x="17" y="38"/>
                  </a:moveTo>
                  <a:lnTo>
                    <a:pt x="0" y="21"/>
                  </a:lnTo>
                  <a:lnTo>
                    <a:pt x="17" y="0"/>
                  </a:lnTo>
                  <a:lnTo>
                    <a:pt x="39" y="21"/>
                  </a:lnTo>
                  <a:lnTo>
                    <a:pt x="17" y="38"/>
                  </a:lnTo>
                  <a:close/>
                </a:path>
              </a:pathLst>
            </a:custGeom>
            <a:solidFill>
              <a:srgbClr val="4f81bd"/>
            </a:solidFill>
            <a:ln w="0">
              <a:no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275" name="Freeform 409"/>
            <p:cNvSpPr/>
            <p:nvPr/>
          </p:nvSpPr>
          <p:spPr>
            <a:xfrm>
              <a:off x="4018320" y="1295280"/>
              <a:ext cx="73080" cy="68040"/>
            </a:xfrm>
            <a:custGeom>
              <a:avLst/>
              <a:gdLst>
                <a:gd name="textAreaLeft" fmla="*/ 0 w 73080"/>
                <a:gd name="textAreaRight" fmla="*/ 73440 w 73080"/>
                <a:gd name="textAreaTop" fmla="*/ 0 h 68040"/>
                <a:gd name="textAreaBottom" fmla="*/ 68400 h 68040"/>
              </a:gdLst>
              <a:ahLst/>
              <a:rect l="textAreaLeft" t="textAreaTop" r="textAreaRight" b="textAreaBottom"/>
              <a:pathLst>
                <a:path w="43" h="43">
                  <a:moveTo>
                    <a:pt x="21" y="43"/>
                  </a:moveTo>
                  <a:lnTo>
                    <a:pt x="21" y="43"/>
                  </a:lnTo>
                  <a:lnTo>
                    <a:pt x="0" y="21"/>
                  </a:lnTo>
                  <a:lnTo>
                    <a:pt x="0" y="21"/>
                  </a:lnTo>
                  <a:lnTo>
                    <a:pt x="21" y="0"/>
                  </a:lnTo>
                  <a:lnTo>
                    <a:pt x="21" y="0"/>
                  </a:lnTo>
                  <a:lnTo>
                    <a:pt x="43" y="21"/>
                  </a:lnTo>
                  <a:lnTo>
                    <a:pt x="43" y="21"/>
                  </a:lnTo>
                  <a:lnTo>
                    <a:pt x="21" y="43"/>
                  </a:lnTo>
                  <a:close/>
                  <a:moveTo>
                    <a:pt x="38" y="21"/>
                  </a:moveTo>
                  <a:lnTo>
                    <a:pt x="38" y="21"/>
                  </a:lnTo>
                  <a:lnTo>
                    <a:pt x="21" y="4"/>
                  </a:lnTo>
                  <a:lnTo>
                    <a:pt x="21" y="4"/>
                  </a:lnTo>
                  <a:lnTo>
                    <a:pt x="4" y="21"/>
                  </a:lnTo>
                  <a:lnTo>
                    <a:pt x="4" y="21"/>
                  </a:lnTo>
                  <a:lnTo>
                    <a:pt x="21" y="38"/>
                  </a:lnTo>
                  <a:lnTo>
                    <a:pt x="21" y="38"/>
                  </a:lnTo>
                  <a:lnTo>
                    <a:pt x="38" y="21"/>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76" name="Freeform 410"/>
            <p:cNvSpPr/>
            <p:nvPr/>
          </p:nvSpPr>
          <p:spPr>
            <a:xfrm>
              <a:off x="2319840" y="1405080"/>
              <a:ext cx="2197080" cy="527040"/>
            </a:xfrm>
            <a:custGeom>
              <a:avLst/>
              <a:gdLst>
                <a:gd name="textAreaLeft" fmla="*/ 0 w 2197080"/>
                <a:gd name="textAreaRight" fmla="*/ 2197440 w 2197080"/>
                <a:gd name="textAreaTop" fmla="*/ 0 h 527040"/>
                <a:gd name="textAreaBottom" fmla="*/ 527400 h 527040"/>
              </a:gdLst>
              <a:ahLst/>
              <a:rect l="textAreaLeft" t="textAreaTop" r="textAreaRight" b="textAreaBottom"/>
              <a:pathLst>
                <a:path w="1291" h="332">
                  <a:moveTo>
                    <a:pt x="0" y="328"/>
                  </a:moveTo>
                  <a:lnTo>
                    <a:pt x="1287" y="0"/>
                  </a:lnTo>
                  <a:lnTo>
                    <a:pt x="1291" y="0"/>
                  </a:lnTo>
                  <a:lnTo>
                    <a:pt x="1287" y="4"/>
                  </a:lnTo>
                  <a:lnTo>
                    <a:pt x="0" y="332"/>
                  </a:lnTo>
                  <a:lnTo>
                    <a:pt x="0" y="328"/>
                  </a:lnTo>
                  <a:lnTo>
                    <a:pt x="0" y="328"/>
                  </a:lnTo>
                  <a:lnTo>
                    <a:pt x="0" y="328"/>
                  </a:lnTo>
                  <a:close/>
                </a:path>
              </a:pathLst>
            </a:custGeom>
            <a:solidFill>
              <a:srgbClr val="000000"/>
            </a:solidFill>
            <a:ln w="6480">
              <a:solidFill>
                <a:srgbClr val="00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grpSp>
      <p:grpSp>
        <p:nvGrpSpPr>
          <p:cNvPr id="277" name="Group 729"/>
          <p:cNvGrpSpPr/>
          <p:nvPr/>
        </p:nvGrpSpPr>
        <p:grpSpPr>
          <a:xfrm>
            <a:off x="2305080" y="2914560"/>
            <a:ext cx="2276280" cy="816120"/>
            <a:chOff x="2305080" y="2914560"/>
            <a:chExt cx="2276280" cy="816120"/>
          </a:xfrm>
        </p:grpSpPr>
        <p:sp>
          <p:nvSpPr>
            <p:cNvPr id="278" name="Freeform 472"/>
            <p:cNvSpPr/>
            <p:nvPr/>
          </p:nvSpPr>
          <p:spPr>
            <a:xfrm>
              <a:off x="2305080" y="3670560"/>
              <a:ext cx="72360" cy="60120"/>
            </a:xfrm>
            <a:custGeom>
              <a:avLst/>
              <a:gdLst>
                <a:gd name="textAreaLeft" fmla="*/ 0 w 72360"/>
                <a:gd name="textAreaRight" fmla="*/ 72720 w 72360"/>
                <a:gd name="textAreaTop" fmla="*/ 0 h 60120"/>
                <a:gd name="textAreaBottom" fmla="*/ 60480 h 60120"/>
              </a:gdLst>
              <a:ahLst/>
              <a:rect l="textAreaLeft" t="textAreaTop" r="textAreaRight" b="textAreaBottom"/>
              <a:pathLst>
                <a:path w="39" h="38">
                  <a:moveTo>
                    <a:pt x="21" y="38"/>
                  </a:moveTo>
                  <a:lnTo>
                    <a:pt x="0" y="17"/>
                  </a:lnTo>
                  <a:lnTo>
                    <a:pt x="21" y="0"/>
                  </a:lnTo>
                  <a:lnTo>
                    <a:pt x="39" y="17"/>
                  </a:lnTo>
                  <a:lnTo>
                    <a:pt x="21" y="38"/>
                  </a:lnTo>
                  <a:close/>
                </a:path>
              </a:pathLst>
            </a:custGeom>
            <a:solidFill>
              <a:srgbClr val="4f81bd"/>
            </a:solidFill>
            <a:ln w="0">
              <a:no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279" name="Freeform 473"/>
            <p:cNvSpPr/>
            <p:nvPr/>
          </p:nvSpPr>
          <p:spPr>
            <a:xfrm>
              <a:off x="2305080" y="3662640"/>
              <a:ext cx="79920" cy="68040"/>
            </a:xfrm>
            <a:custGeom>
              <a:avLst/>
              <a:gdLst>
                <a:gd name="textAreaLeft" fmla="*/ 0 w 79920"/>
                <a:gd name="textAreaRight" fmla="*/ 80280 w 79920"/>
                <a:gd name="textAreaTop" fmla="*/ 0 h 68040"/>
                <a:gd name="textAreaBottom" fmla="*/ 68400 h 68040"/>
              </a:gdLst>
              <a:ahLst/>
              <a:rect l="textAreaLeft" t="textAreaTop" r="textAreaRight" b="textAreaBottom"/>
              <a:pathLst>
                <a:path w="43" h="43">
                  <a:moveTo>
                    <a:pt x="21" y="43"/>
                  </a:moveTo>
                  <a:lnTo>
                    <a:pt x="17" y="43"/>
                  </a:lnTo>
                  <a:lnTo>
                    <a:pt x="0" y="22"/>
                  </a:lnTo>
                  <a:lnTo>
                    <a:pt x="0" y="22"/>
                  </a:lnTo>
                  <a:lnTo>
                    <a:pt x="17" y="0"/>
                  </a:lnTo>
                  <a:lnTo>
                    <a:pt x="21" y="0"/>
                  </a:lnTo>
                  <a:lnTo>
                    <a:pt x="43" y="22"/>
                  </a:lnTo>
                  <a:lnTo>
                    <a:pt x="43" y="22"/>
                  </a:lnTo>
                  <a:lnTo>
                    <a:pt x="21" y="43"/>
                  </a:lnTo>
                  <a:close/>
                  <a:moveTo>
                    <a:pt x="39" y="22"/>
                  </a:moveTo>
                  <a:lnTo>
                    <a:pt x="39" y="22"/>
                  </a:lnTo>
                  <a:lnTo>
                    <a:pt x="17" y="5"/>
                  </a:lnTo>
                  <a:lnTo>
                    <a:pt x="21" y="5"/>
                  </a:lnTo>
                  <a:lnTo>
                    <a:pt x="4" y="22"/>
                  </a:lnTo>
                  <a:lnTo>
                    <a:pt x="4" y="22"/>
                  </a:lnTo>
                  <a:lnTo>
                    <a:pt x="21" y="39"/>
                  </a:lnTo>
                  <a:lnTo>
                    <a:pt x="17" y="39"/>
                  </a:lnTo>
                  <a:lnTo>
                    <a:pt x="39" y="22"/>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80" name="Freeform 474"/>
            <p:cNvSpPr/>
            <p:nvPr/>
          </p:nvSpPr>
          <p:spPr>
            <a:xfrm>
              <a:off x="2305080" y="3670560"/>
              <a:ext cx="72360" cy="60120"/>
            </a:xfrm>
            <a:custGeom>
              <a:avLst/>
              <a:gdLst>
                <a:gd name="textAreaLeft" fmla="*/ 0 w 72360"/>
                <a:gd name="textAreaRight" fmla="*/ 72720 w 72360"/>
                <a:gd name="textAreaTop" fmla="*/ 0 h 60120"/>
                <a:gd name="textAreaBottom" fmla="*/ 60480 h 60120"/>
              </a:gdLst>
              <a:ahLst/>
              <a:rect l="textAreaLeft" t="textAreaTop" r="textAreaRight" b="textAreaBottom"/>
              <a:pathLst>
                <a:path w="39" h="38">
                  <a:moveTo>
                    <a:pt x="21" y="38"/>
                  </a:moveTo>
                  <a:lnTo>
                    <a:pt x="0" y="17"/>
                  </a:lnTo>
                  <a:lnTo>
                    <a:pt x="21" y="0"/>
                  </a:lnTo>
                  <a:lnTo>
                    <a:pt x="39" y="17"/>
                  </a:lnTo>
                  <a:lnTo>
                    <a:pt x="21" y="38"/>
                  </a:lnTo>
                  <a:close/>
                </a:path>
              </a:pathLst>
            </a:custGeom>
            <a:solidFill>
              <a:srgbClr val="4f81bd"/>
            </a:solidFill>
            <a:ln w="0">
              <a:no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281" name="Freeform 475"/>
            <p:cNvSpPr/>
            <p:nvPr/>
          </p:nvSpPr>
          <p:spPr>
            <a:xfrm>
              <a:off x="2305080" y="3662640"/>
              <a:ext cx="79920" cy="68040"/>
            </a:xfrm>
            <a:custGeom>
              <a:avLst/>
              <a:gdLst>
                <a:gd name="textAreaLeft" fmla="*/ 0 w 79920"/>
                <a:gd name="textAreaRight" fmla="*/ 80280 w 79920"/>
                <a:gd name="textAreaTop" fmla="*/ 0 h 68040"/>
                <a:gd name="textAreaBottom" fmla="*/ 68400 h 68040"/>
              </a:gdLst>
              <a:ahLst/>
              <a:rect l="textAreaLeft" t="textAreaTop" r="textAreaRight" b="textAreaBottom"/>
              <a:pathLst>
                <a:path w="43" h="43">
                  <a:moveTo>
                    <a:pt x="21" y="43"/>
                  </a:moveTo>
                  <a:lnTo>
                    <a:pt x="17" y="43"/>
                  </a:lnTo>
                  <a:lnTo>
                    <a:pt x="0" y="22"/>
                  </a:lnTo>
                  <a:lnTo>
                    <a:pt x="0" y="22"/>
                  </a:lnTo>
                  <a:lnTo>
                    <a:pt x="17" y="0"/>
                  </a:lnTo>
                  <a:lnTo>
                    <a:pt x="21" y="0"/>
                  </a:lnTo>
                  <a:lnTo>
                    <a:pt x="43" y="22"/>
                  </a:lnTo>
                  <a:lnTo>
                    <a:pt x="43" y="22"/>
                  </a:lnTo>
                  <a:lnTo>
                    <a:pt x="21" y="43"/>
                  </a:lnTo>
                  <a:close/>
                  <a:moveTo>
                    <a:pt x="39" y="22"/>
                  </a:moveTo>
                  <a:lnTo>
                    <a:pt x="39" y="22"/>
                  </a:lnTo>
                  <a:lnTo>
                    <a:pt x="17" y="5"/>
                  </a:lnTo>
                  <a:lnTo>
                    <a:pt x="21" y="5"/>
                  </a:lnTo>
                  <a:lnTo>
                    <a:pt x="4" y="22"/>
                  </a:lnTo>
                  <a:lnTo>
                    <a:pt x="4" y="22"/>
                  </a:lnTo>
                  <a:lnTo>
                    <a:pt x="21" y="39"/>
                  </a:lnTo>
                  <a:lnTo>
                    <a:pt x="17" y="39"/>
                  </a:lnTo>
                  <a:lnTo>
                    <a:pt x="39" y="22"/>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82" name="Freeform 476"/>
            <p:cNvSpPr/>
            <p:nvPr/>
          </p:nvSpPr>
          <p:spPr>
            <a:xfrm>
              <a:off x="2305080" y="3670560"/>
              <a:ext cx="72360" cy="60120"/>
            </a:xfrm>
            <a:custGeom>
              <a:avLst/>
              <a:gdLst>
                <a:gd name="textAreaLeft" fmla="*/ 0 w 72360"/>
                <a:gd name="textAreaRight" fmla="*/ 72720 w 72360"/>
                <a:gd name="textAreaTop" fmla="*/ 0 h 60120"/>
                <a:gd name="textAreaBottom" fmla="*/ 60480 h 60120"/>
              </a:gdLst>
              <a:ahLst/>
              <a:rect l="textAreaLeft" t="textAreaTop" r="textAreaRight" b="textAreaBottom"/>
              <a:pathLst>
                <a:path w="39" h="38">
                  <a:moveTo>
                    <a:pt x="21" y="38"/>
                  </a:moveTo>
                  <a:lnTo>
                    <a:pt x="0" y="17"/>
                  </a:lnTo>
                  <a:lnTo>
                    <a:pt x="21" y="0"/>
                  </a:lnTo>
                  <a:lnTo>
                    <a:pt x="39" y="17"/>
                  </a:lnTo>
                  <a:lnTo>
                    <a:pt x="21" y="38"/>
                  </a:lnTo>
                  <a:close/>
                </a:path>
              </a:pathLst>
            </a:custGeom>
            <a:solidFill>
              <a:srgbClr val="4f81bd"/>
            </a:solidFill>
            <a:ln w="0">
              <a:no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283" name="Freeform 477"/>
            <p:cNvSpPr/>
            <p:nvPr/>
          </p:nvSpPr>
          <p:spPr>
            <a:xfrm>
              <a:off x="2305080" y="3662640"/>
              <a:ext cx="79920" cy="68040"/>
            </a:xfrm>
            <a:custGeom>
              <a:avLst/>
              <a:gdLst>
                <a:gd name="textAreaLeft" fmla="*/ 0 w 79920"/>
                <a:gd name="textAreaRight" fmla="*/ 80280 w 79920"/>
                <a:gd name="textAreaTop" fmla="*/ 0 h 68040"/>
                <a:gd name="textAreaBottom" fmla="*/ 68400 h 68040"/>
              </a:gdLst>
              <a:ahLst/>
              <a:rect l="textAreaLeft" t="textAreaTop" r="textAreaRight" b="textAreaBottom"/>
              <a:pathLst>
                <a:path w="43" h="43">
                  <a:moveTo>
                    <a:pt x="21" y="43"/>
                  </a:moveTo>
                  <a:lnTo>
                    <a:pt x="17" y="43"/>
                  </a:lnTo>
                  <a:lnTo>
                    <a:pt x="0" y="22"/>
                  </a:lnTo>
                  <a:lnTo>
                    <a:pt x="0" y="22"/>
                  </a:lnTo>
                  <a:lnTo>
                    <a:pt x="17" y="0"/>
                  </a:lnTo>
                  <a:lnTo>
                    <a:pt x="21" y="0"/>
                  </a:lnTo>
                  <a:lnTo>
                    <a:pt x="43" y="22"/>
                  </a:lnTo>
                  <a:lnTo>
                    <a:pt x="43" y="22"/>
                  </a:lnTo>
                  <a:lnTo>
                    <a:pt x="21" y="43"/>
                  </a:lnTo>
                  <a:close/>
                  <a:moveTo>
                    <a:pt x="39" y="22"/>
                  </a:moveTo>
                  <a:lnTo>
                    <a:pt x="39" y="22"/>
                  </a:lnTo>
                  <a:lnTo>
                    <a:pt x="17" y="5"/>
                  </a:lnTo>
                  <a:lnTo>
                    <a:pt x="21" y="5"/>
                  </a:lnTo>
                  <a:lnTo>
                    <a:pt x="4" y="22"/>
                  </a:lnTo>
                  <a:lnTo>
                    <a:pt x="4" y="22"/>
                  </a:lnTo>
                  <a:lnTo>
                    <a:pt x="21" y="39"/>
                  </a:lnTo>
                  <a:lnTo>
                    <a:pt x="17" y="39"/>
                  </a:lnTo>
                  <a:lnTo>
                    <a:pt x="39" y="22"/>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84" name="Freeform 478"/>
            <p:cNvSpPr/>
            <p:nvPr/>
          </p:nvSpPr>
          <p:spPr>
            <a:xfrm>
              <a:off x="2305080" y="3670560"/>
              <a:ext cx="72360" cy="60120"/>
            </a:xfrm>
            <a:custGeom>
              <a:avLst/>
              <a:gdLst>
                <a:gd name="textAreaLeft" fmla="*/ 0 w 72360"/>
                <a:gd name="textAreaRight" fmla="*/ 72720 w 72360"/>
                <a:gd name="textAreaTop" fmla="*/ 0 h 60120"/>
                <a:gd name="textAreaBottom" fmla="*/ 60480 h 60120"/>
              </a:gdLst>
              <a:ahLst/>
              <a:rect l="textAreaLeft" t="textAreaTop" r="textAreaRight" b="textAreaBottom"/>
              <a:pathLst>
                <a:path w="39" h="38">
                  <a:moveTo>
                    <a:pt x="21" y="38"/>
                  </a:moveTo>
                  <a:lnTo>
                    <a:pt x="0" y="17"/>
                  </a:lnTo>
                  <a:lnTo>
                    <a:pt x="21" y="0"/>
                  </a:lnTo>
                  <a:lnTo>
                    <a:pt x="39" y="17"/>
                  </a:lnTo>
                  <a:lnTo>
                    <a:pt x="21" y="38"/>
                  </a:lnTo>
                  <a:close/>
                </a:path>
              </a:pathLst>
            </a:custGeom>
            <a:solidFill>
              <a:srgbClr val="4f81bd"/>
            </a:solidFill>
            <a:ln w="0">
              <a:no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285" name="Freeform 479"/>
            <p:cNvSpPr/>
            <p:nvPr/>
          </p:nvSpPr>
          <p:spPr>
            <a:xfrm>
              <a:off x="2305080" y="3662640"/>
              <a:ext cx="79920" cy="68040"/>
            </a:xfrm>
            <a:custGeom>
              <a:avLst/>
              <a:gdLst>
                <a:gd name="textAreaLeft" fmla="*/ 0 w 79920"/>
                <a:gd name="textAreaRight" fmla="*/ 80280 w 79920"/>
                <a:gd name="textAreaTop" fmla="*/ 0 h 68040"/>
                <a:gd name="textAreaBottom" fmla="*/ 68400 h 68040"/>
              </a:gdLst>
              <a:ahLst/>
              <a:rect l="textAreaLeft" t="textAreaTop" r="textAreaRight" b="textAreaBottom"/>
              <a:pathLst>
                <a:path w="43" h="43">
                  <a:moveTo>
                    <a:pt x="21" y="43"/>
                  </a:moveTo>
                  <a:lnTo>
                    <a:pt x="17" y="43"/>
                  </a:lnTo>
                  <a:lnTo>
                    <a:pt x="0" y="22"/>
                  </a:lnTo>
                  <a:lnTo>
                    <a:pt x="0" y="22"/>
                  </a:lnTo>
                  <a:lnTo>
                    <a:pt x="17" y="0"/>
                  </a:lnTo>
                  <a:lnTo>
                    <a:pt x="21" y="0"/>
                  </a:lnTo>
                  <a:lnTo>
                    <a:pt x="43" y="22"/>
                  </a:lnTo>
                  <a:lnTo>
                    <a:pt x="43" y="22"/>
                  </a:lnTo>
                  <a:lnTo>
                    <a:pt x="21" y="43"/>
                  </a:lnTo>
                  <a:close/>
                  <a:moveTo>
                    <a:pt x="39" y="22"/>
                  </a:moveTo>
                  <a:lnTo>
                    <a:pt x="39" y="22"/>
                  </a:lnTo>
                  <a:lnTo>
                    <a:pt x="17" y="5"/>
                  </a:lnTo>
                  <a:lnTo>
                    <a:pt x="21" y="5"/>
                  </a:lnTo>
                  <a:lnTo>
                    <a:pt x="4" y="22"/>
                  </a:lnTo>
                  <a:lnTo>
                    <a:pt x="4" y="22"/>
                  </a:lnTo>
                  <a:lnTo>
                    <a:pt x="21" y="39"/>
                  </a:lnTo>
                  <a:lnTo>
                    <a:pt x="17" y="39"/>
                  </a:lnTo>
                  <a:lnTo>
                    <a:pt x="39" y="22"/>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86" name="Freeform 480"/>
            <p:cNvSpPr/>
            <p:nvPr/>
          </p:nvSpPr>
          <p:spPr>
            <a:xfrm>
              <a:off x="2305080" y="3670560"/>
              <a:ext cx="72360" cy="60120"/>
            </a:xfrm>
            <a:custGeom>
              <a:avLst/>
              <a:gdLst>
                <a:gd name="textAreaLeft" fmla="*/ 0 w 72360"/>
                <a:gd name="textAreaRight" fmla="*/ 72720 w 72360"/>
                <a:gd name="textAreaTop" fmla="*/ 0 h 60120"/>
                <a:gd name="textAreaBottom" fmla="*/ 60480 h 60120"/>
              </a:gdLst>
              <a:ahLst/>
              <a:rect l="textAreaLeft" t="textAreaTop" r="textAreaRight" b="textAreaBottom"/>
              <a:pathLst>
                <a:path w="39" h="38">
                  <a:moveTo>
                    <a:pt x="21" y="38"/>
                  </a:moveTo>
                  <a:lnTo>
                    <a:pt x="0" y="17"/>
                  </a:lnTo>
                  <a:lnTo>
                    <a:pt x="21" y="0"/>
                  </a:lnTo>
                  <a:lnTo>
                    <a:pt x="39" y="17"/>
                  </a:lnTo>
                  <a:lnTo>
                    <a:pt x="21" y="38"/>
                  </a:lnTo>
                  <a:close/>
                </a:path>
              </a:pathLst>
            </a:custGeom>
            <a:solidFill>
              <a:srgbClr val="4f81bd"/>
            </a:solidFill>
            <a:ln w="0">
              <a:no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287" name="Freeform 481"/>
            <p:cNvSpPr/>
            <p:nvPr/>
          </p:nvSpPr>
          <p:spPr>
            <a:xfrm>
              <a:off x="2305080" y="3662640"/>
              <a:ext cx="79920" cy="68040"/>
            </a:xfrm>
            <a:custGeom>
              <a:avLst/>
              <a:gdLst>
                <a:gd name="textAreaLeft" fmla="*/ 0 w 79920"/>
                <a:gd name="textAreaRight" fmla="*/ 80280 w 79920"/>
                <a:gd name="textAreaTop" fmla="*/ 0 h 68040"/>
                <a:gd name="textAreaBottom" fmla="*/ 68400 h 68040"/>
              </a:gdLst>
              <a:ahLst/>
              <a:rect l="textAreaLeft" t="textAreaTop" r="textAreaRight" b="textAreaBottom"/>
              <a:pathLst>
                <a:path w="43" h="43">
                  <a:moveTo>
                    <a:pt x="21" y="43"/>
                  </a:moveTo>
                  <a:lnTo>
                    <a:pt x="17" y="43"/>
                  </a:lnTo>
                  <a:lnTo>
                    <a:pt x="0" y="22"/>
                  </a:lnTo>
                  <a:lnTo>
                    <a:pt x="0" y="22"/>
                  </a:lnTo>
                  <a:lnTo>
                    <a:pt x="17" y="0"/>
                  </a:lnTo>
                  <a:lnTo>
                    <a:pt x="21" y="0"/>
                  </a:lnTo>
                  <a:lnTo>
                    <a:pt x="43" y="22"/>
                  </a:lnTo>
                  <a:lnTo>
                    <a:pt x="43" y="22"/>
                  </a:lnTo>
                  <a:lnTo>
                    <a:pt x="21" y="43"/>
                  </a:lnTo>
                  <a:close/>
                  <a:moveTo>
                    <a:pt x="39" y="22"/>
                  </a:moveTo>
                  <a:lnTo>
                    <a:pt x="39" y="22"/>
                  </a:lnTo>
                  <a:lnTo>
                    <a:pt x="17" y="5"/>
                  </a:lnTo>
                  <a:lnTo>
                    <a:pt x="21" y="5"/>
                  </a:lnTo>
                  <a:lnTo>
                    <a:pt x="4" y="22"/>
                  </a:lnTo>
                  <a:lnTo>
                    <a:pt x="4" y="22"/>
                  </a:lnTo>
                  <a:lnTo>
                    <a:pt x="21" y="39"/>
                  </a:lnTo>
                  <a:lnTo>
                    <a:pt x="17" y="39"/>
                  </a:lnTo>
                  <a:lnTo>
                    <a:pt x="39" y="22"/>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88" name="Freeform 482"/>
            <p:cNvSpPr/>
            <p:nvPr/>
          </p:nvSpPr>
          <p:spPr>
            <a:xfrm>
              <a:off x="2305080" y="3670560"/>
              <a:ext cx="72360" cy="60120"/>
            </a:xfrm>
            <a:custGeom>
              <a:avLst/>
              <a:gdLst>
                <a:gd name="textAreaLeft" fmla="*/ 0 w 72360"/>
                <a:gd name="textAreaRight" fmla="*/ 72720 w 72360"/>
                <a:gd name="textAreaTop" fmla="*/ 0 h 60120"/>
                <a:gd name="textAreaBottom" fmla="*/ 60480 h 60120"/>
              </a:gdLst>
              <a:ahLst/>
              <a:rect l="textAreaLeft" t="textAreaTop" r="textAreaRight" b="textAreaBottom"/>
              <a:pathLst>
                <a:path w="39" h="38">
                  <a:moveTo>
                    <a:pt x="21" y="38"/>
                  </a:moveTo>
                  <a:lnTo>
                    <a:pt x="0" y="17"/>
                  </a:lnTo>
                  <a:lnTo>
                    <a:pt x="21" y="0"/>
                  </a:lnTo>
                  <a:lnTo>
                    <a:pt x="39" y="17"/>
                  </a:lnTo>
                  <a:lnTo>
                    <a:pt x="21" y="38"/>
                  </a:lnTo>
                  <a:close/>
                </a:path>
              </a:pathLst>
            </a:custGeom>
            <a:solidFill>
              <a:srgbClr val="4f81bd"/>
            </a:solidFill>
            <a:ln w="0">
              <a:no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289" name="Freeform 483"/>
            <p:cNvSpPr/>
            <p:nvPr/>
          </p:nvSpPr>
          <p:spPr>
            <a:xfrm>
              <a:off x="2305080" y="3662640"/>
              <a:ext cx="79920" cy="68040"/>
            </a:xfrm>
            <a:custGeom>
              <a:avLst/>
              <a:gdLst>
                <a:gd name="textAreaLeft" fmla="*/ 0 w 79920"/>
                <a:gd name="textAreaRight" fmla="*/ 80280 w 79920"/>
                <a:gd name="textAreaTop" fmla="*/ 0 h 68040"/>
                <a:gd name="textAreaBottom" fmla="*/ 68400 h 68040"/>
              </a:gdLst>
              <a:ahLst/>
              <a:rect l="textAreaLeft" t="textAreaTop" r="textAreaRight" b="textAreaBottom"/>
              <a:pathLst>
                <a:path w="43" h="43">
                  <a:moveTo>
                    <a:pt x="21" y="43"/>
                  </a:moveTo>
                  <a:lnTo>
                    <a:pt x="17" y="43"/>
                  </a:lnTo>
                  <a:lnTo>
                    <a:pt x="0" y="22"/>
                  </a:lnTo>
                  <a:lnTo>
                    <a:pt x="0" y="22"/>
                  </a:lnTo>
                  <a:lnTo>
                    <a:pt x="17" y="0"/>
                  </a:lnTo>
                  <a:lnTo>
                    <a:pt x="21" y="0"/>
                  </a:lnTo>
                  <a:lnTo>
                    <a:pt x="43" y="22"/>
                  </a:lnTo>
                  <a:lnTo>
                    <a:pt x="43" y="22"/>
                  </a:lnTo>
                  <a:lnTo>
                    <a:pt x="21" y="43"/>
                  </a:lnTo>
                  <a:close/>
                  <a:moveTo>
                    <a:pt x="39" y="22"/>
                  </a:moveTo>
                  <a:lnTo>
                    <a:pt x="39" y="22"/>
                  </a:lnTo>
                  <a:lnTo>
                    <a:pt x="17" y="5"/>
                  </a:lnTo>
                  <a:lnTo>
                    <a:pt x="21" y="5"/>
                  </a:lnTo>
                  <a:lnTo>
                    <a:pt x="4" y="22"/>
                  </a:lnTo>
                  <a:lnTo>
                    <a:pt x="4" y="22"/>
                  </a:lnTo>
                  <a:lnTo>
                    <a:pt x="21" y="39"/>
                  </a:lnTo>
                  <a:lnTo>
                    <a:pt x="17" y="39"/>
                  </a:lnTo>
                  <a:lnTo>
                    <a:pt x="39" y="22"/>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90" name="Freeform 484"/>
            <p:cNvSpPr/>
            <p:nvPr/>
          </p:nvSpPr>
          <p:spPr>
            <a:xfrm>
              <a:off x="2305080" y="3670560"/>
              <a:ext cx="72360" cy="60120"/>
            </a:xfrm>
            <a:custGeom>
              <a:avLst/>
              <a:gdLst>
                <a:gd name="textAreaLeft" fmla="*/ 0 w 72360"/>
                <a:gd name="textAreaRight" fmla="*/ 72720 w 72360"/>
                <a:gd name="textAreaTop" fmla="*/ 0 h 60120"/>
                <a:gd name="textAreaBottom" fmla="*/ 60480 h 60120"/>
              </a:gdLst>
              <a:ahLst/>
              <a:rect l="textAreaLeft" t="textAreaTop" r="textAreaRight" b="textAreaBottom"/>
              <a:pathLst>
                <a:path w="39" h="38">
                  <a:moveTo>
                    <a:pt x="21" y="38"/>
                  </a:moveTo>
                  <a:lnTo>
                    <a:pt x="0" y="17"/>
                  </a:lnTo>
                  <a:lnTo>
                    <a:pt x="21" y="0"/>
                  </a:lnTo>
                  <a:lnTo>
                    <a:pt x="39" y="17"/>
                  </a:lnTo>
                  <a:lnTo>
                    <a:pt x="21" y="38"/>
                  </a:lnTo>
                  <a:close/>
                </a:path>
              </a:pathLst>
            </a:custGeom>
            <a:solidFill>
              <a:srgbClr val="4f81bd"/>
            </a:solidFill>
            <a:ln w="0">
              <a:no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291" name="Freeform 485"/>
            <p:cNvSpPr/>
            <p:nvPr/>
          </p:nvSpPr>
          <p:spPr>
            <a:xfrm>
              <a:off x="2305080" y="3662640"/>
              <a:ext cx="79920" cy="68040"/>
            </a:xfrm>
            <a:custGeom>
              <a:avLst/>
              <a:gdLst>
                <a:gd name="textAreaLeft" fmla="*/ 0 w 79920"/>
                <a:gd name="textAreaRight" fmla="*/ 80280 w 79920"/>
                <a:gd name="textAreaTop" fmla="*/ 0 h 68040"/>
                <a:gd name="textAreaBottom" fmla="*/ 68400 h 68040"/>
              </a:gdLst>
              <a:ahLst/>
              <a:rect l="textAreaLeft" t="textAreaTop" r="textAreaRight" b="textAreaBottom"/>
              <a:pathLst>
                <a:path w="43" h="43">
                  <a:moveTo>
                    <a:pt x="21" y="43"/>
                  </a:moveTo>
                  <a:lnTo>
                    <a:pt x="17" y="43"/>
                  </a:lnTo>
                  <a:lnTo>
                    <a:pt x="0" y="22"/>
                  </a:lnTo>
                  <a:lnTo>
                    <a:pt x="0" y="22"/>
                  </a:lnTo>
                  <a:lnTo>
                    <a:pt x="17" y="0"/>
                  </a:lnTo>
                  <a:lnTo>
                    <a:pt x="21" y="0"/>
                  </a:lnTo>
                  <a:lnTo>
                    <a:pt x="43" y="22"/>
                  </a:lnTo>
                  <a:lnTo>
                    <a:pt x="43" y="22"/>
                  </a:lnTo>
                  <a:lnTo>
                    <a:pt x="21" y="43"/>
                  </a:lnTo>
                  <a:close/>
                  <a:moveTo>
                    <a:pt x="39" y="22"/>
                  </a:moveTo>
                  <a:lnTo>
                    <a:pt x="39" y="22"/>
                  </a:lnTo>
                  <a:lnTo>
                    <a:pt x="17" y="5"/>
                  </a:lnTo>
                  <a:lnTo>
                    <a:pt x="21" y="5"/>
                  </a:lnTo>
                  <a:lnTo>
                    <a:pt x="4" y="22"/>
                  </a:lnTo>
                  <a:lnTo>
                    <a:pt x="4" y="22"/>
                  </a:lnTo>
                  <a:lnTo>
                    <a:pt x="21" y="39"/>
                  </a:lnTo>
                  <a:lnTo>
                    <a:pt x="17" y="39"/>
                  </a:lnTo>
                  <a:lnTo>
                    <a:pt x="39" y="22"/>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92" name="Freeform 486"/>
            <p:cNvSpPr/>
            <p:nvPr/>
          </p:nvSpPr>
          <p:spPr>
            <a:xfrm>
              <a:off x="2305080" y="3670560"/>
              <a:ext cx="72360" cy="60120"/>
            </a:xfrm>
            <a:custGeom>
              <a:avLst/>
              <a:gdLst>
                <a:gd name="textAreaLeft" fmla="*/ 0 w 72360"/>
                <a:gd name="textAreaRight" fmla="*/ 72720 w 72360"/>
                <a:gd name="textAreaTop" fmla="*/ 0 h 60120"/>
                <a:gd name="textAreaBottom" fmla="*/ 60480 h 60120"/>
              </a:gdLst>
              <a:ahLst/>
              <a:rect l="textAreaLeft" t="textAreaTop" r="textAreaRight" b="textAreaBottom"/>
              <a:pathLst>
                <a:path w="39" h="38">
                  <a:moveTo>
                    <a:pt x="21" y="38"/>
                  </a:moveTo>
                  <a:lnTo>
                    <a:pt x="0" y="17"/>
                  </a:lnTo>
                  <a:lnTo>
                    <a:pt x="21" y="0"/>
                  </a:lnTo>
                  <a:lnTo>
                    <a:pt x="39" y="17"/>
                  </a:lnTo>
                  <a:lnTo>
                    <a:pt x="21" y="38"/>
                  </a:lnTo>
                  <a:close/>
                </a:path>
              </a:pathLst>
            </a:custGeom>
            <a:solidFill>
              <a:srgbClr val="4f81bd"/>
            </a:solidFill>
            <a:ln w="0">
              <a:no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293" name="Freeform 487"/>
            <p:cNvSpPr/>
            <p:nvPr/>
          </p:nvSpPr>
          <p:spPr>
            <a:xfrm>
              <a:off x="2305080" y="3662640"/>
              <a:ext cx="79920" cy="68040"/>
            </a:xfrm>
            <a:custGeom>
              <a:avLst/>
              <a:gdLst>
                <a:gd name="textAreaLeft" fmla="*/ 0 w 79920"/>
                <a:gd name="textAreaRight" fmla="*/ 80280 w 79920"/>
                <a:gd name="textAreaTop" fmla="*/ 0 h 68040"/>
                <a:gd name="textAreaBottom" fmla="*/ 68400 h 68040"/>
              </a:gdLst>
              <a:ahLst/>
              <a:rect l="textAreaLeft" t="textAreaTop" r="textAreaRight" b="textAreaBottom"/>
              <a:pathLst>
                <a:path w="43" h="43">
                  <a:moveTo>
                    <a:pt x="21" y="43"/>
                  </a:moveTo>
                  <a:lnTo>
                    <a:pt x="17" y="43"/>
                  </a:lnTo>
                  <a:lnTo>
                    <a:pt x="0" y="22"/>
                  </a:lnTo>
                  <a:lnTo>
                    <a:pt x="0" y="22"/>
                  </a:lnTo>
                  <a:lnTo>
                    <a:pt x="17" y="0"/>
                  </a:lnTo>
                  <a:lnTo>
                    <a:pt x="21" y="0"/>
                  </a:lnTo>
                  <a:lnTo>
                    <a:pt x="43" y="22"/>
                  </a:lnTo>
                  <a:lnTo>
                    <a:pt x="43" y="22"/>
                  </a:lnTo>
                  <a:lnTo>
                    <a:pt x="21" y="43"/>
                  </a:lnTo>
                  <a:close/>
                  <a:moveTo>
                    <a:pt x="39" y="22"/>
                  </a:moveTo>
                  <a:lnTo>
                    <a:pt x="39" y="22"/>
                  </a:lnTo>
                  <a:lnTo>
                    <a:pt x="17" y="5"/>
                  </a:lnTo>
                  <a:lnTo>
                    <a:pt x="21" y="5"/>
                  </a:lnTo>
                  <a:lnTo>
                    <a:pt x="4" y="22"/>
                  </a:lnTo>
                  <a:lnTo>
                    <a:pt x="4" y="22"/>
                  </a:lnTo>
                  <a:lnTo>
                    <a:pt x="21" y="39"/>
                  </a:lnTo>
                  <a:lnTo>
                    <a:pt x="17" y="39"/>
                  </a:lnTo>
                  <a:lnTo>
                    <a:pt x="39" y="22"/>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94" name="Freeform 488"/>
            <p:cNvSpPr/>
            <p:nvPr/>
          </p:nvSpPr>
          <p:spPr>
            <a:xfrm>
              <a:off x="2305080" y="3670560"/>
              <a:ext cx="72360" cy="60120"/>
            </a:xfrm>
            <a:custGeom>
              <a:avLst/>
              <a:gdLst>
                <a:gd name="textAreaLeft" fmla="*/ 0 w 72360"/>
                <a:gd name="textAreaRight" fmla="*/ 72720 w 72360"/>
                <a:gd name="textAreaTop" fmla="*/ 0 h 60120"/>
                <a:gd name="textAreaBottom" fmla="*/ 60480 h 60120"/>
              </a:gdLst>
              <a:ahLst/>
              <a:rect l="textAreaLeft" t="textAreaTop" r="textAreaRight" b="textAreaBottom"/>
              <a:pathLst>
                <a:path w="39" h="38">
                  <a:moveTo>
                    <a:pt x="21" y="38"/>
                  </a:moveTo>
                  <a:lnTo>
                    <a:pt x="0" y="17"/>
                  </a:lnTo>
                  <a:lnTo>
                    <a:pt x="21" y="0"/>
                  </a:lnTo>
                  <a:lnTo>
                    <a:pt x="39" y="17"/>
                  </a:lnTo>
                  <a:lnTo>
                    <a:pt x="21" y="38"/>
                  </a:lnTo>
                  <a:close/>
                </a:path>
              </a:pathLst>
            </a:custGeom>
            <a:solidFill>
              <a:srgbClr val="4f81bd"/>
            </a:solidFill>
            <a:ln w="0">
              <a:no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295" name="Freeform 489"/>
            <p:cNvSpPr/>
            <p:nvPr/>
          </p:nvSpPr>
          <p:spPr>
            <a:xfrm>
              <a:off x="2305080" y="3662640"/>
              <a:ext cx="79920" cy="68040"/>
            </a:xfrm>
            <a:custGeom>
              <a:avLst/>
              <a:gdLst>
                <a:gd name="textAreaLeft" fmla="*/ 0 w 79920"/>
                <a:gd name="textAreaRight" fmla="*/ 80280 w 79920"/>
                <a:gd name="textAreaTop" fmla="*/ 0 h 68040"/>
                <a:gd name="textAreaBottom" fmla="*/ 68400 h 68040"/>
              </a:gdLst>
              <a:ahLst/>
              <a:rect l="textAreaLeft" t="textAreaTop" r="textAreaRight" b="textAreaBottom"/>
              <a:pathLst>
                <a:path w="43" h="43">
                  <a:moveTo>
                    <a:pt x="21" y="43"/>
                  </a:moveTo>
                  <a:lnTo>
                    <a:pt x="17" y="43"/>
                  </a:lnTo>
                  <a:lnTo>
                    <a:pt x="0" y="22"/>
                  </a:lnTo>
                  <a:lnTo>
                    <a:pt x="0" y="22"/>
                  </a:lnTo>
                  <a:lnTo>
                    <a:pt x="17" y="0"/>
                  </a:lnTo>
                  <a:lnTo>
                    <a:pt x="21" y="0"/>
                  </a:lnTo>
                  <a:lnTo>
                    <a:pt x="43" y="22"/>
                  </a:lnTo>
                  <a:lnTo>
                    <a:pt x="43" y="22"/>
                  </a:lnTo>
                  <a:lnTo>
                    <a:pt x="21" y="43"/>
                  </a:lnTo>
                  <a:close/>
                  <a:moveTo>
                    <a:pt x="39" y="22"/>
                  </a:moveTo>
                  <a:lnTo>
                    <a:pt x="39" y="22"/>
                  </a:lnTo>
                  <a:lnTo>
                    <a:pt x="17" y="5"/>
                  </a:lnTo>
                  <a:lnTo>
                    <a:pt x="21" y="5"/>
                  </a:lnTo>
                  <a:lnTo>
                    <a:pt x="4" y="22"/>
                  </a:lnTo>
                  <a:lnTo>
                    <a:pt x="4" y="22"/>
                  </a:lnTo>
                  <a:lnTo>
                    <a:pt x="21" y="39"/>
                  </a:lnTo>
                  <a:lnTo>
                    <a:pt x="17" y="39"/>
                  </a:lnTo>
                  <a:lnTo>
                    <a:pt x="39" y="22"/>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96" name="Freeform 490"/>
            <p:cNvSpPr/>
            <p:nvPr/>
          </p:nvSpPr>
          <p:spPr>
            <a:xfrm>
              <a:off x="2305080" y="3670560"/>
              <a:ext cx="72360" cy="60120"/>
            </a:xfrm>
            <a:custGeom>
              <a:avLst/>
              <a:gdLst>
                <a:gd name="textAreaLeft" fmla="*/ 0 w 72360"/>
                <a:gd name="textAreaRight" fmla="*/ 72720 w 72360"/>
                <a:gd name="textAreaTop" fmla="*/ 0 h 60120"/>
                <a:gd name="textAreaBottom" fmla="*/ 60480 h 60120"/>
              </a:gdLst>
              <a:ahLst/>
              <a:rect l="textAreaLeft" t="textAreaTop" r="textAreaRight" b="textAreaBottom"/>
              <a:pathLst>
                <a:path w="39" h="38">
                  <a:moveTo>
                    <a:pt x="21" y="38"/>
                  </a:moveTo>
                  <a:lnTo>
                    <a:pt x="0" y="17"/>
                  </a:lnTo>
                  <a:lnTo>
                    <a:pt x="21" y="0"/>
                  </a:lnTo>
                  <a:lnTo>
                    <a:pt x="39" y="17"/>
                  </a:lnTo>
                  <a:lnTo>
                    <a:pt x="21" y="38"/>
                  </a:lnTo>
                  <a:close/>
                </a:path>
              </a:pathLst>
            </a:custGeom>
            <a:solidFill>
              <a:srgbClr val="4f81bd"/>
            </a:solidFill>
            <a:ln w="0">
              <a:no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297" name="Freeform 491"/>
            <p:cNvSpPr/>
            <p:nvPr/>
          </p:nvSpPr>
          <p:spPr>
            <a:xfrm>
              <a:off x="2305080" y="3662640"/>
              <a:ext cx="79920" cy="68040"/>
            </a:xfrm>
            <a:custGeom>
              <a:avLst/>
              <a:gdLst>
                <a:gd name="textAreaLeft" fmla="*/ 0 w 79920"/>
                <a:gd name="textAreaRight" fmla="*/ 80280 w 79920"/>
                <a:gd name="textAreaTop" fmla="*/ 0 h 68040"/>
                <a:gd name="textAreaBottom" fmla="*/ 68400 h 68040"/>
              </a:gdLst>
              <a:ahLst/>
              <a:rect l="textAreaLeft" t="textAreaTop" r="textAreaRight" b="textAreaBottom"/>
              <a:pathLst>
                <a:path w="43" h="43">
                  <a:moveTo>
                    <a:pt x="21" y="43"/>
                  </a:moveTo>
                  <a:lnTo>
                    <a:pt x="17" y="43"/>
                  </a:lnTo>
                  <a:lnTo>
                    <a:pt x="0" y="22"/>
                  </a:lnTo>
                  <a:lnTo>
                    <a:pt x="0" y="22"/>
                  </a:lnTo>
                  <a:lnTo>
                    <a:pt x="17" y="0"/>
                  </a:lnTo>
                  <a:lnTo>
                    <a:pt x="21" y="0"/>
                  </a:lnTo>
                  <a:lnTo>
                    <a:pt x="43" y="22"/>
                  </a:lnTo>
                  <a:lnTo>
                    <a:pt x="43" y="22"/>
                  </a:lnTo>
                  <a:lnTo>
                    <a:pt x="21" y="43"/>
                  </a:lnTo>
                  <a:close/>
                  <a:moveTo>
                    <a:pt x="39" y="22"/>
                  </a:moveTo>
                  <a:lnTo>
                    <a:pt x="39" y="22"/>
                  </a:lnTo>
                  <a:lnTo>
                    <a:pt x="17" y="5"/>
                  </a:lnTo>
                  <a:lnTo>
                    <a:pt x="21" y="5"/>
                  </a:lnTo>
                  <a:lnTo>
                    <a:pt x="4" y="22"/>
                  </a:lnTo>
                  <a:lnTo>
                    <a:pt x="4" y="22"/>
                  </a:lnTo>
                  <a:lnTo>
                    <a:pt x="21" y="39"/>
                  </a:lnTo>
                  <a:lnTo>
                    <a:pt x="17" y="39"/>
                  </a:lnTo>
                  <a:lnTo>
                    <a:pt x="39" y="22"/>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298" name="Freeform 492"/>
            <p:cNvSpPr/>
            <p:nvPr/>
          </p:nvSpPr>
          <p:spPr>
            <a:xfrm>
              <a:off x="4501440" y="2914560"/>
              <a:ext cx="72360" cy="61920"/>
            </a:xfrm>
            <a:custGeom>
              <a:avLst/>
              <a:gdLst>
                <a:gd name="textAreaLeft" fmla="*/ 0 w 72360"/>
                <a:gd name="textAreaRight" fmla="*/ 72720 w 72360"/>
                <a:gd name="textAreaTop" fmla="*/ 0 h 61920"/>
                <a:gd name="textAreaBottom" fmla="*/ 62280 h 61920"/>
              </a:gdLst>
              <a:ahLst/>
              <a:rect l="textAreaLeft" t="textAreaTop" r="textAreaRight" b="textAreaBottom"/>
              <a:pathLst>
                <a:path w="39" h="39">
                  <a:moveTo>
                    <a:pt x="21" y="39"/>
                  </a:moveTo>
                  <a:lnTo>
                    <a:pt x="0" y="22"/>
                  </a:lnTo>
                  <a:lnTo>
                    <a:pt x="21" y="0"/>
                  </a:lnTo>
                  <a:lnTo>
                    <a:pt x="39" y="22"/>
                  </a:lnTo>
                  <a:lnTo>
                    <a:pt x="21" y="39"/>
                  </a:lnTo>
                  <a:close/>
                </a:path>
              </a:pathLst>
            </a:custGeom>
            <a:solidFill>
              <a:srgbClr val="4f81bd"/>
            </a:solidFill>
            <a:ln w="0">
              <a:no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299" name="Freeform 493"/>
            <p:cNvSpPr/>
            <p:nvPr/>
          </p:nvSpPr>
          <p:spPr>
            <a:xfrm>
              <a:off x="4501440" y="2914560"/>
              <a:ext cx="79920" cy="69840"/>
            </a:xfrm>
            <a:custGeom>
              <a:avLst/>
              <a:gdLst>
                <a:gd name="textAreaLeft" fmla="*/ 0 w 79920"/>
                <a:gd name="textAreaRight" fmla="*/ 80280 w 79920"/>
                <a:gd name="textAreaTop" fmla="*/ 0 h 69840"/>
                <a:gd name="textAreaBottom" fmla="*/ 70200 h 69840"/>
              </a:gdLst>
              <a:ahLst/>
              <a:rect l="textAreaLeft" t="textAreaTop" r="textAreaRight" b="textAreaBottom"/>
              <a:pathLst>
                <a:path w="43" h="44">
                  <a:moveTo>
                    <a:pt x="21" y="44"/>
                  </a:moveTo>
                  <a:lnTo>
                    <a:pt x="17" y="44"/>
                  </a:lnTo>
                  <a:lnTo>
                    <a:pt x="0" y="22"/>
                  </a:lnTo>
                  <a:lnTo>
                    <a:pt x="0" y="18"/>
                  </a:lnTo>
                  <a:lnTo>
                    <a:pt x="17" y="0"/>
                  </a:lnTo>
                  <a:lnTo>
                    <a:pt x="21" y="0"/>
                  </a:lnTo>
                  <a:lnTo>
                    <a:pt x="43" y="18"/>
                  </a:lnTo>
                  <a:lnTo>
                    <a:pt x="43" y="22"/>
                  </a:lnTo>
                  <a:lnTo>
                    <a:pt x="21" y="44"/>
                  </a:lnTo>
                  <a:close/>
                  <a:moveTo>
                    <a:pt x="39" y="18"/>
                  </a:moveTo>
                  <a:lnTo>
                    <a:pt x="39" y="22"/>
                  </a:lnTo>
                  <a:lnTo>
                    <a:pt x="17" y="5"/>
                  </a:lnTo>
                  <a:lnTo>
                    <a:pt x="21" y="5"/>
                  </a:lnTo>
                  <a:lnTo>
                    <a:pt x="4" y="22"/>
                  </a:lnTo>
                  <a:lnTo>
                    <a:pt x="4" y="18"/>
                  </a:lnTo>
                  <a:lnTo>
                    <a:pt x="21" y="39"/>
                  </a:lnTo>
                  <a:lnTo>
                    <a:pt x="17" y="39"/>
                  </a:lnTo>
                  <a:lnTo>
                    <a:pt x="39" y="18"/>
                  </a:lnTo>
                  <a:close/>
                </a:path>
              </a:pathLst>
            </a:custGeom>
            <a:solidFill>
              <a:srgbClr val="4a7ebb"/>
            </a:solidFill>
            <a:ln w="0">
              <a:solidFill>
                <a:srgbClr val="4a7ebb"/>
              </a:solidFill>
            </a:ln>
          </p:spPr>
          <p:style>
            <a:lnRef idx="0"/>
            <a:fillRef idx="0"/>
            <a:effectRef idx="0"/>
            <a:fontRef idx="minor"/>
          </p:style>
          <p:txBody>
            <a:bodyPr tIns="24480" bIns="24480" anchor="t">
              <a:noAutofit/>
            </a:bodyPr>
            <a:p>
              <a:endParaRPr b="0" lang="en-US" sz="1800" spc="-1" strike="noStrike">
                <a:solidFill>
                  <a:srgbClr val="000000"/>
                </a:solidFill>
                <a:latin typeface="Calibri"/>
              </a:endParaRPr>
            </a:p>
          </p:txBody>
        </p:sp>
        <p:sp>
          <p:nvSpPr>
            <p:cNvPr id="300" name="Freeform 494"/>
            <p:cNvSpPr/>
            <p:nvPr/>
          </p:nvSpPr>
          <p:spPr>
            <a:xfrm>
              <a:off x="4259160" y="3402000"/>
              <a:ext cx="72360" cy="61920"/>
            </a:xfrm>
            <a:custGeom>
              <a:avLst/>
              <a:gdLst>
                <a:gd name="textAreaLeft" fmla="*/ 0 w 72360"/>
                <a:gd name="textAreaRight" fmla="*/ 72720 w 72360"/>
                <a:gd name="textAreaTop" fmla="*/ 0 h 61920"/>
                <a:gd name="textAreaBottom" fmla="*/ 62280 h 61920"/>
              </a:gdLst>
              <a:ahLst/>
              <a:rect l="textAreaLeft" t="textAreaTop" r="textAreaRight" b="textAreaBottom"/>
              <a:pathLst>
                <a:path w="39" h="39">
                  <a:moveTo>
                    <a:pt x="18" y="39"/>
                  </a:moveTo>
                  <a:lnTo>
                    <a:pt x="0" y="17"/>
                  </a:lnTo>
                  <a:lnTo>
                    <a:pt x="18" y="0"/>
                  </a:lnTo>
                  <a:lnTo>
                    <a:pt x="39" y="17"/>
                  </a:lnTo>
                  <a:lnTo>
                    <a:pt x="18" y="39"/>
                  </a:lnTo>
                  <a:close/>
                </a:path>
              </a:pathLst>
            </a:custGeom>
            <a:solidFill>
              <a:srgbClr val="4f81bd"/>
            </a:solidFill>
            <a:ln w="0">
              <a:no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301" name="Freeform 495"/>
            <p:cNvSpPr/>
            <p:nvPr/>
          </p:nvSpPr>
          <p:spPr>
            <a:xfrm>
              <a:off x="4251960" y="3395520"/>
              <a:ext cx="79920" cy="68040"/>
            </a:xfrm>
            <a:custGeom>
              <a:avLst/>
              <a:gdLst>
                <a:gd name="textAreaLeft" fmla="*/ 0 w 79920"/>
                <a:gd name="textAreaRight" fmla="*/ 80280 w 79920"/>
                <a:gd name="textAreaTop" fmla="*/ 0 h 68040"/>
                <a:gd name="textAreaBottom" fmla="*/ 68400 h 68040"/>
              </a:gdLst>
              <a:ahLst/>
              <a:rect l="textAreaLeft" t="textAreaTop" r="textAreaRight" b="textAreaBottom"/>
              <a:pathLst>
                <a:path w="43" h="43">
                  <a:moveTo>
                    <a:pt x="22" y="43"/>
                  </a:moveTo>
                  <a:lnTo>
                    <a:pt x="22" y="43"/>
                  </a:lnTo>
                  <a:lnTo>
                    <a:pt x="0" y="26"/>
                  </a:lnTo>
                  <a:lnTo>
                    <a:pt x="0" y="21"/>
                  </a:lnTo>
                  <a:lnTo>
                    <a:pt x="22" y="0"/>
                  </a:lnTo>
                  <a:lnTo>
                    <a:pt x="22" y="0"/>
                  </a:lnTo>
                  <a:lnTo>
                    <a:pt x="43" y="21"/>
                  </a:lnTo>
                  <a:lnTo>
                    <a:pt x="43" y="26"/>
                  </a:lnTo>
                  <a:lnTo>
                    <a:pt x="22" y="43"/>
                  </a:lnTo>
                  <a:close/>
                  <a:moveTo>
                    <a:pt x="39" y="21"/>
                  </a:moveTo>
                  <a:lnTo>
                    <a:pt x="39" y="26"/>
                  </a:lnTo>
                  <a:lnTo>
                    <a:pt x="22" y="4"/>
                  </a:lnTo>
                  <a:lnTo>
                    <a:pt x="22" y="4"/>
                  </a:lnTo>
                  <a:lnTo>
                    <a:pt x="4" y="26"/>
                  </a:lnTo>
                  <a:lnTo>
                    <a:pt x="4" y="21"/>
                  </a:lnTo>
                  <a:lnTo>
                    <a:pt x="22" y="39"/>
                  </a:lnTo>
                  <a:lnTo>
                    <a:pt x="22" y="39"/>
                  </a:lnTo>
                  <a:lnTo>
                    <a:pt x="39" y="21"/>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302" name="Freeform 496"/>
            <p:cNvSpPr/>
            <p:nvPr/>
          </p:nvSpPr>
          <p:spPr>
            <a:xfrm>
              <a:off x="4123080" y="3354480"/>
              <a:ext cx="72360" cy="61920"/>
            </a:xfrm>
            <a:custGeom>
              <a:avLst/>
              <a:gdLst>
                <a:gd name="textAreaLeft" fmla="*/ 0 w 72360"/>
                <a:gd name="textAreaRight" fmla="*/ 72720 w 72360"/>
                <a:gd name="textAreaTop" fmla="*/ 0 h 61920"/>
                <a:gd name="textAreaBottom" fmla="*/ 62280 h 61920"/>
              </a:gdLst>
              <a:ahLst/>
              <a:rect l="textAreaLeft" t="textAreaTop" r="textAreaRight" b="textAreaBottom"/>
              <a:pathLst>
                <a:path w="39" h="39">
                  <a:moveTo>
                    <a:pt x="21" y="39"/>
                  </a:moveTo>
                  <a:lnTo>
                    <a:pt x="0" y="17"/>
                  </a:lnTo>
                  <a:lnTo>
                    <a:pt x="21" y="0"/>
                  </a:lnTo>
                  <a:lnTo>
                    <a:pt x="39" y="17"/>
                  </a:lnTo>
                  <a:lnTo>
                    <a:pt x="21" y="39"/>
                  </a:lnTo>
                  <a:close/>
                </a:path>
              </a:pathLst>
            </a:custGeom>
            <a:solidFill>
              <a:srgbClr val="4f81bd"/>
            </a:solidFill>
            <a:ln w="0">
              <a:no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303" name="Freeform 497"/>
            <p:cNvSpPr/>
            <p:nvPr/>
          </p:nvSpPr>
          <p:spPr>
            <a:xfrm>
              <a:off x="4123080" y="3346560"/>
              <a:ext cx="72360" cy="69840"/>
            </a:xfrm>
            <a:custGeom>
              <a:avLst/>
              <a:gdLst>
                <a:gd name="textAreaLeft" fmla="*/ 0 w 72360"/>
                <a:gd name="textAreaRight" fmla="*/ 72720 w 72360"/>
                <a:gd name="textAreaTop" fmla="*/ 0 h 69840"/>
                <a:gd name="textAreaBottom" fmla="*/ 70200 h 69840"/>
              </a:gdLst>
              <a:ahLst/>
              <a:rect l="textAreaLeft" t="textAreaTop" r="textAreaRight" b="textAreaBottom"/>
              <a:pathLst>
                <a:path w="39" h="44">
                  <a:moveTo>
                    <a:pt x="21" y="44"/>
                  </a:moveTo>
                  <a:lnTo>
                    <a:pt x="17" y="44"/>
                  </a:lnTo>
                  <a:lnTo>
                    <a:pt x="0" y="22"/>
                  </a:lnTo>
                  <a:lnTo>
                    <a:pt x="0" y="22"/>
                  </a:lnTo>
                  <a:lnTo>
                    <a:pt x="17" y="0"/>
                  </a:lnTo>
                  <a:lnTo>
                    <a:pt x="21" y="0"/>
                  </a:lnTo>
                  <a:lnTo>
                    <a:pt x="39" y="22"/>
                  </a:lnTo>
                  <a:lnTo>
                    <a:pt x="39" y="22"/>
                  </a:lnTo>
                  <a:lnTo>
                    <a:pt x="21" y="44"/>
                  </a:lnTo>
                  <a:close/>
                  <a:moveTo>
                    <a:pt x="39" y="22"/>
                  </a:moveTo>
                  <a:lnTo>
                    <a:pt x="39" y="22"/>
                  </a:lnTo>
                  <a:lnTo>
                    <a:pt x="17" y="5"/>
                  </a:lnTo>
                  <a:lnTo>
                    <a:pt x="21" y="5"/>
                  </a:lnTo>
                  <a:lnTo>
                    <a:pt x="0" y="22"/>
                  </a:lnTo>
                  <a:lnTo>
                    <a:pt x="0" y="22"/>
                  </a:lnTo>
                  <a:lnTo>
                    <a:pt x="21" y="39"/>
                  </a:lnTo>
                  <a:lnTo>
                    <a:pt x="17" y="39"/>
                  </a:lnTo>
                  <a:lnTo>
                    <a:pt x="39" y="22"/>
                  </a:lnTo>
                  <a:close/>
                </a:path>
              </a:pathLst>
            </a:custGeom>
            <a:solidFill>
              <a:srgbClr val="4a7ebb"/>
            </a:solidFill>
            <a:ln w="0">
              <a:solidFill>
                <a:srgbClr val="4a7ebb"/>
              </a:solidFill>
            </a:ln>
          </p:spPr>
          <p:style>
            <a:lnRef idx="0"/>
            <a:fillRef idx="0"/>
            <a:effectRef idx="0"/>
            <a:fontRef idx="minor"/>
          </p:style>
          <p:txBody>
            <a:bodyPr tIns="24480" bIns="24480" anchor="t">
              <a:noAutofit/>
            </a:bodyPr>
            <a:p>
              <a:endParaRPr b="0" lang="en-US" sz="1800" spc="-1" strike="noStrike">
                <a:solidFill>
                  <a:srgbClr val="000000"/>
                </a:solidFill>
                <a:latin typeface="Calibri"/>
              </a:endParaRPr>
            </a:p>
          </p:txBody>
        </p:sp>
        <p:sp>
          <p:nvSpPr>
            <p:cNvPr id="304" name="Freeform 498"/>
            <p:cNvSpPr/>
            <p:nvPr/>
          </p:nvSpPr>
          <p:spPr>
            <a:xfrm>
              <a:off x="3664800" y="3457800"/>
              <a:ext cx="72360" cy="60120"/>
            </a:xfrm>
            <a:custGeom>
              <a:avLst/>
              <a:gdLst>
                <a:gd name="textAreaLeft" fmla="*/ 0 w 72360"/>
                <a:gd name="textAreaRight" fmla="*/ 72720 w 72360"/>
                <a:gd name="textAreaTop" fmla="*/ 0 h 60120"/>
                <a:gd name="textAreaBottom" fmla="*/ 60480 h 60120"/>
              </a:gdLst>
              <a:ahLst/>
              <a:rect l="textAreaLeft" t="textAreaTop" r="textAreaRight" b="textAreaBottom"/>
              <a:pathLst>
                <a:path w="39" h="38">
                  <a:moveTo>
                    <a:pt x="17" y="38"/>
                  </a:moveTo>
                  <a:lnTo>
                    <a:pt x="0" y="21"/>
                  </a:lnTo>
                  <a:lnTo>
                    <a:pt x="17" y="0"/>
                  </a:lnTo>
                  <a:lnTo>
                    <a:pt x="39" y="21"/>
                  </a:lnTo>
                  <a:lnTo>
                    <a:pt x="17" y="38"/>
                  </a:lnTo>
                  <a:close/>
                </a:path>
              </a:pathLst>
            </a:custGeom>
            <a:solidFill>
              <a:srgbClr val="4f81bd"/>
            </a:solidFill>
            <a:ln w="0">
              <a:no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305" name="Freeform 499"/>
            <p:cNvSpPr/>
            <p:nvPr/>
          </p:nvSpPr>
          <p:spPr>
            <a:xfrm>
              <a:off x="3655440" y="3457800"/>
              <a:ext cx="81720" cy="60120"/>
            </a:xfrm>
            <a:custGeom>
              <a:avLst/>
              <a:gdLst>
                <a:gd name="textAreaLeft" fmla="*/ 0 w 81720"/>
                <a:gd name="textAreaRight" fmla="*/ 82080 w 81720"/>
                <a:gd name="textAreaTop" fmla="*/ 0 h 60120"/>
                <a:gd name="textAreaBottom" fmla="*/ 60480 h 60120"/>
              </a:gdLst>
              <a:ahLst/>
              <a:rect l="textAreaLeft" t="textAreaTop" r="textAreaRight" b="textAreaBottom"/>
              <a:pathLst>
                <a:path w="44" h="38">
                  <a:moveTo>
                    <a:pt x="22" y="38"/>
                  </a:moveTo>
                  <a:lnTo>
                    <a:pt x="22" y="38"/>
                  </a:lnTo>
                  <a:lnTo>
                    <a:pt x="0" y="21"/>
                  </a:lnTo>
                  <a:lnTo>
                    <a:pt x="0" y="17"/>
                  </a:lnTo>
                  <a:lnTo>
                    <a:pt x="22" y="0"/>
                  </a:lnTo>
                  <a:lnTo>
                    <a:pt x="22" y="0"/>
                  </a:lnTo>
                  <a:lnTo>
                    <a:pt x="44" y="17"/>
                  </a:lnTo>
                  <a:lnTo>
                    <a:pt x="44" y="21"/>
                  </a:lnTo>
                  <a:lnTo>
                    <a:pt x="22" y="38"/>
                  </a:lnTo>
                  <a:close/>
                  <a:moveTo>
                    <a:pt x="39" y="17"/>
                  </a:moveTo>
                  <a:lnTo>
                    <a:pt x="39" y="21"/>
                  </a:lnTo>
                  <a:lnTo>
                    <a:pt x="22" y="0"/>
                  </a:lnTo>
                  <a:lnTo>
                    <a:pt x="22" y="0"/>
                  </a:lnTo>
                  <a:lnTo>
                    <a:pt x="5" y="21"/>
                  </a:lnTo>
                  <a:lnTo>
                    <a:pt x="5" y="17"/>
                  </a:lnTo>
                  <a:lnTo>
                    <a:pt x="22" y="38"/>
                  </a:lnTo>
                  <a:lnTo>
                    <a:pt x="22" y="38"/>
                  </a:lnTo>
                  <a:lnTo>
                    <a:pt x="39" y="17"/>
                  </a:lnTo>
                  <a:close/>
                </a:path>
              </a:pathLst>
            </a:custGeom>
            <a:solidFill>
              <a:srgbClr val="4a7ebb"/>
            </a:solidFill>
            <a:ln w="0">
              <a:solidFill>
                <a:srgbClr val="4a7ebb"/>
              </a:solid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306" name="Freeform 500"/>
            <p:cNvSpPr/>
            <p:nvPr/>
          </p:nvSpPr>
          <p:spPr>
            <a:xfrm>
              <a:off x="3832560" y="3478320"/>
              <a:ext cx="72360" cy="60120"/>
            </a:xfrm>
            <a:custGeom>
              <a:avLst/>
              <a:gdLst>
                <a:gd name="textAreaLeft" fmla="*/ 0 w 72360"/>
                <a:gd name="textAreaRight" fmla="*/ 72720 w 72360"/>
                <a:gd name="textAreaTop" fmla="*/ 0 h 60120"/>
                <a:gd name="textAreaBottom" fmla="*/ 60480 h 60120"/>
              </a:gdLst>
              <a:ahLst/>
              <a:rect l="textAreaLeft" t="textAreaTop" r="textAreaRight" b="textAreaBottom"/>
              <a:pathLst>
                <a:path w="39" h="38">
                  <a:moveTo>
                    <a:pt x="22" y="38"/>
                  </a:moveTo>
                  <a:lnTo>
                    <a:pt x="0" y="21"/>
                  </a:lnTo>
                  <a:lnTo>
                    <a:pt x="22" y="0"/>
                  </a:lnTo>
                  <a:lnTo>
                    <a:pt x="39" y="21"/>
                  </a:lnTo>
                  <a:lnTo>
                    <a:pt x="22" y="38"/>
                  </a:lnTo>
                  <a:close/>
                </a:path>
              </a:pathLst>
            </a:custGeom>
            <a:solidFill>
              <a:srgbClr val="4f81bd"/>
            </a:solidFill>
            <a:ln w="0">
              <a:noFill/>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307" name="Freeform 501"/>
            <p:cNvSpPr/>
            <p:nvPr/>
          </p:nvSpPr>
          <p:spPr>
            <a:xfrm>
              <a:off x="3832560" y="3478320"/>
              <a:ext cx="81720" cy="68040"/>
            </a:xfrm>
            <a:custGeom>
              <a:avLst/>
              <a:gdLst>
                <a:gd name="textAreaLeft" fmla="*/ 0 w 81720"/>
                <a:gd name="textAreaRight" fmla="*/ 82080 w 81720"/>
                <a:gd name="textAreaTop" fmla="*/ 0 h 68040"/>
                <a:gd name="textAreaBottom" fmla="*/ 68400 h 68040"/>
              </a:gdLst>
              <a:ahLst/>
              <a:rect l="textAreaLeft" t="textAreaTop" r="textAreaRight" b="textAreaBottom"/>
              <a:pathLst>
                <a:path w="44" h="43">
                  <a:moveTo>
                    <a:pt x="22" y="43"/>
                  </a:moveTo>
                  <a:lnTo>
                    <a:pt x="18" y="43"/>
                  </a:lnTo>
                  <a:lnTo>
                    <a:pt x="0" y="21"/>
                  </a:lnTo>
                  <a:lnTo>
                    <a:pt x="0" y="21"/>
                  </a:lnTo>
                  <a:lnTo>
                    <a:pt x="18" y="0"/>
                  </a:lnTo>
                  <a:lnTo>
                    <a:pt x="22" y="0"/>
                  </a:lnTo>
                  <a:lnTo>
                    <a:pt x="44" y="21"/>
                  </a:lnTo>
                  <a:lnTo>
                    <a:pt x="44" y="21"/>
                  </a:lnTo>
                  <a:lnTo>
                    <a:pt x="22" y="43"/>
                  </a:lnTo>
                  <a:close/>
                  <a:moveTo>
                    <a:pt x="39" y="21"/>
                  </a:moveTo>
                  <a:lnTo>
                    <a:pt x="39" y="21"/>
                  </a:lnTo>
                  <a:lnTo>
                    <a:pt x="18" y="4"/>
                  </a:lnTo>
                  <a:lnTo>
                    <a:pt x="22" y="4"/>
                  </a:lnTo>
                  <a:lnTo>
                    <a:pt x="5" y="21"/>
                  </a:lnTo>
                  <a:lnTo>
                    <a:pt x="5" y="21"/>
                  </a:lnTo>
                  <a:lnTo>
                    <a:pt x="22" y="38"/>
                  </a:lnTo>
                  <a:lnTo>
                    <a:pt x="18" y="38"/>
                  </a:lnTo>
                  <a:lnTo>
                    <a:pt x="39" y="21"/>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308" name="Freeform 502"/>
            <p:cNvSpPr/>
            <p:nvPr/>
          </p:nvSpPr>
          <p:spPr>
            <a:xfrm>
              <a:off x="3495240" y="3354480"/>
              <a:ext cx="72360" cy="61920"/>
            </a:xfrm>
            <a:custGeom>
              <a:avLst/>
              <a:gdLst>
                <a:gd name="textAreaLeft" fmla="*/ 0 w 72360"/>
                <a:gd name="textAreaRight" fmla="*/ 72720 w 72360"/>
                <a:gd name="textAreaTop" fmla="*/ 0 h 61920"/>
                <a:gd name="textAreaBottom" fmla="*/ 62280 h 61920"/>
              </a:gdLst>
              <a:ahLst/>
              <a:rect l="textAreaLeft" t="textAreaTop" r="textAreaRight" b="textAreaBottom"/>
              <a:pathLst>
                <a:path w="39" h="39">
                  <a:moveTo>
                    <a:pt x="22" y="39"/>
                  </a:moveTo>
                  <a:lnTo>
                    <a:pt x="0" y="21"/>
                  </a:lnTo>
                  <a:lnTo>
                    <a:pt x="22" y="0"/>
                  </a:lnTo>
                  <a:lnTo>
                    <a:pt x="39" y="21"/>
                  </a:lnTo>
                  <a:lnTo>
                    <a:pt x="22" y="39"/>
                  </a:lnTo>
                  <a:close/>
                </a:path>
              </a:pathLst>
            </a:custGeom>
            <a:solidFill>
              <a:srgbClr val="4f81bd"/>
            </a:solidFill>
            <a:ln w="0">
              <a:no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309" name="Freeform 503"/>
            <p:cNvSpPr/>
            <p:nvPr/>
          </p:nvSpPr>
          <p:spPr>
            <a:xfrm>
              <a:off x="3495240" y="3354480"/>
              <a:ext cx="79920" cy="68040"/>
            </a:xfrm>
            <a:custGeom>
              <a:avLst/>
              <a:gdLst>
                <a:gd name="textAreaLeft" fmla="*/ 0 w 79920"/>
                <a:gd name="textAreaRight" fmla="*/ 80280 w 79920"/>
                <a:gd name="textAreaTop" fmla="*/ 0 h 68040"/>
                <a:gd name="textAreaBottom" fmla="*/ 68400 h 68040"/>
              </a:gdLst>
              <a:ahLst/>
              <a:rect l="textAreaLeft" t="textAreaTop" r="textAreaRight" b="textAreaBottom"/>
              <a:pathLst>
                <a:path w="43" h="43">
                  <a:moveTo>
                    <a:pt x="22" y="43"/>
                  </a:moveTo>
                  <a:lnTo>
                    <a:pt x="22" y="43"/>
                  </a:lnTo>
                  <a:lnTo>
                    <a:pt x="0" y="21"/>
                  </a:lnTo>
                  <a:lnTo>
                    <a:pt x="0" y="17"/>
                  </a:lnTo>
                  <a:lnTo>
                    <a:pt x="22" y="0"/>
                  </a:lnTo>
                  <a:lnTo>
                    <a:pt x="22" y="0"/>
                  </a:lnTo>
                  <a:lnTo>
                    <a:pt x="43" y="17"/>
                  </a:lnTo>
                  <a:lnTo>
                    <a:pt x="43" y="21"/>
                  </a:lnTo>
                  <a:lnTo>
                    <a:pt x="22" y="43"/>
                  </a:lnTo>
                  <a:close/>
                  <a:moveTo>
                    <a:pt x="39" y="17"/>
                  </a:moveTo>
                  <a:lnTo>
                    <a:pt x="39" y="21"/>
                  </a:lnTo>
                  <a:lnTo>
                    <a:pt x="22" y="4"/>
                  </a:lnTo>
                  <a:lnTo>
                    <a:pt x="22" y="4"/>
                  </a:lnTo>
                  <a:lnTo>
                    <a:pt x="4" y="21"/>
                  </a:lnTo>
                  <a:lnTo>
                    <a:pt x="4" y="17"/>
                  </a:lnTo>
                  <a:lnTo>
                    <a:pt x="22" y="39"/>
                  </a:lnTo>
                  <a:lnTo>
                    <a:pt x="22" y="39"/>
                  </a:lnTo>
                  <a:lnTo>
                    <a:pt x="39" y="17"/>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310" name="Freeform 504"/>
            <p:cNvSpPr/>
            <p:nvPr/>
          </p:nvSpPr>
          <p:spPr>
            <a:xfrm>
              <a:off x="3262680" y="3567240"/>
              <a:ext cx="72360" cy="61920"/>
            </a:xfrm>
            <a:custGeom>
              <a:avLst/>
              <a:gdLst>
                <a:gd name="textAreaLeft" fmla="*/ 0 w 72360"/>
                <a:gd name="textAreaRight" fmla="*/ 72720 w 72360"/>
                <a:gd name="textAreaTop" fmla="*/ 0 h 61920"/>
                <a:gd name="textAreaBottom" fmla="*/ 62280 h 61920"/>
              </a:gdLst>
              <a:ahLst/>
              <a:rect l="textAreaLeft" t="textAreaTop" r="textAreaRight" b="textAreaBottom"/>
              <a:pathLst>
                <a:path w="39" h="39">
                  <a:moveTo>
                    <a:pt x="17" y="39"/>
                  </a:moveTo>
                  <a:lnTo>
                    <a:pt x="0" y="21"/>
                  </a:lnTo>
                  <a:lnTo>
                    <a:pt x="17" y="0"/>
                  </a:lnTo>
                  <a:lnTo>
                    <a:pt x="39" y="21"/>
                  </a:lnTo>
                  <a:lnTo>
                    <a:pt x="17" y="39"/>
                  </a:lnTo>
                  <a:close/>
                </a:path>
              </a:pathLst>
            </a:custGeom>
            <a:solidFill>
              <a:srgbClr val="4f81bd"/>
            </a:solidFill>
            <a:ln w="0">
              <a:no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311" name="Freeform 505"/>
            <p:cNvSpPr/>
            <p:nvPr/>
          </p:nvSpPr>
          <p:spPr>
            <a:xfrm>
              <a:off x="3253320" y="3567240"/>
              <a:ext cx="81720" cy="68040"/>
            </a:xfrm>
            <a:custGeom>
              <a:avLst/>
              <a:gdLst>
                <a:gd name="textAreaLeft" fmla="*/ 0 w 81720"/>
                <a:gd name="textAreaRight" fmla="*/ 82080 w 81720"/>
                <a:gd name="textAreaTop" fmla="*/ 0 h 68040"/>
                <a:gd name="textAreaBottom" fmla="*/ 68400 h 68040"/>
              </a:gdLst>
              <a:ahLst/>
              <a:rect l="textAreaLeft" t="textAreaTop" r="textAreaRight" b="textAreaBottom"/>
              <a:pathLst>
                <a:path w="44" h="43">
                  <a:moveTo>
                    <a:pt x="26" y="43"/>
                  </a:moveTo>
                  <a:lnTo>
                    <a:pt x="22" y="43"/>
                  </a:lnTo>
                  <a:lnTo>
                    <a:pt x="0" y="21"/>
                  </a:lnTo>
                  <a:lnTo>
                    <a:pt x="0" y="17"/>
                  </a:lnTo>
                  <a:lnTo>
                    <a:pt x="22" y="0"/>
                  </a:lnTo>
                  <a:lnTo>
                    <a:pt x="26" y="0"/>
                  </a:lnTo>
                  <a:lnTo>
                    <a:pt x="44" y="17"/>
                  </a:lnTo>
                  <a:lnTo>
                    <a:pt x="44" y="21"/>
                  </a:lnTo>
                  <a:lnTo>
                    <a:pt x="26" y="43"/>
                  </a:lnTo>
                  <a:close/>
                  <a:moveTo>
                    <a:pt x="39" y="17"/>
                  </a:moveTo>
                  <a:lnTo>
                    <a:pt x="39" y="21"/>
                  </a:lnTo>
                  <a:lnTo>
                    <a:pt x="22" y="4"/>
                  </a:lnTo>
                  <a:lnTo>
                    <a:pt x="26" y="4"/>
                  </a:lnTo>
                  <a:lnTo>
                    <a:pt x="5" y="21"/>
                  </a:lnTo>
                  <a:lnTo>
                    <a:pt x="5" y="17"/>
                  </a:lnTo>
                  <a:lnTo>
                    <a:pt x="26" y="39"/>
                  </a:lnTo>
                  <a:lnTo>
                    <a:pt x="22" y="39"/>
                  </a:lnTo>
                  <a:lnTo>
                    <a:pt x="39" y="17"/>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312" name="Freeform 506"/>
            <p:cNvSpPr/>
            <p:nvPr/>
          </p:nvSpPr>
          <p:spPr>
            <a:xfrm>
              <a:off x="3664800" y="3340080"/>
              <a:ext cx="72360" cy="61920"/>
            </a:xfrm>
            <a:custGeom>
              <a:avLst/>
              <a:gdLst>
                <a:gd name="textAreaLeft" fmla="*/ 0 w 72360"/>
                <a:gd name="textAreaRight" fmla="*/ 72720 w 72360"/>
                <a:gd name="textAreaTop" fmla="*/ 0 h 61920"/>
                <a:gd name="textAreaBottom" fmla="*/ 62280 h 61920"/>
              </a:gdLst>
              <a:ahLst/>
              <a:rect l="textAreaLeft" t="textAreaTop" r="textAreaRight" b="textAreaBottom"/>
              <a:pathLst>
                <a:path w="39" h="39">
                  <a:moveTo>
                    <a:pt x="17" y="39"/>
                  </a:moveTo>
                  <a:lnTo>
                    <a:pt x="0" y="17"/>
                  </a:lnTo>
                  <a:lnTo>
                    <a:pt x="17" y="0"/>
                  </a:lnTo>
                  <a:lnTo>
                    <a:pt x="39" y="17"/>
                  </a:lnTo>
                  <a:lnTo>
                    <a:pt x="17" y="39"/>
                  </a:lnTo>
                  <a:close/>
                </a:path>
              </a:pathLst>
            </a:custGeom>
            <a:solidFill>
              <a:srgbClr val="4f81bd"/>
            </a:solidFill>
            <a:ln w="0">
              <a:noFill/>
            </a:ln>
          </p:spPr>
          <p:style>
            <a:lnRef idx="0"/>
            <a:fillRef idx="0"/>
            <a:effectRef idx="0"/>
            <a:fontRef idx="minor"/>
          </p:style>
          <p:txBody>
            <a:bodyPr tIns="16560" bIns="16560" anchor="t">
              <a:noAutofit/>
            </a:bodyPr>
            <a:p>
              <a:endParaRPr b="0" lang="en-US" sz="1800" spc="-1" strike="noStrike">
                <a:solidFill>
                  <a:srgbClr val="000000"/>
                </a:solidFill>
                <a:latin typeface="Calibri"/>
              </a:endParaRPr>
            </a:p>
          </p:txBody>
        </p:sp>
        <p:sp>
          <p:nvSpPr>
            <p:cNvPr id="313" name="Freeform 507"/>
            <p:cNvSpPr/>
            <p:nvPr/>
          </p:nvSpPr>
          <p:spPr>
            <a:xfrm>
              <a:off x="3655440" y="3333600"/>
              <a:ext cx="81720" cy="68040"/>
            </a:xfrm>
            <a:custGeom>
              <a:avLst/>
              <a:gdLst>
                <a:gd name="textAreaLeft" fmla="*/ 0 w 81720"/>
                <a:gd name="textAreaRight" fmla="*/ 82080 w 81720"/>
                <a:gd name="textAreaTop" fmla="*/ 0 h 68040"/>
                <a:gd name="textAreaBottom" fmla="*/ 68400 h 68040"/>
              </a:gdLst>
              <a:ahLst/>
              <a:rect l="textAreaLeft" t="textAreaTop" r="textAreaRight" b="textAreaBottom"/>
              <a:pathLst>
                <a:path w="44" h="43">
                  <a:moveTo>
                    <a:pt x="22" y="43"/>
                  </a:moveTo>
                  <a:lnTo>
                    <a:pt x="22" y="43"/>
                  </a:lnTo>
                  <a:lnTo>
                    <a:pt x="0" y="21"/>
                  </a:lnTo>
                  <a:lnTo>
                    <a:pt x="0" y="21"/>
                  </a:lnTo>
                  <a:lnTo>
                    <a:pt x="22" y="0"/>
                  </a:lnTo>
                  <a:lnTo>
                    <a:pt x="22" y="0"/>
                  </a:lnTo>
                  <a:lnTo>
                    <a:pt x="44" y="21"/>
                  </a:lnTo>
                  <a:lnTo>
                    <a:pt x="44" y="21"/>
                  </a:lnTo>
                  <a:lnTo>
                    <a:pt x="22" y="43"/>
                  </a:lnTo>
                  <a:close/>
                  <a:moveTo>
                    <a:pt x="39" y="21"/>
                  </a:moveTo>
                  <a:lnTo>
                    <a:pt x="39" y="21"/>
                  </a:lnTo>
                  <a:lnTo>
                    <a:pt x="22" y="4"/>
                  </a:lnTo>
                  <a:lnTo>
                    <a:pt x="22" y="4"/>
                  </a:lnTo>
                  <a:lnTo>
                    <a:pt x="5" y="21"/>
                  </a:lnTo>
                  <a:lnTo>
                    <a:pt x="5" y="21"/>
                  </a:lnTo>
                  <a:lnTo>
                    <a:pt x="22" y="39"/>
                  </a:lnTo>
                  <a:lnTo>
                    <a:pt x="22" y="39"/>
                  </a:lnTo>
                  <a:lnTo>
                    <a:pt x="39" y="21"/>
                  </a:lnTo>
                  <a:close/>
                </a:path>
              </a:pathLst>
            </a:custGeom>
            <a:solidFill>
              <a:srgbClr val="4a7ebb"/>
            </a:solidFill>
            <a:ln w="0">
              <a:solidFill>
                <a:srgbClr val="4a7ebb"/>
              </a:solidFill>
            </a:ln>
          </p:spPr>
          <p:style>
            <a:lnRef idx="0"/>
            <a:fillRef idx="0"/>
            <a:effectRef idx="0"/>
            <a:fontRef idx="minor"/>
          </p:style>
          <p:txBody>
            <a:bodyPr tIns="22680" bIns="22680" anchor="t">
              <a:noAutofit/>
            </a:bodyPr>
            <a:p>
              <a:endParaRPr b="0" lang="en-US" sz="1800" spc="-1" strike="noStrike">
                <a:solidFill>
                  <a:srgbClr val="000000"/>
                </a:solidFill>
                <a:latin typeface="Calibri"/>
              </a:endParaRPr>
            </a:p>
          </p:txBody>
        </p:sp>
        <p:sp>
          <p:nvSpPr>
            <p:cNvPr id="314" name="Freeform 508"/>
            <p:cNvSpPr/>
            <p:nvPr/>
          </p:nvSpPr>
          <p:spPr>
            <a:xfrm>
              <a:off x="2336400" y="3230640"/>
              <a:ext cx="2203920" cy="479520"/>
            </a:xfrm>
            <a:custGeom>
              <a:avLst/>
              <a:gdLst>
                <a:gd name="textAreaLeft" fmla="*/ 0 w 2203920"/>
                <a:gd name="textAreaRight" fmla="*/ 2204280 w 2203920"/>
                <a:gd name="textAreaTop" fmla="*/ 0 h 479520"/>
                <a:gd name="textAreaBottom" fmla="*/ 479880 h 479520"/>
              </a:gdLst>
              <a:ahLst/>
              <a:rect l="textAreaLeft" t="textAreaTop" r="textAreaRight" b="textAreaBottom"/>
              <a:pathLst>
                <a:path w="1183" h="302">
                  <a:moveTo>
                    <a:pt x="0" y="298"/>
                  </a:moveTo>
                  <a:lnTo>
                    <a:pt x="1179" y="0"/>
                  </a:lnTo>
                  <a:lnTo>
                    <a:pt x="1183" y="0"/>
                  </a:lnTo>
                  <a:lnTo>
                    <a:pt x="1179" y="4"/>
                  </a:lnTo>
                  <a:lnTo>
                    <a:pt x="0" y="302"/>
                  </a:lnTo>
                  <a:lnTo>
                    <a:pt x="0" y="298"/>
                  </a:lnTo>
                  <a:lnTo>
                    <a:pt x="0" y="298"/>
                  </a:lnTo>
                  <a:lnTo>
                    <a:pt x="0" y="298"/>
                  </a:lnTo>
                  <a:close/>
                </a:path>
              </a:pathLst>
            </a:custGeom>
            <a:solidFill>
              <a:srgbClr val="000000"/>
            </a:solidFill>
            <a:ln w="6480">
              <a:solidFill>
                <a:srgbClr val="00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grpSp>
      <p:sp>
        <p:nvSpPr>
          <p:cNvPr id="315" name="TextBox 730"/>
          <p:cNvSpPr/>
          <p:nvPr/>
        </p:nvSpPr>
        <p:spPr>
          <a:xfrm>
            <a:off x="1675800" y="5580000"/>
            <a:ext cx="10998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Retention time (min)</a:t>
            </a:r>
            <a:endParaRPr b="0" lang="en-US" sz="800" spc="-1" strike="noStrike">
              <a:solidFill>
                <a:srgbClr val="000000"/>
              </a:solidFill>
              <a:latin typeface="Calibri"/>
            </a:endParaRPr>
          </a:p>
        </p:txBody>
      </p:sp>
      <p:sp>
        <p:nvSpPr>
          <p:cNvPr id="316" name="TextBox 731"/>
          <p:cNvSpPr/>
          <p:nvPr/>
        </p:nvSpPr>
        <p:spPr>
          <a:xfrm>
            <a:off x="4487040" y="5580000"/>
            <a:ext cx="10998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Retention time (min)</a:t>
            </a:r>
            <a:endParaRPr b="0" lang="en-US" sz="800" spc="-1" strike="noStrike">
              <a:solidFill>
                <a:srgbClr val="000000"/>
              </a:solidFill>
              <a:latin typeface="Calibri"/>
            </a:endParaRPr>
          </a:p>
        </p:txBody>
      </p:sp>
      <p:sp>
        <p:nvSpPr>
          <p:cNvPr id="317" name="TextBox 732"/>
          <p:cNvSpPr/>
          <p:nvPr/>
        </p:nvSpPr>
        <p:spPr>
          <a:xfrm rot="16200000">
            <a:off x="320040" y="4914360"/>
            <a:ext cx="108144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Relative abundance</a:t>
            </a:r>
            <a:endParaRPr b="0" lang="en-US" sz="8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TIC x 10,000 ions)</a:t>
            </a:r>
            <a:endParaRPr b="0" lang="en-US" sz="800" spc="-1" strike="noStrike">
              <a:solidFill>
                <a:srgbClr val="000000"/>
              </a:solidFill>
              <a:latin typeface="Calibri"/>
            </a:endParaRPr>
          </a:p>
        </p:txBody>
      </p:sp>
      <p:sp>
        <p:nvSpPr>
          <p:cNvPr id="318" name="TextBox 733"/>
          <p:cNvSpPr/>
          <p:nvPr/>
        </p:nvSpPr>
        <p:spPr>
          <a:xfrm>
            <a:off x="1649160" y="492588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a:t>
            </a:r>
            <a:endParaRPr b="0" lang="en-US" sz="800" spc="-1" strike="noStrike">
              <a:solidFill>
                <a:srgbClr val="000000"/>
              </a:solidFill>
              <a:latin typeface="Calibri"/>
            </a:endParaRPr>
          </a:p>
        </p:txBody>
      </p:sp>
      <p:sp>
        <p:nvSpPr>
          <p:cNvPr id="319" name="TextBox 734"/>
          <p:cNvSpPr/>
          <p:nvPr/>
        </p:nvSpPr>
        <p:spPr>
          <a:xfrm>
            <a:off x="1766520" y="487368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2</a:t>
            </a:r>
            <a:endParaRPr b="0" lang="en-US" sz="800" spc="-1" strike="noStrike">
              <a:solidFill>
                <a:srgbClr val="000000"/>
              </a:solidFill>
              <a:latin typeface="Calibri"/>
            </a:endParaRPr>
          </a:p>
        </p:txBody>
      </p:sp>
      <p:sp>
        <p:nvSpPr>
          <p:cNvPr id="320" name="TextBox 735"/>
          <p:cNvSpPr/>
          <p:nvPr/>
        </p:nvSpPr>
        <p:spPr>
          <a:xfrm>
            <a:off x="2019600" y="456876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3</a:t>
            </a:r>
            <a:endParaRPr b="0" lang="en-US" sz="800" spc="-1" strike="noStrike">
              <a:solidFill>
                <a:srgbClr val="000000"/>
              </a:solidFill>
              <a:latin typeface="Calibri"/>
            </a:endParaRPr>
          </a:p>
        </p:txBody>
      </p:sp>
      <p:sp>
        <p:nvSpPr>
          <p:cNvPr id="321" name="TextBox 736"/>
          <p:cNvSpPr/>
          <p:nvPr/>
        </p:nvSpPr>
        <p:spPr>
          <a:xfrm>
            <a:off x="2100600" y="523404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4</a:t>
            </a:r>
            <a:endParaRPr b="0" lang="en-US" sz="800" spc="-1" strike="noStrike">
              <a:solidFill>
                <a:srgbClr val="000000"/>
              </a:solidFill>
              <a:latin typeface="Calibri"/>
            </a:endParaRPr>
          </a:p>
        </p:txBody>
      </p:sp>
      <p:sp>
        <p:nvSpPr>
          <p:cNvPr id="322" name="TextBox 739"/>
          <p:cNvSpPr/>
          <p:nvPr/>
        </p:nvSpPr>
        <p:spPr>
          <a:xfrm>
            <a:off x="2647440" y="522936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5</a:t>
            </a:r>
            <a:endParaRPr b="0" lang="en-US" sz="800" spc="-1" strike="noStrike">
              <a:solidFill>
                <a:srgbClr val="000000"/>
              </a:solidFill>
              <a:latin typeface="Calibri"/>
            </a:endParaRPr>
          </a:p>
        </p:txBody>
      </p:sp>
      <p:sp>
        <p:nvSpPr>
          <p:cNvPr id="323" name="TextBox 740"/>
          <p:cNvSpPr/>
          <p:nvPr/>
        </p:nvSpPr>
        <p:spPr>
          <a:xfrm>
            <a:off x="2837880" y="521820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6</a:t>
            </a:r>
            <a:endParaRPr b="0" lang="en-US" sz="800" spc="-1" strike="noStrike">
              <a:solidFill>
                <a:srgbClr val="000000"/>
              </a:solidFill>
              <a:latin typeface="Calibri"/>
            </a:endParaRPr>
          </a:p>
        </p:txBody>
      </p:sp>
      <p:grpSp>
        <p:nvGrpSpPr>
          <p:cNvPr id="324" name="Group 750"/>
          <p:cNvGrpSpPr/>
          <p:nvPr/>
        </p:nvGrpSpPr>
        <p:grpSpPr>
          <a:xfrm>
            <a:off x="3619800" y="4575240"/>
            <a:ext cx="2330280" cy="1017720"/>
            <a:chOff x="3619800" y="4575240"/>
            <a:chExt cx="2330280" cy="1017720"/>
          </a:xfrm>
        </p:grpSpPr>
        <p:sp>
          <p:nvSpPr>
            <p:cNvPr id="325" name="Line 12"/>
            <p:cNvSpPr/>
            <p:nvPr/>
          </p:nvSpPr>
          <p:spPr>
            <a:xfrm>
              <a:off x="3966840" y="5449320"/>
              <a:ext cx="19832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326" name="Line 13"/>
            <p:cNvSpPr/>
            <p:nvPr/>
          </p:nvSpPr>
          <p:spPr>
            <a:xfrm flipV="1">
              <a:off x="396684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27" name="Line 14"/>
            <p:cNvSpPr/>
            <p:nvPr/>
          </p:nvSpPr>
          <p:spPr>
            <a:xfrm flipV="1">
              <a:off x="399384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28" name="Line 15"/>
            <p:cNvSpPr/>
            <p:nvPr/>
          </p:nvSpPr>
          <p:spPr>
            <a:xfrm flipV="1">
              <a:off x="402084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29" name="Line 16"/>
            <p:cNvSpPr/>
            <p:nvPr/>
          </p:nvSpPr>
          <p:spPr>
            <a:xfrm flipV="1">
              <a:off x="404640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30" name="Line 17"/>
            <p:cNvSpPr/>
            <p:nvPr/>
          </p:nvSpPr>
          <p:spPr>
            <a:xfrm flipV="1">
              <a:off x="407340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31" name="Line 18"/>
            <p:cNvSpPr/>
            <p:nvPr/>
          </p:nvSpPr>
          <p:spPr>
            <a:xfrm flipV="1">
              <a:off x="410040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32" name="Line 19"/>
            <p:cNvSpPr/>
            <p:nvPr/>
          </p:nvSpPr>
          <p:spPr>
            <a:xfrm flipV="1">
              <a:off x="412560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33" name="Line 20"/>
            <p:cNvSpPr/>
            <p:nvPr/>
          </p:nvSpPr>
          <p:spPr>
            <a:xfrm flipV="1">
              <a:off x="415260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34" name="Line 21"/>
            <p:cNvSpPr/>
            <p:nvPr/>
          </p:nvSpPr>
          <p:spPr>
            <a:xfrm flipV="1">
              <a:off x="417816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35" name="Line 22"/>
            <p:cNvSpPr/>
            <p:nvPr/>
          </p:nvSpPr>
          <p:spPr>
            <a:xfrm flipV="1">
              <a:off x="420516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36" name="Line 23"/>
            <p:cNvSpPr/>
            <p:nvPr/>
          </p:nvSpPr>
          <p:spPr>
            <a:xfrm flipV="1">
              <a:off x="423216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37" name="Line 24"/>
            <p:cNvSpPr/>
            <p:nvPr/>
          </p:nvSpPr>
          <p:spPr>
            <a:xfrm flipV="1">
              <a:off x="425736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38" name="Line 25"/>
            <p:cNvSpPr/>
            <p:nvPr/>
          </p:nvSpPr>
          <p:spPr>
            <a:xfrm flipV="1">
              <a:off x="428436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39" name="Line 26"/>
            <p:cNvSpPr/>
            <p:nvPr/>
          </p:nvSpPr>
          <p:spPr>
            <a:xfrm flipV="1">
              <a:off x="431136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40" name="Line 27"/>
            <p:cNvSpPr/>
            <p:nvPr/>
          </p:nvSpPr>
          <p:spPr>
            <a:xfrm flipV="1">
              <a:off x="433692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41" name="Line 28"/>
            <p:cNvSpPr/>
            <p:nvPr/>
          </p:nvSpPr>
          <p:spPr>
            <a:xfrm flipV="1">
              <a:off x="436392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42" name="Line 29"/>
            <p:cNvSpPr/>
            <p:nvPr/>
          </p:nvSpPr>
          <p:spPr>
            <a:xfrm flipV="1">
              <a:off x="439092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43" name="Line 30"/>
            <p:cNvSpPr/>
            <p:nvPr/>
          </p:nvSpPr>
          <p:spPr>
            <a:xfrm flipV="1">
              <a:off x="441612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44" name="Line 31"/>
            <p:cNvSpPr/>
            <p:nvPr/>
          </p:nvSpPr>
          <p:spPr>
            <a:xfrm flipV="1">
              <a:off x="444312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45" name="Line 32"/>
            <p:cNvSpPr/>
            <p:nvPr/>
          </p:nvSpPr>
          <p:spPr>
            <a:xfrm flipV="1">
              <a:off x="446868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46" name="Line 33"/>
            <p:cNvSpPr/>
            <p:nvPr/>
          </p:nvSpPr>
          <p:spPr>
            <a:xfrm flipV="1">
              <a:off x="449568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47" name="Line 34"/>
            <p:cNvSpPr/>
            <p:nvPr/>
          </p:nvSpPr>
          <p:spPr>
            <a:xfrm flipV="1">
              <a:off x="452268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48" name="Line 35"/>
            <p:cNvSpPr/>
            <p:nvPr/>
          </p:nvSpPr>
          <p:spPr>
            <a:xfrm flipV="1">
              <a:off x="454788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49" name="Line 36"/>
            <p:cNvSpPr/>
            <p:nvPr/>
          </p:nvSpPr>
          <p:spPr>
            <a:xfrm flipV="1">
              <a:off x="457488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50" name="Line 37"/>
            <p:cNvSpPr/>
            <p:nvPr/>
          </p:nvSpPr>
          <p:spPr>
            <a:xfrm flipV="1">
              <a:off x="460188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51" name="Line 38"/>
            <p:cNvSpPr/>
            <p:nvPr/>
          </p:nvSpPr>
          <p:spPr>
            <a:xfrm flipV="1">
              <a:off x="462744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52" name="Line 39"/>
            <p:cNvSpPr/>
            <p:nvPr/>
          </p:nvSpPr>
          <p:spPr>
            <a:xfrm flipV="1">
              <a:off x="465444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53" name="Line 40"/>
            <p:cNvSpPr/>
            <p:nvPr/>
          </p:nvSpPr>
          <p:spPr>
            <a:xfrm flipV="1">
              <a:off x="468144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54" name="Line 41"/>
            <p:cNvSpPr/>
            <p:nvPr/>
          </p:nvSpPr>
          <p:spPr>
            <a:xfrm flipV="1">
              <a:off x="470700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55" name="Line 42"/>
            <p:cNvSpPr/>
            <p:nvPr/>
          </p:nvSpPr>
          <p:spPr>
            <a:xfrm flipV="1">
              <a:off x="473400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56" name="Line 43"/>
            <p:cNvSpPr/>
            <p:nvPr/>
          </p:nvSpPr>
          <p:spPr>
            <a:xfrm flipV="1">
              <a:off x="476100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57" name="Line 44"/>
            <p:cNvSpPr/>
            <p:nvPr/>
          </p:nvSpPr>
          <p:spPr>
            <a:xfrm flipV="1">
              <a:off x="478620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58" name="Line 45"/>
            <p:cNvSpPr/>
            <p:nvPr/>
          </p:nvSpPr>
          <p:spPr>
            <a:xfrm flipV="1">
              <a:off x="481320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59" name="Line 46"/>
            <p:cNvSpPr/>
            <p:nvPr/>
          </p:nvSpPr>
          <p:spPr>
            <a:xfrm flipV="1">
              <a:off x="483876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60" name="Line 47"/>
            <p:cNvSpPr/>
            <p:nvPr/>
          </p:nvSpPr>
          <p:spPr>
            <a:xfrm flipV="1">
              <a:off x="486576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61" name="Line 48"/>
            <p:cNvSpPr/>
            <p:nvPr/>
          </p:nvSpPr>
          <p:spPr>
            <a:xfrm flipV="1">
              <a:off x="489276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62" name="Line 49"/>
            <p:cNvSpPr/>
            <p:nvPr/>
          </p:nvSpPr>
          <p:spPr>
            <a:xfrm flipV="1">
              <a:off x="491796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63" name="Line 50"/>
            <p:cNvSpPr/>
            <p:nvPr/>
          </p:nvSpPr>
          <p:spPr>
            <a:xfrm flipV="1">
              <a:off x="494496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64" name="Line 51"/>
            <p:cNvSpPr/>
            <p:nvPr/>
          </p:nvSpPr>
          <p:spPr>
            <a:xfrm flipV="1">
              <a:off x="497196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65" name="Line 52"/>
            <p:cNvSpPr/>
            <p:nvPr/>
          </p:nvSpPr>
          <p:spPr>
            <a:xfrm flipV="1">
              <a:off x="499752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66" name="Line 53"/>
            <p:cNvSpPr/>
            <p:nvPr/>
          </p:nvSpPr>
          <p:spPr>
            <a:xfrm flipV="1">
              <a:off x="502452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67" name="Line 54"/>
            <p:cNvSpPr/>
            <p:nvPr/>
          </p:nvSpPr>
          <p:spPr>
            <a:xfrm flipV="1">
              <a:off x="505152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68" name="Line 55"/>
            <p:cNvSpPr/>
            <p:nvPr/>
          </p:nvSpPr>
          <p:spPr>
            <a:xfrm flipV="1">
              <a:off x="507672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69" name="Line 56"/>
            <p:cNvSpPr/>
            <p:nvPr/>
          </p:nvSpPr>
          <p:spPr>
            <a:xfrm flipV="1">
              <a:off x="510372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70" name="Line 57"/>
            <p:cNvSpPr/>
            <p:nvPr/>
          </p:nvSpPr>
          <p:spPr>
            <a:xfrm flipV="1">
              <a:off x="512928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71" name="Line 58"/>
            <p:cNvSpPr/>
            <p:nvPr/>
          </p:nvSpPr>
          <p:spPr>
            <a:xfrm flipV="1">
              <a:off x="515628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72" name="Line 59"/>
            <p:cNvSpPr/>
            <p:nvPr/>
          </p:nvSpPr>
          <p:spPr>
            <a:xfrm flipV="1">
              <a:off x="518328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73" name="Line 60"/>
            <p:cNvSpPr/>
            <p:nvPr/>
          </p:nvSpPr>
          <p:spPr>
            <a:xfrm flipV="1">
              <a:off x="520848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74" name="Line 61"/>
            <p:cNvSpPr/>
            <p:nvPr/>
          </p:nvSpPr>
          <p:spPr>
            <a:xfrm flipV="1">
              <a:off x="523548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75" name="Line 62"/>
            <p:cNvSpPr/>
            <p:nvPr/>
          </p:nvSpPr>
          <p:spPr>
            <a:xfrm flipV="1">
              <a:off x="526248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76" name="Line 63"/>
            <p:cNvSpPr/>
            <p:nvPr/>
          </p:nvSpPr>
          <p:spPr>
            <a:xfrm flipV="1">
              <a:off x="528804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77" name="Line 64"/>
            <p:cNvSpPr/>
            <p:nvPr/>
          </p:nvSpPr>
          <p:spPr>
            <a:xfrm flipV="1">
              <a:off x="531504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78" name="Line 65"/>
            <p:cNvSpPr/>
            <p:nvPr/>
          </p:nvSpPr>
          <p:spPr>
            <a:xfrm flipV="1">
              <a:off x="534204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79" name="Line 66"/>
            <p:cNvSpPr/>
            <p:nvPr/>
          </p:nvSpPr>
          <p:spPr>
            <a:xfrm flipV="1">
              <a:off x="536760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80" name="Line 67"/>
            <p:cNvSpPr/>
            <p:nvPr/>
          </p:nvSpPr>
          <p:spPr>
            <a:xfrm flipV="1">
              <a:off x="539460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81" name="Line 68"/>
            <p:cNvSpPr/>
            <p:nvPr/>
          </p:nvSpPr>
          <p:spPr>
            <a:xfrm flipV="1">
              <a:off x="542160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82" name="Line 69"/>
            <p:cNvSpPr/>
            <p:nvPr/>
          </p:nvSpPr>
          <p:spPr>
            <a:xfrm flipV="1">
              <a:off x="544680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83" name="Line 70"/>
            <p:cNvSpPr/>
            <p:nvPr/>
          </p:nvSpPr>
          <p:spPr>
            <a:xfrm flipV="1">
              <a:off x="547380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84" name="Line 71"/>
            <p:cNvSpPr/>
            <p:nvPr/>
          </p:nvSpPr>
          <p:spPr>
            <a:xfrm flipV="1">
              <a:off x="549936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85" name="Line 72"/>
            <p:cNvSpPr/>
            <p:nvPr/>
          </p:nvSpPr>
          <p:spPr>
            <a:xfrm flipV="1">
              <a:off x="552636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86" name="Line 73"/>
            <p:cNvSpPr/>
            <p:nvPr/>
          </p:nvSpPr>
          <p:spPr>
            <a:xfrm flipV="1">
              <a:off x="555336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87" name="Line 74"/>
            <p:cNvSpPr/>
            <p:nvPr/>
          </p:nvSpPr>
          <p:spPr>
            <a:xfrm flipV="1">
              <a:off x="557856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88" name="Line 75"/>
            <p:cNvSpPr/>
            <p:nvPr/>
          </p:nvSpPr>
          <p:spPr>
            <a:xfrm flipV="1">
              <a:off x="560556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89" name="Line 76"/>
            <p:cNvSpPr/>
            <p:nvPr/>
          </p:nvSpPr>
          <p:spPr>
            <a:xfrm flipV="1">
              <a:off x="563256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90" name="Line 77"/>
            <p:cNvSpPr/>
            <p:nvPr/>
          </p:nvSpPr>
          <p:spPr>
            <a:xfrm flipV="1">
              <a:off x="565812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91" name="Line 78"/>
            <p:cNvSpPr/>
            <p:nvPr/>
          </p:nvSpPr>
          <p:spPr>
            <a:xfrm flipV="1">
              <a:off x="568512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92" name="Line 79"/>
            <p:cNvSpPr/>
            <p:nvPr/>
          </p:nvSpPr>
          <p:spPr>
            <a:xfrm flipV="1">
              <a:off x="571212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93" name="Line 80"/>
            <p:cNvSpPr/>
            <p:nvPr/>
          </p:nvSpPr>
          <p:spPr>
            <a:xfrm flipV="1">
              <a:off x="573732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94" name="Line 81"/>
            <p:cNvSpPr/>
            <p:nvPr/>
          </p:nvSpPr>
          <p:spPr>
            <a:xfrm flipV="1">
              <a:off x="576432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95" name="Line 82"/>
            <p:cNvSpPr/>
            <p:nvPr/>
          </p:nvSpPr>
          <p:spPr>
            <a:xfrm flipV="1">
              <a:off x="578988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96" name="Line 83"/>
            <p:cNvSpPr/>
            <p:nvPr/>
          </p:nvSpPr>
          <p:spPr>
            <a:xfrm flipV="1">
              <a:off x="581688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97" name="Line 84"/>
            <p:cNvSpPr/>
            <p:nvPr/>
          </p:nvSpPr>
          <p:spPr>
            <a:xfrm flipV="1">
              <a:off x="584388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98" name="Line 85"/>
            <p:cNvSpPr/>
            <p:nvPr/>
          </p:nvSpPr>
          <p:spPr>
            <a:xfrm flipV="1">
              <a:off x="586944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399" name="Line 86"/>
            <p:cNvSpPr/>
            <p:nvPr/>
          </p:nvSpPr>
          <p:spPr>
            <a:xfrm flipV="1">
              <a:off x="589644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400" name="Line 87"/>
            <p:cNvSpPr/>
            <p:nvPr/>
          </p:nvSpPr>
          <p:spPr>
            <a:xfrm flipV="1">
              <a:off x="592344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401" name="Line 88"/>
            <p:cNvSpPr/>
            <p:nvPr/>
          </p:nvSpPr>
          <p:spPr>
            <a:xfrm flipV="1">
              <a:off x="5948640" y="5449320"/>
              <a:ext cx="144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Calibri"/>
              </a:endParaRPr>
            </a:p>
          </p:txBody>
        </p:sp>
        <p:sp>
          <p:nvSpPr>
            <p:cNvPr id="402" name="Line 104"/>
            <p:cNvSpPr/>
            <p:nvPr/>
          </p:nvSpPr>
          <p:spPr>
            <a:xfrm flipV="1">
              <a:off x="3966840" y="5449320"/>
              <a:ext cx="1440" cy="12960"/>
            </a:xfrm>
            <a:prstGeom prst="line">
              <a:avLst/>
            </a:prstGeom>
            <a:ln w="936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403" name="Line 105"/>
            <p:cNvSpPr/>
            <p:nvPr/>
          </p:nvSpPr>
          <p:spPr>
            <a:xfrm flipV="1">
              <a:off x="4100400" y="5449320"/>
              <a:ext cx="1440" cy="12960"/>
            </a:xfrm>
            <a:prstGeom prst="line">
              <a:avLst/>
            </a:prstGeom>
            <a:ln w="936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404" name="Line 106"/>
            <p:cNvSpPr/>
            <p:nvPr/>
          </p:nvSpPr>
          <p:spPr>
            <a:xfrm flipV="1">
              <a:off x="4232160" y="5449320"/>
              <a:ext cx="1440" cy="12960"/>
            </a:xfrm>
            <a:prstGeom prst="line">
              <a:avLst/>
            </a:prstGeom>
            <a:ln w="936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405" name="Line 107"/>
            <p:cNvSpPr/>
            <p:nvPr/>
          </p:nvSpPr>
          <p:spPr>
            <a:xfrm flipV="1">
              <a:off x="4363920" y="5449320"/>
              <a:ext cx="1440" cy="12960"/>
            </a:xfrm>
            <a:prstGeom prst="line">
              <a:avLst/>
            </a:prstGeom>
            <a:ln w="936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406" name="Line 108"/>
            <p:cNvSpPr/>
            <p:nvPr/>
          </p:nvSpPr>
          <p:spPr>
            <a:xfrm flipV="1">
              <a:off x="4495680" y="5449320"/>
              <a:ext cx="1440" cy="12960"/>
            </a:xfrm>
            <a:prstGeom prst="line">
              <a:avLst/>
            </a:prstGeom>
            <a:ln w="936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407" name="Line 109"/>
            <p:cNvSpPr/>
            <p:nvPr/>
          </p:nvSpPr>
          <p:spPr>
            <a:xfrm flipV="1">
              <a:off x="4627440" y="5449320"/>
              <a:ext cx="1440" cy="12960"/>
            </a:xfrm>
            <a:prstGeom prst="line">
              <a:avLst/>
            </a:prstGeom>
            <a:ln w="936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408" name="Line 110"/>
            <p:cNvSpPr/>
            <p:nvPr/>
          </p:nvSpPr>
          <p:spPr>
            <a:xfrm flipV="1">
              <a:off x="4761000" y="5449320"/>
              <a:ext cx="1440" cy="12960"/>
            </a:xfrm>
            <a:prstGeom prst="line">
              <a:avLst/>
            </a:prstGeom>
            <a:ln w="936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409" name="Line 111"/>
            <p:cNvSpPr/>
            <p:nvPr/>
          </p:nvSpPr>
          <p:spPr>
            <a:xfrm flipV="1">
              <a:off x="4892760" y="5449320"/>
              <a:ext cx="1440" cy="12960"/>
            </a:xfrm>
            <a:prstGeom prst="line">
              <a:avLst/>
            </a:prstGeom>
            <a:ln w="936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410" name="Line 112"/>
            <p:cNvSpPr/>
            <p:nvPr/>
          </p:nvSpPr>
          <p:spPr>
            <a:xfrm flipV="1">
              <a:off x="5024520" y="5449320"/>
              <a:ext cx="1440" cy="12960"/>
            </a:xfrm>
            <a:prstGeom prst="line">
              <a:avLst/>
            </a:prstGeom>
            <a:ln w="936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411" name="Line 113"/>
            <p:cNvSpPr/>
            <p:nvPr/>
          </p:nvSpPr>
          <p:spPr>
            <a:xfrm flipV="1">
              <a:off x="5156280" y="5449320"/>
              <a:ext cx="1440" cy="12960"/>
            </a:xfrm>
            <a:prstGeom prst="line">
              <a:avLst/>
            </a:prstGeom>
            <a:ln w="936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412" name="Line 114"/>
            <p:cNvSpPr/>
            <p:nvPr/>
          </p:nvSpPr>
          <p:spPr>
            <a:xfrm flipV="1">
              <a:off x="5288040" y="5449320"/>
              <a:ext cx="1440" cy="12960"/>
            </a:xfrm>
            <a:prstGeom prst="line">
              <a:avLst/>
            </a:prstGeom>
            <a:ln w="936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413" name="Line 115"/>
            <p:cNvSpPr/>
            <p:nvPr/>
          </p:nvSpPr>
          <p:spPr>
            <a:xfrm flipV="1">
              <a:off x="5421600" y="5449320"/>
              <a:ext cx="1440" cy="12960"/>
            </a:xfrm>
            <a:prstGeom prst="line">
              <a:avLst/>
            </a:prstGeom>
            <a:ln w="936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414" name="Line 116"/>
            <p:cNvSpPr/>
            <p:nvPr/>
          </p:nvSpPr>
          <p:spPr>
            <a:xfrm flipV="1">
              <a:off x="5553360" y="5449320"/>
              <a:ext cx="1440" cy="12960"/>
            </a:xfrm>
            <a:prstGeom prst="line">
              <a:avLst/>
            </a:prstGeom>
            <a:ln w="936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415" name="Line 117"/>
            <p:cNvSpPr/>
            <p:nvPr/>
          </p:nvSpPr>
          <p:spPr>
            <a:xfrm flipV="1">
              <a:off x="5685120" y="5449320"/>
              <a:ext cx="1440" cy="12960"/>
            </a:xfrm>
            <a:prstGeom prst="line">
              <a:avLst/>
            </a:prstGeom>
            <a:ln w="936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416" name="Line 118"/>
            <p:cNvSpPr/>
            <p:nvPr/>
          </p:nvSpPr>
          <p:spPr>
            <a:xfrm flipV="1">
              <a:off x="5816880" y="5449320"/>
              <a:ext cx="1440" cy="12960"/>
            </a:xfrm>
            <a:prstGeom prst="line">
              <a:avLst/>
            </a:prstGeom>
            <a:ln w="936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417" name="Line 119"/>
            <p:cNvSpPr/>
            <p:nvPr/>
          </p:nvSpPr>
          <p:spPr>
            <a:xfrm flipV="1">
              <a:off x="5948640" y="5449320"/>
              <a:ext cx="1440" cy="12960"/>
            </a:xfrm>
            <a:prstGeom prst="line">
              <a:avLst/>
            </a:prstGeom>
            <a:ln w="936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418" name="Line 120"/>
            <p:cNvSpPr/>
            <p:nvPr/>
          </p:nvSpPr>
          <p:spPr>
            <a:xfrm flipV="1">
              <a:off x="3966840" y="4618440"/>
              <a:ext cx="1440" cy="8308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19" name="Line 121"/>
            <p:cNvSpPr/>
            <p:nvPr/>
          </p:nvSpPr>
          <p:spPr>
            <a:xfrm>
              <a:off x="3963600" y="543492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20" name="Line 122"/>
            <p:cNvSpPr/>
            <p:nvPr/>
          </p:nvSpPr>
          <p:spPr>
            <a:xfrm>
              <a:off x="3963600" y="541908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21" name="Line 123"/>
            <p:cNvSpPr/>
            <p:nvPr/>
          </p:nvSpPr>
          <p:spPr>
            <a:xfrm>
              <a:off x="3963600" y="540324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22" name="Line 124"/>
            <p:cNvSpPr/>
            <p:nvPr/>
          </p:nvSpPr>
          <p:spPr>
            <a:xfrm>
              <a:off x="3963600" y="538848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23" name="Line 125"/>
            <p:cNvSpPr/>
            <p:nvPr/>
          </p:nvSpPr>
          <p:spPr>
            <a:xfrm>
              <a:off x="3963600" y="537264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24" name="Line 126"/>
            <p:cNvSpPr/>
            <p:nvPr/>
          </p:nvSpPr>
          <p:spPr>
            <a:xfrm>
              <a:off x="3963600" y="535824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25" name="Line 127"/>
            <p:cNvSpPr/>
            <p:nvPr/>
          </p:nvSpPr>
          <p:spPr>
            <a:xfrm>
              <a:off x="3963600" y="534204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26" name="Line 128"/>
            <p:cNvSpPr/>
            <p:nvPr/>
          </p:nvSpPr>
          <p:spPr>
            <a:xfrm>
              <a:off x="3963600" y="532764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27" name="Line 129"/>
            <p:cNvSpPr/>
            <p:nvPr/>
          </p:nvSpPr>
          <p:spPr>
            <a:xfrm>
              <a:off x="3963600" y="531180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28" name="Line 130"/>
            <p:cNvSpPr/>
            <p:nvPr/>
          </p:nvSpPr>
          <p:spPr>
            <a:xfrm>
              <a:off x="3963600" y="529740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29" name="Line 131"/>
            <p:cNvSpPr/>
            <p:nvPr/>
          </p:nvSpPr>
          <p:spPr>
            <a:xfrm>
              <a:off x="3963600" y="528120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30" name="Line 132"/>
            <p:cNvSpPr/>
            <p:nvPr/>
          </p:nvSpPr>
          <p:spPr>
            <a:xfrm>
              <a:off x="3963600" y="526536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31" name="Line 133"/>
            <p:cNvSpPr/>
            <p:nvPr/>
          </p:nvSpPr>
          <p:spPr>
            <a:xfrm>
              <a:off x="3963600" y="525096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32" name="Line 134"/>
            <p:cNvSpPr/>
            <p:nvPr/>
          </p:nvSpPr>
          <p:spPr>
            <a:xfrm>
              <a:off x="3963600" y="523476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33" name="Line 135"/>
            <p:cNvSpPr/>
            <p:nvPr/>
          </p:nvSpPr>
          <p:spPr>
            <a:xfrm>
              <a:off x="3963600" y="522036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34" name="Line 136"/>
            <p:cNvSpPr/>
            <p:nvPr/>
          </p:nvSpPr>
          <p:spPr>
            <a:xfrm>
              <a:off x="3963600" y="520452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35" name="Line 137"/>
            <p:cNvSpPr/>
            <p:nvPr/>
          </p:nvSpPr>
          <p:spPr>
            <a:xfrm>
              <a:off x="3963600" y="518976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36" name="Line 138"/>
            <p:cNvSpPr/>
            <p:nvPr/>
          </p:nvSpPr>
          <p:spPr>
            <a:xfrm>
              <a:off x="3963600" y="517392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37" name="Line 139"/>
            <p:cNvSpPr/>
            <p:nvPr/>
          </p:nvSpPr>
          <p:spPr>
            <a:xfrm>
              <a:off x="3963600" y="515952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38" name="Line 140"/>
            <p:cNvSpPr/>
            <p:nvPr/>
          </p:nvSpPr>
          <p:spPr>
            <a:xfrm>
              <a:off x="3963600" y="514368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39" name="Line 141"/>
            <p:cNvSpPr/>
            <p:nvPr/>
          </p:nvSpPr>
          <p:spPr>
            <a:xfrm>
              <a:off x="3963600" y="512748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40" name="Line 142"/>
            <p:cNvSpPr/>
            <p:nvPr/>
          </p:nvSpPr>
          <p:spPr>
            <a:xfrm>
              <a:off x="3963600" y="511308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41" name="Line 143"/>
            <p:cNvSpPr/>
            <p:nvPr/>
          </p:nvSpPr>
          <p:spPr>
            <a:xfrm>
              <a:off x="3963600" y="509724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42" name="Line 144"/>
            <p:cNvSpPr/>
            <p:nvPr/>
          </p:nvSpPr>
          <p:spPr>
            <a:xfrm>
              <a:off x="3963600" y="508248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43" name="Line 145"/>
            <p:cNvSpPr/>
            <p:nvPr/>
          </p:nvSpPr>
          <p:spPr>
            <a:xfrm>
              <a:off x="3963600" y="506664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44" name="Line 146"/>
            <p:cNvSpPr/>
            <p:nvPr/>
          </p:nvSpPr>
          <p:spPr>
            <a:xfrm>
              <a:off x="3963600" y="505224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45" name="Line 147"/>
            <p:cNvSpPr/>
            <p:nvPr/>
          </p:nvSpPr>
          <p:spPr>
            <a:xfrm>
              <a:off x="3963600" y="503604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46" name="Line 148"/>
            <p:cNvSpPr/>
            <p:nvPr/>
          </p:nvSpPr>
          <p:spPr>
            <a:xfrm>
              <a:off x="3963600" y="502164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47" name="Line 149"/>
            <p:cNvSpPr/>
            <p:nvPr/>
          </p:nvSpPr>
          <p:spPr>
            <a:xfrm>
              <a:off x="3963600" y="500580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48" name="Line 150"/>
            <p:cNvSpPr/>
            <p:nvPr/>
          </p:nvSpPr>
          <p:spPr>
            <a:xfrm>
              <a:off x="3963600" y="498996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49" name="Line 151"/>
            <p:cNvSpPr/>
            <p:nvPr/>
          </p:nvSpPr>
          <p:spPr>
            <a:xfrm>
              <a:off x="3963600" y="497520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50" name="Line 152"/>
            <p:cNvSpPr/>
            <p:nvPr/>
          </p:nvSpPr>
          <p:spPr>
            <a:xfrm>
              <a:off x="3963600" y="495936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51" name="Line 153"/>
            <p:cNvSpPr/>
            <p:nvPr/>
          </p:nvSpPr>
          <p:spPr>
            <a:xfrm>
              <a:off x="3963600" y="494496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52" name="Line 154"/>
            <p:cNvSpPr/>
            <p:nvPr/>
          </p:nvSpPr>
          <p:spPr>
            <a:xfrm>
              <a:off x="3963600" y="492876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53" name="Line 155"/>
            <p:cNvSpPr/>
            <p:nvPr/>
          </p:nvSpPr>
          <p:spPr>
            <a:xfrm>
              <a:off x="3963600" y="491436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54" name="Line 156"/>
            <p:cNvSpPr/>
            <p:nvPr/>
          </p:nvSpPr>
          <p:spPr>
            <a:xfrm>
              <a:off x="3963600" y="489852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55" name="Line 157"/>
            <p:cNvSpPr/>
            <p:nvPr/>
          </p:nvSpPr>
          <p:spPr>
            <a:xfrm>
              <a:off x="3963600" y="488412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56" name="Line 158"/>
            <p:cNvSpPr/>
            <p:nvPr/>
          </p:nvSpPr>
          <p:spPr>
            <a:xfrm>
              <a:off x="3963600" y="486792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57" name="Line 159"/>
            <p:cNvSpPr/>
            <p:nvPr/>
          </p:nvSpPr>
          <p:spPr>
            <a:xfrm>
              <a:off x="3963600" y="485208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58" name="Line 160"/>
            <p:cNvSpPr/>
            <p:nvPr/>
          </p:nvSpPr>
          <p:spPr>
            <a:xfrm>
              <a:off x="3963600" y="483768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59" name="Line 161"/>
            <p:cNvSpPr/>
            <p:nvPr/>
          </p:nvSpPr>
          <p:spPr>
            <a:xfrm>
              <a:off x="3963600" y="482148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60" name="Line 162"/>
            <p:cNvSpPr/>
            <p:nvPr/>
          </p:nvSpPr>
          <p:spPr>
            <a:xfrm>
              <a:off x="3963600" y="480708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61" name="Line 163"/>
            <p:cNvSpPr/>
            <p:nvPr/>
          </p:nvSpPr>
          <p:spPr>
            <a:xfrm>
              <a:off x="3963600" y="479124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62" name="Line 164"/>
            <p:cNvSpPr/>
            <p:nvPr/>
          </p:nvSpPr>
          <p:spPr>
            <a:xfrm>
              <a:off x="3963600" y="477648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63" name="Line 165"/>
            <p:cNvSpPr/>
            <p:nvPr/>
          </p:nvSpPr>
          <p:spPr>
            <a:xfrm>
              <a:off x="3963600" y="476064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64" name="Line 166"/>
            <p:cNvSpPr/>
            <p:nvPr/>
          </p:nvSpPr>
          <p:spPr>
            <a:xfrm>
              <a:off x="3963600" y="474480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65" name="Line 167"/>
            <p:cNvSpPr/>
            <p:nvPr/>
          </p:nvSpPr>
          <p:spPr>
            <a:xfrm>
              <a:off x="3963600" y="473040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66" name="Line 168"/>
            <p:cNvSpPr/>
            <p:nvPr/>
          </p:nvSpPr>
          <p:spPr>
            <a:xfrm>
              <a:off x="3963600" y="471420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67" name="Line 169"/>
            <p:cNvSpPr/>
            <p:nvPr/>
          </p:nvSpPr>
          <p:spPr>
            <a:xfrm>
              <a:off x="3963600" y="469980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68" name="Line 170"/>
            <p:cNvSpPr/>
            <p:nvPr/>
          </p:nvSpPr>
          <p:spPr>
            <a:xfrm>
              <a:off x="3963600" y="468396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69" name="Line 171"/>
            <p:cNvSpPr/>
            <p:nvPr/>
          </p:nvSpPr>
          <p:spPr>
            <a:xfrm>
              <a:off x="3963600" y="466920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70" name="Line 172"/>
            <p:cNvSpPr/>
            <p:nvPr/>
          </p:nvSpPr>
          <p:spPr>
            <a:xfrm>
              <a:off x="3963600" y="465336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71" name="Line 173"/>
            <p:cNvSpPr/>
            <p:nvPr/>
          </p:nvSpPr>
          <p:spPr>
            <a:xfrm>
              <a:off x="3963600" y="463896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72" name="Line 174"/>
            <p:cNvSpPr/>
            <p:nvPr/>
          </p:nvSpPr>
          <p:spPr>
            <a:xfrm>
              <a:off x="3963600" y="4623120"/>
              <a:ext cx="2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73" name="Line 175"/>
            <p:cNvSpPr/>
            <p:nvPr/>
          </p:nvSpPr>
          <p:spPr>
            <a:xfrm>
              <a:off x="3960360" y="5372640"/>
              <a:ext cx="61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74" name="Rectangle 176"/>
            <p:cNvSpPr/>
            <p:nvPr/>
          </p:nvSpPr>
          <p:spPr>
            <a:xfrm>
              <a:off x="3760560" y="5278320"/>
              <a:ext cx="169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200</a:t>
              </a:r>
              <a:endParaRPr b="0" lang="en-US" sz="800" spc="-1" strike="noStrike">
                <a:solidFill>
                  <a:srgbClr val="000000"/>
                </a:solidFill>
                <a:latin typeface="Calibri"/>
              </a:endParaRPr>
            </a:p>
          </p:txBody>
        </p:sp>
        <p:sp>
          <p:nvSpPr>
            <p:cNvPr id="475" name="Line 177"/>
            <p:cNvSpPr/>
            <p:nvPr/>
          </p:nvSpPr>
          <p:spPr>
            <a:xfrm>
              <a:off x="3960360" y="5297400"/>
              <a:ext cx="61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76" name="Line 179"/>
            <p:cNvSpPr/>
            <p:nvPr/>
          </p:nvSpPr>
          <p:spPr>
            <a:xfrm>
              <a:off x="3960360" y="5220360"/>
              <a:ext cx="61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77" name="Rectangle 180"/>
            <p:cNvSpPr/>
            <p:nvPr/>
          </p:nvSpPr>
          <p:spPr>
            <a:xfrm>
              <a:off x="3760560" y="5126040"/>
              <a:ext cx="169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600</a:t>
              </a:r>
              <a:endParaRPr b="0" lang="en-US" sz="800" spc="-1" strike="noStrike">
                <a:solidFill>
                  <a:srgbClr val="000000"/>
                </a:solidFill>
                <a:latin typeface="Calibri"/>
              </a:endParaRPr>
            </a:p>
          </p:txBody>
        </p:sp>
        <p:sp>
          <p:nvSpPr>
            <p:cNvPr id="478" name="Line 181"/>
            <p:cNvSpPr/>
            <p:nvPr/>
          </p:nvSpPr>
          <p:spPr>
            <a:xfrm>
              <a:off x="3960360" y="5143680"/>
              <a:ext cx="61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79" name="Line 183"/>
            <p:cNvSpPr/>
            <p:nvPr/>
          </p:nvSpPr>
          <p:spPr>
            <a:xfrm>
              <a:off x="3960360" y="5066640"/>
              <a:ext cx="61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80" name="Rectangle 184"/>
            <p:cNvSpPr/>
            <p:nvPr/>
          </p:nvSpPr>
          <p:spPr>
            <a:xfrm>
              <a:off x="3619800" y="4972320"/>
              <a:ext cx="3132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   </a:t>
              </a:r>
              <a:r>
                <a:rPr b="0" lang="de-DE" sz="800" spc="-1" strike="noStrike">
                  <a:solidFill>
                    <a:srgbClr val="000000"/>
                  </a:solidFill>
                  <a:latin typeface="Arial"/>
                  <a:ea typeface="Arial"/>
                </a:rPr>
                <a:t>1000</a:t>
              </a:r>
              <a:endParaRPr b="0" lang="en-US" sz="800" spc="-1" strike="noStrike">
                <a:solidFill>
                  <a:srgbClr val="000000"/>
                </a:solidFill>
                <a:latin typeface="Calibri"/>
              </a:endParaRPr>
            </a:p>
          </p:txBody>
        </p:sp>
        <p:sp>
          <p:nvSpPr>
            <p:cNvPr id="481" name="Line 185"/>
            <p:cNvSpPr/>
            <p:nvPr/>
          </p:nvSpPr>
          <p:spPr>
            <a:xfrm>
              <a:off x="3960360" y="4989960"/>
              <a:ext cx="61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82" name="Line 187"/>
            <p:cNvSpPr/>
            <p:nvPr/>
          </p:nvSpPr>
          <p:spPr>
            <a:xfrm>
              <a:off x="3960360" y="4914360"/>
              <a:ext cx="61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83" name="Rectangle 188"/>
            <p:cNvSpPr/>
            <p:nvPr/>
          </p:nvSpPr>
          <p:spPr>
            <a:xfrm>
              <a:off x="3677040" y="4820040"/>
              <a:ext cx="255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 </a:t>
              </a:r>
              <a:r>
                <a:rPr b="0" lang="de-DE" sz="800" spc="-1" strike="noStrike">
                  <a:solidFill>
                    <a:srgbClr val="000000"/>
                  </a:solidFill>
                  <a:latin typeface="Arial"/>
                  <a:ea typeface="Arial"/>
                </a:rPr>
                <a:t>1400</a:t>
              </a:r>
              <a:endParaRPr b="0" lang="en-US" sz="800" spc="-1" strike="noStrike">
                <a:solidFill>
                  <a:srgbClr val="000000"/>
                </a:solidFill>
                <a:latin typeface="Calibri"/>
              </a:endParaRPr>
            </a:p>
          </p:txBody>
        </p:sp>
        <p:sp>
          <p:nvSpPr>
            <p:cNvPr id="484" name="Line 189"/>
            <p:cNvSpPr/>
            <p:nvPr/>
          </p:nvSpPr>
          <p:spPr>
            <a:xfrm>
              <a:off x="3960360" y="4837680"/>
              <a:ext cx="61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85" name="Line 191"/>
            <p:cNvSpPr/>
            <p:nvPr/>
          </p:nvSpPr>
          <p:spPr>
            <a:xfrm>
              <a:off x="3960360" y="4760640"/>
              <a:ext cx="61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86" name="Rectangle 192"/>
            <p:cNvSpPr/>
            <p:nvPr/>
          </p:nvSpPr>
          <p:spPr>
            <a:xfrm>
              <a:off x="3677040" y="4666320"/>
              <a:ext cx="255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 </a:t>
              </a:r>
              <a:r>
                <a:rPr b="0" lang="de-DE" sz="800" spc="-1" strike="noStrike">
                  <a:solidFill>
                    <a:srgbClr val="000000"/>
                  </a:solidFill>
                  <a:latin typeface="Arial"/>
                  <a:ea typeface="Arial"/>
                </a:rPr>
                <a:t>1800</a:t>
              </a:r>
              <a:endParaRPr b="0" lang="en-US" sz="800" spc="-1" strike="noStrike">
                <a:solidFill>
                  <a:srgbClr val="000000"/>
                </a:solidFill>
                <a:latin typeface="Calibri"/>
              </a:endParaRPr>
            </a:p>
          </p:txBody>
        </p:sp>
        <p:sp>
          <p:nvSpPr>
            <p:cNvPr id="487" name="Line 193"/>
            <p:cNvSpPr/>
            <p:nvPr/>
          </p:nvSpPr>
          <p:spPr>
            <a:xfrm>
              <a:off x="3960360" y="4683960"/>
              <a:ext cx="61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88" name="Freeform 198"/>
            <p:cNvSpPr/>
            <p:nvPr/>
          </p:nvSpPr>
          <p:spPr>
            <a:xfrm flipV="1">
              <a:off x="3966840" y="4633920"/>
              <a:ext cx="1983240" cy="814680"/>
            </a:xfrm>
            <a:custGeom>
              <a:avLst/>
              <a:gdLst>
                <a:gd name="textAreaLeft" fmla="*/ 0 w 1983240"/>
                <a:gd name="textAreaRight" fmla="*/ 1983600 w 1983240"/>
                <a:gd name="textAreaTop" fmla="*/ -360 h 814680"/>
                <a:gd name="textAreaBottom" fmla="*/ 814680 h 814680"/>
              </a:gdLst>
              <a:ahLst/>
              <a:rect l="textAreaLeft" t="textAreaTop" r="textAreaRight" b="textAreaBottom"/>
              <a:pathLst>
                <a:path w="11254" h="10401">
                  <a:moveTo>
                    <a:pt x="0" y="64"/>
                  </a:moveTo>
                  <a:lnTo>
                    <a:pt x="7" y="71"/>
                  </a:lnTo>
                  <a:lnTo>
                    <a:pt x="17" y="84"/>
                  </a:lnTo>
                  <a:lnTo>
                    <a:pt x="28" y="91"/>
                  </a:lnTo>
                  <a:lnTo>
                    <a:pt x="38" y="96"/>
                  </a:lnTo>
                  <a:lnTo>
                    <a:pt x="48" y="98"/>
                  </a:lnTo>
                  <a:lnTo>
                    <a:pt x="58" y="101"/>
                  </a:lnTo>
                  <a:lnTo>
                    <a:pt x="69" y="92"/>
                  </a:lnTo>
                  <a:lnTo>
                    <a:pt x="79" y="83"/>
                  </a:lnTo>
                  <a:lnTo>
                    <a:pt x="89" y="75"/>
                  </a:lnTo>
                  <a:lnTo>
                    <a:pt x="99" y="62"/>
                  </a:lnTo>
                  <a:lnTo>
                    <a:pt x="110" y="49"/>
                  </a:lnTo>
                  <a:lnTo>
                    <a:pt x="120" y="38"/>
                  </a:lnTo>
                  <a:lnTo>
                    <a:pt x="130" y="31"/>
                  </a:lnTo>
                  <a:lnTo>
                    <a:pt x="140" y="25"/>
                  </a:lnTo>
                  <a:lnTo>
                    <a:pt x="151" y="19"/>
                  </a:lnTo>
                  <a:lnTo>
                    <a:pt x="161" y="14"/>
                  </a:lnTo>
                  <a:lnTo>
                    <a:pt x="171" y="11"/>
                  </a:lnTo>
                  <a:lnTo>
                    <a:pt x="181" y="9"/>
                  </a:lnTo>
                  <a:lnTo>
                    <a:pt x="191" y="6"/>
                  </a:lnTo>
                  <a:lnTo>
                    <a:pt x="202" y="7"/>
                  </a:lnTo>
                  <a:lnTo>
                    <a:pt x="212" y="6"/>
                  </a:lnTo>
                  <a:lnTo>
                    <a:pt x="222" y="8"/>
                  </a:lnTo>
                  <a:lnTo>
                    <a:pt x="232" y="8"/>
                  </a:lnTo>
                  <a:lnTo>
                    <a:pt x="243" y="10"/>
                  </a:lnTo>
                  <a:lnTo>
                    <a:pt x="253" y="14"/>
                  </a:lnTo>
                  <a:lnTo>
                    <a:pt x="263" y="18"/>
                  </a:lnTo>
                  <a:lnTo>
                    <a:pt x="273" y="23"/>
                  </a:lnTo>
                  <a:lnTo>
                    <a:pt x="284" y="25"/>
                  </a:lnTo>
                  <a:lnTo>
                    <a:pt x="294" y="32"/>
                  </a:lnTo>
                  <a:lnTo>
                    <a:pt x="304" y="34"/>
                  </a:lnTo>
                  <a:lnTo>
                    <a:pt x="314" y="36"/>
                  </a:lnTo>
                  <a:lnTo>
                    <a:pt x="324" y="37"/>
                  </a:lnTo>
                  <a:lnTo>
                    <a:pt x="335" y="40"/>
                  </a:lnTo>
                  <a:lnTo>
                    <a:pt x="345" y="38"/>
                  </a:lnTo>
                  <a:lnTo>
                    <a:pt x="355" y="37"/>
                  </a:lnTo>
                  <a:lnTo>
                    <a:pt x="365" y="34"/>
                  </a:lnTo>
                  <a:lnTo>
                    <a:pt x="376" y="30"/>
                  </a:lnTo>
                  <a:lnTo>
                    <a:pt x="386" y="25"/>
                  </a:lnTo>
                  <a:lnTo>
                    <a:pt x="396" y="22"/>
                  </a:lnTo>
                  <a:lnTo>
                    <a:pt x="406" y="18"/>
                  </a:lnTo>
                  <a:lnTo>
                    <a:pt x="417" y="15"/>
                  </a:lnTo>
                  <a:lnTo>
                    <a:pt x="427" y="12"/>
                  </a:lnTo>
                  <a:lnTo>
                    <a:pt x="437" y="9"/>
                  </a:lnTo>
                  <a:lnTo>
                    <a:pt x="447" y="8"/>
                  </a:lnTo>
                  <a:lnTo>
                    <a:pt x="458" y="7"/>
                  </a:lnTo>
                  <a:lnTo>
                    <a:pt x="468" y="5"/>
                  </a:lnTo>
                  <a:lnTo>
                    <a:pt x="478" y="4"/>
                  </a:lnTo>
                  <a:lnTo>
                    <a:pt x="488" y="4"/>
                  </a:lnTo>
                  <a:lnTo>
                    <a:pt x="498" y="3"/>
                  </a:lnTo>
                  <a:lnTo>
                    <a:pt x="509" y="3"/>
                  </a:lnTo>
                  <a:lnTo>
                    <a:pt x="519" y="3"/>
                  </a:lnTo>
                  <a:lnTo>
                    <a:pt x="529" y="2"/>
                  </a:lnTo>
                  <a:lnTo>
                    <a:pt x="539" y="2"/>
                  </a:lnTo>
                  <a:lnTo>
                    <a:pt x="550" y="3"/>
                  </a:lnTo>
                  <a:lnTo>
                    <a:pt x="560" y="2"/>
                  </a:lnTo>
                  <a:lnTo>
                    <a:pt x="570" y="2"/>
                  </a:lnTo>
                  <a:lnTo>
                    <a:pt x="580" y="4"/>
                  </a:lnTo>
                  <a:lnTo>
                    <a:pt x="591" y="4"/>
                  </a:lnTo>
                  <a:lnTo>
                    <a:pt x="601" y="6"/>
                  </a:lnTo>
                  <a:lnTo>
                    <a:pt x="611" y="7"/>
                  </a:lnTo>
                  <a:lnTo>
                    <a:pt x="621" y="10"/>
                  </a:lnTo>
                  <a:lnTo>
                    <a:pt x="631" y="11"/>
                  </a:lnTo>
                  <a:lnTo>
                    <a:pt x="642" y="14"/>
                  </a:lnTo>
                  <a:lnTo>
                    <a:pt x="652" y="16"/>
                  </a:lnTo>
                  <a:lnTo>
                    <a:pt x="662" y="18"/>
                  </a:lnTo>
                  <a:lnTo>
                    <a:pt x="672" y="22"/>
                  </a:lnTo>
                  <a:lnTo>
                    <a:pt x="683" y="23"/>
                  </a:lnTo>
                  <a:lnTo>
                    <a:pt x="693" y="26"/>
                  </a:lnTo>
                  <a:lnTo>
                    <a:pt x="703" y="27"/>
                  </a:lnTo>
                  <a:lnTo>
                    <a:pt x="713" y="28"/>
                  </a:lnTo>
                  <a:lnTo>
                    <a:pt x="724" y="27"/>
                  </a:lnTo>
                  <a:lnTo>
                    <a:pt x="734" y="28"/>
                  </a:lnTo>
                  <a:lnTo>
                    <a:pt x="744" y="27"/>
                  </a:lnTo>
                  <a:lnTo>
                    <a:pt x="754" y="27"/>
                  </a:lnTo>
                  <a:lnTo>
                    <a:pt x="765" y="26"/>
                  </a:lnTo>
                  <a:lnTo>
                    <a:pt x="775" y="24"/>
                  </a:lnTo>
                  <a:lnTo>
                    <a:pt x="785" y="22"/>
                  </a:lnTo>
                  <a:lnTo>
                    <a:pt x="795" y="20"/>
                  </a:lnTo>
                  <a:lnTo>
                    <a:pt x="805" y="18"/>
                  </a:lnTo>
                  <a:lnTo>
                    <a:pt x="816" y="15"/>
                  </a:lnTo>
                  <a:lnTo>
                    <a:pt x="826" y="13"/>
                  </a:lnTo>
                  <a:lnTo>
                    <a:pt x="836" y="12"/>
                  </a:lnTo>
                  <a:lnTo>
                    <a:pt x="846" y="12"/>
                  </a:lnTo>
                  <a:lnTo>
                    <a:pt x="857" y="9"/>
                  </a:lnTo>
                  <a:lnTo>
                    <a:pt x="867" y="10"/>
                  </a:lnTo>
                  <a:lnTo>
                    <a:pt x="877" y="8"/>
                  </a:lnTo>
                  <a:lnTo>
                    <a:pt x="887" y="8"/>
                  </a:lnTo>
                  <a:lnTo>
                    <a:pt x="898" y="8"/>
                  </a:lnTo>
                  <a:lnTo>
                    <a:pt x="908" y="8"/>
                  </a:lnTo>
                  <a:lnTo>
                    <a:pt x="918" y="7"/>
                  </a:lnTo>
                  <a:lnTo>
                    <a:pt x="928" y="9"/>
                  </a:lnTo>
                  <a:lnTo>
                    <a:pt x="938" y="11"/>
                  </a:lnTo>
                  <a:lnTo>
                    <a:pt x="949" y="13"/>
                  </a:lnTo>
                  <a:lnTo>
                    <a:pt x="959" y="17"/>
                  </a:lnTo>
                  <a:lnTo>
                    <a:pt x="969" y="23"/>
                  </a:lnTo>
                  <a:lnTo>
                    <a:pt x="979" y="29"/>
                  </a:lnTo>
                  <a:lnTo>
                    <a:pt x="990" y="37"/>
                  </a:lnTo>
                  <a:lnTo>
                    <a:pt x="1000" y="48"/>
                  </a:lnTo>
                  <a:lnTo>
                    <a:pt x="1010" y="58"/>
                  </a:lnTo>
                  <a:lnTo>
                    <a:pt x="1020" y="68"/>
                  </a:lnTo>
                  <a:lnTo>
                    <a:pt x="1031" y="82"/>
                  </a:lnTo>
                  <a:lnTo>
                    <a:pt x="1041" y="91"/>
                  </a:lnTo>
                  <a:lnTo>
                    <a:pt x="1051" y="95"/>
                  </a:lnTo>
                  <a:lnTo>
                    <a:pt x="1061" y="98"/>
                  </a:lnTo>
                  <a:lnTo>
                    <a:pt x="1072" y="99"/>
                  </a:lnTo>
                  <a:lnTo>
                    <a:pt x="1082" y="87"/>
                  </a:lnTo>
                  <a:lnTo>
                    <a:pt x="1092" y="81"/>
                  </a:lnTo>
                  <a:lnTo>
                    <a:pt x="1102" y="69"/>
                  </a:lnTo>
                  <a:lnTo>
                    <a:pt x="1112" y="57"/>
                  </a:lnTo>
                  <a:lnTo>
                    <a:pt x="1123" y="48"/>
                  </a:lnTo>
                  <a:lnTo>
                    <a:pt x="1133" y="38"/>
                  </a:lnTo>
                  <a:lnTo>
                    <a:pt x="1143" y="29"/>
                  </a:lnTo>
                  <a:lnTo>
                    <a:pt x="1153" y="23"/>
                  </a:lnTo>
                  <a:lnTo>
                    <a:pt x="1164" y="18"/>
                  </a:lnTo>
                  <a:lnTo>
                    <a:pt x="1174" y="14"/>
                  </a:lnTo>
                  <a:lnTo>
                    <a:pt x="1184" y="11"/>
                  </a:lnTo>
                  <a:lnTo>
                    <a:pt x="1194" y="8"/>
                  </a:lnTo>
                  <a:lnTo>
                    <a:pt x="1205" y="7"/>
                  </a:lnTo>
                  <a:lnTo>
                    <a:pt x="1215" y="6"/>
                  </a:lnTo>
                  <a:lnTo>
                    <a:pt x="1225" y="7"/>
                  </a:lnTo>
                  <a:lnTo>
                    <a:pt x="1235" y="5"/>
                  </a:lnTo>
                  <a:lnTo>
                    <a:pt x="1245" y="4"/>
                  </a:lnTo>
                  <a:lnTo>
                    <a:pt x="1256" y="4"/>
                  </a:lnTo>
                  <a:lnTo>
                    <a:pt x="1266" y="4"/>
                  </a:lnTo>
                  <a:lnTo>
                    <a:pt x="1276" y="4"/>
                  </a:lnTo>
                  <a:lnTo>
                    <a:pt x="1286" y="3"/>
                  </a:lnTo>
                  <a:lnTo>
                    <a:pt x="1297" y="3"/>
                  </a:lnTo>
                  <a:lnTo>
                    <a:pt x="1307" y="4"/>
                  </a:lnTo>
                  <a:lnTo>
                    <a:pt x="1317" y="4"/>
                  </a:lnTo>
                  <a:lnTo>
                    <a:pt x="1327" y="4"/>
                  </a:lnTo>
                  <a:lnTo>
                    <a:pt x="1338" y="4"/>
                  </a:lnTo>
                  <a:lnTo>
                    <a:pt x="1348" y="5"/>
                  </a:lnTo>
                  <a:lnTo>
                    <a:pt x="1358" y="6"/>
                  </a:lnTo>
                  <a:lnTo>
                    <a:pt x="1368" y="6"/>
                  </a:lnTo>
                  <a:lnTo>
                    <a:pt x="1379" y="6"/>
                  </a:lnTo>
                  <a:lnTo>
                    <a:pt x="1389" y="6"/>
                  </a:lnTo>
                  <a:lnTo>
                    <a:pt x="1399" y="7"/>
                  </a:lnTo>
                  <a:lnTo>
                    <a:pt x="1409" y="6"/>
                  </a:lnTo>
                  <a:lnTo>
                    <a:pt x="1419" y="6"/>
                  </a:lnTo>
                  <a:lnTo>
                    <a:pt x="1430" y="8"/>
                  </a:lnTo>
                  <a:lnTo>
                    <a:pt x="1440" y="6"/>
                  </a:lnTo>
                  <a:lnTo>
                    <a:pt x="1450" y="6"/>
                  </a:lnTo>
                  <a:lnTo>
                    <a:pt x="1460" y="6"/>
                  </a:lnTo>
                  <a:lnTo>
                    <a:pt x="1471" y="7"/>
                  </a:lnTo>
                  <a:lnTo>
                    <a:pt x="1481" y="7"/>
                  </a:lnTo>
                  <a:lnTo>
                    <a:pt x="1491" y="7"/>
                  </a:lnTo>
                  <a:lnTo>
                    <a:pt x="1501" y="9"/>
                  </a:lnTo>
                  <a:lnTo>
                    <a:pt x="1512" y="11"/>
                  </a:lnTo>
                  <a:lnTo>
                    <a:pt x="1522" y="11"/>
                  </a:lnTo>
                  <a:lnTo>
                    <a:pt x="1532" y="12"/>
                  </a:lnTo>
                  <a:lnTo>
                    <a:pt x="1542" y="14"/>
                  </a:lnTo>
                  <a:lnTo>
                    <a:pt x="1552" y="14"/>
                  </a:lnTo>
                  <a:lnTo>
                    <a:pt x="1563" y="15"/>
                  </a:lnTo>
                  <a:lnTo>
                    <a:pt x="1573" y="15"/>
                  </a:lnTo>
                  <a:lnTo>
                    <a:pt x="1583" y="14"/>
                  </a:lnTo>
                  <a:lnTo>
                    <a:pt x="1593" y="15"/>
                  </a:lnTo>
                  <a:lnTo>
                    <a:pt x="1604" y="13"/>
                  </a:lnTo>
                  <a:lnTo>
                    <a:pt x="1614" y="13"/>
                  </a:lnTo>
                  <a:lnTo>
                    <a:pt x="1624" y="11"/>
                  </a:lnTo>
                  <a:lnTo>
                    <a:pt x="1634" y="11"/>
                  </a:lnTo>
                  <a:lnTo>
                    <a:pt x="1645" y="9"/>
                  </a:lnTo>
                  <a:lnTo>
                    <a:pt x="1655" y="8"/>
                  </a:lnTo>
                  <a:lnTo>
                    <a:pt x="1665" y="6"/>
                  </a:lnTo>
                  <a:lnTo>
                    <a:pt x="1675" y="6"/>
                  </a:lnTo>
                  <a:lnTo>
                    <a:pt x="1686" y="5"/>
                  </a:lnTo>
                  <a:lnTo>
                    <a:pt x="1696" y="3"/>
                  </a:lnTo>
                  <a:lnTo>
                    <a:pt x="1706" y="2"/>
                  </a:lnTo>
                  <a:lnTo>
                    <a:pt x="1716" y="2"/>
                  </a:lnTo>
                  <a:lnTo>
                    <a:pt x="1726" y="3"/>
                  </a:lnTo>
                  <a:lnTo>
                    <a:pt x="1737" y="3"/>
                  </a:lnTo>
                  <a:lnTo>
                    <a:pt x="1747" y="2"/>
                  </a:lnTo>
                  <a:lnTo>
                    <a:pt x="1757" y="2"/>
                  </a:lnTo>
                  <a:lnTo>
                    <a:pt x="1767" y="2"/>
                  </a:lnTo>
                  <a:lnTo>
                    <a:pt x="1778" y="2"/>
                  </a:lnTo>
                  <a:lnTo>
                    <a:pt x="1788" y="2"/>
                  </a:lnTo>
                  <a:lnTo>
                    <a:pt x="1798" y="3"/>
                  </a:lnTo>
                  <a:lnTo>
                    <a:pt x="1808" y="3"/>
                  </a:lnTo>
                  <a:lnTo>
                    <a:pt x="1819" y="3"/>
                  </a:lnTo>
                  <a:lnTo>
                    <a:pt x="1829" y="3"/>
                  </a:lnTo>
                  <a:lnTo>
                    <a:pt x="1839" y="4"/>
                  </a:lnTo>
                  <a:lnTo>
                    <a:pt x="1849" y="4"/>
                  </a:lnTo>
                  <a:lnTo>
                    <a:pt x="1859" y="5"/>
                  </a:lnTo>
                  <a:lnTo>
                    <a:pt x="1870" y="6"/>
                  </a:lnTo>
                  <a:lnTo>
                    <a:pt x="1880" y="6"/>
                  </a:lnTo>
                  <a:lnTo>
                    <a:pt x="1890" y="8"/>
                  </a:lnTo>
                  <a:lnTo>
                    <a:pt x="1900" y="8"/>
                  </a:lnTo>
                  <a:lnTo>
                    <a:pt x="1911" y="9"/>
                  </a:lnTo>
                  <a:lnTo>
                    <a:pt x="1921" y="11"/>
                  </a:lnTo>
                  <a:lnTo>
                    <a:pt x="1931" y="13"/>
                  </a:lnTo>
                  <a:lnTo>
                    <a:pt x="1941" y="13"/>
                  </a:lnTo>
                  <a:lnTo>
                    <a:pt x="1952" y="13"/>
                  </a:lnTo>
                  <a:lnTo>
                    <a:pt x="1962" y="13"/>
                  </a:lnTo>
                  <a:lnTo>
                    <a:pt x="1972" y="12"/>
                  </a:lnTo>
                  <a:lnTo>
                    <a:pt x="1982" y="11"/>
                  </a:lnTo>
                  <a:lnTo>
                    <a:pt x="1993" y="9"/>
                  </a:lnTo>
                  <a:lnTo>
                    <a:pt x="2003" y="9"/>
                  </a:lnTo>
                  <a:lnTo>
                    <a:pt x="2013" y="7"/>
                  </a:lnTo>
                  <a:lnTo>
                    <a:pt x="2023" y="6"/>
                  </a:lnTo>
                  <a:lnTo>
                    <a:pt x="2033" y="6"/>
                  </a:lnTo>
                  <a:lnTo>
                    <a:pt x="2044" y="6"/>
                  </a:lnTo>
                  <a:lnTo>
                    <a:pt x="2054" y="5"/>
                  </a:lnTo>
                  <a:lnTo>
                    <a:pt x="2064" y="4"/>
                  </a:lnTo>
                  <a:lnTo>
                    <a:pt x="2074" y="5"/>
                  </a:lnTo>
                  <a:lnTo>
                    <a:pt x="2085" y="4"/>
                  </a:lnTo>
                  <a:lnTo>
                    <a:pt x="2095" y="5"/>
                  </a:lnTo>
                  <a:lnTo>
                    <a:pt x="2105" y="4"/>
                  </a:lnTo>
                  <a:lnTo>
                    <a:pt x="2115" y="5"/>
                  </a:lnTo>
                  <a:lnTo>
                    <a:pt x="2126" y="4"/>
                  </a:lnTo>
                  <a:lnTo>
                    <a:pt x="2136" y="4"/>
                  </a:lnTo>
                  <a:lnTo>
                    <a:pt x="2146" y="3"/>
                  </a:lnTo>
                  <a:lnTo>
                    <a:pt x="2156" y="2"/>
                  </a:lnTo>
                  <a:lnTo>
                    <a:pt x="2166" y="3"/>
                  </a:lnTo>
                  <a:lnTo>
                    <a:pt x="2177" y="3"/>
                  </a:lnTo>
                  <a:lnTo>
                    <a:pt x="2187" y="1"/>
                  </a:lnTo>
                  <a:lnTo>
                    <a:pt x="2197" y="2"/>
                  </a:lnTo>
                  <a:lnTo>
                    <a:pt x="2207" y="1"/>
                  </a:lnTo>
                  <a:lnTo>
                    <a:pt x="2218" y="1"/>
                  </a:lnTo>
                  <a:lnTo>
                    <a:pt x="2228" y="1"/>
                  </a:lnTo>
                  <a:lnTo>
                    <a:pt x="2238" y="1"/>
                  </a:lnTo>
                  <a:lnTo>
                    <a:pt x="2248" y="0"/>
                  </a:lnTo>
                  <a:lnTo>
                    <a:pt x="2259" y="1"/>
                  </a:lnTo>
                  <a:lnTo>
                    <a:pt x="2269" y="0"/>
                  </a:lnTo>
                  <a:lnTo>
                    <a:pt x="2279" y="1"/>
                  </a:lnTo>
                  <a:lnTo>
                    <a:pt x="2289" y="0"/>
                  </a:lnTo>
                  <a:lnTo>
                    <a:pt x="2300" y="0"/>
                  </a:lnTo>
                  <a:lnTo>
                    <a:pt x="2310" y="0"/>
                  </a:lnTo>
                  <a:lnTo>
                    <a:pt x="2320" y="0"/>
                  </a:lnTo>
                  <a:lnTo>
                    <a:pt x="2330" y="0"/>
                  </a:lnTo>
                  <a:lnTo>
                    <a:pt x="2340" y="2"/>
                  </a:lnTo>
                  <a:lnTo>
                    <a:pt x="2351" y="1"/>
                  </a:lnTo>
                  <a:lnTo>
                    <a:pt x="2361" y="1"/>
                  </a:lnTo>
                  <a:lnTo>
                    <a:pt x="2371" y="2"/>
                  </a:lnTo>
                  <a:lnTo>
                    <a:pt x="2381" y="2"/>
                  </a:lnTo>
                  <a:lnTo>
                    <a:pt x="2392" y="2"/>
                  </a:lnTo>
                  <a:lnTo>
                    <a:pt x="2402" y="3"/>
                  </a:lnTo>
                  <a:lnTo>
                    <a:pt x="2412" y="2"/>
                  </a:lnTo>
                  <a:lnTo>
                    <a:pt x="2422" y="3"/>
                  </a:lnTo>
                  <a:lnTo>
                    <a:pt x="2433" y="3"/>
                  </a:lnTo>
                  <a:lnTo>
                    <a:pt x="2443" y="4"/>
                  </a:lnTo>
                  <a:lnTo>
                    <a:pt x="2453" y="4"/>
                  </a:lnTo>
                  <a:lnTo>
                    <a:pt x="2463" y="5"/>
                  </a:lnTo>
                  <a:lnTo>
                    <a:pt x="2473" y="7"/>
                  </a:lnTo>
                  <a:lnTo>
                    <a:pt x="2484" y="7"/>
                  </a:lnTo>
                  <a:lnTo>
                    <a:pt x="2494" y="11"/>
                  </a:lnTo>
                  <a:lnTo>
                    <a:pt x="2504" y="15"/>
                  </a:lnTo>
                  <a:lnTo>
                    <a:pt x="2514" y="22"/>
                  </a:lnTo>
                  <a:lnTo>
                    <a:pt x="2525" y="38"/>
                  </a:lnTo>
                  <a:lnTo>
                    <a:pt x="2535" y="59"/>
                  </a:lnTo>
                  <a:lnTo>
                    <a:pt x="2545" y="98"/>
                  </a:lnTo>
                  <a:lnTo>
                    <a:pt x="2555" y="157"/>
                  </a:lnTo>
                  <a:lnTo>
                    <a:pt x="2566" y="252"/>
                  </a:lnTo>
                  <a:lnTo>
                    <a:pt x="2576" y="387"/>
                  </a:lnTo>
                  <a:lnTo>
                    <a:pt x="2586" y="578"/>
                  </a:lnTo>
                  <a:lnTo>
                    <a:pt x="2596" y="835"/>
                  </a:lnTo>
                  <a:lnTo>
                    <a:pt x="2607" y="1150"/>
                  </a:lnTo>
                  <a:lnTo>
                    <a:pt x="2617" y="1488"/>
                  </a:lnTo>
                  <a:lnTo>
                    <a:pt x="2627" y="1872"/>
                  </a:lnTo>
                  <a:lnTo>
                    <a:pt x="2637" y="2297"/>
                  </a:lnTo>
                  <a:lnTo>
                    <a:pt x="2647" y="2849"/>
                  </a:lnTo>
                  <a:lnTo>
                    <a:pt x="2658" y="3385"/>
                  </a:lnTo>
                  <a:lnTo>
                    <a:pt x="2668" y="3847"/>
                  </a:lnTo>
                  <a:lnTo>
                    <a:pt x="2678" y="4331"/>
                  </a:lnTo>
                  <a:lnTo>
                    <a:pt x="2688" y="4698"/>
                  </a:lnTo>
                  <a:lnTo>
                    <a:pt x="2699" y="5072"/>
                  </a:lnTo>
                  <a:lnTo>
                    <a:pt x="2709" y="5376"/>
                  </a:lnTo>
                  <a:lnTo>
                    <a:pt x="2719" y="5631"/>
                  </a:lnTo>
                  <a:lnTo>
                    <a:pt x="2729" y="5793"/>
                  </a:lnTo>
                  <a:lnTo>
                    <a:pt x="2740" y="5722"/>
                  </a:lnTo>
                  <a:lnTo>
                    <a:pt x="2750" y="5423"/>
                  </a:lnTo>
                  <a:lnTo>
                    <a:pt x="2760" y="4967"/>
                  </a:lnTo>
                  <a:lnTo>
                    <a:pt x="2770" y="4293"/>
                  </a:lnTo>
                  <a:lnTo>
                    <a:pt x="2780" y="3363"/>
                  </a:lnTo>
                  <a:lnTo>
                    <a:pt x="2791" y="2507"/>
                  </a:lnTo>
                  <a:lnTo>
                    <a:pt x="2801" y="1684"/>
                  </a:lnTo>
                  <a:lnTo>
                    <a:pt x="2811" y="1090"/>
                  </a:lnTo>
                  <a:lnTo>
                    <a:pt x="2821" y="668"/>
                  </a:lnTo>
                  <a:lnTo>
                    <a:pt x="2832" y="412"/>
                  </a:lnTo>
                  <a:lnTo>
                    <a:pt x="2842" y="246"/>
                  </a:lnTo>
                  <a:lnTo>
                    <a:pt x="2852" y="149"/>
                  </a:lnTo>
                  <a:lnTo>
                    <a:pt x="2862" y="97"/>
                  </a:lnTo>
                  <a:lnTo>
                    <a:pt x="2873" y="68"/>
                  </a:lnTo>
                  <a:lnTo>
                    <a:pt x="2883" y="49"/>
                  </a:lnTo>
                  <a:lnTo>
                    <a:pt x="2893" y="35"/>
                  </a:lnTo>
                  <a:lnTo>
                    <a:pt x="2903" y="26"/>
                  </a:lnTo>
                  <a:lnTo>
                    <a:pt x="2914" y="19"/>
                  </a:lnTo>
                  <a:lnTo>
                    <a:pt x="2924" y="15"/>
                  </a:lnTo>
                  <a:lnTo>
                    <a:pt x="2934" y="11"/>
                  </a:lnTo>
                  <a:lnTo>
                    <a:pt x="2944" y="9"/>
                  </a:lnTo>
                  <a:lnTo>
                    <a:pt x="2954" y="7"/>
                  </a:lnTo>
                  <a:lnTo>
                    <a:pt x="2965" y="6"/>
                  </a:lnTo>
                  <a:lnTo>
                    <a:pt x="2975" y="5"/>
                  </a:lnTo>
                  <a:lnTo>
                    <a:pt x="2985" y="4"/>
                  </a:lnTo>
                  <a:lnTo>
                    <a:pt x="2995" y="4"/>
                  </a:lnTo>
                  <a:lnTo>
                    <a:pt x="3006" y="4"/>
                  </a:lnTo>
                  <a:lnTo>
                    <a:pt x="3016" y="4"/>
                  </a:lnTo>
                  <a:lnTo>
                    <a:pt x="3026" y="4"/>
                  </a:lnTo>
                  <a:lnTo>
                    <a:pt x="3036" y="3"/>
                  </a:lnTo>
                  <a:lnTo>
                    <a:pt x="3047" y="5"/>
                  </a:lnTo>
                  <a:lnTo>
                    <a:pt x="3057" y="5"/>
                  </a:lnTo>
                  <a:lnTo>
                    <a:pt x="3067" y="6"/>
                  </a:lnTo>
                  <a:lnTo>
                    <a:pt x="3077" y="7"/>
                  </a:lnTo>
                  <a:lnTo>
                    <a:pt x="3087" y="8"/>
                  </a:lnTo>
                  <a:lnTo>
                    <a:pt x="3098" y="9"/>
                  </a:lnTo>
                  <a:lnTo>
                    <a:pt x="3108" y="9"/>
                  </a:lnTo>
                  <a:lnTo>
                    <a:pt x="3118" y="12"/>
                  </a:lnTo>
                  <a:lnTo>
                    <a:pt x="3128" y="15"/>
                  </a:lnTo>
                  <a:lnTo>
                    <a:pt x="3139" y="22"/>
                  </a:lnTo>
                  <a:lnTo>
                    <a:pt x="3149" y="32"/>
                  </a:lnTo>
                  <a:lnTo>
                    <a:pt x="3159" y="51"/>
                  </a:lnTo>
                  <a:lnTo>
                    <a:pt x="3169" y="88"/>
                  </a:lnTo>
                  <a:lnTo>
                    <a:pt x="3180" y="142"/>
                  </a:lnTo>
                  <a:lnTo>
                    <a:pt x="3190" y="231"/>
                  </a:lnTo>
                  <a:lnTo>
                    <a:pt x="3200" y="351"/>
                  </a:lnTo>
                  <a:lnTo>
                    <a:pt x="3210" y="537"/>
                  </a:lnTo>
                  <a:lnTo>
                    <a:pt x="3221" y="776"/>
                  </a:lnTo>
                  <a:lnTo>
                    <a:pt x="3231" y="1042"/>
                  </a:lnTo>
                  <a:lnTo>
                    <a:pt x="3241" y="1396"/>
                  </a:lnTo>
                  <a:lnTo>
                    <a:pt x="3251" y="1828"/>
                  </a:lnTo>
                  <a:lnTo>
                    <a:pt x="3261" y="2315"/>
                  </a:lnTo>
                  <a:lnTo>
                    <a:pt x="3272" y="2867"/>
                  </a:lnTo>
                  <a:lnTo>
                    <a:pt x="3282" y="3449"/>
                  </a:lnTo>
                  <a:lnTo>
                    <a:pt x="3292" y="4052"/>
                  </a:lnTo>
                  <a:lnTo>
                    <a:pt x="3302" y="4596"/>
                  </a:lnTo>
                  <a:lnTo>
                    <a:pt x="3313" y="5144"/>
                  </a:lnTo>
                  <a:lnTo>
                    <a:pt x="3323" y="5545"/>
                  </a:lnTo>
                  <a:lnTo>
                    <a:pt x="3333" y="5894"/>
                  </a:lnTo>
                  <a:lnTo>
                    <a:pt x="3343" y="6256"/>
                  </a:lnTo>
                  <a:lnTo>
                    <a:pt x="3354" y="6321"/>
                  </a:lnTo>
                  <a:lnTo>
                    <a:pt x="3364" y="6218"/>
                  </a:lnTo>
                  <a:lnTo>
                    <a:pt x="3374" y="5869"/>
                  </a:lnTo>
                  <a:lnTo>
                    <a:pt x="3384" y="5293"/>
                  </a:lnTo>
                  <a:lnTo>
                    <a:pt x="3395" y="4350"/>
                  </a:lnTo>
                  <a:lnTo>
                    <a:pt x="3405" y="3257"/>
                  </a:lnTo>
                  <a:lnTo>
                    <a:pt x="3415" y="2249"/>
                  </a:lnTo>
                  <a:lnTo>
                    <a:pt x="3425" y="1469"/>
                  </a:lnTo>
                  <a:lnTo>
                    <a:pt x="3435" y="902"/>
                  </a:lnTo>
                  <a:lnTo>
                    <a:pt x="3446" y="524"/>
                  </a:lnTo>
                  <a:lnTo>
                    <a:pt x="3456" y="295"/>
                  </a:lnTo>
                  <a:lnTo>
                    <a:pt x="3466" y="170"/>
                  </a:lnTo>
                  <a:lnTo>
                    <a:pt x="3476" y="101"/>
                  </a:lnTo>
                  <a:lnTo>
                    <a:pt x="3487" y="62"/>
                  </a:lnTo>
                  <a:lnTo>
                    <a:pt x="3497" y="45"/>
                  </a:lnTo>
                  <a:lnTo>
                    <a:pt x="3507" y="33"/>
                  </a:lnTo>
                  <a:lnTo>
                    <a:pt x="3517" y="26"/>
                  </a:lnTo>
                  <a:lnTo>
                    <a:pt x="3528" y="24"/>
                  </a:lnTo>
                  <a:lnTo>
                    <a:pt x="3538" y="23"/>
                  </a:lnTo>
                  <a:lnTo>
                    <a:pt x="3548" y="23"/>
                  </a:lnTo>
                  <a:lnTo>
                    <a:pt x="3558" y="25"/>
                  </a:lnTo>
                  <a:lnTo>
                    <a:pt x="3568" y="24"/>
                  </a:lnTo>
                  <a:lnTo>
                    <a:pt x="3579" y="25"/>
                  </a:lnTo>
                  <a:lnTo>
                    <a:pt x="3589" y="25"/>
                  </a:lnTo>
                  <a:lnTo>
                    <a:pt x="3599" y="25"/>
                  </a:lnTo>
                  <a:lnTo>
                    <a:pt x="3609" y="24"/>
                  </a:lnTo>
                  <a:lnTo>
                    <a:pt x="3620" y="21"/>
                  </a:lnTo>
                  <a:lnTo>
                    <a:pt x="3630" y="19"/>
                  </a:lnTo>
                  <a:lnTo>
                    <a:pt x="3640" y="16"/>
                  </a:lnTo>
                  <a:lnTo>
                    <a:pt x="3650" y="15"/>
                  </a:lnTo>
                  <a:lnTo>
                    <a:pt x="3661" y="14"/>
                  </a:lnTo>
                  <a:lnTo>
                    <a:pt x="3671" y="15"/>
                  </a:lnTo>
                  <a:lnTo>
                    <a:pt x="3681" y="18"/>
                  </a:lnTo>
                  <a:lnTo>
                    <a:pt x="3691" y="24"/>
                  </a:lnTo>
                  <a:lnTo>
                    <a:pt x="3702" y="35"/>
                  </a:lnTo>
                  <a:lnTo>
                    <a:pt x="3712" y="50"/>
                  </a:lnTo>
                  <a:lnTo>
                    <a:pt x="3722" y="69"/>
                  </a:lnTo>
                  <a:lnTo>
                    <a:pt x="3732" y="96"/>
                  </a:lnTo>
                  <a:lnTo>
                    <a:pt x="3742" y="127"/>
                  </a:lnTo>
                  <a:lnTo>
                    <a:pt x="3753" y="156"/>
                  </a:lnTo>
                  <a:lnTo>
                    <a:pt x="3763" y="192"/>
                  </a:lnTo>
                  <a:lnTo>
                    <a:pt x="3773" y="224"/>
                  </a:lnTo>
                  <a:lnTo>
                    <a:pt x="3783" y="242"/>
                  </a:lnTo>
                  <a:lnTo>
                    <a:pt x="3794" y="253"/>
                  </a:lnTo>
                  <a:lnTo>
                    <a:pt x="3804" y="259"/>
                  </a:lnTo>
                  <a:lnTo>
                    <a:pt x="3814" y="247"/>
                  </a:lnTo>
                  <a:lnTo>
                    <a:pt x="3824" y="225"/>
                  </a:lnTo>
                  <a:lnTo>
                    <a:pt x="3835" y="199"/>
                  </a:lnTo>
                  <a:lnTo>
                    <a:pt x="3845" y="168"/>
                  </a:lnTo>
                  <a:lnTo>
                    <a:pt x="3855" y="144"/>
                  </a:lnTo>
                  <a:lnTo>
                    <a:pt x="3865" y="117"/>
                  </a:lnTo>
                  <a:lnTo>
                    <a:pt x="3875" y="92"/>
                  </a:lnTo>
                  <a:lnTo>
                    <a:pt x="3886" y="71"/>
                  </a:lnTo>
                  <a:lnTo>
                    <a:pt x="3896" y="55"/>
                  </a:lnTo>
                  <a:lnTo>
                    <a:pt x="3906" y="43"/>
                  </a:lnTo>
                  <a:lnTo>
                    <a:pt x="3916" y="35"/>
                  </a:lnTo>
                  <a:lnTo>
                    <a:pt x="3927" y="30"/>
                  </a:lnTo>
                  <a:lnTo>
                    <a:pt x="3937" y="26"/>
                  </a:lnTo>
                  <a:lnTo>
                    <a:pt x="3947" y="25"/>
                  </a:lnTo>
                  <a:lnTo>
                    <a:pt x="3957" y="24"/>
                  </a:lnTo>
                  <a:lnTo>
                    <a:pt x="3968" y="24"/>
                  </a:lnTo>
                  <a:lnTo>
                    <a:pt x="3978" y="25"/>
                  </a:lnTo>
                  <a:lnTo>
                    <a:pt x="3988" y="25"/>
                  </a:lnTo>
                  <a:lnTo>
                    <a:pt x="3998" y="25"/>
                  </a:lnTo>
                  <a:lnTo>
                    <a:pt x="4009" y="28"/>
                  </a:lnTo>
                  <a:lnTo>
                    <a:pt x="4019" y="28"/>
                  </a:lnTo>
                  <a:lnTo>
                    <a:pt x="4029" y="27"/>
                  </a:lnTo>
                  <a:lnTo>
                    <a:pt x="4039" y="27"/>
                  </a:lnTo>
                  <a:lnTo>
                    <a:pt x="4049" y="24"/>
                  </a:lnTo>
                  <a:lnTo>
                    <a:pt x="4060" y="23"/>
                  </a:lnTo>
                  <a:lnTo>
                    <a:pt x="4070" y="21"/>
                  </a:lnTo>
                  <a:lnTo>
                    <a:pt x="4080" y="18"/>
                  </a:lnTo>
                  <a:lnTo>
                    <a:pt x="4090" y="17"/>
                  </a:lnTo>
                  <a:lnTo>
                    <a:pt x="4101" y="15"/>
                  </a:lnTo>
                  <a:lnTo>
                    <a:pt x="4111" y="14"/>
                  </a:lnTo>
                  <a:lnTo>
                    <a:pt x="4121" y="13"/>
                  </a:lnTo>
                  <a:lnTo>
                    <a:pt x="4131" y="12"/>
                  </a:lnTo>
                  <a:lnTo>
                    <a:pt x="4142" y="10"/>
                  </a:lnTo>
                  <a:lnTo>
                    <a:pt x="4152" y="8"/>
                  </a:lnTo>
                  <a:lnTo>
                    <a:pt x="4162" y="9"/>
                  </a:lnTo>
                  <a:lnTo>
                    <a:pt x="4172" y="8"/>
                  </a:lnTo>
                  <a:lnTo>
                    <a:pt x="4182" y="7"/>
                  </a:lnTo>
                  <a:lnTo>
                    <a:pt x="4193" y="8"/>
                  </a:lnTo>
                  <a:lnTo>
                    <a:pt x="4203" y="8"/>
                  </a:lnTo>
                  <a:lnTo>
                    <a:pt x="4213" y="8"/>
                  </a:lnTo>
                  <a:lnTo>
                    <a:pt x="4223" y="11"/>
                  </a:lnTo>
                  <a:lnTo>
                    <a:pt x="4234" y="16"/>
                  </a:lnTo>
                  <a:lnTo>
                    <a:pt x="4244" y="25"/>
                  </a:lnTo>
                  <a:lnTo>
                    <a:pt x="4254" y="45"/>
                  </a:lnTo>
                  <a:lnTo>
                    <a:pt x="4264" y="80"/>
                  </a:lnTo>
                  <a:lnTo>
                    <a:pt x="4275" y="135"/>
                  </a:lnTo>
                  <a:lnTo>
                    <a:pt x="4285" y="220"/>
                  </a:lnTo>
                  <a:lnTo>
                    <a:pt x="4295" y="349"/>
                  </a:lnTo>
                  <a:lnTo>
                    <a:pt x="4305" y="527"/>
                  </a:lnTo>
                  <a:lnTo>
                    <a:pt x="4316" y="761"/>
                  </a:lnTo>
                  <a:lnTo>
                    <a:pt x="4326" y="1050"/>
                  </a:lnTo>
                  <a:lnTo>
                    <a:pt x="4336" y="1443"/>
                  </a:lnTo>
                  <a:lnTo>
                    <a:pt x="4346" y="1891"/>
                  </a:lnTo>
                  <a:lnTo>
                    <a:pt x="4356" y="2353"/>
                  </a:lnTo>
                  <a:lnTo>
                    <a:pt x="4367" y="2799"/>
                  </a:lnTo>
                  <a:lnTo>
                    <a:pt x="4377" y="3313"/>
                  </a:lnTo>
                  <a:lnTo>
                    <a:pt x="4387" y="3852"/>
                  </a:lnTo>
                  <a:lnTo>
                    <a:pt x="4397" y="4511"/>
                  </a:lnTo>
                  <a:lnTo>
                    <a:pt x="4408" y="5148"/>
                  </a:lnTo>
                  <a:lnTo>
                    <a:pt x="4418" y="5837"/>
                  </a:lnTo>
                  <a:lnTo>
                    <a:pt x="4428" y="6379"/>
                  </a:lnTo>
                  <a:lnTo>
                    <a:pt x="4438" y="6876"/>
                  </a:lnTo>
                  <a:lnTo>
                    <a:pt x="4449" y="7404"/>
                  </a:lnTo>
                  <a:lnTo>
                    <a:pt x="4459" y="7836"/>
                  </a:lnTo>
                  <a:lnTo>
                    <a:pt x="4469" y="8423"/>
                  </a:lnTo>
                  <a:lnTo>
                    <a:pt x="4479" y="8952"/>
                  </a:lnTo>
                  <a:lnTo>
                    <a:pt x="4489" y="9325"/>
                  </a:lnTo>
                  <a:lnTo>
                    <a:pt x="4500" y="9738"/>
                  </a:lnTo>
                  <a:lnTo>
                    <a:pt x="4510" y="10110"/>
                  </a:lnTo>
                  <a:lnTo>
                    <a:pt x="4520" y="10240"/>
                  </a:lnTo>
                  <a:lnTo>
                    <a:pt x="4530" y="10401"/>
                  </a:lnTo>
                  <a:lnTo>
                    <a:pt x="4541" y="10110"/>
                  </a:lnTo>
                  <a:lnTo>
                    <a:pt x="4551" y="9218"/>
                  </a:lnTo>
                  <a:lnTo>
                    <a:pt x="4561" y="7523"/>
                  </a:lnTo>
                  <a:lnTo>
                    <a:pt x="4571" y="5019"/>
                  </a:lnTo>
                  <a:lnTo>
                    <a:pt x="4582" y="2793"/>
                  </a:lnTo>
                  <a:lnTo>
                    <a:pt x="4592" y="1293"/>
                  </a:lnTo>
                  <a:lnTo>
                    <a:pt x="4602" y="554"/>
                  </a:lnTo>
                  <a:lnTo>
                    <a:pt x="4612" y="240"/>
                  </a:lnTo>
                  <a:lnTo>
                    <a:pt x="4623" y="116"/>
                  </a:lnTo>
                  <a:lnTo>
                    <a:pt x="4633" y="72"/>
                  </a:lnTo>
                  <a:lnTo>
                    <a:pt x="4643" y="57"/>
                  </a:lnTo>
                  <a:lnTo>
                    <a:pt x="4653" y="49"/>
                  </a:lnTo>
                  <a:lnTo>
                    <a:pt x="4663" y="46"/>
                  </a:lnTo>
                  <a:lnTo>
                    <a:pt x="4674" y="43"/>
                  </a:lnTo>
                  <a:lnTo>
                    <a:pt x="4684" y="42"/>
                  </a:lnTo>
                  <a:lnTo>
                    <a:pt x="4694" y="37"/>
                  </a:lnTo>
                  <a:lnTo>
                    <a:pt x="4704" y="36"/>
                  </a:lnTo>
                  <a:lnTo>
                    <a:pt x="4715" y="33"/>
                  </a:lnTo>
                  <a:lnTo>
                    <a:pt x="4725" y="30"/>
                  </a:lnTo>
                  <a:lnTo>
                    <a:pt x="4735" y="26"/>
                  </a:lnTo>
                  <a:lnTo>
                    <a:pt x="4745" y="23"/>
                  </a:lnTo>
                  <a:lnTo>
                    <a:pt x="4756" y="21"/>
                  </a:lnTo>
                  <a:lnTo>
                    <a:pt x="4766" y="18"/>
                  </a:lnTo>
                  <a:lnTo>
                    <a:pt x="4776" y="17"/>
                  </a:lnTo>
                  <a:lnTo>
                    <a:pt x="4786" y="15"/>
                  </a:lnTo>
                  <a:lnTo>
                    <a:pt x="4796" y="14"/>
                  </a:lnTo>
                  <a:lnTo>
                    <a:pt x="4807" y="14"/>
                  </a:lnTo>
                  <a:lnTo>
                    <a:pt x="4817" y="13"/>
                  </a:lnTo>
                  <a:lnTo>
                    <a:pt x="4827" y="14"/>
                  </a:lnTo>
                  <a:lnTo>
                    <a:pt x="4837" y="14"/>
                  </a:lnTo>
                  <a:lnTo>
                    <a:pt x="4848" y="13"/>
                  </a:lnTo>
                  <a:lnTo>
                    <a:pt x="4858" y="14"/>
                  </a:lnTo>
                  <a:lnTo>
                    <a:pt x="4868" y="14"/>
                  </a:lnTo>
                  <a:lnTo>
                    <a:pt x="4878" y="17"/>
                  </a:lnTo>
                  <a:lnTo>
                    <a:pt x="4889" y="17"/>
                  </a:lnTo>
                  <a:lnTo>
                    <a:pt x="4899" y="17"/>
                  </a:lnTo>
                  <a:lnTo>
                    <a:pt x="4909" y="19"/>
                  </a:lnTo>
                  <a:lnTo>
                    <a:pt x="4919" y="19"/>
                  </a:lnTo>
                  <a:lnTo>
                    <a:pt x="4930" y="18"/>
                  </a:lnTo>
                  <a:lnTo>
                    <a:pt x="4940" y="18"/>
                  </a:lnTo>
                  <a:lnTo>
                    <a:pt x="4950" y="17"/>
                  </a:lnTo>
                  <a:lnTo>
                    <a:pt x="4960" y="15"/>
                  </a:lnTo>
                  <a:lnTo>
                    <a:pt x="4970" y="14"/>
                  </a:lnTo>
                  <a:lnTo>
                    <a:pt x="4981" y="13"/>
                  </a:lnTo>
                  <a:lnTo>
                    <a:pt x="4991" y="14"/>
                  </a:lnTo>
                  <a:lnTo>
                    <a:pt x="5001" y="14"/>
                  </a:lnTo>
                  <a:lnTo>
                    <a:pt x="5011" y="16"/>
                  </a:lnTo>
                  <a:lnTo>
                    <a:pt x="5022" y="19"/>
                  </a:lnTo>
                  <a:lnTo>
                    <a:pt x="5032" y="24"/>
                  </a:lnTo>
                  <a:lnTo>
                    <a:pt x="5042" y="34"/>
                  </a:lnTo>
                  <a:lnTo>
                    <a:pt x="5052" y="47"/>
                  </a:lnTo>
                  <a:lnTo>
                    <a:pt x="5063" y="67"/>
                  </a:lnTo>
                  <a:lnTo>
                    <a:pt x="5073" y="94"/>
                  </a:lnTo>
                  <a:lnTo>
                    <a:pt x="5083" y="128"/>
                  </a:lnTo>
                  <a:lnTo>
                    <a:pt x="5093" y="169"/>
                  </a:lnTo>
                  <a:lnTo>
                    <a:pt x="5103" y="226"/>
                  </a:lnTo>
                  <a:lnTo>
                    <a:pt x="5114" y="276"/>
                  </a:lnTo>
                  <a:lnTo>
                    <a:pt x="5124" y="328"/>
                  </a:lnTo>
                  <a:lnTo>
                    <a:pt x="5134" y="372"/>
                  </a:lnTo>
                  <a:lnTo>
                    <a:pt x="5144" y="420"/>
                  </a:lnTo>
                  <a:lnTo>
                    <a:pt x="5155" y="451"/>
                  </a:lnTo>
                  <a:lnTo>
                    <a:pt x="5165" y="461"/>
                  </a:lnTo>
                  <a:lnTo>
                    <a:pt x="5175" y="455"/>
                  </a:lnTo>
                  <a:lnTo>
                    <a:pt x="5185" y="437"/>
                  </a:lnTo>
                  <a:lnTo>
                    <a:pt x="5196" y="400"/>
                  </a:lnTo>
                  <a:lnTo>
                    <a:pt x="5206" y="364"/>
                  </a:lnTo>
                  <a:lnTo>
                    <a:pt x="5216" y="314"/>
                  </a:lnTo>
                  <a:lnTo>
                    <a:pt x="5226" y="263"/>
                  </a:lnTo>
                  <a:lnTo>
                    <a:pt x="5237" y="210"/>
                  </a:lnTo>
                  <a:lnTo>
                    <a:pt x="5247" y="166"/>
                  </a:lnTo>
                  <a:lnTo>
                    <a:pt x="5257" y="131"/>
                  </a:lnTo>
                  <a:lnTo>
                    <a:pt x="5267" y="102"/>
                  </a:lnTo>
                  <a:lnTo>
                    <a:pt x="5277" y="81"/>
                  </a:lnTo>
                  <a:lnTo>
                    <a:pt x="5288" y="63"/>
                  </a:lnTo>
                  <a:lnTo>
                    <a:pt x="5298" y="50"/>
                  </a:lnTo>
                  <a:lnTo>
                    <a:pt x="5308" y="40"/>
                  </a:lnTo>
                  <a:lnTo>
                    <a:pt x="5318" y="34"/>
                  </a:lnTo>
                  <a:lnTo>
                    <a:pt x="5329" y="29"/>
                  </a:lnTo>
                  <a:lnTo>
                    <a:pt x="5339" y="24"/>
                  </a:lnTo>
                  <a:lnTo>
                    <a:pt x="5349" y="21"/>
                  </a:lnTo>
                  <a:lnTo>
                    <a:pt x="5359" y="18"/>
                  </a:lnTo>
                  <a:lnTo>
                    <a:pt x="5370" y="16"/>
                  </a:lnTo>
                  <a:lnTo>
                    <a:pt x="5380" y="15"/>
                  </a:lnTo>
                  <a:lnTo>
                    <a:pt x="5390" y="14"/>
                  </a:lnTo>
                  <a:lnTo>
                    <a:pt x="5400" y="13"/>
                  </a:lnTo>
                  <a:lnTo>
                    <a:pt x="5410" y="11"/>
                  </a:lnTo>
                  <a:lnTo>
                    <a:pt x="5421" y="10"/>
                  </a:lnTo>
                  <a:lnTo>
                    <a:pt x="5431" y="9"/>
                  </a:lnTo>
                  <a:lnTo>
                    <a:pt x="5441" y="9"/>
                  </a:lnTo>
                  <a:lnTo>
                    <a:pt x="5451" y="8"/>
                  </a:lnTo>
                  <a:lnTo>
                    <a:pt x="5462" y="7"/>
                  </a:lnTo>
                  <a:lnTo>
                    <a:pt x="5472" y="7"/>
                  </a:lnTo>
                  <a:lnTo>
                    <a:pt x="5482" y="7"/>
                  </a:lnTo>
                  <a:lnTo>
                    <a:pt x="5492" y="7"/>
                  </a:lnTo>
                  <a:lnTo>
                    <a:pt x="5503" y="8"/>
                  </a:lnTo>
                  <a:lnTo>
                    <a:pt x="5513" y="8"/>
                  </a:lnTo>
                  <a:lnTo>
                    <a:pt x="5523" y="8"/>
                  </a:lnTo>
                  <a:lnTo>
                    <a:pt x="5533" y="8"/>
                  </a:lnTo>
                  <a:lnTo>
                    <a:pt x="5544" y="8"/>
                  </a:lnTo>
                  <a:lnTo>
                    <a:pt x="5554" y="9"/>
                  </a:lnTo>
                  <a:lnTo>
                    <a:pt x="5564" y="10"/>
                  </a:lnTo>
                  <a:lnTo>
                    <a:pt x="5574" y="11"/>
                  </a:lnTo>
                  <a:lnTo>
                    <a:pt x="5584" y="12"/>
                  </a:lnTo>
                  <a:lnTo>
                    <a:pt x="5595" y="11"/>
                  </a:lnTo>
                  <a:lnTo>
                    <a:pt x="5605" y="12"/>
                  </a:lnTo>
                  <a:lnTo>
                    <a:pt x="5615" y="13"/>
                  </a:lnTo>
                  <a:lnTo>
                    <a:pt x="5625" y="14"/>
                  </a:lnTo>
                  <a:lnTo>
                    <a:pt x="5636" y="14"/>
                  </a:lnTo>
                  <a:lnTo>
                    <a:pt x="5646" y="14"/>
                  </a:lnTo>
                  <a:lnTo>
                    <a:pt x="5656" y="13"/>
                  </a:lnTo>
                  <a:lnTo>
                    <a:pt x="5666" y="14"/>
                  </a:lnTo>
                  <a:lnTo>
                    <a:pt x="5677" y="12"/>
                  </a:lnTo>
                  <a:lnTo>
                    <a:pt x="5687" y="11"/>
                  </a:lnTo>
                  <a:lnTo>
                    <a:pt x="5697" y="12"/>
                  </a:lnTo>
                  <a:lnTo>
                    <a:pt x="5707" y="10"/>
                  </a:lnTo>
                  <a:lnTo>
                    <a:pt x="5717" y="10"/>
                  </a:lnTo>
                  <a:lnTo>
                    <a:pt x="5728" y="8"/>
                  </a:lnTo>
                  <a:lnTo>
                    <a:pt x="5738" y="8"/>
                  </a:lnTo>
                  <a:lnTo>
                    <a:pt x="5748" y="9"/>
                  </a:lnTo>
                  <a:lnTo>
                    <a:pt x="5758" y="8"/>
                  </a:lnTo>
                  <a:lnTo>
                    <a:pt x="5769" y="7"/>
                  </a:lnTo>
                  <a:lnTo>
                    <a:pt x="5779" y="7"/>
                  </a:lnTo>
                  <a:lnTo>
                    <a:pt x="5789" y="7"/>
                  </a:lnTo>
                  <a:lnTo>
                    <a:pt x="5799" y="8"/>
                  </a:lnTo>
                  <a:lnTo>
                    <a:pt x="5810" y="7"/>
                  </a:lnTo>
                  <a:lnTo>
                    <a:pt x="5820" y="7"/>
                  </a:lnTo>
                  <a:lnTo>
                    <a:pt x="5830" y="8"/>
                  </a:lnTo>
                  <a:lnTo>
                    <a:pt x="5840" y="8"/>
                  </a:lnTo>
                  <a:lnTo>
                    <a:pt x="5851" y="7"/>
                  </a:lnTo>
                  <a:lnTo>
                    <a:pt x="5861" y="6"/>
                  </a:lnTo>
                  <a:lnTo>
                    <a:pt x="5871" y="8"/>
                  </a:lnTo>
                  <a:lnTo>
                    <a:pt x="5881" y="6"/>
                  </a:lnTo>
                  <a:lnTo>
                    <a:pt x="5891" y="7"/>
                  </a:lnTo>
                  <a:lnTo>
                    <a:pt x="5902" y="8"/>
                  </a:lnTo>
                  <a:lnTo>
                    <a:pt x="5912" y="7"/>
                  </a:lnTo>
                  <a:lnTo>
                    <a:pt x="5922" y="8"/>
                  </a:lnTo>
                  <a:lnTo>
                    <a:pt x="5932" y="9"/>
                  </a:lnTo>
                  <a:lnTo>
                    <a:pt x="5943" y="11"/>
                  </a:lnTo>
                  <a:lnTo>
                    <a:pt x="5953" y="13"/>
                  </a:lnTo>
                  <a:lnTo>
                    <a:pt x="5963" y="15"/>
                  </a:lnTo>
                  <a:lnTo>
                    <a:pt x="5973" y="16"/>
                  </a:lnTo>
                  <a:lnTo>
                    <a:pt x="5984" y="22"/>
                  </a:lnTo>
                  <a:lnTo>
                    <a:pt x="5994" y="26"/>
                  </a:lnTo>
                  <a:lnTo>
                    <a:pt x="6004" y="28"/>
                  </a:lnTo>
                  <a:lnTo>
                    <a:pt x="6014" y="36"/>
                  </a:lnTo>
                  <a:lnTo>
                    <a:pt x="6024" y="39"/>
                  </a:lnTo>
                  <a:lnTo>
                    <a:pt x="6035" y="42"/>
                  </a:lnTo>
                  <a:lnTo>
                    <a:pt x="6045" y="42"/>
                  </a:lnTo>
                  <a:lnTo>
                    <a:pt x="6055" y="42"/>
                  </a:lnTo>
                  <a:lnTo>
                    <a:pt x="6065" y="41"/>
                  </a:lnTo>
                  <a:lnTo>
                    <a:pt x="6076" y="38"/>
                  </a:lnTo>
                  <a:lnTo>
                    <a:pt x="6086" y="37"/>
                  </a:lnTo>
                  <a:lnTo>
                    <a:pt x="6096" y="32"/>
                  </a:lnTo>
                  <a:lnTo>
                    <a:pt x="6106" y="29"/>
                  </a:lnTo>
                  <a:lnTo>
                    <a:pt x="6117" y="26"/>
                  </a:lnTo>
                  <a:lnTo>
                    <a:pt x="6127" y="22"/>
                  </a:lnTo>
                  <a:lnTo>
                    <a:pt x="6137" y="20"/>
                  </a:lnTo>
                  <a:lnTo>
                    <a:pt x="6147" y="21"/>
                  </a:lnTo>
                  <a:lnTo>
                    <a:pt x="6158" y="21"/>
                  </a:lnTo>
                  <a:lnTo>
                    <a:pt x="6168" y="21"/>
                  </a:lnTo>
                  <a:lnTo>
                    <a:pt x="6178" y="23"/>
                  </a:lnTo>
                  <a:lnTo>
                    <a:pt x="6188" y="26"/>
                  </a:lnTo>
                  <a:lnTo>
                    <a:pt x="6198" y="28"/>
                  </a:lnTo>
                  <a:lnTo>
                    <a:pt x="6209" y="31"/>
                  </a:lnTo>
                  <a:lnTo>
                    <a:pt x="6219" y="34"/>
                  </a:lnTo>
                  <a:lnTo>
                    <a:pt x="6229" y="37"/>
                  </a:lnTo>
                  <a:lnTo>
                    <a:pt x="6239" y="40"/>
                  </a:lnTo>
                  <a:lnTo>
                    <a:pt x="6250" y="44"/>
                  </a:lnTo>
                  <a:lnTo>
                    <a:pt x="6260" y="50"/>
                  </a:lnTo>
                  <a:lnTo>
                    <a:pt x="6270" y="52"/>
                  </a:lnTo>
                  <a:lnTo>
                    <a:pt x="6280" y="54"/>
                  </a:lnTo>
                  <a:lnTo>
                    <a:pt x="6291" y="59"/>
                  </a:lnTo>
                  <a:lnTo>
                    <a:pt x="6301" y="59"/>
                  </a:lnTo>
                  <a:lnTo>
                    <a:pt x="6311" y="58"/>
                  </a:lnTo>
                  <a:lnTo>
                    <a:pt x="6321" y="58"/>
                  </a:lnTo>
                  <a:lnTo>
                    <a:pt x="6331" y="57"/>
                  </a:lnTo>
                  <a:lnTo>
                    <a:pt x="6342" y="55"/>
                  </a:lnTo>
                  <a:lnTo>
                    <a:pt x="6352" y="50"/>
                  </a:lnTo>
                  <a:lnTo>
                    <a:pt x="6362" y="44"/>
                  </a:lnTo>
                  <a:lnTo>
                    <a:pt x="6372" y="40"/>
                  </a:lnTo>
                  <a:lnTo>
                    <a:pt x="6383" y="34"/>
                  </a:lnTo>
                  <a:lnTo>
                    <a:pt x="6393" y="29"/>
                  </a:lnTo>
                  <a:lnTo>
                    <a:pt x="6403" y="25"/>
                  </a:lnTo>
                  <a:lnTo>
                    <a:pt x="6413" y="23"/>
                  </a:lnTo>
                  <a:lnTo>
                    <a:pt x="6424" y="21"/>
                  </a:lnTo>
                  <a:lnTo>
                    <a:pt x="6434" y="22"/>
                  </a:lnTo>
                  <a:lnTo>
                    <a:pt x="6444" y="24"/>
                  </a:lnTo>
                  <a:lnTo>
                    <a:pt x="6454" y="27"/>
                  </a:lnTo>
                  <a:lnTo>
                    <a:pt x="6465" y="31"/>
                  </a:lnTo>
                  <a:lnTo>
                    <a:pt x="6475" y="37"/>
                  </a:lnTo>
                  <a:lnTo>
                    <a:pt x="6485" y="41"/>
                  </a:lnTo>
                  <a:lnTo>
                    <a:pt x="6495" y="45"/>
                  </a:lnTo>
                  <a:lnTo>
                    <a:pt x="6505" y="48"/>
                  </a:lnTo>
                  <a:lnTo>
                    <a:pt x="6516" y="51"/>
                  </a:lnTo>
                  <a:lnTo>
                    <a:pt x="6526" y="52"/>
                  </a:lnTo>
                  <a:lnTo>
                    <a:pt x="6536" y="52"/>
                  </a:lnTo>
                  <a:lnTo>
                    <a:pt x="6546" y="49"/>
                  </a:lnTo>
                  <a:lnTo>
                    <a:pt x="6557" y="46"/>
                  </a:lnTo>
                  <a:lnTo>
                    <a:pt x="6567" y="42"/>
                  </a:lnTo>
                  <a:lnTo>
                    <a:pt x="6577" y="38"/>
                  </a:lnTo>
                  <a:lnTo>
                    <a:pt x="6587" y="36"/>
                  </a:lnTo>
                  <a:lnTo>
                    <a:pt x="6598" y="31"/>
                  </a:lnTo>
                  <a:lnTo>
                    <a:pt x="6608" y="27"/>
                  </a:lnTo>
                  <a:lnTo>
                    <a:pt x="6618" y="22"/>
                  </a:lnTo>
                  <a:lnTo>
                    <a:pt x="6628" y="19"/>
                  </a:lnTo>
                  <a:lnTo>
                    <a:pt x="6638" y="17"/>
                  </a:lnTo>
                  <a:lnTo>
                    <a:pt x="6649" y="15"/>
                  </a:lnTo>
                  <a:lnTo>
                    <a:pt x="6659" y="14"/>
                  </a:lnTo>
                  <a:lnTo>
                    <a:pt x="6669" y="13"/>
                  </a:lnTo>
                  <a:lnTo>
                    <a:pt x="6679" y="13"/>
                  </a:lnTo>
                  <a:lnTo>
                    <a:pt x="6690" y="13"/>
                  </a:lnTo>
                  <a:lnTo>
                    <a:pt x="6700" y="13"/>
                  </a:lnTo>
                  <a:lnTo>
                    <a:pt x="6710" y="16"/>
                  </a:lnTo>
                  <a:lnTo>
                    <a:pt x="6720" y="14"/>
                  </a:lnTo>
                  <a:lnTo>
                    <a:pt x="6731" y="15"/>
                  </a:lnTo>
                  <a:lnTo>
                    <a:pt x="6741" y="17"/>
                  </a:lnTo>
                  <a:lnTo>
                    <a:pt x="6751" y="17"/>
                  </a:lnTo>
                  <a:lnTo>
                    <a:pt x="6761" y="18"/>
                  </a:lnTo>
                  <a:lnTo>
                    <a:pt x="6772" y="20"/>
                  </a:lnTo>
                  <a:lnTo>
                    <a:pt x="6782" y="24"/>
                  </a:lnTo>
                  <a:lnTo>
                    <a:pt x="6792" y="27"/>
                  </a:lnTo>
                  <a:lnTo>
                    <a:pt x="6802" y="31"/>
                  </a:lnTo>
                  <a:lnTo>
                    <a:pt x="6812" y="37"/>
                  </a:lnTo>
                  <a:lnTo>
                    <a:pt x="6823" y="42"/>
                  </a:lnTo>
                  <a:lnTo>
                    <a:pt x="6833" y="46"/>
                  </a:lnTo>
                  <a:lnTo>
                    <a:pt x="6843" y="49"/>
                  </a:lnTo>
                  <a:lnTo>
                    <a:pt x="6853" y="53"/>
                  </a:lnTo>
                  <a:lnTo>
                    <a:pt x="6864" y="52"/>
                  </a:lnTo>
                  <a:lnTo>
                    <a:pt x="6874" y="52"/>
                  </a:lnTo>
                  <a:lnTo>
                    <a:pt x="6884" y="50"/>
                  </a:lnTo>
                  <a:lnTo>
                    <a:pt x="6894" y="47"/>
                  </a:lnTo>
                  <a:lnTo>
                    <a:pt x="6905" y="43"/>
                  </a:lnTo>
                  <a:lnTo>
                    <a:pt x="6915" y="38"/>
                  </a:lnTo>
                  <a:lnTo>
                    <a:pt x="6925" y="34"/>
                  </a:lnTo>
                  <a:lnTo>
                    <a:pt x="6935" y="31"/>
                  </a:lnTo>
                  <a:lnTo>
                    <a:pt x="6945" y="28"/>
                  </a:lnTo>
                  <a:lnTo>
                    <a:pt x="6956" y="25"/>
                  </a:lnTo>
                  <a:lnTo>
                    <a:pt x="6966" y="22"/>
                  </a:lnTo>
                  <a:lnTo>
                    <a:pt x="6976" y="21"/>
                  </a:lnTo>
                  <a:lnTo>
                    <a:pt x="6986" y="19"/>
                  </a:lnTo>
                  <a:lnTo>
                    <a:pt x="6997" y="18"/>
                  </a:lnTo>
                  <a:lnTo>
                    <a:pt x="7007" y="17"/>
                  </a:lnTo>
                  <a:lnTo>
                    <a:pt x="7017" y="16"/>
                  </a:lnTo>
                  <a:lnTo>
                    <a:pt x="7027" y="16"/>
                  </a:lnTo>
                  <a:lnTo>
                    <a:pt x="7038" y="15"/>
                  </a:lnTo>
                  <a:lnTo>
                    <a:pt x="7048" y="14"/>
                  </a:lnTo>
                  <a:lnTo>
                    <a:pt x="7058" y="13"/>
                  </a:lnTo>
                  <a:lnTo>
                    <a:pt x="7068" y="13"/>
                  </a:lnTo>
                  <a:lnTo>
                    <a:pt x="7079" y="11"/>
                  </a:lnTo>
                  <a:lnTo>
                    <a:pt x="7089" y="11"/>
                  </a:lnTo>
                  <a:lnTo>
                    <a:pt x="7099" y="10"/>
                  </a:lnTo>
                  <a:lnTo>
                    <a:pt x="7109" y="8"/>
                  </a:lnTo>
                  <a:lnTo>
                    <a:pt x="7119" y="7"/>
                  </a:lnTo>
                  <a:lnTo>
                    <a:pt x="7130" y="8"/>
                  </a:lnTo>
                  <a:lnTo>
                    <a:pt x="7140" y="6"/>
                  </a:lnTo>
                  <a:lnTo>
                    <a:pt x="7150" y="6"/>
                  </a:lnTo>
                  <a:lnTo>
                    <a:pt x="7160" y="5"/>
                  </a:lnTo>
                  <a:lnTo>
                    <a:pt x="7171" y="6"/>
                  </a:lnTo>
                  <a:lnTo>
                    <a:pt x="7181" y="5"/>
                  </a:lnTo>
                  <a:lnTo>
                    <a:pt x="7191" y="5"/>
                  </a:lnTo>
                  <a:lnTo>
                    <a:pt x="7201" y="6"/>
                  </a:lnTo>
                  <a:lnTo>
                    <a:pt x="7212" y="6"/>
                  </a:lnTo>
                  <a:lnTo>
                    <a:pt x="7222" y="5"/>
                  </a:lnTo>
                  <a:lnTo>
                    <a:pt x="7232" y="6"/>
                  </a:lnTo>
                  <a:lnTo>
                    <a:pt x="7242" y="6"/>
                  </a:lnTo>
                  <a:lnTo>
                    <a:pt x="7252" y="7"/>
                  </a:lnTo>
                  <a:lnTo>
                    <a:pt x="7263" y="7"/>
                  </a:lnTo>
                  <a:lnTo>
                    <a:pt x="7273" y="8"/>
                  </a:lnTo>
                  <a:lnTo>
                    <a:pt x="7283" y="9"/>
                  </a:lnTo>
                  <a:lnTo>
                    <a:pt x="7293" y="11"/>
                  </a:lnTo>
                  <a:lnTo>
                    <a:pt x="7304" y="15"/>
                  </a:lnTo>
                  <a:lnTo>
                    <a:pt x="7314" y="19"/>
                  </a:lnTo>
                  <a:lnTo>
                    <a:pt x="7324" y="26"/>
                  </a:lnTo>
                  <a:lnTo>
                    <a:pt x="7334" y="37"/>
                  </a:lnTo>
                  <a:lnTo>
                    <a:pt x="7345" y="52"/>
                  </a:lnTo>
                  <a:lnTo>
                    <a:pt x="7355" y="68"/>
                  </a:lnTo>
                  <a:lnTo>
                    <a:pt x="7365" y="90"/>
                  </a:lnTo>
                  <a:lnTo>
                    <a:pt x="7375" y="111"/>
                  </a:lnTo>
                  <a:lnTo>
                    <a:pt x="7386" y="141"/>
                  </a:lnTo>
                  <a:lnTo>
                    <a:pt x="7396" y="164"/>
                  </a:lnTo>
                  <a:lnTo>
                    <a:pt x="7406" y="190"/>
                  </a:lnTo>
                  <a:lnTo>
                    <a:pt x="7416" y="210"/>
                  </a:lnTo>
                  <a:lnTo>
                    <a:pt x="7426" y="220"/>
                  </a:lnTo>
                  <a:lnTo>
                    <a:pt x="7437" y="221"/>
                  </a:lnTo>
                  <a:lnTo>
                    <a:pt x="7447" y="220"/>
                  </a:lnTo>
                  <a:lnTo>
                    <a:pt x="7457" y="208"/>
                  </a:lnTo>
                  <a:lnTo>
                    <a:pt x="7467" y="190"/>
                  </a:lnTo>
                  <a:lnTo>
                    <a:pt x="7478" y="158"/>
                  </a:lnTo>
                  <a:lnTo>
                    <a:pt x="7488" y="136"/>
                  </a:lnTo>
                  <a:lnTo>
                    <a:pt x="7498" y="113"/>
                  </a:lnTo>
                  <a:lnTo>
                    <a:pt x="7508" y="91"/>
                  </a:lnTo>
                  <a:lnTo>
                    <a:pt x="7519" y="74"/>
                  </a:lnTo>
                  <a:lnTo>
                    <a:pt x="7529" y="60"/>
                  </a:lnTo>
                  <a:lnTo>
                    <a:pt x="7539" y="49"/>
                  </a:lnTo>
                  <a:lnTo>
                    <a:pt x="7549" y="43"/>
                  </a:lnTo>
                  <a:lnTo>
                    <a:pt x="7560" y="38"/>
                  </a:lnTo>
                  <a:lnTo>
                    <a:pt x="7570" y="36"/>
                  </a:lnTo>
                  <a:lnTo>
                    <a:pt x="7580" y="34"/>
                  </a:lnTo>
                  <a:lnTo>
                    <a:pt x="7590" y="33"/>
                  </a:lnTo>
                  <a:lnTo>
                    <a:pt x="7600" y="33"/>
                  </a:lnTo>
                  <a:lnTo>
                    <a:pt x="7611" y="30"/>
                  </a:lnTo>
                  <a:lnTo>
                    <a:pt x="7621" y="29"/>
                  </a:lnTo>
                  <a:lnTo>
                    <a:pt x="7631" y="28"/>
                  </a:lnTo>
                  <a:lnTo>
                    <a:pt x="7641" y="26"/>
                  </a:lnTo>
                  <a:lnTo>
                    <a:pt x="7652" y="24"/>
                  </a:lnTo>
                  <a:lnTo>
                    <a:pt x="7662" y="24"/>
                  </a:lnTo>
                  <a:lnTo>
                    <a:pt x="7672" y="24"/>
                  </a:lnTo>
                  <a:lnTo>
                    <a:pt x="7682" y="26"/>
                  </a:lnTo>
                  <a:lnTo>
                    <a:pt x="7693" y="27"/>
                  </a:lnTo>
                  <a:lnTo>
                    <a:pt x="7703" y="30"/>
                  </a:lnTo>
                  <a:lnTo>
                    <a:pt x="7713" y="33"/>
                  </a:lnTo>
                  <a:lnTo>
                    <a:pt x="7723" y="35"/>
                  </a:lnTo>
                  <a:lnTo>
                    <a:pt x="7733" y="38"/>
                  </a:lnTo>
                  <a:lnTo>
                    <a:pt x="7744" y="41"/>
                  </a:lnTo>
                  <a:lnTo>
                    <a:pt x="7754" y="41"/>
                  </a:lnTo>
                  <a:lnTo>
                    <a:pt x="7764" y="44"/>
                  </a:lnTo>
                  <a:lnTo>
                    <a:pt x="7774" y="46"/>
                  </a:lnTo>
                  <a:lnTo>
                    <a:pt x="7785" y="47"/>
                  </a:lnTo>
                  <a:lnTo>
                    <a:pt x="7795" y="49"/>
                  </a:lnTo>
                  <a:lnTo>
                    <a:pt x="7805" y="49"/>
                  </a:lnTo>
                  <a:lnTo>
                    <a:pt x="7815" y="51"/>
                  </a:lnTo>
                  <a:lnTo>
                    <a:pt x="7826" y="51"/>
                  </a:lnTo>
                  <a:lnTo>
                    <a:pt x="7836" y="53"/>
                  </a:lnTo>
                  <a:lnTo>
                    <a:pt x="7846" y="55"/>
                  </a:lnTo>
                  <a:lnTo>
                    <a:pt x="7856" y="54"/>
                  </a:lnTo>
                  <a:lnTo>
                    <a:pt x="7867" y="55"/>
                  </a:lnTo>
                  <a:lnTo>
                    <a:pt x="7877" y="53"/>
                  </a:lnTo>
                  <a:lnTo>
                    <a:pt x="7887" y="51"/>
                  </a:lnTo>
                  <a:lnTo>
                    <a:pt x="7897" y="47"/>
                  </a:lnTo>
                  <a:lnTo>
                    <a:pt x="7907" y="42"/>
                  </a:lnTo>
                  <a:lnTo>
                    <a:pt x="7918" y="41"/>
                  </a:lnTo>
                  <a:lnTo>
                    <a:pt x="7928" y="35"/>
                  </a:lnTo>
                  <a:lnTo>
                    <a:pt x="7938" y="30"/>
                  </a:lnTo>
                  <a:lnTo>
                    <a:pt x="7948" y="25"/>
                  </a:lnTo>
                  <a:lnTo>
                    <a:pt x="7959" y="21"/>
                  </a:lnTo>
                  <a:lnTo>
                    <a:pt x="7969" y="19"/>
                  </a:lnTo>
                  <a:lnTo>
                    <a:pt x="7979" y="16"/>
                  </a:lnTo>
                  <a:lnTo>
                    <a:pt x="7989" y="15"/>
                  </a:lnTo>
                  <a:lnTo>
                    <a:pt x="8000" y="12"/>
                  </a:lnTo>
                  <a:lnTo>
                    <a:pt x="8010" y="10"/>
                  </a:lnTo>
                  <a:lnTo>
                    <a:pt x="8020" y="10"/>
                  </a:lnTo>
                  <a:lnTo>
                    <a:pt x="8030" y="9"/>
                  </a:lnTo>
                  <a:lnTo>
                    <a:pt x="8040" y="9"/>
                  </a:lnTo>
                  <a:lnTo>
                    <a:pt x="8051" y="9"/>
                  </a:lnTo>
                  <a:lnTo>
                    <a:pt x="8061" y="8"/>
                  </a:lnTo>
                  <a:lnTo>
                    <a:pt x="8071" y="10"/>
                  </a:lnTo>
                  <a:lnTo>
                    <a:pt x="8081" y="9"/>
                  </a:lnTo>
                  <a:lnTo>
                    <a:pt x="8092" y="11"/>
                  </a:lnTo>
                  <a:lnTo>
                    <a:pt x="8102" y="10"/>
                  </a:lnTo>
                  <a:lnTo>
                    <a:pt x="8112" y="12"/>
                  </a:lnTo>
                  <a:lnTo>
                    <a:pt x="8122" y="12"/>
                  </a:lnTo>
                  <a:lnTo>
                    <a:pt x="8133" y="13"/>
                  </a:lnTo>
                  <a:lnTo>
                    <a:pt x="8143" y="14"/>
                  </a:lnTo>
                  <a:lnTo>
                    <a:pt x="8153" y="16"/>
                  </a:lnTo>
                  <a:lnTo>
                    <a:pt x="8163" y="17"/>
                  </a:lnTo>
                  <a:lnTo>
                    <a:pt x="8174" y="21"/>
                  </a:lnTo>
                  <a:lnTo>
                    <a:pt x="8184" y="27"/>
                  </a:lnTo>
                  <a:lnTo>
                    <a:pt x="8194" y="35"/>
                  </a:lnTo>
                  <a:lnTo>
                    <a:pt x="8204" y="48"/>
                  </a:lnTo>
                  <a:lnTo>
                    <a:pt x="8214" y="70"/>
                  </a:lnTo>
                  <a:lnTo>
                    <a:pt x="8225" y="95"/>
                  </a:lnTo>
                  <a:lnTo>
                    <a:pt x="8235" y="129"/>
                  </a:lnTo>
                  <a:lnTo>
                    <a:pt x="8245" y="173"/>
                  </a:lnTo>
                  <a:lnTo>
                    <a:pt x="8255" y="222"/>
                  </a:lnTo>
                  <a:lnTo>
                    <a:pt x="8266" y="265"/>
                  </a:lnTo>
                  <a:lnTo>
                    <a:pt x="8276" y="312"/>
                  </a:lnTo>
                  <a:lnTo>
                    <a:pt x="8286" y="356"/>
                  </a:lnTo>
                  <a:lnTo>
                    <a:pt x="8296" y="379"/>
                  </a:lnTo>
                  <a:lnTo>
                    <a:pt x="8307" y="399"/>
                  </a:lnTo>
                  <a:lnTo>
                    <a:pt x="8317" y="402"/>
                  </a:lnTo>
                  <a:lnTo>
                    <a:pt x="8327" y="393"/>
                  </a:lnTo>
                  <a:lnTo>
                    <a:pt x="8337" y="366"/>
                  </a:lnTo>
                  <a:lnTo>
                    <a:pt x="8347" y="324"/>
                  </a:lnTo>
                  <a:lnTo>
                    <a:pt x="8358" y="287"/>
                  </a:lnTo>
                  <a:lnTo>
                    <a:pt x="8368" y="250"/>
                  </a:lnTo>
                  <a:lnTo>
                    <a:pt x="8378" y="207"/>
                  </a:lnTo>
                  <a:lnTo>
                    <a:pt x="8388" y="173"/>
                  </a:lnTo>
                  <a:lnTo>
                    <a:pt x="8399" y="144"/>
                  </a:lnTo>
                  <a:lnTo>
                    <a:pt x="8409" y="121"/>
                  </a:lnTo>
                  <a:lnTo>
                    <a:pt x="8419" y="105"/>
                  </a:lnTo>
                  <a:lnTo>
                    <a:pt x="8429" y="90"/>
                  </a:lnTo>
                  <a:lnTo>
                    <a:pt x="8440" y="78"/>
                  </a:lnTo>
                  <a:lnTo>
                    <a:pt x="8450" y="64"/>
                  </a:lnTo>
                  <a:lnTo>
                    <a:pt x="8460" y="52"/>
                  </a:lnTo>
                  <a:lnTo>
                    <a:pt x="8470" y="45"/>
                  </a:lnTo>
                  <a:lnTo>
                    <a:pt x="8481" y="35"/>
                  </a:lnTo>
                  <a:lnTo>
                    <a:pt x="8491" y="29"/>
                  </a:lnTo>
                  <a:lnTo>
                    <a:pt x="8501" y="24"/>
                  </a:lnTo>
                  <a:lnTo>
                    <a:pt x="8511" y="19"/>
                  </a:lnTo>
                  <a:lnTo>
                    <a:pt x="8521" y="16"/>
                  </a:lnTo>
                  <a:lnTo>
                    <a:pt x="8532" y="15"/>
                  </a:lnTo>
                  <a:lnTo>
                    <a:pt x="8542" y="15"/>
                  </a:lnTo>
                  <a:lnTo>
                    <a:pt x="8552" y="14"/>
                  </a:lnTo>
                  <a:lnTo>
                    <a:pt x="8562" y="17"/>
                  </a:lnTo>
                  <a:lnTo>
                    <a:pt x="8573" y="17"/>
                  </a:lnTo>
                  <a:lnTo>
                    <a:pt x="8583" y="20"/>
                  </a:lnTo>
                  <a:lnTo>
                    <a:pt x="8593" y="19"/>
                  </a:lnTo>
                  <a:lnTo>
                    <a:pt x="8603" y="20"/>
                  </a:lnTo>
                  <a:lnTo>
                    <a:pt x="8614" y="20"/>
                  </a:lnTo>
                  <a:lnTo>
                    <a:pt x="8624" y="21"/>
                  </a:lnTo>
                  <a:lnTo>
                    <a:pt x="8634" y="20"/>
                  </a:lnTo>
                  <a:lnTo>
                    <a:pt x="8644" y="20"/>
                  </a:lnTo>
                  <a:lnTo>
                    <a:pt x="8654" y="19"/>
                  </a:lnTo>
                  <a:lnTo>
                    <a:pt x="8665" y="17"/>
                  </a:lnTo>
                  <a:lnTo>
                    <a:pt x="8675" y="16"/>
                  </a:lnTo>
                  <a:lnTo>
                    <a:pt x="8685" y="13"/>
                  </a:lnTo>
                  <a:lnTo>
                    <a:pt x="8695" y="13"/>
                  </a:lnTo>
                  <a:lnTo>
                    <a:pt x="8706" y="10"/>
                  </a:lnTo>
                  <a:lnTo>
                    <a:pt x="8716" y="11"/>
                  </a:lnTo>
                  <a:lnTo>
                    <a:pt x="8726" y="9"/>
                  </a:lnTo>
                  <a:lnTo>
                    <a:pt x="8736" y="9"/>
                  </a:lnTo>
                  <a:lnTo>
                    <a:pt x="8747" y="10"/>
                  </a:lnTo>
                  <a:lnTo>
                    <a:pt x="8757" y="7"/>
                  </a:lnTo>
                  <a:lnTo>
                    <a:pt x="8767" y="7"/>
                  </a:lnTo>
                  <a:lnTo>
                    <a:pt x="8777" y="7"/>
                  </a:lnTo>
                  <a:lnTo>
                    <a:pt x="8788" y="8"/>
                  </a:lnTo>
                  <a:lnTo>
                    <a:pt x="8798" y="7"/>
                  </a:lnTo>
                  <a:lnTo>
                    <a:pt x="8808" y="8"/>
                  </a:lnTo>
                  <a:lnTo>
                    <a:pt x="8818" y="10"/>
                  </a:lnTo>
                  <a:lnTo>
                    <a:pt x="8828" y="12"/>
                  </a:lnTo>
                  <a:lnTo>
                    <a:pt x="8839" y="13"/>
                  </a:lnTo>
                  <a:lnTo>
                    <a:pt x="8849" y="14"/>
                  </a:lnTo>
                  <a:lnTo>
                    <a:pt x="8859" y="14"/>
                  </a:lnTo>
                  <a:lnTo>
                    <a:pt x="8869" y="16"/>
                  </a:lnTo>
                  <a:lnTo>
                    <a:pt x="8880" y="18"/>
                  </a:lnTo>
                  <a:lnTo>
                    <a:pt x="8890" y="18"/>
                  </a:lnTo>
                  <a:lnTo>
                    <a:pt x="8900" y="18"/>
                  </a:lnTo>
                  <a:lnTo>
                    <a:pt x="8910" y="16"/>
                  </a:lnTo>
                  <a:lnTo>
                    <a:pt x="8921" y="16"/>
                  </a:lnTo>
                  <a:lnTo>
                    <a:pt x="8931" y="14"/>
                  </a:lnTo>
                  <a:lnTo>
                    <a:pt x="8941" y="13"/>
                  </a:lnTo>
                  <a:lnTo>
                    <a:pt x="8951" y="11"/>
                  </a:lnTo>
                  <a:lnTo>
                    <a:pt x="8961" y="10"/>
                  </a:lnTo>
                  <a:lnTo>
                    <a:pt x="8972" y="9"/>
                  </a:lnTo>
                  <a:lnTo>
                    <a:pt x="8982" y="7"/>
                  </a:lnTo>
                  <a:lnTo>
                    <a:pt x="8992" y="7"/>
                  </a:lnTo>
                  <a:lnTo>
                    <a:pt x="9002" y="7"/>
                  </a:lnTo>
                  <a:lnTo>
                    <a:pt x="9013" y="6"/>
                  </a:lnTo>
                  <a:lnTo>
                    <a:pt x="9023" y="8"/>
                  </a:lnTo>
                  <a:lnTo>
                    <a:pt x="9033" y="7"/>
                  </a:lnTo>
                  <a:lnTo>
                    <a:pt x="9043" y="8"/>
                  </a:lnTo>
                  <a:lnTo>
                    <a:pt x="9054" y="10"/>
                  </a:lnTo>
                  <a:lnTo>
                    <a:pt x="9064" y="9"/>
                  </a:lnTo>
                  <a:lnTo>
                    <a:pt x="9074" y="11"/>
                  </a:lnTo>
                  <a:lnTo>
                    <a:pt x="9084" y="10"/>
                  </a:lnTo>
                  <a:lnTo>
                    <a:pt x="9095" y="12"/>
                  </a:lnTo>
                  <a:lnTo>
                    <a:pt x="9105" y="12"/>
                  </a:lnTo>
                  <a:lnTo>
                    <a:pt x="9115" y="14"/>
                  </a:lnTo>
                  <a:lnTo>
                    <a:pt x="9125" y="12"/>
                  </a:lnTo>
                  <a:lnTo>
                    <a:pt x="9135" y="12"/>
                  </a:lnTo>
                  <a:lnTo>
                    <a:pt x="9146" y="9"/>
                  </a:lnTo>
                  <a:lnTo>
                    <a:pt x="9156" y="10"/>
                  </a:lnTo>
                  <a:lnTo>
                    <a:pt x="9166" y="9"/>
                  </a:lnTo>
                  <a:lnTo>
                    <a:pt x="9176" y="8"/>
                  </a:lnTo>
                  <a:lnTo>
                    <a:pt x="9187" y="7"/>
                  </a:lnTo>
                  <a:lnTo>
                    <a:pt x="9197" y="7"/>
                  </a:lnTo>
                  <a:lnTo>
                    <a:pt x="9207" y="7"/>
                  </a:lnTo>
                  <a:lnTo>
                    <a:pt x="9217" y="7"/>
                  </a:lnTo>
                  <a:lnTo>
                    <a:pt x="9228" y="7"/>
                  </a:lnTo>
                  <a:lnTo>
                    <a:pt x="9238" y="8"/>
                  </a:lnTo>
                  <a:lnTo>
                    <a:pt x="9248" y="10"/>
                  </a:lnTo>
                  <a:lnTo>
                    <a:pt x="9258" y="14"/>
                  </a:lnTo>
                  <a:lnTo>
                    <a:pt x="9268" y="22"/>
                  </a:lnTo>
                  <a:lnTo>
                    <a:pt x="9279" y="36"/>
                  </a:lnTo>
                  <a:lnTo>
                    <a:pt x="9289" y="56"/>
                  </a:lnTo>
                  <a:lnTo>
                    <a:pt x="9299" y="92"/>
                  </a:lnTo>
                  <a:lnTo>
                    <a:pt x="9309" y="143"/>
                  </a:lnTo>
                  <a:lnTo>
                    <a:pt x="9320" y="214"/>
                  </a:lnTo>
                  <a:lnTo>
                    <a:pt x="9330" y="308"/>
                  </a:lnTo>
                  <a:lnTo>
                    <a:pt x="9340" y="414"/>
                  </a:lnTo>
                  <a:lnTo>
                    <a:pt x="9350" y="555"/>
                  </a:lnTo>
                  <a:lnTo>
                    <a:pt x="9361" y="708"/>
                  </a:lnTo>
                  <a:lnTo>
                    <a:pt x="9371" y="853"/>
                  </a:lnTo>
                  <a:lnTo>
                    <a:pt x="9381" y="998"/>
                  </a:lnTo>
                  <a:lnTo>
                    <a:pt x="9391" y="1121"/>
                  </a:lnTo>
                  <a:lnTo>
                    <a:pt x="9402" y="1218"/>
                  </a:lnTo>
                  <a:lnTo>
                    <a:pt x="9412" y="1235"/>
                  </a:lnTo>
                  <a:lnTo>
                    <a:pt x="9422" y="1238"/>
                  </a:lnTo>
                  <a:lnTo>
                    <a:pt x="9432" y="1142"/>
                  </a:lnTo>
                  <a:lnTo>
                    <a:pt x="9442" y="1026"/>
                  </a:lnTo>
                  <a:lnTo>
                    <a:pt x="9453" y="889"/>
                  </a:lnTo>
                  <a:lnTo>
                    <a:pt x="9463" y="752"/>
                  </a:lnTo>
                  <a:lnTo>
                    <a:pt x="9473" y="604"/>
                  </a:lnTo>
                  <a:lnTo>
                    <a:pt x="9483" y="466"/>
                  </a:lnTo>
                  <a:lnTo>
                    <a:pt x="9494" y="350"/>
                  </a:lnTo>
                  <a:lnTo>
                    <a:pt x="9504" y="250"/>
                  </a:lnTo>
                  <a:lnTo>
                    <a:pt x="9514" y="176"/>
                  </a:lnTo>
                  <a:lnTo>
                    <a:pt x="9524" y="125"/>
                  </a:lnTo>
                  <a:lnTo>
                    <a:pt x="9535" y="86"/>
                  </a:lnTo>
                  <a:lnTo>
                    <a:pt x="9545" y="65"/>
                  </a:lnTo>
                  <a:lnTo>
                    <a:pt x="9555" y="52"/>
                  </a:lnTo>
                  <a:lnTo>
                    <a:pt x="9565" y="42"/>
                  </a:lnTo>
                  <a:lnTo>
                    <a:pt x="9575" y="35"/>
                  </a:lnTo>
                  <a:lnTo>
                    <a:pt x="9586" y="32"/>
                  </a:lnTo>
                  <a:lnTo>
                    <a:pt x="9596" y="27"/>
                  </a:lnTo>
                  <a:lnTo>
                    <a:pt x="9606" y="25"/>
                  </a:lnTo>
                  <a:lnTo>
                    <a:pt x="9616" y="25"/>
                  </a:lnTo>
                  <a:lnTo>
                    <a:pt x="9627" y="22"/>
                  </a:lnTo>
                  <a:lnTo>
                    <a:pt x="9637" y="20"/>
                  </a:lnTo>
                  <a:lnTo>
                    <a:pt x="9647" y="18"/>
                  </a:lnTo>
                  <a:lnTo>
                    <a:pt x="9657" y="16"/>
                  </a:lnTo>
                  <a:lnTo>
                    <a:pt x="9668" y="13"/>
                  </a:lnTo>
                  <a:lnTo>
                    <a:pt x="9678" y="13"/>
                  </a:lnTo>
                  <a:lnTo>
                    <a:pt x="9688" y="12"/>
                  </a:lnTo>
                  <a:lnTo>
                    <a:pt x="9698" y="12"/>
                  </a:lnTo>
                  <a:lnTo>
                    <a:pt x="9709" y="9"/>
                  </a:lnTo>
                  <a:lnTo>
                    <a:pt x="9719" y="10"/>
                  </a:lnTo>
                  <a:lnTo>
                    <a:pt x="9729" y="9"/>
                  </a:lnTo>
                  <a:lnTo>
                    <a:pt x="9739" y="8"/>
                  </a:lnTo>
                  <a:lnTo>
                    <a:pt x="9749" y="7"/>
                  </a:lnTo>
                  <a:lnTo>
                    <a:pt x="9760" y="7"/>
                  </a:lnTo>
                  <a:lnTo>
                    <a:pt x="9770" y="7"/>
                  </a:lnTo>
                  <a:lnTo>
                    <a:pt x="9780" y="6"/>
                  </a:lnTo>
                  <a:lnTo>
                    <a:pt x="9790" y="5"/>
                  </a:lnTo>
                  <a:lnTo>
                    <a:pt x="9801" y="6"/>
                  </a:lnTo>
                  <a:lnTo>
                    <a:pt x="9811" y="4"/>
                  </a:lnTo>
                  <a:lnTo>
                    <a:pt x="9821" y="5"/>
                  </a:lnTo>
                  <a:lnTo>
                    <a:pt x="9831" y="5"/>
                  </a:lnTo>
                  <a:lnTo>
                    <a:pt x="9842" y="5"/>
                  </a:lnTo>
                  <a:lnTo>
                    <a:pt x="9852" y="5"/>
                  </a:lnTo>
                  <a:lnTo>
                    <a:pt x="9862" y="5"/>
                  </a:lnTo>
                  <a:lnTo>
                    <a:pt x="9872" y="4"/>
                  </a:lnTo>
                  <a:lnTo>
                    <a:pt x="9882" y="5"/>
                  </a:lnTo>
                  <a:lnTo>
                    <a:pt x="9893" y="5"/>
                  </a:lnTo>
                  <a:lnTo>
                    <a:pt x="9903" y="5"/>
                  </a:lnTo>
                  <a:lnTo>
                    <a:pt x="9913" y="4"/>
                  </a:lnTo>
                  <a:lnTo>
                    <a:pt x="9923" y="5"/>
                  </a:lnTo>
                  <a:lnTo>
                    <a:pt x="9934" y="4"/>
                  </a:lnTo>
                  <a:lnTo>
                    <a:pt x="9944" y="5"/>
                  </a:lnTo>
                  <a:lnTo>
                    <a:pt x="9954" y="5"/>
                  </a:lnTo>
                  <a:lnTo>
                    <a:pt x="9964" y="6"/>
                  </a:lnTo>
                  <a:lnTo>
                    <a:pt x="9975" y="6"/>
                  </a:lnTo>
                  <a:lnTo>
                    <a:pt x="9985" y="5"/>
                  </a:lnTo>
                  <a:lnTo>
                    <a:pt x="9995" y="6"/>
                  </a:lnTo>
                  <a:lnTo>
                    <a:pt x="10005" y="7"/>
                  </a:lnTo>
                  <a:lnTo>
                    <a:pt x="10016" y="6"/>
                  </a:lnTo>
                  <a:lnTo>
                    <a:pt x="10026" y="8"/>
                  </a:lnTo>
                  <a:lnTo>
                    <a:pt x="10036" y="8"/>
                  </a:lnTo>
                  <a:lnTo>
                    <a:pt x="10046" y="8"/>
                  </a:lnTo>
                  <a:lnTo>
                    <a:pt x="10056" y="8"/>
                  </a:lnTo>
                  <a:lnTo>
                    <a:pt x="10067" y="9"/>
                  </a:lnTo>
                  <a:lnTo>
                    <a:pt x="10077" y="9"/>
                  </a:lnTo>
                  <a:lnTo>
                    <a:pt x="10087" y="9"/>
                  </a:lnTo>
                  <a:lnTo>
                    <a:pt x="10097" y="9"/>
                  </a:lnTo>
                  <a:lnTo>
                    <a:pt x="10108" y="9"/>
                  </a:lnTo>
                  <a:lnTo>
                    <a:pt x="10118" y="9"/>
                  </a:lnTo>
                  <a:lnTo>
                    <a:pt x="10128" y="8"/>
                  </a:lnTo>
                  <a:lnTo>
                    <a:pt x="10138" y="8"/>
                  </a:lnTo>
                  <a:lnTo>
                    <a:pt x="10149" y="7"/>
                  </a:lnTo>
                  <a:lnTo>
                    <a:pt x="10159" y="7"/>
                  </a:lnTo>
                  <a:lnTo>
                    <a:pt x="10169" y="6"/>
                  </a:lnTo>
                  <a:lnTo>
                    <a:pt x="10179" y="6"/>
                  </a:lnTo>
                  <a:lnTo>
                    <a:pt x="10189" y="7"/>
                  </a:lnTo>
                  <a:lnTo>
                    <a:pt x="10200" y="6"/>
                  </a:lnTo>
                  <a:lnTo>
                    <a:pt x="10210" y="6"/>
                  </a:lnTo>
                  <a:lnTo>
                    <a:pt x="10220" y="7"/>
                  </a:lnTo>
                  <a:lnTo>
                    <a:pt x="10230" y="7"/>
                  </a:lnTo>
                  <a:lnTo>
                    <a:pt x="10241" y="6"/>
                  </a:lnTo>
                  <a:lnTo>
                    <a:pt x="10251" y="6"/>
                  </a:lnTo>
                  <a:lnTo>
                    <a:pt x="10261" y="7"/>
                  </a:lnTo>
                  <a:lnTo>
                    <a:pt x="10271" y="7"/>
                  </a:lnTo>
                  <a:lnTo>
                    <a:pt x="10282" y="7"/>
                  </a:lnTo>
                  <a:lnTo>
                    <a:pt x="10292" y="7"/>
                  </a:lnTo>
                  <a:lnTo>
                    <a:pt x="10302" y="9"/>
                  </a:lnTo>
                  <a:lnTo>
                    <a:pt x="10312" y="9"/>
                  </a:lnTo>
                  <a:lnTo>
                    <a:pt x="10323" y="11"/>
                  </a:lnTo>
                  <a:lnTo>
                    <a:pt x="10333" y="12"/>
                  </a:lnTo>
                  <a:lnTo>
                    <a:pt x="10343" y="14"/>
                  </a:lnTo>
                  <a:lnTo>
                    <a:pt x="10353" y="17"/>
                  </a:lnTo>
                  <a:lnTo>
                    <a:pt x="10363" y="17"/>
                  </a:lnTo>
                  <a:lnTo>
                    <a:pt x="10374" y="20"/>
                  </a:lnTo>
                  <a:lnTo>
                    <a:pt x="10384" y="21"/>
                  </a:lnTo>
                  <a:lnTo>
                    <a:pt x="10394" y="22"/>
                  </a:lnTo>
                  <a:lnTo>
                    <a:pt x="10404" y="21"/>
                  </a:lnTo>
                  <a:lnTo>
                    <a:pt x="10415" y="23"/>
                  </a:lnTo>
                  <a:lnTo>
                    <a:pt x="10425" y="21"/>
                  </a:lnTo>
                  <a:lnTo>
                    <a:pt x="10435" y="19"/>
                  </a:lnTo>
                  <a:lnTo>
                    <a:pt x="10445" y="18"/>
                  </a:lnTo>
                  <a:lnTo>
                    <a:pt x="10456" y="17"/>
                  </a:lnTo>
                  <a:lnTo>
                    <a:pt x="10466" y="16"/>
                  </a:lnTo>
                  <a:lnTo>
                    <a:pt x="10476" y="13"/>
                  </a:lnTo>
                  <a:lnTo>
                    <a:pt x="10486" y="14"/>
                  </a:lnTo>
                  <a:lnTo>
                    <a:pt x="10496" y="11"/>
                  </a:lnTo>
                  <a:lnTo>
                    <a:pt x="10507" y="11"/>
                  </a:lnTo>
                  <a:lnTo>
                    <a:pt x="10517" y="11"/>
                  </a:lnTo>
                  <a:lnTo>
                    <a:pt x="10527" y="11"/>
                  </a:lnTo>
                  <a:lnTo>
                    <a:pt x="10537" y="10"/>
                  </a:lnTo>
                  <a:lnTo>
                    <a:pt x="10548" y="12"/>
                  </a:lnTo>
                  <a:lnTo>
                    <a:pt x="10558" y="10"/>
                  </a:lnTo>
                  <a:lnTo>
                    <a:pt x="10568" y="11"/>
                  </a:lnTo>
                  <a:lnTo>
                    <a:pt x="10578" y="12"/>
                  </a:lnTo>
                  <a:lnTo>
                    <a:pt x="10589" y="12"/>
                  </a:lnTo>
                  <a:lnTo>
                    <a:pt x="10599" y="13"/>
                  </a:lnTo>
                  <a:lnTo>
                    <a:pt x="10609" y="15"/>
                  </a:lnTo>
                  <a:lnTo>
                    <a:pt x="10619" y="14"/>
                  </a:lnTo>
                  <a:lnTo>
                    <a:pt x="10630" y="14"/>
                  </a:lnTo>
                  <a:lnTo>
                    <a:pt x="10640" y="15"/>
                  </a:lnTo>
                  <a:lnTo>
                    <a:pt x="10650" y="16"/>
                  </a:lnTo>
                  <a:lnTo>
                    <a:pt x="10660" y="15"/>
                  </a:lnTo>
                  <a:lnTo>
                    <a:pt x="10670" y="16"/>
                  </a:lnTo>
                  <a:lnTo>
                    <a:pt x="10681" y="15"/>
                  </a:lnTo>
                  <a:lnTo>
                    <a:pt x="10691" y="16"/>
                  </a:lnTo>
                  <a:lnTo>
                    <a:pt x="10701" y="16"/>
                  </a:lnTo>
                  <a:lnTo>
                    <a:pt x="10711" y="15"/>
                  </a:lnTo>
                  <a:lnTo>
                    <a:pt x="10722" y="15"/>
                  </a:lnTo>
                  <a:lnTo>
                    <a:pt x="10732" y="14"/>
                  </a:lnTo>
                  <a:lnTo>
                    <a:pt x="10742" y="14"/>
                  </a:lnTo>
                  <a:lnTo>
                    <a:pt x="10752" y="14"/>
                  </a:lnTo>
                  <a:lnTo>
                    <a:pt x="10763" y="13"/>
                  </a:lnTo>
                  <a:lnTo>
                    <a:pt x="10773" y="12"/>
                  </a:lnTo>
                  <a:lnTo>
                    <a:pt x="10783" y="11"/>
                  </a:lnTo>
                  <a:lnTo>
                    <a:pt x="10793" y="11"/>
                  </a:lnTo>
                  <a:lnTo>
                    <a:pt x="10803" y="9"/>
                  </a:lnTo>
                  <a:lnTo>
                    <a:pt x="10814" y="9"/>
                  </a:lnTo>
                  <a:lnTo>
                    <a:pt x="10824" y="8"/>
                  </a:lnTo>
                  <a:lnTo>
                    <a:pt x="10834" y="8"/>
                  </a:lnTo>
                  <a:lnTo>
                    <a:pt x="10844" y="7"/>
                  </a:lnTo>
                  <a:lnTo>
                    <a:pt x="10855" y="7"/>
                  </a:lnTo>
                  <a:lnTo>
                    <a:pt x="10865" y="7"/>
                  </a:lnTo>
                  <a:lnTo>
                    <a:pt x="10875" y="6"/>
                  </a:lnTo>
                  <a:lnTo>
                    <a:pt x="10885" y="7"/>
                  </a:lnTo>
                  <a:lnTo>
                    <a:pt x="10896" y="6"/>
                  </a:lnTo>
                  <a:lnTo>
                    <a:pt x="10906" y="6"/>
                  </a:lnTo>
                  <a:lnTo>
                    <a:pt x="10916" y="6"/>
                  </a:lnTo>
                  <a:lnTo>
                    <a:pt x="10926" y="6"/>
                  </a:lnTo>
                  <a:lnTo>
                    <a:pt x="10937" y="7"/>
                  </a:lnTo>
                  <a:lnTo>
                    <a:pt x="10947" y="7"/>
                  </a:lnTo>
                  <a:lnTo>
                    <a:pt x="10957" y="8"/>
                  </a:lnTo>
                  <a:lnTo>
                    <a:pt x="10967" y="6"/>
                  </a:lnTo>
                  <a:lnTo>
                    <a:pt x="10977" y="6"/>
                  </a:lnTo>
                  <a:lnTo>
                    <a:pt x="10988" y="7"/>
                  </a:lnTo>
                  <a:lnTo>
                    <a:pt x="10998" y="7"/>
                  </a:lnTo>
                  <a:lnTo>
                    <a:pt x="11008" y="7"/>
                  </a:lnTo>
                  <a:lnTo>
                    <a:pt x="11018" y="7"/>
                  </a:lnTo>
                  <a:lnTo>
                    <a:pt x="11029" y="7"/>
                  </a:lnTo>
                  <a:lnTo>
                    <a:pt x="11039" y="7"/>
                  </a:lnTo>
                  <a:lnTo>
                    <a:pt x="11049" y="6"/>
                  </a:lnTo>
                  <a:lnTo>
                    <a:pt x="11059" y="7"/>
                  </a:lnTo>
                  <a:lnTo>
                    <a:pt x="11070" y="8"/>
                  </a:lnTo>
                  <a:lnTo>
                    <a:pt x="11080" y="7"/>
                  </a:lnTo>
                  <a:lnTo>
                    <a:pt x="11090" y="8"/>
                  </a:lnTo>
                  <a:lnTo>
                    <a:pt x="11100" y="11"/>
                  </a:lnTo>
                  <a:lnTo>
                    <a:pt x="11110" y="12"/>
                  </a:lnTo>
                  <a:lnTo>
                    <a:pt x="11121" y="17"/>
                  </a:lnTo>
                  <a:lnTo>
                    <a:pt x="11131" y="21"/>
                  </a:lnTo>
                  <a:lnTo>
                    <a:pt x="11141" y="26"/>
                  </a:lnTo>
                  <a:lnTo>
                    <a:pt x="11151" y="33"/>
                  </a:lnTo>
                  <a:lnTo>
                    <a:pt x="11162" y="40"/>
                  </a:lnTo>
                  <a:lnTo>
                    <a:pt x="11172" y="49"/>
                  </a:lnTo>
                  <a:lnTo>
                    <a:pt x="11182" y="58"/>
                  </a:lnTo>
                  <a:lnTo>
                    <a:pt x="11192" y="65"/>
                  </a:lnTo>
                  <a:lnTo>
                    <a:pt x="11203" y="72"/>
                  </a:lnTo>
                  <a:lnTo>
                    <a:pt x="11213" y="72"/>
                  </a:lnTo>
                  <a:lnTo>
                    <a:pt x="11223" y="74"/>
                  </a:lnTo>
                  <a:lnTo>
                    <a:pt x="11233" y="71"/>
                  </a:lnTo>
                  <a:lnTo>
                    <a:pt x="11244" y="66"/>
                  </a:lnTo>
                  <a:lnTo>
                    <a:pt x="11254" y="58"/>
                  </a:lnTo>
                  <a:lnTo>
                    <a:pt x="11254" y="57"/>
                  </a:lnTo>
                </a:path>
              </a:pathLst>
            </a:custGeom>
            <a:noFill/>
            <a:ln w="9360">
              <a:solidFill>
                <a:srgbClr val="00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489" name="Rectangle 278"/>
            <p:cNvSpPr/>
            <p:nvPr/>
          </p:nvSpPr>
          <p:spPr>
            <a:xfrm>
              <a:off x="4013640" y="5470920"/>
              <a:ext cx="198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4.2</a:t>
              </a:r>
              <a:endParaRPr b="0" lang="en-US" sz="800" spc="-1" strike="noStrike">
                <a:solidFill>
                  <a:srgbClr val="000000"/>
                </a:solidFill>
                <a:latin typeface="Calibri"/>
              </a:endParaRPr>
            </a:p>
          </p:txBody>
        </p:sp>
        <p:sp>
          <p:nvSpPr>
            <p:cNvPr id="490" name="Rectangle 280"/>
            <p:cNvSpPr/>
            <p:nvPr/>
          </p:nvSpPr>
          <p:spPr>
            <a:xfrm>
              <a:off x="4278600" y="5470920"/>
              <a:ext cx="198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4.6</a:t>
              </a:r>
              <a:endParaRPr b="0" lang="en-US" sz="800" spc="-1" strike="noStrike">
                <a:solidFill>
                  <a:srgbClr val="000000"/>
                </a:solidFill>
                <a:latin typeface="Calibri"/>
              </a:endParaRPr>
            </a:p>
          </p:txBody>
        </p:sp>
        <p:sp>
          <p:nvSpPr>
            <p:cNvPr id="491" name="Rectangle 282"/>
            <p:cNvSpPr/>
            <p:nvPr/>
          </p:nvSpPr>
          <p:spPr>
            <a:xfrm>
              <a:off x="4542480" y="5470920"/>
              <a:ext cx="198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5.0</a:t>
              </a:r>
              <a:endParaRPr b="0" lang="en-US" sz="800" spc="-1" strike="noStrike">
                <a:solidFill>
                  <a:srgbClr val="000000"/>
                </a:solidFill>
                <a:latin typeface="Calibri"/>
              </a:endParaRPr>
            </a:p>
          </p:txBody>
        </p:sp>
        <p:sp>
          <p:nvSpPr>
            <p:cNvPr id="492" name="Rectangle 284"/>
            <p:cNvSpPr/>
            <p:nvPr/>
          </p:nvSpPr>
          <p:spPr>
            <a:xfrm>
              <a:off x="4806000" y="5470920"/>
              <a:ext cx="198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5.4</a:t>
              </a:r>
              <a:endParaRPr b="0" lang="en-US" sz="800" spc="-1" strike="noStrike">
                <a:solidFill>
                  <a:srgbClr val="000000"/>
                </a:solidFill>
                <a:latin typeface="Calibri"/>
              </a:endParaRPr>
            </a:p>
          </p:txBody>
        </p:sp>
        <p:sp>
          <p:nvSpPr>
            <p:cNvPr id="493" name="Rectangle 286"/>
            <p:cNvSpPr/>
            <p:nvPr/>
          </p:nvSpPr>
          <p:spPr>
            <a:xfrm>
              <a:off x="5070960" y="5470920"/>
              <a:ext cx="198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5.8</a:t>
              </a:r>
              <a:endParaRPr b="0" lang="en-US" sz="800" spc="-1" strike="noStrike">
                <a:solidFill>
                  <a:srgbClr val="000000"/>
                </a:solidFill>
                <a:latin typeface="Calibri"/>
              </a:endParaRPr>
            </a:p>
          </p:txBody>
        </p:sp>
        <p:sp>
          <p:nvSpPr>
            <p:cNvPr id="494" name="Rectangle 288"/>
            <p:cNvSpPr/>
            <p:nvPr/>
          </p:nvSpPr>
          <p:spPr>
            <a:xfrm>
              <a:off x="5334840" y="5470920"/>
              <a:ext cx="198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6.2</a:t>
              </a:r>
              <a:endParaRPr b="0" lang="en-US" sz="800" spc="-1" strike="noStrike">
                <a:solidFill>
                  <a:srgbClr val="000000"/>
                </a:solidFill>
                <a:latin typeface="Calibri"/>
              </a:endParaRPr>
            </a:p>
          </p:txBody>
        </p:sp>
        <p:sp>
          <p:nvSpPr>
            <p:cNvPr id="495" name="Rectangle 290"/>
            <p:cNvSpPr/>
            <p:nvPr/>
          </p:nvSpPr>
          <p:spPr>
            <a:xfrm>
              <a:off x="5599800" y="5470920"/>
              <a:ext cx="198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6.6</a:t>
              </a:r>
              <a:endParaRPr b="0" lang="en-US" sz="800" spc="-1" strike="noStrike">
                <a:solidFill>
                  <a:srgbClr val="000000"/>
                </a:solidFill>
                <a:latin typeface="Calibri"/>
              </a:endParaRPr>
            </a:p>
          </p:txBody>
        </p:sp>
        <p:sp>
          <p:nvSpPr>
            <p:cNvPr id="496" name="TextBox 737"/>
            <p:cNvSpPr/>
            <p:nvPr/>
          </p:nvSpPr>
          <p:spPr>
            <a:xfrm>
              <a:off x="4314600" y="483552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1</a:t>
              </a:r>
              <a:endParaRPr b="0" lang="en-US" sz="800" spc="-1" strike="noStrike">
                <a:solidFill>
                  <a:srgbClr val="000000"/>
                </a:solidFill>
                <a:latin typeface="Calibri"/>
              </a:endParaRPr>
            </a:p>
          </p:txBody>
        </p:sp>
        <p:sp>
          <p:nvSpPr>
            <p:cNvPr id="497" name="TextBox 741"/>
            <p:cNvSpPr/>
            <p:nvPr/>
          </p:nvSpPr>
          <p:spPr>
            <a:xfrm>
              <a:off x="4447080" y="480672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2</a:t>
              </a:r>
              <a:endParaRPr b="0" lang="en-US" sz="800" spc="-1" strike="noStrike">
                <a:solidFill>
                  <a:srgbClr val="000000"/>
                </a:solidFill>
                <a:latin typeface="Calibri"/>
              </a:endParaRPr>
            </a:p>
          </p:txBody>
        </p:sp>
        <p:sp>
          <p:nvSpPr>
            <p:cNvPr id="498" name="TextBox 742"/>
            <p:cNvSpPr/>
            <p:nvPr/>
          </p:nvSpPr>
          <p:spPr>
            <a:xfrm>
              <a:off x="4708800" y="457524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3</a:t>
              </a:r>
              <a:endParaRPr b="0" lang="en-US" sz="800" spc="-1" strike="noStrike">
                <a:solidFill>
                  <a:srgbClr val="000000"/>
                </a:solidFill>
                <a:latin typeface="Calibri"/>
              </a:endParaRPr>
            </a:p>
          </p:txBody>
        </p:sp>
        <p:sp>
          <p:nvSpPr>
            <p:cNvPr id="499" name="TextBox 743"/>
            <p:cNvSpPr/>
            <p:nvPr/>
          </p:nvSpPr>
          <p:spPr>
            <a:xfrm>
              <a:off x="4764240" y="526176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4</a:t>
              </a:r>
              <a:endParaRPr b="0" lang="en-US" sz="800" spc="-1" strike="noStrike">
                <a:solidFill>
                  <a:srgbClr val="000000"/>
                </a:solidFill>
                <a:latin typeface="Calibri"/>
              </a:endParaRPr>
            </a:p>
          </p:txBody>
        </p:sp>
        <p:sp>
          <p:nvSpPr>
            <p:cNvPr id="500" name="TextBox 745"/>
            <p:cNvSpPr/>
            <p:nvPr/>
          </p:nvSpPr>
          <p:spPr>
            <a:xfrm>
              <a:off x="5518440" y="519912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6</a:t>
              </a:r>
              <a:endParaRPr b="0" lang="en-US" sz="800" spc="-1" strike="noStrike">
                <a:solidFill>
                  <a:srgbClr val="000000"/>
                </a:solidFill>
                <a:latin typeface="Calibri"/>
              </a:endParaRPr>
            </a:p>
          </p:txBody>
        </p:sp>
        <p:sp>
          <p:nvSpPr>
            <p:cNvPr id="501" name="TextBox 746"/>
            <p:cNvSpPr/>
            <p:nvPr/>
          </p:nvSpPr>
          <p:spPr>
            <a:xfrm>
              <a:off x="5326200" y="527508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5</a:t>
              </a:r>
              <a:endParaRPr b="0" lang="en-US" sz="800" spc="-1" strike="noStrike">
                <a:solidFill>
                  <a:srgbClr val="000000"/>
                </a:solidFill>
                <a:latin typeface="Calibri"/>
              </a:endParaRPr>
            </a:p>
          </p:txBody>
        </p:sp>
      </p:grpSp>
      <p:sp>
        <p:nvSpPr>
          <p:cNvPr id="502" name="TextBox 747"/>
          <p:cNvSpPr/>
          <p:nvPr/>
        </p:nvSpPr>
        <p:spPr>
          <a:xfrm>
            <a:off x="2293920" y="5153040"/>
            <a:ext cx="5763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cont.</a:t>
            </a:r>
            <a:endParaRPr b="0" lang="en-US" sz="800" spc="-1" strike="noStrike">
              <a:solidFill>
                <a:srgbClr val="000000"/>
              </a:solidFill>
              <a:latin typeface="Calibri"/>
            </a:endParaRPr>
          </a:p>
        </p:txBody>
      </p:sp>
      <p:sp>
        <p:nvSpPr>
          <p:cNvPr id="503" name="TextBox 748"/>
          <p:cNvSpPr/>
          <p:nvPr/>
        </p:nvSpPr>
        <p:spPr>
          <a:xfrm>
            <a:off x="4023000" y="4160880"/>
            <a:ext cx="1910520" cy="3985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Arial"/>
                <a:ea typeface="Arial"/>
              </a:rPr>
              <a:t>Sesquiterpene volatiles from</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Arial"/>
                <a:ea typeface="Arial"/>
              </a:rPr>
              <a:t> </a:t>
            </a:r>
            <a:r>
              <a:rPr b="1" lang="de-DE" sz="1000" spc="-1" strike="noStrike">
                <a:solidFill>
                  <a:srgbClr val="000000"/>
                </a:solidFill>
                <a:latin typeface="Arial"/>
                <a:ea typeface="Arial"/>
              </a:rPr>
              <a:t>intact plants</a:t>
            </a:r>
            <a:endParaRPr b="0" lang="en-US" sz="1000" spc="-1" strike="noStrike">
              <a:solidFill>
                <a:srgbClr val="000000"/>
              </a:solidFill>
              <a:latin typeface="Calibri"/>
            </a:endParaRPr>
          </a:p>
        </p:txBody>
      </p:sp>
      <p:sp>
        <p:nvSpPr>
          <p:cNvPr id="504" name="TextBox 749"/>
          <p:cNvSpPr/>
          <p:nvPr/>
        </p:nvSpPr>
        <p:spPr>
          <a:xfrm>
            <a:off x="1267920" y="4160880"/>
            <a:ext cx="1910520" cy="3985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Arial"/>
                <a:ea typeface="Arial"/>
              </a:rPr>
              <a:t>Sesquiterpene volatiles from</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Arial"/>
                <a:ea typeface="Arial"/>
              </a:rPr>
              <a:t>macerated leaves</a:t>
            </a:r>
            <a:endParaRPr b="0" lang="en-US" sz="1000" spc="-1" strike="noStrike">
              <a:solidFill>
                <a:srgbClr val="000000"/>
              </a:solidFill>
              <a:latin typeface="Calibri"/>
            </a:endParaRPr>
          </a:p>
        </p:txBody>
      </p:sp>
      <p:sp>
        <p:nvSpPr>
          <p:cNvPr id="505" name="TextBox 751"/>
          <p:cNvSpPr/>
          <p:nvPr/>
        </p:nvSpPr>
        <p:spPr>
          <a:xfrm rot="16200000">
            <a:off x="2956680" y="4914360"/>
            <a:ext cx="108144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Relative abundance</a:t>
            </a:r>
            <a:endParaRPr b="0" lang="en-US" sz="8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ea typeface="Arial"/>
              </a:rPr>
              <a:t>(TIC x 10,000 ions)</a:t>
            </a:r>
            <a:endParaRPr b="0" lang="en-US" sz="800" spc="-1" strike="noStrike">
              <a:solidFill>
                <a:srgbClr val="000000"/>
              </a:solidFill>
              <a:latin typeface="Calibri"/>
            </a:endParaRPr>
          </a:p>
        </p:txBody>
      </p:sp>
      <p:sp>
        <p:nvSpPr>
          <p:cNvPr id="506" name="TextBox 461"/>
          <p:cNvSpPr/>
          <p:nvPr/>
        </p:nvSpPr>
        <p:spPr>
          <a:xfrm>
            <a:off x="260280" y="6173640"/>
            <a:ext cx="6408720" cy="28317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l figure 1 – Comparison of sesquiterpene emission from intact plants as measured by standard headspace volatile collection vs. SPME collection from macerated tissue. </a:t>
            </a: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The results of the two methods are directly correlated with each other in terms of the amount emitted and the relative proportion of individual sesquiterpenes. (</a:t>
            </a:r>
            <a:r>
              <a:rPr b="1" lang="en-US" sz="1200" spc="-1" strike="noStrike">
                <a:solidFill>
                  <a:srgbClr val="000000"/>
                </a:solidFill>
                <a:latin typeface="Times New Roman"/>
                <a:ea typeface="Times New Roman"/>
              </a:rPr>
              <a:t>A</a:t>
            </a:r>
            <a:r>
              <a:rPr b="0" lang="en-US" sz="1200" spc="-1" strike="noStrike">
                <a:solidFill>
                  <a:srgbClr val="000000"/>
                </a:solidFill>
                <a:latin typeface="Times New Roman"/>
                <a:ea typeface="Times New Roman"/>
              </a:rPr>
              <a:t>) Maize plants were treated with </a:t>
            </a:r>
            <a:r>
              <a:rPr b="0" i="1" lang="en-US" sz="1200" spc="-1" strike="noStrike">
                <a:solidFill>
                  <a:srgbClr val="000000"/>
                </a:solidFill>
                <a:latin typeface="Times New Roman"/>
                <a:ea typeface="Times New Roman"/>
              </a:rPr>
              <a:t>Spodoptera littoralis </a:t>
            </a:r>
            <a:r>
              <a:rPr b="0" lang="en-US" sz="1200" spc="-1" strike="noStrike">
                <a:solidFill>
                  <a:srgbClr val="000000"/>
                </a:solidFill>
                <a:latin typeface="Times New Roman"/>
                <a:ea typeface="Times New Roman"/>
              </a:rPr>
              <a:t>caterpillars (see Methods). Headspace collection was carried out using a standard system as described in the Methods. For maceration-SPME, the plants were frozen right after volatile collection and ground in liquid nitrogen. Sesquiterpenes released from plant powder were collected using SPME. Samples were analyzed using GC-MS and the peak areas for (</a:t>
            </a:r>
            <a:r>
              <a:rPr b="0" i="1" lang="en-US" sz="1200" spc="-1" strike="noStrike">
                <a:solidFill>
                  <a:srgbClr val="000000"/>
                </a:solidFill>
                <a:latin typeface="Times New Roman"/>
                <a:ea typeface="Times New Roman"/>
              </a:rPr>
              <a:t>E</a:t>
            </a:r>
            <a:r>
              <a:rPr b="0" lang="en-US" sz="1200" spc="-1" strike="noStrike">
                <a:solidFill>
                  <a:srgbClr val="000000"/>
                </a:solidFill>
                <a:latin typeface="Times New Roman"/>
                <a:ea typeface="Times New Roman"/>
              </a:rPr>
              <a:t>)-β-farnesene + (</a:t>
            </a:r>
            <a:r>
              <a:rPr b="0" i="1" lang="en-US" sz="1200" spc="-1" strike="noStrike">
                <a:solidFill>
                  <a:srgbClr val="000000"/>
                </a:solidFill>
                <a:latin typeface="Times New Roman"/>
                <a:ea typeface="Times New Roman"/>
              </a:rPr>
              <a:t>E</a:t>
            </a:r>
            <a:r>
              <a:rPr b="0" lang="en-US" sz="1200" spc="-1" strike="noStrike">
                <a:solidFill>
                  <a:srgbClr val="000000"/>
                </a:solidFill>
                <a:latin typeface="Times New Roman"/>
                <a:ea typeface="Times New Roman"/>
              </a:rPr>
              <a:t>)-α-bergamotene (TPS10 products) and (</a:t>
            </a:r>
            <a:r>
              <a:rPr b="0" i="1" lang="en-US" sz="1200" spc="-1" strike="noStrike">
                <a:solidFill>
                  <a:srgbClr val="000000"/>
                </a:solidFill>
                <a:latin typeface="Times New Roman"/>
                <a:ea typeface="Times New Roman"/>
              </a:rPr>
              <a:t>E</a:t>
            </a:r>
            <a:r>
              <a:rPr b="0" lang="en-US" sz="1200" spc="-1" strike="noStrike">
                <a:solidFill>
                  <a:srgbClr val="000000"/>
                </a:solidFill>
                <a:latin typeface="Times New Roman"/>
                <a:ea typeface="Times New Roman"/>
              </a:rPr>
              <a:t>)-β-caryophyllene (TPS23 product) were used for comparison. To cover a broad range of volatile emission, plants of the inbred line B73 (which are known to emit only low amounts of sesquiterpenes) as well as plants of the hybrid Delprim (which are described as strong emitters) were used in this experiment. (</a:t>
            </a:r>
            <a:r>
              <a:rPr b="1" lang="en-US" sz="1200" spc="-1" strike="noStrike">
                <a:solidFill>
                  <a:srgbClr val="000000"/>
                </a:solidFill>
                <a:latin typeface="Times New Roman"/>
                <a:ea typeface="Times New Roman"/>
              </a:rPr>
              <a:t>B</a:t>
            </a:r>
            <a:r>
              <a:rPr b="0" lang="en-US" sz="1200" spc="-1" strike="noStrike">
                <a:solidFill>
                  <a:srgbClr val="000000"/>
                </a:solidFill>
                <a:latin typeface="Times New Roman"/>
                <a:ea typeface="Times New Roman"/>
              </a:rPr>
              <a:t>) GC-MS traces of sesquiterpenes emitted from an intact herbivore-induced Delprim plant (left) and sesquiterpenes released from powder of the same plant (right). 1, (</a:t>
            </a:r>
            <a:r>
              <a:rPr b="0" i="1" lang="en-US" sz="1200" spc="-1" strike="noStrike">
                <a:solidFill>
                  <a:srgbClr val="000000"/>
                </a:solidFill>
                <a:latin typeface="Times New Roman"/>
                <a:ea typeface="Times New Roman"/>
              </a:rPr>
              <a:t>E</a:t>
            </a:r>
            <a:r>
              <a:rPr b="0" lang="en-US" sz="1200" spc="-1" strike="noStrike">
                <a:solidFill>
                  <a:srgbClr val="000000"/>
                </a:solidFill>
                <a:latin typeface="Times New Roman"/>
                <a:ea typeface="Times New Roman"/>
              </a:rPr>
              <a:t>)-β-caryophyllene ; 2, (</a:t>
            </a:r>
            <a:r>
              <a:rPr b="0" i="1" lang="en-US" sz="1200" spc="-1" strike="noStrike">
                <a:solidFill>
                  <a:srgbClr val="000000"/>
                </a:solidFill>
                <a:latin typeface="Times New Roman"/>
                <a:ea typeface="Times New Roman"/>
              </a:rPr>
              <a:t>E</a:t>
            </a:r>
            <a:r>
              <a:rPr b="0" lang="en-US" sz="1200" spc="-1" strike="noStrike">
                <a:solidFill>
                  <a:srgbClr val="000000"/>
                </a:solidFill>
                <a:latin typeface="Times New Roman"/>
                <a:ea typeface="Times New Roman"/>
              </a:rPr>
              <a:t>)-α-bergamotene ; 3, (</a:t>
            </a:r>
            <a:r>
              <a:rPr b="0" i="1" lang="en-US" sz="1200" spc="-1" strike="noStrike">
                <a:solidFill>
                  <a:srgbClr val="000000"/>
                </a:solidFill>
                <a:latin typeface="Times New Roman"/>
                <a:ea typeface="Times New Roman"/>
              </a:rPr>
              <a:t>E</a:t>
            </a:r>
            <a:r>
              <a:rPr b="0" lang="en-US" sz="1200" spc="-1" strike="noStrike">
                <a:solidFill>
                  <a:srgbClr val="000000"/>
                </a:solidFill>
                <a:latin typeface="Times New Roman"/>
                <a:ea typeface="Times New Roman"/>
              </a:rPr>
              <a:t>)-β-farnesene ; 4, α-humulene; 5, β-bisabolene ; 6, β-sesquiphellandrene.</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12-18T15:04:51Z</dcterms:created>
  <dc:creator>koellner</dc:creator>
  <dc:description/>
  <dc:language>en-US</dc:language>
  <cp:lastModifiedBy>koellner</cp:lastModifiedBy>
  <dcterms:modified xsi:type="dcterms:W3CDTF">2013-01-07T15:33:45Z</dcterms:modified>
  <cp:revision>37</cp:revision>
  <dc:subject/>
  <dc:title>Slide 1</dc:title>
</cp:coreProperties>
</file>